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3.xml" ContentType="application/vnd.openxmlformats-officedocument.themeOverride+xml"/>
  <Override PartName="/ppt/drawings/drawing1.xml" ContentType="application/vnd.openxmlformats-officedocument.drawingml.chartshapes+xml"/>
  <Override PartName="/ppt/charts/chart4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4.xml" ContentType="application/vnd.openxmlformats-officedocument.themeOverride+xml"/>
  <Override PartName="/ppt/drawings/drawing2.xml" ContentType="application/vnd.openxmlformats-officedocument.drawingml.chartshapes+xml"/>
  <Override PartName="/ppt/charts/chart5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5.xml" ContentType="application/vnd.openxmlformats-officedocument.themeOverride+xml"/>
  <Override PartName="/ppt/drawings/drawing3.xml" ContentType="application/vnd.openxmlformats-officedocument.drawingml.chartshapes+xml"/>
  <Override PartName="/ppt/charts/chart6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6.xml" ContentType="application/vnd.openxmlformats-officedocument.themeOverride+xml"/>
  <Override PartName="/ppt/drawings/drawing4.xml" ContentType="application/vnd.openxmlformats-officedocument.drawingml.chartshapes+xml"/>
  <Override PartName="/ppt/charts/chart7.xml" ContentType="application/vnd.openxmlformats-officedocument.drawingml.chart+xml"/>
  <Override PartName="/ppt/theme/themeOverride7.xml" ContentType="application/vnd.openxmlformats-officedocument.themeOverride+xml"/>
  <Override PartName="/ppt/charts/chart8.xml" ContentType="application/vnd.openxmlformats-officedocument.drawingml.chart+xml"/>
  <Override PartName="/ppt/theme/themeOverride8.xml" ContentType="application/vnd.openxmlformats-officedocument.themeOverride+xml"/>
  <Override PartName="/ppt/charts/chart9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9.xml" ContentType="application/vnd.openxmlformats-officedocument.themeOverride+xml"/>
  <Override PartName="/ppt/charts/chart10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10.xml" ContentType="application/vnd.openxmlformats-officedocument.themeOverride+xml"/>
  <Override PartName="/ppt/charts/chart11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theme/themeOverride11.xml" ContentType="application/vnd.openxmlformats-officedocument.themeOverride+xml"/>
  <Override PartName="/ppt/charts/chart12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13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314" r:id="rId2"/>
    <p:sldId id="304" r:id="rId3"/>
    <p:sldId id="316" r:id="rId4"/>
    <p:sldId id="313" r:id="rId5"/>
    <p:sldId id="317" r:id="rId6"/>
    <p:sldId id="319" r:id="rId7"/>
    <p:sldId id="320" r:id="rId8"/>
    <p:sldId id="321" r:id="rId9"/>
  </p:sldIdLst>
  <p:sldSz cx="6858000" cy="9144000" type="screen4x3"/>
  <p:notesSz cx="7023100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33CC"/>
    <a:srgbClr val="0000FF"/>
    <a:srgbClr val="3333FF"/>
    <a:srgbClr val="0000CC"/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1" autoAdjust="0"/>
    <p:restoredTop sz="93129" autoAdjust="0"/>
  </p:normalViewPr>
  <p:slideViewPr>
    <p:cSldViewPr>
      <p:cViewPr varScale="1">
        <p:scale>
          <a:sx n="87" d="100"/>
          <a:sy n="87" d="100"/>
        </p:scale>
        <p:origin x="2986" y="10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.xlsx"/><Relationship Id="rId1" Type="http://schemas.openxmlformats.org/officeDocument/2006/relationships/themeOverride" Target="../theme/themeOverrid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0.xm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package" Target="../embeddings/Microsoft_Excel_Worksheet9.xlsx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1.xml"/><Relationship Id="rId2" Type="http://schemas.microsoft.com/office/2011/relationships/chartColorStyle" Target="colors7.xml"/><Relationship Id="rId1" Type="http://schemas.microsoft.com/office/2011/relationships/chartStyle" Target="style7.xml"/><Relationship Id="rId4" Type="http://schemas.openxmlformats.org/officeDocument/2006/relationships/package" Target="../embeddings/Microsoft_Excel_Worksheet10.xlsx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jinyu\anti-CTLA4+%20anti-MIC%20therapy%20of%20all%20excel%20file\Wu%20EDIT%2002-21-16%20anti-CTLA4+anti-MIC%20therapy%20excel%20data%20reorganized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jinyu\anti-CTLA4+%20anti-MIC%20therapy%20of%20all%20excel%20file\Wu%20EDIT%2002-21-16%20anti-CTLA4+anti-MIC%20therapy%20excel%20data%20reorganized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1.xml"/><Relationship Id="rId1" Type="http://schemas.microsoft.com/office/2011/relationships/chartStyle" Target="style1.xml"/><Relationship Id="rId5" Type="http://schemas.openxmlformats.org/officeDocument/2006/relationships/chartUserShapes" Target="../drawings/drawing1.xml"/><Relationship Id="rId4" Type="http://schemas.openxmlformats.org/officeDocument/2006/relationships/package" Target="../embeddings/Microsoft_Excel_Worksheet2.xlsx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2.xml"/><Relationship Id="rId1" Type="http://schemas.microsoft.com/office/2011/relationships/chartStyle" Target="style2.xml"/><Relationship Id="rId5" Type="http://schemas.openxmlformats.org/officeDocument/2006/relationships/chartUserShapes" Target="../drawings/drawing2.xml"/><Relationship Id="rId4" Type="http://schemas.openxmlformats.org/officeDocument/2006/relationships/package" Target="../embeddings/Microsoft_Excel_Worksheet3.xlsx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3.xml"/><Relationship Id="rId1" Type="http://schemas.microsoft.com/office/2011/relationships/chartStyle" Target="style3.xml"/><Relationship Id="rId5" Type="http://schemas.openxmlformats.org/officeDocument/2006/relationships/chartUserShapes" Target="../drawings/drawing3.xml"/><Relationship Id="rId4" Type="http://schemas.openxmlformats.org/officeDocument/2006/relationships/package" Target="../embeddings/Microsoft_Excel_Worksheet4.xlsx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6.xml"/><Relationship Id="rId2" Type="http://schemas.microsoft.com/office/2011/relationships/chartColorStyle" Target="colors4.xml"/><Relationship Id="rId1" Type="http://schemas.microsoft.com/office/2011/relationships/chartStyle" Target="style4.xml"/><Relationship Id="rId5" Type="http://schemas.openxmlformats.org/officeDocument/2006/relationships/chartUserShapes" Target="../drawings/drawing4.xml"/><Relationship Id="rId4" Type="http://schemas.openxmlformats.org/officeDocument/2006/relationships/package" Target="../embeddings/Microsoft_Excel_Worksheet5.xlsx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6.xlsx"/><Relationship Id="rId1" Type="http://schemas.openxmlformats.org/officeDocument/2006/relationships/themeOverride" Target="../theme/themeOverride7.xm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7.xlsx"/><Relationship Id="rId1" Type="http://schemas.openxmlformats.org/officeDocument/2006/relationships/themeOverride" Target="../theme/themeOverrid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9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package" Target="../embeddings/Microsoft_Excel_Worksheet8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3076076274217693"/>
          <c:y val="0.24816776318530101"/>
          <c:w val="0.63702267918157929"/>
          <c:h val="0.59608724752068298"/>
        </c:manualLayout>
      </c:layout>
      <c:lineChart>
        <c:grouping val="standard"/>
        <c:varyColors val="0"/>
        <c:ser>
          <c:idx val="2"/>
          <c:order val="0"/>
          <c:tx>
            <c:v>TC2-sMICB</c:v>
          </c:tx>
          <c:spPr>
            <a:ln>
              <a:solidFill>
                <a:sysClr val="windowText" lastClr="000000"/>
              </a:solidFill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'Tumor Growth and BW'!$F$76:$M$76</c:f>
                <c:numCache>
                  <c:formatCode>General</c:formatCode>
                  <c:ptCount val="8"/>
                  <c:pt idx="1">
                    <c:v>10.850161936915583</c:v>
                  </c:pt>
                  <c:pt idx="2">
                    <c:v>16.744635598702448</c:v>
                  </c:pt>
                  <c:pt idx="3">
                    <c:v>15.701574715348352</c:v>
                  </c:pt>
                  <c:pt idx="4">
                    <c:v>35.426989427421383</c:v>
                  </c:pt>
                  <c:pt idx="5">
                    <c:v>74.34588872781849</c:v>
                  </c:pt>
                  <c:pt idx="6">
                    <c:v>90.696585379839391</c:v>
                  </c:pt>
                  <c:pt idx="7">
                    <c:v>119.7214645001359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Tumor Growth and BW'!$G$59:$N$59</c:f>
              <c:numCache>
                <c:formatCode>General</c:formatCode>
                <c:ptCount val="8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1</c:v>
                </c:pt>
                <c:pt idx="5">
                  <c:v>13</c:v>
                </c:pt>
                <c:pt idx="6">
                  <c:v>15</c:v>
                </c:pt>
                <c:pt idx="7">
                  <c:v>18</c:v>
                </c:pt>
              </c:numCache>
            </c:numRef>
          </c:cat>
          <c:val>
            <c:numRef>
              <c:f>'Tumor Growth and BW'!$G$65:$M$65</c:f>
              <c:numCache>
                <c:formatCode>0.00</c:formatCode>
                <c:ptCount val="7"/>
                <c:pt idx="0">
                  <c:v>42.217874999999999</c:v>
                </c:pt>
                <c:pt idx="1">
                  <c:v>116.09074999999999</c:v>
                </c:pt>
                <c:pt idx="2">
                  <c:v>197.62587500000001</c:v>
                </c:pt>
                <c:pt idx="3">
                  <c:v>287.84162499999996</c:v>
                </c:pt>
                <c:pt idx="4">
                  <c:v>378.131125</c:v>
                </c:pt>
                <c:pt idx="5">
                  <c:v>547.85337500000003</c:v>
                </c:pt>
                <c:pt idx="6">
                  <c:v>791.611875000000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5FC-4109-A09A-374F9352BEA0}"/>
            </c:ext>
          </c:extLst>
        </c:ser>
        <c:ser>
          <c:idx val="0"/>
          <c:order val="1"/>
          <c:tx>
            <c:v>TC2-sMICB+anti-PD-L1</c:v>
          </c:tx>
          <c:spPr>
            <a:ln>
              <a:solidFill>
                <a:srgbClr val="C00000"/>
              </a:solidFill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'Tumor Growth and BW'!$G$76:$M$76</c:f>
                <c:numCache>
                  <c:formatCode>General</c:formatCode>
                  <c:ptCount val="7"/>
                  <c:pt idx="0">
                    <c:v>10.850161936915583</c:v>
                  </c:pt>
                  <c:pt idx="1">
                    <c:v>16.744635598702448</c:v>
                  </c:pt>
                  <c:pt idx="2">
                    <c:v>15.701574715348352</c:v>
                  </c:pt>
                  <c:pt idx="3">
                    <c:v>35.426989427421383</c:v>
                  </c:pt>
                  <c:pt idx="4">
                    <c:v>74.34588872781849</c:v>
                  </c:pt>
                  <c:pt idx="5">
                    <c:v>90.696585379839391</c:v>
                  </c:pt>
                  <c:pt idx="6">
                    <c:v>119.7214645001359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Tumor Growth and BW'!$G$59:$N$59</c:f>
              <c:numCache>
                <c:formatCode>General</c:formatCode>
                <c:ptCount val="8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1</c:v>
                </c:pt>
                <c:pt idx="5">
                  <c:v>13</c:v>
                </c:pt>
                <c:pt idx="6">
                  <c:v>15</c:v>
                </c:pt>
                <c:pt idx="7">
                  <c:v>18</c:v>
                </c:pt>
              </c:numCache>
            </c:numRef>
          </c:cat>
          <c:val>
            <c:numRef>
              <c:f>'Tumor Growth and BW'!$G$64:$M$64</c:f>
              <c:numCache>
                <c:formatCode>0.00</c:formatCode>
                <c:ptCount val="7"/>
                <c:pt idx="0">
                  <c:v>44.975166666666667</c:v>
                </c:pt>
                <c:pt idx="1">
                  <c:v>94.842666666666673</c:v>
                </c:pt>
                <c:pt idx="2">
                  <c:v>101.08800000000001</c:v>
                </c:pt>
                <c:pt idx="3">
                  <c:v>164.58849999999998</c:v>
                </c:pt>
                <c:pt idx="4">
                  <c:v>296.59366666666665</c:v>
                </c:pt>
                <c:pt idx="5">
                  <c:v>424.80733333333336</c:v>
                </c:pt>
                <c:pt idx="6">
                  <c:v>687.9421666666667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5FC-4109-A09A-374F9352BE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04579328"/>
        <c:axId val="304580864"/>
      </c:lineChart>
      <c:catAx>
        <c:axId val="3045793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800" b="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304580864"/>
        <c:crosses val="autoZero"/>
        <c:auto val="1"/>
        <c:lblAlgn val="ctr"/>
        <c:lblOffset val="100"/>
        <c:noMultiLvlLbl val="0"/>
      </c:catAx>
      <c:valAx>
        <c:axId val="304580864"/>
        <c:scaling>
          <c:orientation val="minMax"/>
          <c:max val="1000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800" b="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304579328"/>
        <c:crosses val="autoZero"/>
        <c:crossBetween val="midCat"/>
        <c:majorUnit val="200"/>
      </c:valAx>
    </c:plotArea>
    <c:legend>
      <c:legendPos val="r"/>
      <c:layout>
        <c:manualLayout>
          <c:xMode val="edge"/>
          <c:yMode val="edge"/>
          <c:x val="0.14457881211845172"/>
          <c:y val="2.8955682873295401E-2"/>
          <c:w val="0.81159968560530094"/>
          <c:h val="0.18127272070851119"/>
        </c:manualLayout>
      </c:layout>
      <c:overlay val="0"/>
      <c:txPr>
        <a:bodyPr/>
        <a:lstStyle/>
        <a:p>
          <a:pPr>
            <a:defRPr sz="800">
              <a:latin typeface="Arial" pitchFamily="34" charset="0"/>
              <a:cs typeface="Arial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9.5142813030724097E-2"/>
          <c:y val="0.10739938757655293"/>
          <c:w val="0.85309233253059857"/>
          <c:h val="0.8416746864975212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chemeClr val="accent2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ure S6'!$F$4:$F$10</c:f>
                <c:numCache>
                  <c:formatCode>General</c:formatCode>
                  <c:ptCount val="7"/>
                  <c:pt idx="0">
                    <c:v>0.5</c:v>
                  </c:pt>
                  <c:pt idx="1">
                    <c:v>1</c:v>
                  </c:pt>
                  <c:pt idx="2">
                    <c:v>1.3</c:v>
                  </c:pt>
                  <c:pt idx="3">
                    <c:v>0.4</c:v>
                  </c:pt>
                  <c:pt idx="4">
                    <c:v>1.1000000000000001</c:v>
                  </c:pt>
                  <c:pt idx="5">
                    <c:v>0.7</c:v>
                  </c:pt>
                  <c:pt idx="6">
                    <c:v>0.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Figure S6'!$E$4:$E$10</c:f>
              <c:numCache>
                <c:formatCode>General</c:formatCode>
                <c:ptCount val="7"/>
                <c:pt idx="0">
                  <c:v>2.4</c:v>
                </c:pt>
                <c:pt idx="1">
                  <c:v>11.2</c:v>
                </c:pt>
                <c:pt idx="2">
                  <c:v>17.5</c:v>
                </c:pt>
                <c:pt idx="3">
                  <c:v>3.2</c:v>
                </c:pt>
                <c:pt idx="4">
                  <c:v>12.1</c:v>
                </c:pt>
                <c:pt idx="5">
                  <c:v>5.5</c:v>
                </c:pt>
                <c:pt idx="6">
                  <c:v>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E3D-4140-9DCB-7265DA910A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71942303"/>
        <c:axId val="116618463"/>
      </c:barChart>
      <c:catAx>
        <c:axId val="171942303"/>
        <c:scaling>
          <c:orientation val="maxMin"/>
        </c:scaling>
        <c:delete val="0"/>
        <c:axPos val="l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6618463"/>
        <c:crosses val="autoZero"/>
        <c:auto val="1"/>
        <c:lblAlgn val="ctr"/>
        <c:lblOffset val="100"/>
        <c:noMultiLvlLbl val="0"/>
      </c:catAx>
      <c:valAx>
        <c:axId val="116618463"/>
        <c:scaling>
          <c:orientation val="minMax"/>
          <c:max val="30"/>
        </c:scaling>
        <c:delete val="0"/>
        <c:axPos val="t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194230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0046135537405651"/>
          <c:y val="0.10739938757655293"/>
          <c:w val="0.84488025953277579"/>
          <c:h val="0.8416746864975212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rgbClr val="7030A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ure S6'!$H$4:$H$10</c:f>
                <c:numCache>
                  <c:formatCode>General</c:formatCode>
                  <c:ptCount val="7"/>
                  <c:pt idx="0">
                    <c:v>0.05</c:v>
                  </c:pt>
                  <c:pt idx="1">
                    <c:v>0.3</c:v>
                  </c:pt>
                  <c:pt idx="2">
                    <c:v>0.6</c:v>
                  </c:pt>
                  <c:pt idx="3">
                    <c:v>0.04</c:v>
                  </c:pt>
                  <c:pt idx="4">
                    <c:v>0.7</c:v>
                  </c:pt>
                  <c:pt idx="5">
                    <c:v>0.2</c:v>
                  </c:pt>
                  <c:pt idx="6">
                    <c:v>0.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Figure S6'!$G$4:$G$10</c:f>
              <c:numCache>
                <c:formatCode>General</c:formatCode>
                <c:ptCount val="7"/>
                <c:pt idx="0">
                  <c:v>0.28999999999999998</c:v>
                </c:pt>
                <c:pt idx="1">
                  <c:v>4.4000000000000004</c:v>
                </c:pt>
                <c:pt idx="2">
                  <c:v>6.9</c:v>
                </c:pt>
                <c:pt idx="3">
                  <c:v>0.32</c:v>
                </c:pt>
                <c:pt idx="4">
                  <c:v>4.5</c:v>
                </c:pt>
                <c:pt idx="5">
                  <c:v>2.7</c:v>
                </c:pt>
                <c:pt idx="6">
                  <c:v>4.59999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A7B-4BC7-B018-6E2CD67F0D3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473344527"/>
        <c:axId val="336198975"/>
      </c:barChart>
      <c:catAx>
        <c:axId val="473344527"/>
        <c:scaling>
          <c:orientation val="maxMin"/>
        </c:scaling>
        <c:delete val="0"/>
        <c:axPos val="l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6198975"/>
        <c:crosses val="autoZero"/>
        <c:auto val="1"/>
        <c:lblAlgn val="ctr"/>
        <c:lblOffset val="100"/>
        <c:noMultiLvlLbl val="0"/>
      </c:catAx>
      <c:valAx>
        <c:axId val="336198975"/>
        <c:scaling>
          <c:orientation val="minMax"/>
          <c:max val="10"/>
        </c:scaling>
        <c:delete val="0"/>
        <c:axPos val="t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73344527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941169532603302"/>
          <c:y val="5.398527598214007E-2"/>
          <c:w val="0.70465733500232897"/>
          <c:h val="0.8763217495364985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0BD-42A1-B267-EEF34829CC1C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30BD-42A1-B267-EEF34829CC1C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30BD-42A1-B267-EEF34829CC1C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30BD-42A1-B267-EEF34829CC1C}"/>
              </c:ext>
            </c:extLst>
          </c:dPt>
          <c:errBars>
            <c:errBarType val="plus"/>
            <c:errValType val="cust"/>
            <c:noEndCap val="0"/>
            <c:plus>
              <c:numRef>
                <c:f>Spleen!$W$57:$W$60</c:f>
                <c:numCache>
                  <c:formatCode>General</c:formatCode>
                  <c:ptCount val="4"/>
                  <c:pt idx="0">
                    <c:v>30.601700000000001</c:v>
                  </c:pt>
                  <c:pt idx="1">
                    <c:v>35.268169999999998</c:v>
                  </c:pt>
                  <c:pt idx="2">
                    <c:v>55.006</c:v>
                  </c:pt>
                  <c:pt idx="3">
                    <c:v>10.2062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pleen!$Y$55:$Y$58</c:f>
              <c:numCache>
                <c:formatCode>General</c:formatCode>
                <c:ptCount val="4"/>
              </c:numCache>
            </c:numRef>
          </c:cat>
          <c:val>
            <c:numRef>
              <c:f>Spleen!$V$57:$V$60</c:f>
              <c:numCache>
                <c:formatCode>General</c:formatCode>
                <c:ptCount val="4"/>
                <c:pt idx="0">
                  <c:v>347</c:v>
                </c:pt>
                <c:pt idx="1">
                  <c:v>515.71429999999998</c:v>
                </c:pt>
                <c:pt idx="2">
                  <c:v>378.4</c:v>
                </c:pt>
                <c:pt idx="3">
                  <c:v>5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30BD-42A1-B267-EEF34829CC1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37577664"/>
        <c:axId val="437579232"/>
      </c:barChart>
      <c:catAx>
        <c:axId val="4375776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7579232"/>
        <c:crosses val="autoZero"/>
        <c:auto val="1"/>
        <c:lblAlgn val="ctr"/>
        <c:lblOffset val="100"/>
        <c:noMultiLvlLbl val="0"/>
      </c:catAx>
      <c:valAx>
        <c:axId val="4375792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375776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501045769049383"/>
          <c:y val="5.6770229302732504E-2"/>
          <c:w val="0.72069829804948049"/>
          <c:h val="0.8634291643777085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886-4B9D-8100-3DDFC2C0DF80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886-4B9D-8100-3DDFC2C0DF80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E886-4B9D-8100-3DDFC2C0DF80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E886-4B9D-8100-3DDFC2C0DF80}"/>
              </c:ext>
            </c:extLst>
          </c:dPt>
          <c:errBars>
            <c:errBarType val="plus"/>
            <c:errValType val="cust"/>
            <c:noEndCap val="0"/>
            <c:plus>
              <c:numRef>
                <c:f>TIL!$X$48:$X$51</c:f>
                <c:numCache>
                  <c:formatCode>General</c:formatCode>
                  <c:ptCount val="4"/>
                  <c:pt idx="0">
                    <c:v>46.48</c:v>
                  </c:pt>
                  <c:pt idx="1">
                    <c:v>13.768929999999999</c:v>
                  </c:pt>
                  <c:pt idx="2">
                    <c:v>21.44</c:v>
                  </c:pt>
                  <c:pt idx="3">
                    <c:v>78.18000000000000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TIL!$Y$52:$Y$55</c:f>
              <c:numCache>
                <c:formatCode>General</c:formatCode>
                <c:ptCount val="4"/>
              </c:numCache>
            </c:numRef>
          </c:cat>
          <c:val>
            <c:numRef>
              <c:f>TIL!$W$48:$W$51</c:f>
              <c:numCache>
                <c:formatCode>General</c:formatCode>
                <c:ptCount val="4"/>
                <c:pt idx="0">
                  <c:v>401.3</c:v>
                </c:pt>
                <c:pt idx="1">
                  <c:v>567.5</c:v>
                </c:pt>
                <c:pt idx="2">
                  <c:v>435</c:v>
                </c:pt>
                <c:pt idx="3">
                  <c:v>898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E886-4B9D-8100-3DDFC2C0DF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37581976"/>
        <c:axId val="437583936"/>
      </c:barChart>
      <c:catAx>
        <c:axId val="4375819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7583936"/>
        <c:crosses val="autoZero"/>
        <c:auto val="1"/>
        <c:lblAlgn val="ctr"/>
        <c:lblOffset val="100"/>
        <c:noMultiLvlLbl val="0"/>
      </c:catAx>
      <c:valAx>
        <c:axId val="4375839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375819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6393776658788489"/>
          <c:y val="0.25829020742857117"/>
          <c:w val="0.80103194891320528"/>
          <c:h val="0.5882030213634698"/>
        </c:manualLayout>
      </c:layout>
      <c:lineChart>
        <c:grouping val="standard"/>
        <c:varyColors val="0"/>
        <c:ser>
          <c:idx val="0"/>
          <c:order val="0"/>
          <c:tx>
            <c:v>TC2</c:v>
          </c:tx>
          <c:spPr>
            <a:ln>
              <a:solidFill>
                <a:srgbClr val="0070C0"/>
              </a:solidFill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'Tumor Growth and BW'!$G$74:$M$74</c:f>
                <c:numCache>
                  <c:formatCode>General</c:formatCode>
                  <c:ptCount val="7"/>
                  <c:pt idx="0">
                    <c:v>0.4962499999999998</c:v>
                  </c:pt>
                  <c:pt idx="1">
                    <c:v>6.8759999999999977</c:v>
                  </c:pt>
                  <c:pt idx="2">
                    <c:v>6.0917500000000038</c:v>
                  </c:pt>
                  <c:pt idx="3">
                    <c:v>57.12</c:v>
                  </c:pt>
                  <c:pt idx="4">
                    <c:v>4.9747500000000002</c:v>
                  </c:pt>
                  <c:pt idx="5">
                    <c:v>2.5190000000000055</c:v>
                  </c:pt>
                  <c:pt idx="6">
                    <c:v>27.40100000000001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Tumor Growth and BW'!$G$59:$M$59</c:f>
              <c:numCache>
                <c:formatCode>General</c:formatCode>
                <c:ptCount val="7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1</c:v>
                </c:pt>
                <c:pt idx="5">
                  <c:v>13</c:v>
                </c:pt>
                <c:pt idx="6">
                  <c:v>15</c:v>
                </c:pt>
              </c:numCache>
            </c:numRef>
          </c:cat>
          <c:val>
            <c:numRef>
              <c:f>'Tumor Growth and BW'!$G$62:$M$62</c:f>
              <c:numCache>
                <c:formatCode>0.00</c:formatCode>
                <c:ptCount val="7"/>
                <c:pt idx="0">
                  <c:v>37.583749999999995</c:v>
                </c:pt>
                <c:pt idx="1">
                  <c:v>106.02000000000001</c:v>
                </c:pt>
                <c:pt idx="2">
                  <c:v>134.88875000000002</c:v>
                </c:pt>
                <c:pt idx="3">
                  <c:v>247.584</c:v>
                </c:pt>
                <c:pt idx="4">
                  <c:v>460.72125000000005</c:v>
                </c:pt>
                <c:pt idx="5">
                  <c:v>614.88099999999997</c:v>
                </c:pt>
                <c:pt idx="6">
                  <c:v>890.689000000000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628-4EDC-824F-3CD62B8CAD14}"/>
            </c:ext>
          </c:extLst>
        </c:ser>
        <c:ser>
          <c:idx val="1"/>
          <c:order val="1"/>
          <c:tx>
            <c:v>TC2+anti-PD-L1</c:v>
          </c:tx>
          <c:spPr>
            <a:ln>
              <a:solidFill>
                <a:srgbClr val="C00000"/>
              </a:solidFill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'Tumor Growth and BW'!$G$75:$M$75</c:f>
                <c:numCache>
                  <c:formatCode>General</c:formatCode>
                  <c:ptCount val="7"/>
                  <c:pt idx="0">
                    <c:v>10.931859514485383</c:v>
                  </c:pt>
                  <c:pt idx="1">
                    <c:v>8.1985037405207901</c:v>
                  </c:pt>
                  <c:pt idx="2">
                    <c:v>12.172672403562194</c:v>
                  </c:pt>
                  <c:pt idx="3">
                    <c:v>34.27203075192817</c:v>
                  </c:pt>
                  <c:pt idx="4">
                    <c:v>48.424777907194461</c:v>
                  </c:pt>
                  <c:pt idx="5">
                    <c:v>84.427528696378303</c:v>
                  </c:pt>
                  <c:pt idx="6">
                    <c:v>134.527240642927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Tumor Growth and BW'!$G$59:$M$59</c:f>
              <c:numCache>
                <c:formatCode>General</c:formatCode>
                <c:ptCount val="7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1</c:v>
                </c:pt>
                <c:pt idx="5">
                  <c:v>13</c:v>
                </c:pt>
                <c:pt idx="6">
                  <c:v>15</c:v>
                </c:pt>
              </c:numCache>
            </c:numRef>
          </c:cat>
          <c:val>
            <c:numRef>
              <c:f>'Tumor Growth and BW'!$G$63:$M$63</c:f>
              <c:numCache>
                <c:formatCode>0.00</c:formatCode>
                <c:ptCount val="7"/>
                <c:pt idx="0">
                  <c:v>34.673333333333332</c:v>
                </c:pt>
                <c:pt idx="1">
                  <c:v>42.029499999999999</c:v>
                </c:pt>
                <c:pt idx="2">
                  <c:v>50.834333333333326</c:v>
                </c:pt>
                <c:pt idx="3">
                  <c:v>100.85066666666667</c:v>
                </c:pt>
                <c:pt idx="4">
                  <c:v>167.18583333333333</c:v>
                </c:pt>
                <c:pt idx="5">
                  <c:v>245.36266666666666</c:v>
                </c:pt>
                <c:pt idx="6">
                  <c:v>327.59700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628-4EDC-824F-3CD62B8CAD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45526144"/>
        <c:axId val="243106944"/>
      </c:lineChart>
      <c:catAx>
        <c:axId val="1455261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crossAx val="243106944"/>
        <c:crosses val="autoZero"/>
        <c:auto val="1"/>
        <c:lblAlgn val="ctr"/>
        <c:lblOffset val="100"/>
        <c:noMultiLvlLbl val="0"/>
      </c:catAx>
      <c:valAx>
        <c:axId val="243106944"/>
        <c:scaling>
          <c:orientation val="minMax"/>
          <c:max val="1000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145526144"/>
        <c:crosses val="autoZero"/>
        <c:crossBetween val="midCat"/>
        <c:majorUnit val="200"/>
      </c:valAx>
    </c:plotArea>
    <c:legend>
      <c:legendPos val="r"/>
      <c:layout>
        <c:manualLayout>
          <c:xMode val="edge"/>
          <c:yMode val="edge"/>
          <c:x val="0.22118820533901312"/>
          <c:y val="3.7491294978328607E-2"/>
          <c:w val="0.69426637494447385"/>
          <c:h val="0.17976459619424318"/>
        </c:manualLayout>
      </c:layout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cIgG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4.0</a:t>
            </a:r>
            <a:r>
              <a:rPr lang="en-US" sz="800" b="1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mg/Kg)</a:t>
            </a:r>
          </a:p>
        </c:rich>
      </c:tx>
      <c:layout>
        <c:manualLayout>
          <c:xMode val="edge"/>
          <c:yMode val="edge"/>
          <c:x val="0.17973152276969412"/>
          <c:y val="6.840287201593833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411259785920304"/>
          <c:y val="6.4128809190360861E-2"/>
          <c:w val="0.78949481643222563"/>
          <c:h val="0.71033904543781445"/>
        </c:manualLayout>
      </c:layout>
      <c:lineChart>
        <c:grouping val="standard"/>
        <c:varyColors val="0"/>
        <c:ser>
          <c:idx val="0"/>
          <c:order val="0"/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'Tumor Growth Curve'!$C$31:$C$43</c:f>
              <c:numCache>
                <c:formatCode>General</c:formatCode>
                <c:ptCount val="13"/>
                <c:pt idx="0">
                  <c:v>22</c:v>
                </c:pt>
                <c:pt idx="1">
                  <c:v>23</c:v>
                </c:pt>
                <c:pt idx="2">
                  <c:v>25</c:v>
                </c:pt>
                <c:pt idx="3">
                  <c:v>27</c:v>
                </c:pt>
                <c:pt idx="4">
                  <c:v>31</c:v>
                </c:pt>
                <c:pt idx="5">
                  <c:v>33</c:v>
                </c:pt>
                <c:pt idx="6">
                  <c:v>36</c:v>
                </c:pt>
                <c:pt idx="7">
                  <c:v>38</c:v>
                </c:pt>
                <c:pt idx="8">
                  <c:v>40</c:v>
                </c:pt>
                <c:pt idx="9">
                  <c:v>43</c:v>
                </c:pt>
                <c:pt idx="10">
                  <c:v>45</c:v>
                </c:pt>
                <c:pt idx="11">
                  <c:v>47</c:v>
                </c:pt>
                <c:pt idx="12">
                  <c:v>50</c:v>
                </c:pt>
              </c:numCache>
            </c:numRef>
          </c:cat>
          <c:val>
            <c:numRef>
              <c:f>'Tumor Growth Curve'!$E$31:$E$43</c:f>
              <c:numCache>
                <c:formatCode>General</c:formatCode>
                <c:ptCount val="13"/>
                <c:pt idx="0">
                  <c:v>6.8769999999999998</c:v>
                </c:pt>
                <c:pt idx="1">
                  <c:v>8.25</c:v>
                </c:pt>
                <c:pt idx="2">
                  <c:v>8</c:v>
                </c:pt>
                <c:pt idx="3">
                  <c:v>83.125</c:v>
                </c:pt>
                <c:pt idx="4">
                  <c:v>123.92</c:v>
                </c:pt>
                <c:pt idx="5">
                  <c:v>275.68400000000003</c:v>
                </c:pt>
                <c:pt idx="6">
                  <c:v>470.59</c:v>
                </c:pt>
                <c:pt idx="7">
                  <c:v>481.52600000000001</c:v>
                </c:pt>
                <c:pt idx="8">
                  <c:v>485.00200000000001</c:v>
                </c:pt>
                <c:pt idx="9">
                  <c:v>605.69600000000003</c:v>
                </c:pt>
                <c:pt idx="10">
                  <c:v>617.16</c:v>
                </c:pt>
                <c:pt idx="11">
                  <c:v>617.46299999999997</c:v>
                </c:pt>
                <c:pt idx="12">
                  <c:v>51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389-4636-A06E-517D72AC22F2}"/>
            </c:ext>
          </c:extLst>
        </c:ser>
        <c:ser>
          <c:idx val="4"/>
          <c:order val="1"/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numRef>
              <c:f>'Tumor Growth Curve'!$C$31:$C$43</c:f>
              <c:numCache>
                <c:formatCode>General</c:formatCode>
                <c:ptCount val="13"/>
                <c:pt idx="0">
                  <c:v>22</c:v>
                </c:pt>
                <c:pt idx="1">
                  <c:v>23</c:v>
                </c:pt>
                <c:pt idx="2">
                  <c:v>25</c:v>
                </c:pt>
                <c:pt idx="3">
                  <c:v>27</c:v>
                </c:pt>
                <c:pt idx="4">
                  <c:v>31</c:v>
                </c:pt>
                <c:pt idx="5">
                  <c:v>33</c:v>
                </c:pt>
                <c:pt idx="6">
                  <c:v>36</c:v>
                </c:pt>
                <c:pt idx="7">
                  <c:v>38</c:v>
                </c:pt>
                <c:pt idx="8">
                  <c:v>40</c:v>
                </c:pt>
                <c:pt idx="9">
                  <c:v>43</c:v>
                </c:pt>
                <c:pt idx="10">
                  <c:v>45</c:v>
                </c:pt>
                <c:pt idx="11">
                  <c:v>47</c:v>
                </c:pt>
                <c:pt idx="12">
                  <c:v>50</c:v>
                </c:pt>
              </c:numCache>
            </c:numRef>
          </c:cat>
          <c:val>
            <c:numRef>
              <c:f>'Tumor Growth Curve'!$I$31:$I$43</c:f>
              <c:numCache>
                <c:formatCode>General</c:formatCode>
                <c:ptCount val="13"/>
                <c:pt idx="0">
                  <c:v>86.097999999999999</c:v>
                </c:pt>
                <c:pt idx="1">
                  <c:v>75.429000000000002</c:v>
                </c:pt>
                <c:pt idx="2">
                  <c:v>132.9615</c:v>
                </c:pt>
                <c:pt idx="3">
                  <c:v>163.35</c:v>
                </c:pt>
                <c:pt idx="4">
                  <c:v>358.9</c:v>
                </c:pt>
                <c:pt idx="5">
                  <c:v>625.93100000000004</c:v>
                </c:pt>
                <c:pt idx="6">
                  <c:v>843.55</c:v>
                </c:pt>
                <c:pt idx="7">
                  <c:v>847.226</c:v>
                </c:pt>
                <c:pt idx="8">
                  <c:v>951.28</c:v>
                </c:pt>
                <c:pt idx="9">
                  <c:v>1593.9829999999999</c:v>
                </c:pt>
                <c:pt idx="10">
                  <c:v>180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389-4636-A06E-517D72AC22F2}"/>
            </c:ext>
          </c:extLst>
        </c:ser>
        <c:ser>
          <c:idx val="5"/>
          <c:order val="2"/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numRef>
              <c:f>'Tumor Growth Curve'!$C$31:$C$43</c:f>
              <c:numCache>
                <c:formatCode>General</c:formatCode>
                <c:ptCount val="13"/>
                <c:pt idx="0">
                  <c:v>22</c:v>
                </c:pt>
                <c:pt idx="1">
                  <c:v>23</c:v>
                </c:pt>
                <c:pt idx="2">
                  <c:v>25</c:v>
                </c:pt>
                <c:pt idx="3">
                  <c:v>27</c:v>
                </c:pt>
                <c:pt idx="4">
                  <c:v>31</c:v>
                </c:pt>
                <c:pt idx="5">
                  <c:v>33</c:v>
                </c:pt>
                <c:pt idx="6">
                  <c:v>36</c:v>
                </c:pt>
                <c:pt idx="7">
                  <c:v>38</c:v>
                </c:pt>
                <c:pt idx="8">
                  <c:v>40</c:v>
                </c:pt>
                <c:pt idx="9">
                  <c:v>43</c:v>
                </c:pt>
                <c:pt idx="10">
                  <c:v>45</c:v>
                </c:pt>
                <c:pt idx="11">
                  <c:v>47</c:v>
                </c:pt>
                <c:pt idx="12">
                  <c:v>50</c:v>
                </c:pt>
              </c:numCache>
            </c:numRef>
          </c:cat>
          <c:val>
            <c:numRef>
              <c:f>'Tumor Growth Curve'!$J$31:$J$43</c:f>
              <c:numCache>
                <c:formatCode>General</c:formatCode>
                <c:ptCount val="13"/>
                <c:pt idx="0">
                  <c:v>115.3359</c:v>
                </c:pt>
                <c:pt idx="1">
                  <c:v>98.695999999999998</c:v>
                </c:pt>
                <c:pt idx="2">
                  <c:v>159.744</c:v>
                </c:pt>
                <c:pt idx="3">
                  <c:v>157.60400000000001</c:v>
                </c:pt>
                <c:pt idx="4">
                  <c:v>490.39800000000002</c:v>
                </c:pt>
                <c:pt idx="5">
                  <c:v>625.86400000000003</c:v>
                </c:pt>
                <c:pt idx="6">
                  <c:v>647.29999999999995</c:v>
                </c:pt>
                <c:pt idx="7">
                  <c:v>1158.9480000000001</c:v>
                </c:pt>
                <c:pt idx="8">
                  <c:v>1304.6880000000001</c:v>
                </c:pt>
                <c:pt idx="9">
                  <c:v>1813</c:v>
                </c:pt>
                <c:pt idx="10">
                  <c:v>181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389-4636-A06E-517D72AC22F2}"/>
            </c:ext>
          </c:extLst>
        </c:ser>
        <c:ser>
          <c:idx val="6"/>
          <c:order val="3"/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numRef>
              <c:f>'Tumor Growth Curve'!$C$31:$C$43</c:f>
              <c:numCache>
                <c:formatCode>General</c:formatCode>
                <c:ptCount val="13"/>
                <c:pt idx="0">
                  <c:v>22</c:v>
                </c:pt>
                <c:pt idx="1">
                  <c:v>23</c:v>
                </c:pt>
                <c:pt idx="2">
                  <c:v>25</c:v>
                </c:pt>
                <c:pt idx="3">
                  <c:v>27</c:v>
                </c:pt>
                <c:pt idx="4">
                  <c:v>31</c:v>
                </c:pt>
                <c:pt idx="5">
                  <c:v>33</c:v>
                </c:pt>
                <c:pt idx="6">
                  <c:v>36</c:v>
                </c:pt>
                <c:pt idx="7">
                  <c:v>38</c:v>
                </c:pt>
                <c:pt idx="8">
                  <c:v>40</c:v>
                </c:pt>
                <c:pt idx="9">
                  <c:v>43</c:v>
                </c:pt>
                <c:pt idx="10">
                  <c:v>45</c:v>
                </c:pt>
                <c:pt idx="11">
                  <c:v>47</c:v>
                </c:pt>
                <c:pt idx="12">
                  <c:v>50</c:v>
                </c:pt>
              </c:numCache>
            </c:numRef>
          </c:cat>
          <c:val>
            <c:numRef>
              <c:f>'Tumor Growth Curve'!$K$31:$K$43</c:f>
              <c:numCache>
                <c:formatCode>General</c:formatCode>
                <c:ptCount val="13"/>
                <c:pt idx="0">
                  <c:v>26.95</c:v>
                </c:pt>
                <c:pt idx="1">
                  <c:v>35.301000000000002</c:v>
                </c:pt>
                <c:pt idx="2">
                  <c:v>47.587499999999999</c:v>
                </c:pt>
                <c:pt idx="3">
                  <c:v>56.448</c:v>
                </c:pt>
                <c:pt idx="4">
                  <c:v>94.08</c:v>
                </c:pt>
                <c:pt idx="5">
                  <c:v>120.9325</c:v>
                </c:pt>
                <c:pt idx="6">
                  <c:v>194.5</c:v>
                </c:pt>
                <c:pt idx="7">
                  <c:v>225.26400000000001</c:v>
                </c:pt>
                <c:pt idx="8">
                  <c:v>303</c:v>
                </c:pt>
                <c:pt idx="9">
                  <c:v>516.096</c:v>
                </c:pt>
                <c:pt idx="10">
                  <c:v>682.34400000000005</c:v>
                </c:pt>
                <c:pt idx="11">
                  <c:v>796.54</c:v>
                </c:pt>
                <c:pt idx="12">
                  <c:v>555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389-4636-A06E-517D72AC22F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34577727"/>
        <c:axId val="1934573151"/>
      </c:lineChart>
      <c:catAx>
        <c:axId val="1934577727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34573151"/>
        <c:crosses val="autoZero"/>
        <c:auto val="1"/>
        <c:lblAlgn val="ctr"/>
        <c:lblOffset val="100"/>
        <c:noMultiLvlLbl val="0"/>
      </c:catAx>
      <c:valAx>
        <c:axId val="1934573151"/>
        <c:scaling>
          <c:orientation val="minMax"/>
          <c:max val="1400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34577727"/>
        <c:crosses val="autoZero"/>
        <c:crossBetween val="midCat"/>
        <c:majorUnit val="2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B10G5</a:t>
            </a:r>
            <a:r>
              <a:rPr lang="en-US" sz="800" b="1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800" b="1" baseline="0" dirty="0">
                <a:latin typeface="Arial" panose="020B0604020202020204" pitchFamily="34" charset="0"/>
                <a:cs typeface="Arial" panose="020B0604020202020204" pitchFamily="34" charset="0"/>
              </a:rPr>
              <a:t>(4.0 mg/Kg) 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15079518299023847"/>
          <c:y val="7.391264551569552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8.1738258941081554E-2"/>
          <c:y val="0.10772585158756662"/>
          <c:w val="0.82325822654831671"/>
          <c:h val="0.72173742806201457"/>
        </c:manualLayout>
      </c:layout>
      <c:lineChart>
        <c:grouping val="standard"/>
        <c:varyColors val="0"/>
        <c:ser>
          <c:idx val="0"/>
          <c:order val="0"/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'Tumor Growth Curve'!$C$31:$C$43</c:f>
              <c:numCache>
                <c:formatCode>General</c:formatCode>
                <c:ptCount val="13"/>
                <c:pt idx="0">
                  <c:v>22</c:v>
                </c:pt>
                <c:pt idx="1">
                  <c:v>23</c:v>
                </c:pt>
                <c:pt idx="2">
                  <c:v>25</c:v>
                </c:pt>
                <c:pt idx="3">
                  <c:v>27</c:v>
                </c:pt>
                <c:pt idx="4">
                  <c:v>31</c:v>
                </c:pt>
                <c:pt idx="5">
                  <c:v>33</c:v>
                </c:pt>
                <c:pt idx="6">
                  <c:v>36</c:v>
                </c:pt>
                <c:pt idx="7">
                  <c:v>38</c:v>
                </c:pt>
                <c:pt idx="8">
                  <c:v>40</c:v>
                </c:pt>
                <c:pt idx="9">
                  <c:v>43</c:v>
                </c:pt>
                <c:pt idx="10">
                  <c:v>45</c:v>
                </c:pt>
                <c:pt idx="11">
                  <c:v>47</c:v>
                </c:pt>
                <c:pt idx="12">
                  <c:v>50</c:v>
                </c:pt>
              </c:numCache>
            </c:numRef>
          </c:cat>
          <c:val>
            <c:numRef>
              <c:f>'Tumor Growth Curve'!$L$31:$L$43</c:f>
              <c:numCache>
                <c:formatCode>General</c:formatCode>
                <c:ptCount val="13"/>
                <c:pt idx="0">
                  <c:v>55.47</c:v>
                </c:pt>
                <c:pt idx="1">
                  <c:v>49.392000000000003</c:v>
                </c:pt>
                <c:pt idx="2">
                  <c:v>57.33</c:v>
                </c:pt>
                <c:pt idx="3">
                  <c:v>82.524000000000001</c:v>
                </c:pt>
                <c:pt idx="4">
                  <c:v>114.0475</c:v>
                </c:pt>
                <c:pt idx="5">
                  <c:v>368.08199999999999</c:v>
                </c:pt>
                <c:pt idx="6">
                  <c:v>275.12799999999999</c:v>
                </c:pt>
                <c:pt idx="7">
                  <c:v>257.72500000000002</c:v>
                </c:pt>
                <c:pt idx="8">
                  <c:v>234.423</c:v>
                </c:pt>
                <c:pt idx="9">
                  <c:v>371.25</c:v>
                </c:pt>
                <c:pt idx="10">
                  <c:v>586.625</c:v>
                </c:pt>
                <c:pt idx="11">
                  <c:v>640</c:v>
                </c:pt>
                <c:pt idx="12">
                  <c:v>546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C8B-42D9-838B-AD43ED07D4C7}"/>
            </c:ext>
          </c:extLst>
        </c:ser>
        <c:ser>
          <c:idx val="1"/>
          <c:order val="1"/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'Tumor Growth Curve'!$C$31:$C$43</c:f>
              <c:numCache>
                <c:formatCode>General</c:formatCode>
                <c:ptCount val="13"/>
                <c:pt idx="0">
                  <c:v>22</c:v>
                </c:pt>
                <c:pt idx="1">
                  <c:v>23</c:v>
                </c:pt>
                <c:pt idx="2">
                  <c:v>25</c:v>
                </c:pt>
                <c:pt idx="3">
                  <c:v>27</c:v>
                </c:pt>
                <c:pt idx="4">
                  <c:v>31</c:v>
                </c:pt>
                <c:pt idx="5">
                  <c:v>33</c:v>
                </c:pt>
                <c:pt idx="6">
                  <c:v>36</c:v>
                </c:pt>
                <c:pt idx="7">
                  <c:v>38</c:v>
                </c:pt>
                <c:pt idx="8">
                  <c:v>40</c:v>
                </c:pt>
                <c:pt idx="9">
                  <c:v>43</c:v>
                </c:pt>
                <c:pt idx="10">
                  <c:v>45</c:v>
                </c:pt>
                <c:pt idx="11">
                  <c:v>47</c:v>
                </c:pt>
                <c:pt idx="12">
                  <c:v>50</c:v>
                </c:pt>
              </c:numCache>
            </c:numRef>
          </c:cat>
          <c:val>
            <c:numRef>
              <c:f>'Tumor Growth Curve'!$M$31:$M$43</c:f>
              <c:numCache>
                <c:formatCode>General</c:formatCode>
                <c:ptCount val="13"/>
                <c:pt idx="0">
                  <c:v>48.4</c:v>
                </c:pt>
                <c:pt idx="1">
                  <c:v>48.51</c:v>
                </c:pt>
                <c:pt idx="2">
                  <c:v>83.75</c:v>
                </c:pt>
                <c:pt idx="3">
                  <c:v>141.53749999999999</c:v>
                </c:pt>
                <c:pt idx="4">
                  <c:v>89.888000000000005</c:v>
                </c:pt>
                <c:pt idx="5">
                  <c:v>161.172</c:v>
                </c:pt>
                <c:pt idx="6">
                  <c:v>249.5</c:v>
                </c:pt>
                <c:pt idx="7">
                  <c:v>215.8245</c:v>
                </c:pt>
                <c:pt idx="8">
                  <c:v>281.60000000000002</c:v>
                </c:pt>
                <c:pt idx="9">
                  <c:v>406.53</c:v>
                </c:pt>
                <c:pt idx="10">
                  <c:v>414.05</c:v>
                </c:pt>
                <c:pt idx="11">
                  <c:v>435.22</c:v>
                </c:pt>
                <c:pt idx="12">
                  <c:v>402.1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C8B-42D9-838B-AD43ED07D4C7}"/>
            </c:ext>
          </c:extLst>
        </c:ser>
        <c:ser>
          <c:idx val="3"/>
          <c:order val="2"/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numRef>
              <c:f>'Tumor Growth Curve'!$C$31:$C$43</c:f>
              <c:numCache>
                <c:formatCode>General</c:formatCode>
                <c:ptCount val="13"/>
                <c:pt idx="0">
                  <c:v>22</c:v>
                </c:pt>
                <c:pt idx="1">
                  <c:v>23</c:v>
                </c:pt>
                <c:pt idx="2">
                  <c:v>25</c:v>
                </c:pt>
                <c:pt idx="3">
                  <c:v>27</c:v>
                </c:pt>
                <c:pt idx="4">
                  <c:v>31</c:v>
                </c:pt>
                <c:pt idx="5">
                  <c:v>33</c:v>
                </c:pt>
                <c:pt idx="6">
                  <c:v>36</c:v>
                </c:pt>
                <c:pt idx="7">
                  <c:v>38</c:v>
                </c:pt>
                <c:pt idx="8">
                  <c:v>40</c:v>
                </c:pt>
                <c:pt idx="9">
                  <c:v>43</c:v>
                </c:pt>
                <c:pt idx="10">
                  <c:v>45</c:v>
                </c:pt>
                <c:pt idx="11">
                  <c:v>47</c:v>
                </c:pt>
                <c:pt idx="12">
                  <c:v>50</c:v>
                </c:pt>
              </c:numCache>
            </c:numRef>
          </c:cat>
          <c:val>
            <c:numRef>
              <c:f>'Tumor Growth Curve'!$O$31:$O$43</c:f>
              <c:numCache>
                <c:formatCode>General</c:formatCode>
                <c:ptCount val="13"/>
                <c:pt idx="0">
                  <c:v>24.024999999999999</c:v>
                </c:pt>
                <c:pt idx="1">
                  <c:v>26.111999999999998</c:v>
                </c:pt>
                <c:pt idx="2">
                  <c:v>26.111999999999998</c:v>
                </c:pt>
                <c:pt idx="3">
                  <c:v>35.200000000000003</c:v>
                </c:pt>
                <c:pt idx="4">
                  <c:v>81.311999999999998</c:v>
                </c:pt>
                <c:pt idx="5">
                  <c:v>131</c:v>
                </c:pt>
                <c:pt idx="6">
                  <c:v>120.9</c:v>
                </c:pt>
                <c:pt idx="7">
                  <c:v>142.88399999999999</c:v>
                </c:pt>
                <c:pt idx="8">
                  <c:v>191.45500000000001</c:v>
                </c:pt>
                <c:pt idx="9">
                  <c:v>264.23</c:v>
                </c:pt>
                <c:pt idx="10">
                  <c:v>309</c:v>
                </c:pt>
                <c:pt idx="11">
                  <c:v>366.1</c:v>
                </c:pt>
                <c:pt idx="12">
                  <c:v>189.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CC8B-42D9-838B-AD43ED07D4C7}"/>
            </c:ext>
          </c:extLst>
        </c:ser>
        <c:ser>
          <c:idx val="4"/>
          <c:order val="3"/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numRef>
              <c:f>'Tumor Growth Curve'!$C$31:$C$43</c:f>
              <c:numCache>
                <c:formatCode>General</c:formatCode>
                <c:ptCount val="13"/>
                <c:pt idx="0">
                  <c:v>22</c:v>
                </c:pt>
                <c:pt idx="1">
                  <c:v>23</c:v>
                </c:pt>
                <c:pt idx="2">
                  <c:v>25</c:v>
                </c:pt>
                <c:pt idx="3">
                  <c:v>27</c:v>
                </c:pt>
                <c:pt idx="4">
                  <c:v>31</c:v>
                </c:pt>
                <c:pt idx="5">
                  <c:v>33</c:v>
                </c:pt>
                <c:pt idx="6">
                  <c:v>36</c:v>
                </c:pt>
                <c:pt idx="7">
                  <c:v>38</c:v>
                </c:pt>
                <c:pt idx="8">
                  <c:v>40</c:v>
                </c:pt>
                <c:pt idx="9">
                  <c:v>43</c:v>
                </c:pt>
                <c:pt idx="10">
                  <c:v>45</c:v>
                </c:pt>
                <c:pt idx="11">
                  <c:v>47</c:v>
                </c:pt>
                <c:pt idx="12">
                  <c:v>50</c:v>
                </c:pt>
              </c:numCache>
            </c:numRef>
          </c:cat>
          <c:val>
            <c:numRef>
              <c:f>'Tumor Growth Curve'!$P$31:$P$43</c:f>
              <c:numCache>
                <c:formatCode>General</c:formatCode>
                <c:ptCount val="13"/>
                <c:pt idx="0">
                  <c:v>28.512</c:v>
                </c:pt>
                <c:pt idx="1">
                  <c:v>63.625999999999998</c:v>
                </c:pt>
                <c:pt idx="2">
                  <c:v>92.262500000000003</c:v>
                </c:pt>
                <c:pt idx="3">
                  <c:v>135.16800000000001</c:v>
                </c:pt>
                <c:pt idx="4">
                  <c:v>134.54</c:v>
                </c:pt>
                <c:pt idx="5">
                  <c:v>278.4375</c:v>
                </c:pt>
                <c:pt idx="6">
                  <c:v>369.82</c:v>
                </c:pt>
                <c:pt idx="7">
                  <c:v>380.70100000000002</c:v>
                </c:pt>
                <c:pt idx="8">
                  <c:v>406.8</c:v>
                </c:pt>
                <c:pt idx="9">
                  <c:v>571.32000000000005</c:v>
                </c:pt>
                <c:pt idx="10">
                  <c:v>640</c:v>
                </c:pt>
                <c:pt idx="11">
                  <c:v>617.1</c:v>
                </c:pt>
                <c:pt idx="12">
                  <c:v>908.8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CC8B-42D9-838B-AD43ED07D4C7}"/>
            </c:ext>
          </c:extLst>
        </c:ser>
        <c:ser>
          <c:idx val="5"/>
          <c:order val="4"/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numRef>
              <c:f>'Tumor Growth Curve'!$C$31:$C$43</c:f>
              <c:numCache>
                <c:formatCode>General</c:formatCode>
                <c:ptCount val="13"/>
                <c:pt idx="0">
                  <c:v>22</c:v>
                </c:pt>
                <c:pt idx="1">
                  <c:v>23</c:v>
                </c:pt>
                <c:pt idx="2">
                  <c:v>25</c:v>
                </c:pt>
                <c:pt idx="3">
                  <c:v>27</c:v>
                </c:pt>
                <c:pt idx="4">
                  <c:v>31</c:v>
                </c:pt>
                <c:pt idx="5">
                  <c:v>33</c:v>
                </c:pt>
                <c:pt idx="6">
                  <c:v>36</c:v>
                </c:pt>
                <c:pt idx="7">
                  <c:v>38</c:v>
                </c:pt>
                <c:pt idx="8">
                  <c:v>40</c:v>
                </c:pt>
                <c:pt idx="9">
                  <c:v>43</c:v>
                </c:pt>
                <c:pt idx="10">
                  <c:v>45</c:v>
                </c:pt>
                <c:pt idx="11">
                  <c:v>47</c:v>
                </c:pt>
                <c:pt idx="12">
                  <c:v>50</c:v>
                </c:pt>
              </c:numCache>
            </c:numRef>
          </c:cat>
          <c:val>
            <c:numRef>
              <c:f>'Tumor Growth Curve'!$Q$31:$Q$43</c:f>
              <c:numCache>
                <c:formatCode>General</c:formatCode>
                <c:ptCount val="13"/>
                <c:pt idx="0">
                  <c:v>0</c:v>
                </c:pt>
                <c:pt idx="1">
                  <c:v>77.247500000000002</c:v>
                </c:pt>
                <c:pt idx="2">
                  <c:v>105.33750000000001</c:v>
                </c:pt>
                <c:pt idx="3">
                  <c:v>124.65349999999999</c:v>
                </c:pt>
                <c:pt idx="4">
                  <c:v>134.54</c:v>
                </c:pt>
                <c:pt idx="5">
                  <c:v>235.2</c:v>
                </c:pt>
                <c:pt idx="6">
                  <c:v>371.3</c:v>
                </c:pt>
                <c:pt idx="7">
                  <c:v>328.536</c:v>
                </c:pt>
                <c:pt idx="8">
                  <c:v>340.6</c:v>
                </c:pt>
                <c:pt idx="9">
                  <c:v>419.81299999999999</c:v>
                </c:pt>
                <c:pt idx="10">
                  <c:v>505</c:v>
                </c:pt>
                <c:pt idx="11">
                  <c:v>515.15</c:v>
                </c:pt>
                <c:pt idx="12">
                  <c:v>740.601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CC8B-42D9-838B-AD43ED07D4C7}"/>
            </c:ext>
          </c:extLst>
        </c:ser>
        <c:ser>
          <c:idx val="6"/>
          <c:order val="5"/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numRef>
              <c:f>'Tumor Growth Curve'!$C$31:$C$43</c:f>
              <c:numCache>
                <c:formatCode>General</c:formatCode>
                <c:ptCount val="13"/>
                <c:pt idx="0">
                  <c:v>22</c:v>
                </c:pt>
                <c:pt idx="1">
                  <c:v>23</c:v>
                </c:pt>
                <c:pt idx="2">
                  <c:v>25</c:v>
                </c:pt>
                <c:pt idx="3">
                  <c:v>27</c:v>
                </c:pt>
                <c:pt idx="4">
                  <c:v>31</c:v>
                </c:pt>
                <c:pt idx="5">
                  <c:v>33</c:v>
                </c:pt>
                <c:pt idx="6">
                  <c:v>36</c:v>
                </c:pt>
                <c:pt idx="7">
                  <c:v>38</c:v>
                </c:pt>
                <c:pt idx="8">
                  <c:v>40</c:v>
                </c:pt>
                <c:pt idx="9">
                  <c:v>43</c:v>
                </c:pt>
                <c:pt idx="10">
                  <c:v>45</c:v>
                </c:pt>
                <c:pt idx="11">
                  <c:v>47</c:v>
                </c:pt>
                <c:pt idx="12">
                  <c:v>50</c:v>
                </c:pt>
              </c:numCache>
            </c:numRef>
          </c:cat>
          <c:val>
            <c:numRef>
              <c:f>'Tumor Growth Curve'!$R$31:$R$43</c:f>
              <c:numCache>
                <c:formatCode>General</c:formatCode>
                <c:ptCount val="13"/>
                <c:pt idx="0">
                  <c:v>85.235500000000002</c:v>
                </c:pt>
                <c:pt idx="1">
                  <c:v>94.936499999999995</c:v>
                </c:pt>
                <c:pt idx="2">
                  <c:v>186.36799999999999</c:v>
                </c:pt>
                <c:pt idx="3">
                  <c:v>180.58590000000001</c:v>
                </c:pt>
                <c:pt idx="4">
                  <c:v>147.392</c:v>
                </c:pt>
                <c:pt idx="5">
                  <c:v>374.166</c:v>
                </c:pt>
                <c:pt idx="6">
                  <c:v>437.3</c:v>
                </c:pt>
                <c:pt idx="7">
                  <c:v>368.08199999999999</c:v>
                </c:pt>
                <c:pt idx="8">
                  <c:v>400.221</c:v>
                </c:pt>
                <c:pt idx="9">
                  <c:v>499.488</c:v>
                </c:pt>
                <c:pt idx="10">
                  <c:v>352.87</c:v>
                </c:pt>
                <c:pt idx="11">
                  <c:v>459.27</c:v>
                </c:pt>
                <c:pt idx="12">
                  <c:v>400.75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CC8B-42D9-838B-AD43ED07D4C7}"/>
            </c:ext>
          </c:extLst>
        </c:ser>
        <c:ser>
          <c:idx val="8"/>
          <c:order val="6"/>
          <c:spPr>
            <a:ln w="19050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cat>
            <c:numRef>
              <c:f>'Tumor Growth Curve'!$C$31:$C$43</c:f>
              <c:numCache>
                <c:formatCode>General</c:formatCode>
                <c:ptCount val="13"/>
                <c:pt idx="0">
                  <c:v>22</c:v>
                </c:pt>
                <c:pt idx="1">
                  <c:v>23</c:v>
                </c:pt>
                <c:pt idx="2">
                  <c:v>25</c:v>
                </c:pt>
                <c:pt idx="3">
                  <c:v>27</c:v>
                </c:pt>
                <c:pt idx="4">
                  <c:v>31</c:v>
                </c:pt>
                <c:pt idx="5">
                  <c:v>33</c:v>
                </c:pt>
                <c:pt idx="6">
                  <c:v>36</c:v>
                </c:pt>
                <c:pt idx="7">
                  <c:v>38</c:v>
                </c:pt>
                <c:pt idx="8">
                  <c:v>40</c:v>
                </c:pt>
                <c:pt idx="9">
                  <c:v>43</c:v>
                </c:pt>
                <c:pt idx="10">
                  <c:v>45</c:v>
                </c:pt>
                <c:pt idx="11">
                  <c:v>47</c:v>
                </c:pt>
                <c:pt idx="12">
                  <c:v>50</c:v>
                </c:pt>
              </c:numCache>
            </c:numRef>
          </c:cat>
          <c:val>
            <c:numRef>
              <c:f>'Tumor Growth Curve'!$T$31:$T$43</c:f>
              <c:numCache>
                <c:formatCode>General</c:formatCode>
                <c:ptCount val="13"/>
                <c:pt idx="0">
                  <c:v>97.2</c:v>
                </c:pt>
                <c:pt idx="1">
                  <c:v>87.88</c:v>
                </c:pt>
                <c:pt idx="2">
                  <c:v>127.8</c:v>
                </c:pt>
                <c:pt idx="3">
                  <c:v>124.2</c:v>
                </c:pt>
                <c:pt idx="4">
                  <c:v>222.376</c:v>
                </c:pt>
                <c:pt idx="5">
                  <c:v>449</c:v>
                </c:pt>
                <c:pt idx="6">
                  <c:v>423</c:v>
                </c:pt>
                <c:pt idx="7">
                  <c:v>431.66399999999999</c:v>
                </c:pt>
                <c:pt idx="8">
                  <c:v>258.11</c:v>
                </c:pt>
                <c:pt idx="9">
                  <c:v>543.95000000000005</c:v>
                </c:pt>
                <c:pt idx="10">
                  <c:v>640.45000000000005</c:v>
                </c:pt>
                <c:pt idx="11">
                  <c:v>580.06399999999996</c:v>
                </c:pt>
                <c:pt idx="12">
                  <c:v>92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CC8B-42D9-838B-AD43ED07D4C7}"/>
            </c:ext>
          </c:extLst>
        </c:ser>
        <c:ser>
          <c:idx val="9"/>
          <c:order val="7"/>
          <c:spPr>
            <a:ln w="19050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</a:schemeClr>
              </a:solidFill>
              <a:ln w="9525">
                <a:solidFill>
                  <a:schemeClr val="accent4">
                    <a:lumMod val="60000"/>
                  </a:schemeClr>
                </a:solidFill>
              </a:ln>
              <a:effectLst/>
            </c:spPr>
          </c:marker>
          <c:cat>
            <c:numRef>
              <c:f>'Tumor Growth Curve'!$C$31:$C$43</c:f>
              <c:numCache>
                <c:formatCode>General</c:formatCode>
                <c:ptCount val="13"/>
                <c:pt idx="0">
                  <c:v>22</c:v>
                </c:pt>
                <c:pt idx="1">
                  <c:v>23</c:v>
                </c:pt>
                <c:pt idx="2">
                  <c:v>25</c:v>
                </c:pt>
                <c:pt idx="3">
                  <c:v>27</c:v>
                </c:pt>
                <c:pt idx="4">
                  <c:v>31</c:v>
                </c:pt>
                <c:pt idx="5">
                  <c:v>33</c:v>
                </c:pt>
                <c:pt idx="6">
                  <c:v>36</c:v>
                </c:pt>
                <c:pt idx="7">
                  <c:v>38</c:v>
                </c:pt>
                <c:pt idx="8">
                  <c:v>40</c:v>
                </c:pt>
                <c:pt idx="9">
                  <c:v>43</c:v>
                </c:pt>
                <c:pt idx="10">
                  <c:v>45</c:v>
                </c:pt>
                <c:pt idx="11">
                  <c:v>47</c:v>
                </c:pt>
                <c:pt idx="12">
                  <c:v>50</c:v>
                </c:pt>
              </c:numCache>
            </c:numRef>
          </c:cat>
          <c:val>
            <c:numRef>
              <c:f>'Tumor Growth Curve'!$U$31:$U$43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27.864000000000001</c:v>
                </c:pt>
                <c:pt idx="3">
                  <c:v>36.011000000000003</c:v>
                </c:pt>
                <c:pt idx="4">
                  <c:v>77.962500000000006</c:v>
                </c:pt>
                <c:pt idx="5">
                  <c:v>94.162499999999994</c:v>
                </c:pt>
                <c:pt idx="6">
                  <c:v>160.1</c:v>
                </c:pt>
                <c:pt idx="7">
                  <c:v>202.8</c:v>
                </c:pt>
                <c:pt idx="8">
                  <c:v>214.245</c:v>
                </c:pt>
                <c:pt idx="9">
                  <c:v>192.6</c:v>
                </c:pt>
                <c:pt idx="10">
                  <c:v>250.36</c:v>
                </c:pt>
                <c:pt idx="11">
                  <c:v>259.83</c:v>
                </c:pt>
                <c:pt idx="12">
                  <c:v>160.3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CC8B-42D9-838B-AD43ED07D4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34590207"/>
        <c:axId val="1934576895"/>
      </c:lineChart>
      <c:catAx>
        <c:axId val="1934590207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34576895"/>
        <c:crosses val="autoZero"/>
        <c:auto val="1"/>
        <c:lblAlgn val="ctr"/>
        <c:lblOffset val="100"/>
        <c:noMultiLvlLbl val="0"/>
      </c:catAx>
      <c:valAx>
        <c:axId val="1934576895"/>
        <c:scaling>
          <c:orientation val="minMax"/>
          <c:max val="1400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34590207"/>
        <c:crosses val="autoZero"/>
        <c:crossBetween val="midCat"/>
        <c:majorUnit val="2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i-PD1 and B10G5</a:t>
            </a:r>
          </a:p>
        </c:rich>
      </c:tx>
      <c:layout>
        <c:manualLayout>
          <c:xMode val="edge"/>
          <c:yMode val="edge"/>
          <c:x val="0.15894768616918858"/>
          <c:y val="8.816000091631993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544984234686546"/>
          <c:y val="6.0670922080551776E-2"/>
          <c:w val="0.84617054121303215"/>
          <c:h val="0.83192970403988686"/>
        </c:manualLayout>
      </c:layout>
      <c:lineChart>
        <c:grouping val="standard"/>
        <c:varyColors val="0"/>
        <c:ser>
          <c:idx val="0"/>
          <c:order val="0"/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'Tumor Growth Curve'!$C$31:$C$43</c:f>
              <c:numCache>
                <c:formatCode>General</c:formatCode>
                <c:ptCount val="13"/>
                <c:pt idx="0">
                  <c:v>22</c:v>
                </c:pt>
                <c:pt idx="1">
                  <c:v>23</c:v>
                </c:pt>
                <c:pt idx="2">
                  <c:v>25</c:v>
                </c:pt>
                <c:pt idx="3">
                  <c:v>27</c:v>
                </c:pt>
                <c:pt idx="4">
                  <c:v>31</c:v>
                </c:pt>
                <c:pt idx="5">
                  <c:v>33</c:v>
                </c:pt>
                <c:pt idx="6">
                  <c:v>36</c:v>
                </c:pt>
                <c:pt idx="7">
                  <c:v>38</c:v>
                </c:pt>
                <c:pt idx="8">
                  <c:v>40</c:v>
                </c:pt>
                <c:pt idx="9">
                  <c:v>43</c:v>
                </c:pt>
                <c:pt idx="10">
                  <c:v>45</c:v>
                </c:pt>
                <c:pt idx="11">
                  <c:v>47</c:v>
                </c:pt>
                <c:pt idx="12">
                  <c:v>50</c:v>
                </c:pt>
              </c:numCache>
            </c:numRef>
          </c:cat>
          <c:val>
            <c:numRef>
              <c:f>'Tumor Growth Curve'!$V$31:$V$43</c:f>
              <c:numCache>
                <c:formatCode>General</c:formatCode>
                <c:ptCount val="13"/>
                <c:pt idx="0">
                  <c:v>24.504999999999999</c:v>
                </c:pt>
                <c:pt idx="1">
                  <c:v>27.864000000000001</c:v>
                </c:pt>
                <c:pt idx="2">
                  <c:v>21.4375</c:v>
                </c:pt>
                <c:pt idx="3">
                  <c:v>78.335999999999999</c:v>
                </c:pt>
                <c:pt idx="4">
                  <c:v>47.432000000000002</c:v>
                </c:pt>
                <c:pt idx="5">
                  <c:v>115.351</c:v>
                </c:pt>
                <c:pt idx="6">
                  <c:v>121.8</c:v>
                </c:pt>
                <c:pt idx="7">
                  <c:v>141.53</c:v>
                </c:pt>
                <c:pt idx="8">
                  <c:v>100.7</c:v>
                </c:pt>
                <c:pt idx="9">
                  <c:v>128.99</c:v>
                </c:pt>
                <c:pt idx="10">
                  <c:v>207.3</c:v>
                </c:pt>
                <c:pt idx="11">
                  <c:v>216</c:v>
                </c:pt>
                <c:pt idx="12">
                  <c:v>216.301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418-478E-A15D-ED610E525D73}"/>
            </c:ext>
          </c:extLst>
        </c:ser>
        <c:ser>
          <c:idx val="1"/>
          <c:order val="1"/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'Tumor Growth Curve'!$C$31:$C$43</c:f>
              <c:numCache>
                <c:formatCode>General</c:formatCode>
                <c:ptCount val="13"/>
                <c:pt idx="0">
                  <c:v>22</c:v>
                </c:pt>
                <c:pt idx="1">
                  <c:v>23</c:v>
                </c:pt>
                <c:pt idx="2">
                  <c:v>25</c:v>
                </c:pt>
                <c:pt idx="3">
                  <c:v>27</c:v>
                </c:pt>
                <c:pt idx="4">
                  <c:v>31</c:v>
                </c:pt>
                <c:pt idx="5">
                  <c:v>33</c:v>
                </c:pt>
                <c:pt idx="6">
                  <c:v>36</c:v>
                </c:pt>
                <c:pt idx="7">
                  <c:v>38</c:v>
                </c:pt>
                <c:pt idx="8">
                  <c:v>40</c:v>
                </c:pt>
                <c:pt idx="9">
                  <c:v>43</c:v>
                </c:pt>
                <c:pt idx="10">
                  <c:v>45</c:v>
                </c:pt>
                <c:pt idx="11">
                  <c:v>47</c:v>
                </c:pt>
                <c:pt idx="12">
                  <c:v>50</c:v>
                </c:pt>
              </c:numCache>
            </c:numRef>
          </c:cat>
          <c:val>
            <c:numRef>
              <c:f>'Tumor Growth Curve'!$W$31:$W$43</c:f>
              <c:numCache>
                <c:formatCode>General</c:formatCode>
                <c:ptCount val="13"/>
                <c:pt idx="0">
                  <c:v>5</c:v>
                </c:pt>
                <c:pt idx="1">
                  <c:v>26.864000000000001</c:v>
                </c:pt>
                <c:pt idx="2">
                  <c:v>25.271999999999998</c:v>
                </c:pt>
                <c:pt idx="3">
                  <c:v>53.957999999999998</c:v>
                </c:pt>
                <c:pt idx="4">
                  <c:v>73.007999999999996</c:v>
                </c:pt>
                <c:pt idx="5">
                  <c:v>100.602</c:v>
                </c:pt>
                <c:pt idx="6">
                  <c:v>116.03</c:v>
                </c:pt>
                <c:pt idx="7">
                  <c:v>178.95500000000001</c:v>
                </c:pt>
                <c:pt idx="8">
                  <c:v>230.625</c:v>
                </c:pt>
                <c:pt idx="9">
                  <c:v>166.09</c:v>
                </c:pt>
                <c:pt idx="10">
                  <c:v>225.5</c:v>
                </c:pt>
                <c:pt idx="11">
                  <c:v>284.59199999999998</c:v>
                </c:pt>
                <c:pt idx="12">
                  <c:v>204.7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418-478E-A15D-ED610E525D73}"/>
            </c:ext>
          </c:extLst>
        </c:ser>
        <c:ser>
          <c:idx val="2"/>
          <c:order val="2"/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'Tumor Growth Curve'!$C$31:$C$43</c:f>
              <c:numCache>
                <c:formatCode>General</c:formatCode>
                <c:ptCount val="13"/>
                <c:pt idx="0">
                  <c:v>22</c:v>
                </c:pt>
                <c:pt idx="1">
                  <c:v>23</c:v>
                </c:pt>
                <c:pt idx="2">
                  <c:v>25</c:v>
                </c:pt>
                <c:pt idx="3">
                  <c:v>27</c:v>
                </c:pt>
                <c:pt idx="4">
                  <c:v>31</c:v>
                </c:pt>
                <c:pt idx="5">
                  <c:v>33</c:v>
                </c:pt>
                <c:pt idx="6">
                  <c:v>36</c:v>
                </c:pt>
                <c:pt idx="7">
                  <c:v>38</c:v>
                </c:pt>
                <c:pt idx="8">
                  <c:v>40</c:v>
                </c:pt>
                <c:pt idx="9">
                  <c:v>43</c:v>
                </c:pt>
                <c:pt idx="10">
                  <c:v>45</c:v>
                </c:pt>
                <c:pt idx="11">
                  <c:v>47</c:v>
                </c:pt>
                <c:pt idx="12">
                  <c:v>50</c:v>
                </c:pt>
              </c:numCache>
            </c:numRef>
          </c:cat>
          <c:val>
            <c:numRef>
              <c:f>'Tumor Growth Curve'!$X$31:$X$43</c:f>
              <c:numCache>
                <c:formatCode>General</c:formatCode>
                <c:ptCount val="13"/>
                <c:pt idx="0">
                  <c:v>40.344000000000001</c:v>
                </c:pt>
                <c:pt idx="1">
                  <c:v>26.95</c:v>
                </c:pt>
                <c:pt idx="2">
                  <c:v>78.731999999999999</c:v>
                </c:pt>
                <c:pt idx="3">
                  <c:v>77.063999999999993</c:v>
                </c:pt>
                <c:pt idx="4">
                  <c:v>51.304000000000002</c:v>
                </c:pt>
                <c:pt idx="5">
                  <c:v>158.994</c:v>
                </c:pt>
                <c:pt idx="6">
                  <c:v>229.1</c:v>
                </c:pt>
                <c:pt idx="7">
                  <c:v>340.73599999999999</c:v>
                </c:pt>
                <c:pt idx="8">
                  <c:v>183.7</c:v>
                </c:pt>
                <c:pt idx="9">
                  <c:v>346.8</c:v>
                </c:pt>
                <c:pt idx="10">
                  <c:v>540.65</c:v>
                </c:pt>
                <c:pt idx="11">
                  <c:v>534.52</c:v>
                </c:pt>
                <c:pt idx="12">
                  <c:v>269.7694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3418-478E-A15D-ED610E525D73}"/>
            </c:ext>
          </c:extLst>
        </c:ser>
        <c:ser>
          <c:idx val="3"/>
          <c:order val="3"/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numRef>
              <c:f>'Tumor Growth Curve'!$C$31:$C$43</c:f>
              <c:numCache>
                <c:formatCode>General</c:formatCode>
                <c:ptCount val="13"/>
                <c:pt idx="0">
                  <c:v>22</c:v>
                </c:pt>
                <c:pt idx="1">
                  <c:v>23</c:v>
                </c:pt>
                <c:pt idx="2">
                  <c:v>25</c:v>
                </c:pt>
                <c:pt idx="3">
                  <c:v>27</c:v>
                </c:pt>
                <c:pt idx="4">
                  <c:v>31</c:v>
                </c:pt>
                <c:pt idx="5">
                  <c:v>33</c:v>
                </c:pt>
                <c:pt idx="6">
                  <c:v>36</c:v>
                </c:pt>
                <c:pt idx="7">
                  <c:v>38</c:v>
                </c:pt>
                <c:pt idx="8">
                  <c:v>40</c:v>
                </c:pt>
                <c:pt idx="9">
                  <c:v>43</c:v>
                </c:pt>
                <c:pt idx="10">
                  <c:v>45</c:v>
                </c:pt>
                <c:pt idx="11">
                  <c:v>47</c:v>
                </c:pt>
                <c:pt idx="12">
                  <c:v>50</c:v>
                </c:pt>
              </c:numCache>
            </c:numRef>
          </c:cat>
          <c:val>
            <c:numRef>
              <c:f>'Tumor Growth Curve'!$Y$31:$Y$43</c:f>
              <c:numCache>
                <c:formatCode>General</c:formatCode>
                <c:ptCount val="13"/>
                <c:pt idx="0">
                  <c:v>73.567999999999998</c:v>
                </c:pt>
                <c:pt idx="1">
                  <c:v>43.56</c:v>
                </c:pt>
                <c:pt idx="2">
                  <c:v>101.124</c:v>
                </c:pt>
                <c:pt idx="3">
                  <c:v>48.667999999999999</c:v>
                </c:pt>
                <c:pt idx="4">
                  <c:v>111.392</c:v>
                </c:pt>
                <c:pt idx="5">
                  <c:v>135.59399999999999</c:v>
                </c:pt>
                <c:pt idx="6">
                  <c:v>151.83799999999999</c:v>
                </c:pt>
                <c:pt idx="7">
                  <c:v>123.87</c:v>
                </c:pt>
                <c:pt idx="8">
                  <c:v>132.09</c:v>
                </c:pt>
                <c:pt idx="9">
                  <c:v>129.96</c:v>
                </c:pt>
                <c:pt idx="10">
                  <c:v>167.4</c:v>
                </c:pt>
                <c:pt idx="11">
                  <c:v>192.49</c:v>
                </c:pt>
                <c:pt idx="12">
                  <c:v>45.4859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3418-478E-A15D-ED610E525D73}"/>
            </c:ext>
          </c:extLst>
        </c:ser>
        <c:ser>
          <c:idx val="4"/>
          <c:order val="4"/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numRef>
              <c:f>'Tumor Growth Curve'!$C$31:$C$43</c:f>
              <c:numCache>
                <c:formatCode>General</c:formatCode>
                <c:ptCount val="13"/>
                <c:pt idx="0">
                  <c:v>22</c:v>
                </c:pt>
                <c:pt idx="1">
                  <c:v>23</c:v>
                </c:pt>
                <c:pt idx="2">
                  <c:v>25</c:v>
                </c:pt>
                <c:pt idx="3">
                  <c:v>27</c:v>
                </c:pt>
                <c:pt idx="4">
                  <c:v>31</c:v>
                </c:pt>
                <c:pt idx="5">
                  <c:v>33</c:v>
                </c:pt>
                <c:pt idx="6">
                  <c:v>36</c:v>
                </c:pt>
                <c:pt idx="7">
                  <c:v>38</c:v>
                </c:pt>
                <c:pt idx="8">
                  <c:v>40</c:v>
                </c:pt>
                <c:pt idx="9">
                  <c:v>43</c:v>
                </c:pt>
                <c:pt idx="10">
                  <c:v>45</c:v>
                </c:pt>
                <c:pt idx="11">
                  <c:v>47</c:v>
                </c:pt>
                <c:pt idx="12">
                  <c:v>50</c:v>
                </c:pt>
              </c:numCache>
            </c:numRef>
          </c:cat>
          <c:val>
            <c:numRef>
              <c:f>'Tumor Growth Curve'!$Z$31:$Z$43</c:f>
              <c:numCache>
                <c:formatCode>General</c:formatCode>
                <c:ptCount val="13"/>
                <c:pt idx="0">
                  <c:v>17.100000000000001</c:v>
                </c:pt>
                <c:pt idx="1">
                  <c:v>51.304000000000002</c:v>
                </c:pt>
                <c:pt idx="2">
                  <c:v>31.751999999999999</c:v>
                </c:pt>
                <c:pt idx="3">
                  <c:v>42.4</c:v>
                </c:pt>
                <c:pt idx="4">
                  <c:v>58.53</c:v>
                </c:pt>
                <c:pt idx="5">
                  <c:v>100.62</c:v>
                </c:pt>
                <c:pt idx="6">
                  <c:v>66.150000000000006</c:v>
                </c:pt>
                <c:pt idx="7">
                  <c:v>76.031999999999996</c:v>
                </c:pt>
                <c:pt idx="8">
                  <c:v>48.8</c:v>
                </c:pt>
                <c:pt idx="9">
                  <c:v>56.375999999999998</c:v>
                </c:pt>
                <c:pt idx="10">
                  <c:v>52.9</c:v>
                </c:pt>
                <c:pt idx="11">
                  <c:v>70.875</c:v>
                </c:pt>
                <c:pt idx="12">
                  <c:v>22.2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3418-478E-A15D-ED610E525D73}"/>
            </c:ext>
          </c:extLst>
        </c:ser>
        <c:ser>
          <c:idx val="5"/>
          <c:order val="5"/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numRef>
              <c:f>'Tumor Growth Curve'!$C$31:$C$43</c:f>
              <c:numCache>
                <c:formatCode>General</c:formatCode>
                <c:ptCount val="13"/>
                <c:pt idx="0">
                  <c:v>22</c:v>
                </c:pt>
                <c:pt idx="1">
                  <c:v>23</c:v>
                </c:pt>
                <c:pt idx="2">
                  <c:v>25</c:v>
                </c:pt>
                <c:pt idx="3">
                  <c:v>27</c:v>
                </c:pt>
                <c:pt idx="4">
                  <c:v>31</c:v>
                </c:pt>
                <c:pt idx="5">
                  <c:v>33</c:v>
                </c:pt>
                <c:pt idx="6">
                  <c:v>36</c:v>
                </c:pt>
                <c:pt idx="7">
                  <c:v>38</c:v>
                </c:pt>
                <c:pt idx="8">
                  <c:v>40</c:v>
                </c:pt>
                <c:pt idx="9">
                  <c:v>43</c:v>
                </c:pt>
                <c:pt idx="10">
                  <c:v>45</c:v>
                </c:pt>
                <c:pt idx="11">
                  <c:v>47</c:v>
                </c:pt>
                <c:pt idx="12">
                  <c:v>50</c:v>
                </c:pt>
              </c:numCache>
            </c:numRef>
          </c:cat>
          <c:val>
            <c:numRef>
              <c:f>'Tumor Growth Curve'!$AA$31:$AA$43</c:f>
              <c:numCache>
                <c:formatCode>General</c:formatCode>
                <c:ptCount val="13"/>
                <c:pt idx="0">
                  <c:v>38.808</c:v>
                </c:pt>
                <c:pt idx="1">
                  <c:v>31.23</c:v>
                </c:pt>
                <c:pt idx="2">
                  <c:v>50.335999999999999</c:v>
                </c:pt>
                <c:pt idx="3">
                  <c:v>46.575000000000003</c:v>
                </c:pt>
                <c:pt idx="4">
                  <c:v>43.218000000000004</c:v>
                </c:pt>
                <c:pt idx="5">
                  <c:v>143.74799999999999</c:v>
                </c:pt>
                <c:pt idx="6">
                  <c:v>97.215999999999994</c:v>
                </c:pt>
                <c:pt idx="7">
                  <c:v>122.79</c:v>
                </c:pt>
                <c:pt idx="8">
                  <c:v>95.28</c:v>
                </c:pt>
                <c:pt idx="9">
                  <c:v>109.33</c:v>
                </c:pt>
                <c:pt idx="10">
                  <c:v>189</c:v>
                </c:pt>
                <c:pt idx="11">
                  <c:v>164.25</c:v>
                </c:pt>
                <c:pt idx="12">
                  <c:v>116.613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3418-478E-A15D-ED610E525D73}"/>
            </c:ext>
          </c:extLst>
        </c:ser>
        <c:ser>
          <c:idx val="6"/>
          <c:order val="6"/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numRef>
              <c:f>'Tumor Growth Curve'!$C$31:$C$43</c:f>
              <c:numCache>
                <c:formatCode>General</c:formatCode>
                <c:ptCount val="13"/>
                <c:pt idx="0">
                  <c:v>22</c:v>
                </c:pt>
                <c:pt idx="1">
                  <c:v>23</c:v>
                </c:pt>
                <c:pt idx="2">
                  <c:v>25</c:v>
                </c:pt>
                <c:pt idx="3">
                  <c:v>27</c:v>
                </c:pt>
                <c:pt idx="4">
                  <c:v>31</c:v>
                </c:pt>
                <c:pt idx="5">
                  <c:v>33</c:v>
                </c:pt>
                <c:pt idx="6">
                  <c:v>36</c:v>
                </c:pt>
                <c:pt idx="7">
                  <c:v>38</c:v>
                </c:pt>
                <c:pt idx="8">
                  <c:v>40</c:v>
                </c:pt>
                <c:pt idx="9">
                  <c:v>43</c:v>
                </c:pt>
                <c:pt idx="10">
                  <c:v>45</c:v>
                </c:pt>
                <c:pt idx="11">
                  <c:v>47</c:v>
                </c:pt>
                <c:pt idx="12">
                  <c:v>50</c:v>
                </c:pt>
              </c:numCache>
            </c:numRef>
          </c:cat>
          <c:val>
            <c:numRef>
              <c:f>'Tumor Growth Curve'!$AB$31:$AB$43</c:f>
              <c:numCache>
                <c:formatCode>General</c:formatCode>
                <c:ptCount val="13"/>
                <c:pt idx="0">
                  <c:v>45.5625</c:v>
                </c:pt>
                <c:pt idx="1">
                  <c:v>45.496000000000002</c:v>
                </c:pt>
                <c:pt idx="2">
                  <c:v>97.215999999999994</c:v>
                </c:pt>
                <c:pt idx="3">
                  <c:v>50.625</c:v>
                </c:pt>
                <c:pt idx="4">
                  <c:v>120.0945</c:v>
                </c:pt>
                <c:pt idx="5">
                  <c:v>167.93600000000001</c:v>
                </c:pt>
                <c:pt idx="6">
                  <c:v>184.04900000000001</c:v>
                </c:pt>
                <c:pt idx="7">
                  <c:v>243.089</c:v>
                </c:pt>
                <c:pt idx="8">
                  <c:v>262.39999999999998</c:v>
                </c:pt>
                <c:pt idx="9">
                  <c:v>312.13200000000001</c:v>
                </c:pt>
                <c:pt idx="10">
                  <c:v>391.988</c:v>
                </c:pt>
                <c:pt idx="11">
                  <c:v>425.27</c:v>
                </c:pt>
                <c:pt idx="12">
                  <c:v>245.133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3418-478E-A15D-ED610E525D73}"/>
            </c:ext>
          </c:extLst>
        </c:ser>
        <c:ser>
          <c:idx val="7"/>
          <c:order val="7"/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numRef>
              <c:f>'Tumor Growth Curve'!$C$31:$C$43</c:f>
              <c:numCache>
                <c:formatCode>General</c:formatCode>
                <c:ptCount val="13"/>
                <c:pt idx="0">
                  <c:v>22</c:v>
                </c:pt>
                <c:pt idx="1">
                  <c:v>23</c:v>
                </c:pt>
                <c:pt idx="2">
                  <c:v>25</c:v>
                </c:pt>
                <c:pt idx="3">
                  <c:v>27</c:v>
                </c:pt>
                <c:pt idx="4">
                  <c:v>31</c:v>
                </c:pt>
                <c:pt idx="5">
                  <c:v>33</c:v>
                </c:pt>
                <c:pt idx="6">
                  <c:v>36</c:v>
                </c:pt>
                <c:pt idx="7">
                  <c:v>38</c:v>
                </c:pt>
                <c:pt idx="8">
                  <c:v>40</c:v>
                </c:pt>
                <c:pt idx="9">
                  <c:v>43</c:v>
                </c:pt>
                <c:pt idx="10">
                  <c:v>45</c:v>
                </c:pt>
                <c:pt idx="11">
                  <c:v>47</c:v>
                </c:pt>
                <c:pt idx="12">
                  <c:v>50</c:v>
                </c:pt>
              </c:numCache>
            </c:numRef>
          </c:cat>
          <c:val>
            <c:numRef>
              <c:f>'Tumor Growth Curve'!$AC$31:$AC$43</c:f>
              <c:numCache>
                <c:formatCode>General</c:formatCode>
                <c:ptCount val="13"/>
                <c:pt idx="0">
                  <c:v>9.375</c:v>
                </c:pt>
                <c:pt idx="1">
                  <c:v>49.953000000000003</c:v>
                </c:pt>
                <c:pt idx="2">
                  <c:v>27.864000000000001</c:v>
                </c:pt>
                <c:pt idx="3">
                  <c:v>27.864000000000001</c:v>
                </c:pt>
                <c:pt idx="4">
                  <c:v>80.052599999999998</c:v>
                </c:pt>
                <c:pt idx="5">
                  <c:v>30.456</c:v>
                </c:pt>
                <c:pt idx="6">
                  <c:v>27.56</c:v>
                </c:pt>
                <c:pt idx="7">
                  <c:v>60.75</c:v>
                </c:pt>
                <c:pt idx="8">
                  <c:v>52</c:v>
                </c:pt>
                <c:pt idx="9">
                  <c:v>135.75899999999999</c:v>
                </c:pt>
                <c:pt idx="10">
                  <c:v>158.13999999999999</c:v>
                </c:pt>
                <c:pt idx="11">
                  <c:v>168.68</c:v>
                </c:pt>
                <c:pt idx="12">
                  <c:v>36.4814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3418-478E-A15D-ED610E525D73}"/>
            </c:ext>
          </c:extLst>
        </c:ser>
        <c:ser>
          <c:idx val="8"/>
          <c:order val="8"/>
          <c:spPr>
            <a:ln w="19050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cat>
            <c:numRef>
              <c:f>'Tumor Growth Curve'!$C$31:$C$43</c:f>
              <c:numCache>
                <c:formatCode>General</c:formatCode>
                <c:ptCount val="13"/>
                <c:pt idx="0">
                  <c:v>22</c:v>
                </c:pt>
                <c:pt idx="1">
                  <c:v>23</c:v>
                </c:pt>
                <c:pt idx="2">
                  <c:v>25</c:v>
                </c:pt>
                <c:pt idx="3">
                  <c:v>27</c:v>
                </c:pt>
                <c:pt idx="4">
                  <c:v>31</c:v>
                </c:pt>
                <c:pt idx="5">
                  <c:v>33</c:v>
                </c:pt>
                <c:pt idx="6">
                  <c:v>36</c:v>
                </c:pt>
                <c:pt idx="7">
                  <c:v>38</c:v>
                </c:pt>
                <c:pt idx="8">
                  <c:v>40</c:v>
                </c:pt>
                <c:pt idx="9">
                  <c:v>43</c:v>
                </c:pt>
                <c:pt idx="10">
                  <c:v>45</c:v>
                </c:pt>
                <c:pt idx="11">
                  <c:v>47</c:v>
                </c:pt>
                <c:pt idx="12">
                  <c:v>50</c:v>
                </c:pt>
              </c:numCache>
            </c:numRef>
          </c:cat>
          <c:val>
            <c:numRef>
              <c:f>'Tumor Growth Curve'!$AD$31:$AD$43</c:f>
              <c:numCache>
                <c:formatCode>General</c:formatCode>
                <c:ptCount val="13"/>
                <c:pt idx="0">
                  <c:v>28.175000000000001</c:v>
                </c:pt>
                <c:pt idx="1">
                  <c:v>9.375</c:v>
                </c:pt>
                <c:pt idx="2">
                  <c:v>50.847499999999997</c:v>
                </c:pt>
                <c:pt idx="3">
                  <c:v>95.647999999999996</c:v>
                </c:pt>
                <c:pt idx="4">
                  <c:v>111.328</c:v>
                </c:pt>
                <c:pt idx="5">
                  <c:v>188.65</c:v>
                </c:pt>
                <c:pt idx="6">
                  <c:v>261.60000000000002</c:v>
                </c:pt>
                <c:pt idx="7">
                  <c:v>274.60000000000002</c:v>
                </c:pt>
                <c:pt idx="8">
                  <c:v>164.25</c:v>
                </c:pt>
                <c:pt idx="9">
                  <c:v>259.61149999999998</c:v>
                </c:pt>
                <c:pt idx="10">
                  <c:v>283.02999999999997</c:v>
                </c:pt>
                <c:pt idx="11">
                  <c:v>262.8</c:v>
                </c:pt>
                <c:pt idx="12">
                  <c:v>281.62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3418-478E-A15D-ED610E525D73}"/>
            </c:ext>
          </c:extLst>
        </c:ser>
        <c:ser>
          <c:idx val="9"/>
          <c:order val="9"/>
          <c:spPr>
            <a:ln w="19050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</a:schemeClr>
              </a:solidFill>
              <a:ln w="9525">
                <a:solidFill>
                  <a:schemeClr val="accent4">
                    <a:lumMod val="60000"/>
                  </a:schemeClr>
                </a:solidFill>
              </a:ln>
              <a:effectLst/>
            </c:spPr>
          </c:marker>
          <c:cat>
            <c:numRef>
              <c:f>'Tumor Growth Curve'!$C$31:$C$43</c:f>
              <c:numCache>
                <c:formatCode>General</c:formatCode>
                <c:ptCount val="13"/>
                <c:pt idx="0">
                  <c:v>22</c:v>
                </c:pt>
                <c:pt idx="1">
                  <c:v>23</c:v>
                </c:pt>
                <c:pt idx="2">
                  <c:v>25</c:v>
                </c:pt>
                <c:pt idx="3">
                  <c:v>27</c:v>
                </c:pt>
                <c:pt idx="4">
                  <c:v>31</c:v>
                </c:pt>
                <c:pt idx="5">
                  <c:v>33</c:v>
                </c:pt>
                <c:pt idx="6">
                  <c:v>36</c:v>
                </c:pt>
                <c:pt idx="7">
                  <c:v>38</c:v>
                </c:pt>
                <c:pt idx="8">
                  <c:v>40</c:v>
                </c:pt>
                <c:pt idx="9">
                  <c:v>43</c:v>
                </c:pt>
                <c:pt idx="10">
                  <c:v>45</c:v>
                </c:pt>
                <c:pt idx="11">
                  <c:v>47</c:v>
                </c:pt>
                <c:pt idx="12">
                  <c:v>50</c:v>
                </c:pt>
              </c:numCache>
            </c:numRef>
          </c:cat>
          <c:val>
            <c:numRef>
              <c:f>'Tumor Growth Curve'!$AE$31:$AE$43</c:f>
              <c:numCache>
                <c:formatCode>General</c:formatCode>
                <c:ptCount val="13"/>
                <c:pt idx="0">
                  <c:v>48.749000000000002</c:v>
                </c:pt>
                <c:pt idx="1">
                  <c:v>71.790000000000006</c:v>
                </c:pt>
                <c:pt idx="2">
                  <c:v>78.731999999999999</c:v>
                </c:pt>
                <c:pt idx="3">
                  <c:v>68.926500000000004</c:v>
                </c:pt>
                <c:pt idx="4">
                  <c:v>66.325500000000005</c:v>
                </c:pt>
                <c:pt idx="5">
                  <c:v>111.012</c:v>
                </c:pt>
                <c:pt idx="6">
                  <c:v>78.415999999999997</c:v>
                </c:pt>
                <c:pt idx="7">
                  <c:v>68.923000000000002</c:v>
                </c:pt>
                <c:pt idx="8">
                  <c:v>52</c:v>
                </c:pt>
                <c:pt idx="9">
                  <c:v>59.643000000000001</c:v>
                </c:pt>
                <c:pt idx="10">
                  <c:v>88.9</c:v>
                </c:pt>
                <c:pt idx="11">
                  <c:v>109.35</c:v>
                </c:pt>
                <c:pt idx="12">
                  <c:v>25.1125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3418-478E-A15D-ED610E525D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34583551"/>
        <c:axId val="1934573983"/>
      </c:lineChart>
      <c:catAx>
        <c:axId val="193458355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34573983"/>
        <c:crosses val="autoZero"/>
        <c:auto val="1"/>
        <c:lblAlgn val="ctr"/>
        <c:lblOffset val="100"/>
        <c:noMultiLvlLbl val="0"/>
      </c:catAx>
      <c:valAx>
        <c:axId val="1934573983"/>
        <c:scaling>
          <c:orientation val="minMax"/>
          <c:max val="1400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34583551"/>
        <c:crosses val="autoZero"/>
        <c:crossBetween val="midCat"/>
        <c:majorUnit val="2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 b="1" i="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-PD1</a:t>
            </a:r>
          </a:p>
          <a:p>
            <a:pPr>
              <a:defRPr sz="8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800" b="1" i="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(4.0 mg/Kg)</a:t>
            </a:r>
            <a:endParaRPr lang="en-US" sz="800" b="1" dirty="0"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16769139673370545"/>
          <c:y val="5.735079948670281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7.8025371828521428E-2"/>
          <c:y val="6.823104233875027E-2"/>
          <c:w val="0.81082645556431143"/>
          <c:h val="0.73235532025193129"/>
        </c:manualLayout>
      </c:layout>
      <c:lineChart>
        <c:grouping val="standard"/>
        <c:varyColors val="0"/>
        <c:ser>
          <c:idx val="0"/>
          <c:order val="0"/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'Tumor Growth Curve'!$C$31:$C$43</c:f>
              <c:numCache>
                <c:formatCode>General</c:formatCode>
                <c:ptCount val="13"/>
                <c:pt idx="0">
                  <c:v>22</c:v>
                </c:pt>
                <c:pt idx="1">
                  <c:v>23</c:v>
                </c:pt>
                <c:pt idx="2">
                  <c:v>25</c:v>
                </c:pt>
                <c:pt idx="3">
                  <c:v>27</c:v>
                </c:pt>
                <c:pt idx="4">
                  <c:v>31</c:v>
                </c:pt>
                <c:pt idx="5">
                  <c:v>33</c:v>
                </c:pt>
                <c:pt idx="6">
                  <c:v>36</c:v>
                </c:pt>
                <c:pt idx="7">
                  <c:v>38</c:v>
                </c:pt>
                <c:pt idx="8">
                  <c:v>40</c:v>
                </c:pt>
                <c:pt idx="9">
                  <c:v>43</c:v>
                </c:pt>
                <c:pt idx="10">
                  <c:v>45</c:v>
                </c:pt>
                <c:pt idx="11">
                  <c:v>47</c:v>
                </c:pt>
                <c:pt idx="12">
                  <c:v>50</c:v>
                </c:pt>
              </c:numCache>
            </c:numRef>
          </c:cat>
          <c:val>
            <c:numRef>
              <c:f>'Tumor Growth Curve'!$AF$31:$AF$43</c:f>
              <c:numCache>
                <c:formatCode>General</c:formatCode>
                <c:ptCount val="13"/>
                <c:pt idx="0">
                  <c:v>21.167999999999999</c:v>
                </c:pt>
                <c:pt idx="1">
                  <c:v>57.112000000000002</c:v>
                </c:pt>
                <c:pt idx="2">
                  <c:v>59.643000000000001</c:v>
                </c:pt>
                <c:pt idx="3">
                  <c:v>89.055999999999997</c:v>
                </c:pt>
                <c:pt idx="4">
                  <c:v>133.95599999999999</c:v>
                </c:pt>
                <c:pt idx="5">
                  <c:v>214.08150000000001</c:v>
                </c:pt>
                <c:pt idx="6">
                  <c:v>266.24</c:v>
                </c:pt>
                <c:pt idx="7">
                  <c:v>367.24</c:v>
                </c:pt>
                <c:pt idx="8">
                  <c:v>314.2</c:v>
                </c:pt>
                <c:pt idx="9">
                  <c:v>419.2</c:v>
                </c:pt>
                <c:pt idx="10">
                  <c:v>342.7</c:v>
                </c:pt>
                <c:pt idx="11">
                  <c:v>435.2</c:v>
                </c:pt>
                <c:pt idx="12">
                  <c:v>335.3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354-49E2-8A58-1DCF2FC59DE9}"/>
            </c:ext>
          </c:extLst>
        </c:ser>
        <c:ser>
          <c:idx val="4"/>
          <c:order val="1"/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numRef>
              <c:f>'Tumor Growth Curve'!$C$31:$C$43</c:f>
              <c:numCache>
                <c:formatCode>General</c:formatCode>
                <c:ptCount val="13"/>
                <c:pt idx="0">
                  <c:v>22</c:v>
                </c:pt>
                <c:pt idx="1">
                  <c:v>23</c:v>
                </c:pt>
                <c:pt idx="2">
                  <c:v>25</c:v>
                </c:pt>
                <c:pt idx="3">
                  <c:v>27</c:v>
                </c:pt>
                <c:pt idx="4">
                  <c:v>31</c:v>
                </c:pt>
                <c:pt idx="5">
                  <c:v>33</c:v>
                </c:pt>
                <c:pt idx="6">
                  <c:v>36</c:v>
                </c:pt>
                <c:pt idx="7">
                  <c:v>38</c:v>
                </c:pt>
                <c:pt idx="8">
                  <c:v>40</c:v>
                </c:pt>
                <c:pt idx="9">
                  <c:v>43</c:v>
                </c:pt>
                <c:pt idx="10">
                  <c:v>45</c:v>
                </c:pt>
                <c:pt idx="11">
                  <c:v>47</c:v>
                </c:pt>
                <c:pt idx="12">
                  <c:v>50</c:v>
                </c:pt>
              </c:numCache>
            </c:numRef>
          </c:cat>
          <c:val>
            <c:numRef>
              <c:f>'Tumor Growth Curve'!$AJ$31:$AJ$43</c:f>
              <c:numCache>
                <c:formatCode>General</c:formatCode>
                <c:ptCount val="13"/>
                <c:pt idx="0">
                  <c:v>84.7</c:v>
                </c:pt>
                <c:pt idx="1">
                  <c:v>59.048000000000002</c:v>
                </c:pt>
                <c:pt idx="2">
                  <c:v>99.719499999999996</c:v>
                </c:pt>
                <c:pt idx="3">
                  <c:v>134.946</c:v>
                </c:pt>
                <c:pt idx="4">
                  <c:v>175.173</c:v>
                </c:pt>
                <c:pt idx="5">
                  <c:v>304</c:v>
                </c:pt>
                <c:pt idx="6">
                  <c:v>413</c:v>
                </c:pt>
                <c:pt idx="7">
                  <c:v>420.22899999999998</c:v>
                </c:pt>
                <c:pt idx="8">
                  <c:v>611.79999999999995</c:v>
                </c:pt>
                <c:pt idx="9">
                  <c:v>813.18600000000004</c:v>
                </c:pt>
                <c:pt idx="10">
                  <c:v>950</c:v>
                </c:pt>
                <c:pt idx="11">
                  <c:v>1098.3</c:v>
                </c:pt>
                <c:pt idx="12">
                  <c:v>1017.5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354-49E2-8A58-1DCF2FC59DE9}"/>
            </c:ext>
          </c:extLst>
        </c:ser>
        <c:ser>
          <c:idx val="5"/>
          <c:order val="2"/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numRef>
              <c:f>'Tumor Growth Curve'!$C$31:$C$43</c:f>
              <c:numCache>
                <c:formatCode>General</c:formatCode>
                <c:ptCount val="13"/>
                <c:pt idx="0">
                  <c:v>22</c:v>
                </c:pt>
                <c:pt idx="1">
                  <c:v>23</c:v>
                </c:pt>
                <c:pt idx="2">
                  <c:v>25</c:v>
                </c:pt>
                <c:pt idx="3">
                  <c:v>27</c:v>
                </c:pt>
                <c:pt idx="4">
                  <c:v>31</c:v>
                </c:pt>
                <c:pt idx="5">
                  <c:v>33</c:v>
                </c:pt>
                <c:pt idx="6">
                  <c:v>36</c:v>
                </c:pt>
                <c:pt idx="7">
                  <c:v>38</c:v>
                </c:pt>
                <c:pt idx="8">
                  <c:v>40</c:v>
                </c:pt>
                <c:pt idx="9">
                  <c:v>43</c:v>
                </c:pt>
                <c:pt idx="10">
                  <c:v>45</c:v>
                </c:pt>
                <c:pt idx="11">
                  <c:v>47</c:v>
                </c:pt>
                <c:pt idx="12">
                  <c:v>50</c:v>
                </c:pt>
              </c:numCache>
            </c:numRef>
          </c:cat>
          <c:val>
            <c:numRef>
              <c:f>'Tumor Growth Curve'!$AK$31:$AK$43</c:f>
              <c:numCache>
                <c:formatCode>General</c:formatCode>
                <c:ptCount val="13"/>
                <c:pt idx="0">
                  <c:v>69.12</c:v>
                </c:pt>
                <c:pt idx="1">
                  <c:v>88.48</c:v>
                </c:pt>
                <c:pt idx="2">
                  <c:v>173.95</c:v>
                </c:pt>
                <c:pt idx="3">
                  <c:v>120.0945</c:v>
                </c:pt>
                <c:pt idx="4">
                  <c:v>197.173</c:v>
                </c:pt>
                <c:pt idx="5">
                  <c:v>164.71350000000001</c:v>
                </c:pt>
                <c:pt idx="6">
                  <c:v>210.49</c:v>
                </c:pt>
                <c:pt idx="7">
                  <c:v>222.18700000000001</c:v>
                </c:pt>
                <c:pt idx="8">
                  <c:v>391.072</c:v>
                </c:pt>
                <c:pt idx="9">
                  <c:v>454.07</c:v>
                </c:pt>
                <c:pt idx="10">
                  <c:v>585</c:v>
                </c:pt>
                <c:pt idx="11">
                  <c:v>720.77</c:v>
                </c:pt>
                <c:pt idx="12">
                  <c:v>746.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3354-49E2-8A58-1DCF2FC59DE9}"/>
            </c:ext>
          </c:extLst>
        </c:ser>
        <c:ser>
          <c:idx val="6"/>
          <c:order val="3"/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numRef>
              <c:f>'Tumor Growth Curve'!$C$31:$C$43</c:f>
              <c:numCache>
                <c:formatCode>General</c:formatCode>
                <c:ptCount val="13"/>
                <c:pt idx="0">
                  <c:v>22</c:v>
                </c:pt>
                <c:pt idx="1">
                  <c:v>23</c:v>
                </c:pt>
                <c:pt idx="2">
                  <c:v>25</c:v>
                </c:pt>
                <c:pt idx="3">
                  <c:v>27</c:v>
                </c:pt>
                <c:pt idx="4">
                  <c:v>31</c:v>
                </c:pt>
                <c:pt idx="5">
                  <c:v>33</c:v>
                </c:pt>
                <c:pt idx="6">
                  <c:v>36</c:v>
                </c:pt>
                <c:pt idx="7">
                  <c:v>38</c:v>
                </c:pt>
                <c:pt idx="8">
                  <c:v>40</c:v>
                </c:pt>
                <c:pt idx="9">
                  <c:v>43</c:v>
                </c:pt>
                <c:pt idx="10">
                  <c:v>45</c:v>
                </c:pt>
                <c:pt idx="11">
                  <c:v>47</c:v>
                </c:pt>
                <c:pt idx="12">
                  <c:v>50</c:v>
                </c:pt>
              </c:numCache>
            </c:numRef>
          </c:cat>
          <c:val>
            <c:numRef>
              <c:f>'Tumor Growth Curve'!$AL$31:$AL$43</c:f>
              <c:numCache>
                <c:formatCode>General</c:formatCode>
                <c:ptCount val="13"/>
                <c:pt idx="0">
                  <c:v>49.392000000000003</c:v>
                </c:pt>
                <c:pt idx="1">
                  <c:v>59.643000000000001</c:v>
                </c:pt>
                <c:pt idx="2">
                  <c:v>87.078999999999994</c:v>
                </c:pt>
                <c:pt idx="3">
                  <c:v>165.52799999999999</c:v>
                </c:pt>
                <c:pt idx="4">
                  <c:v>352.87</c:v>
                </c:pt>
                <c:pt idx="5">
                  <c:v>603.28</c:v>
                </c:pt>
                <c:pt idx="6">
                  <c:v>962</c:v>
                </c:pt>
                <c:pt idx="7">
                  <c:v>1108.02</c:v>
                </c:pt>
                <c:pt idx="8">
                  <c:v>1437.5</c:v>
                </c:pt>
                <c:pt idx="9">
                  <c:v>1638.87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3354-49E2-8A58-1DCF2FC59DE9}"/>
            </c:ext>
          </c:extLst>
        </c:ser>
        <c:ser>
          <c:idx val="7"/>
          <c:order val="4"/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numRef>
              <c:f>'Tumor Growth Curve'!$C$31:$C$43</c:f>
              <c:numCache>
                <c:formatCode>General</c:formatCode>
                <c:ptCount val="13"/>
                <c:pt idx="0">
                  <c:v>22</c:v>
                </c:pt>
                <c:pt idx="1">
                  <c:v>23</c:v>
                </c:pt>
                <c:pt idx="2">
                  <c:v>25</c:v>
                </c:pt>
                <c:pt idx="3">
                  <c:v>27</c:v>
                </c:pt>
                <c:pt idx="4">
                  <c:v>31</c:v>
                </c:pt>
                <c:pt idx="5">
                  <c:v>33</c:v>
                </c:pt>
                <c:pt idx="6">
                  <c:v>36</c:v>
                </c:pt>
                <c:pt idx="7">
                  <c:v>38</c:v>
                </c:pt>
                <c:pt idx="8">
                  <c:v>40</c:v>
                </c:pt>
                <c:pt idx="9">
                  <c:v>43</c:v>
                </c:pt>
                <c:pt idx="10">
                  <c:v>45</c:v>
                </c:pt>
                <c:pt idx="11">
                  <c:v>47</c:v>
                </c:pt>
                <c:pt idx="12">
                  <c:v>50</c:v>
                </c:pt>
              </c:numCache>
            </c:numRef>
          </c:cat>
          <c:val>
            <c:numRef>
              <c:f>'Tumor Growth Curve'!$AM$31:$AM$43</c:f>
              <c:numCache>
                <c:formatCode>General</c:formatCode>
                <c:ptCount val="13"/>
                <c:pt idx="0">
                  <c:v>152.626</c:v>
                </c:pt>
                <c:pt idx="1">
                  <c:v>169.01599999999999</c:v>
                </c:pt>
                <c:pt idx="2">
                  <c:v>249.4</c:v>
                </c:pt>
                <c:pt idx="3">
                  <c:v>189.48599999999999</c:v>
                </c:pt>
                <c:pt idx="4">
                  <c:v>272</c:v>
                </c:pt>
                <c:pt idx="5">
                  <c:v>518.61599999999999</c:v>
                </c:pt>
                <c:pt idx="6">
                  <c:v>616.51199999999994</c:v>
                </c:pt>
                <c:pt idx="7">
                  <c:v>766.58399999999995</c:v>
                </c:pt>
                <c:pt idx="8">
                  <c:v>695.39549999999997</c:v>
                </c:pt>
                <c:pt idx="9">
                  <c:v>1106.95</c:v>
                </c:pt>
                <c:pt idx="10">
                  <c:v>1402.6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3354-49E2-8A58-1DCF2FC59D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34589791"/>
        <c:axId val="1934591871"/>
      </c:lineChart>
      <c:catAx>
        <c:axId val="193458979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34591871"/>
        <c:crosses val="autoZero"/>
        <c:auto val="1"/>
        <c:lblAlgn val="ctr"/>
        <c:lblOffset val="100"/>
        <c:noMultiLvlLbl val="0"/>
      </c:catAx>
      <c:valAx>
        <c:axId val="1934591871"/>
        <c:scaling>
          <c:orientation val="minMax"/>
          <c:max val="1400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34589791"/>
        <c:crosses val="autoZero"/>
        <c:crossBetween val="midCat"/>
        <c:majorUnit val="2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0926514980329445"/>
          <c:y val="4.4491660764626649E-2"/>
          <c:w val="0.88432352412902027"/>
          <c:h val="0.82972718687941782"/>
        </c:manualLayout>
      </c:layout>
      <c:lineChart>
        <c:grouping val="standard"/>
        <c:varyColors val="0"/>
        <c:ser>
          <c:idx val="0"/>
          <c:order val="0"/>
          <c:tx>
            <c:strRef>
              <c:f>Photometric1!$C$38</c:f>
              <c:strCache>
                <c:ptCount val="1"/>
                <c:pt idx="0">
                  <c:v>no sMICA/B</c:v>
                </c:pt>
              </c:strCache>
            </c:strRef>
          </c:tx>
          <c:spPr>
            <a:ln w="12700"/>
          </c:spPr>
          <c:cat>
            <c:numRef>
              <c:f>Photometric1!$C$41:$C$48</c:f>
              <c:numCache>
                <c:formatCode>General</c:formatCode>
                <c:ptCount val="8"/>
                <c:pt idx="0">
                  <c:v>0</c:v>
                </c:pt>
                <c:pt idx="1">
                  <c:v>15.6</c:v>
                </c:pt>
                <c:pt idx="2">
                  <c:v>31.3</c:v>
                </c:pt>
                <c:pt idx="3">
                  <c:v>62.5</c:v>
                </c:pt>
                <c:pt idx="4">
                  <c:v>125</c:v>
                </c:pt>
                <c:pt idx="5">
                  <c:v>250</c:v>
                </c:pt>
                <c:pt idx="6">
                  <c:v>500</c:v>
                </c:pt>
                <c:pt idx="7">
                  <c:v>1000</c:v>
                </c:pt>
              </c:numCache>
            </c:numRef>
          </c:cat>
          <c:val>
            <c:numRef>
              <c:f>Photometric1!$D$41:$D$48</c:f>
              <c:numCache>
                <c:formatCode>0.000</c:formatCode>
                <c:ptCount val="8"/>
                <c:pt idx="0">
                  <c:v>0.12231722863342342</c:v>
                </c:pt>
                <c:pt idx="1">
                  <c:v>0.13772160343609782</c:v>
                </c:pt>
                <c:pt idx="2">
                  <c:v>0.13395810222842022</c:v>
                </c:pt>
                <c:pt idx="3">
                  <c:v>0.13066081539742025</c:v>
                </c:pt>
                <c:pt idx="4">
                  <c:v>0.12023384606679199</c:v>
                </c:pt>
                <c:pt idx="5">
                  <c:v>0.12988418282375636</c:v>
                </c:pt>
                <c:pt idx="6">
                  <c:v>0.12783940684674525</c:v>
                </c:pt>
                <c:pt idx="7">
                  <c:v>0.1283887317875781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394-4462-8F0B-4C5F97BC7EA3}"/>
            </c:ext>
          </c:extLst>
        </c:ser>
        <c:ser>
          <c:idx val="3"/>
          <c:order val="1"/>
          <c:tx>
            <c:strRef>
              <c:f>Photometric1!$G$38</c:f>
              <c:strCache>
                <c:ptCount val="1"/>
                <c:pt idx="0">
                  <c:v>sMICB 2ug/ml</c:v>
                </c:pt>
              </c:strCache>
            </c:strRef>
          </c:tx>
          <c:spPr>
            <a:ln w="12700"/>
          </c:spPr>
          <c:marker>
            <c:symbol val="square"/>
            <c:size val="5"/>
            <c:spPr>
              <a:solidFill>
                <a:sysClr val="window" lastClr="FFFFFF"/>
              </a:solidFill>
              <a:ln w="12700">
                <a:solidFill>
                  <a:srgbClr val="7030A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hotometric1!$L$41:$L$48</c:f>
                <c:numCache>
                  <c:formatCode>General</c:formatCode>
                  <c:ptCount val="8"/>
                  <c:pt idx="0">
                    <c:v>3.3233443399097477E-3</c:v>
                  </c:pt>
                  <c:pt idx="1">
                    <c:v>2.8433958885835131E-3</c:v>
                  </c:pt>
                  <c:pt idx="2">
                    <c:v>4.497640905504959E-3</c:v>
                  </c:pt>
                  <c:pt idx="3">
                    <c:v>1.0467380488889639E-2</c:v>
                  </c:pt>
                  <c:pt idx="4">
                    <c:v>3.4584395733327916E-3</c:v>
                  </c:pt>
                  <c:pt idx="5">
                    <c:v>2.8211241172592643E-2</c:v>
                  </c:pt>
                  <c:pt idx="6">
                    <c:v>2.9013744746299544E-2</c:v>
                  </c:pt>
                  <c:pt idx="7">
                    <c:v>4.9515448315260883E-2</c:v>
                  </c:pt>
                </c:numCache>
              </c:numRef>
            </c:plus>
            <c:minus>
              <c:numRef>
                <c:f>Photometric1!$L$41:$L$48</c:f>
                <c:numCache>
                  <c:formatCode>General</c:formatCode>
                  <c:ptCount val="8"/>
                  <c:pt idx="0">
                    <c:v>3.3233443399097477E-3</c:v>
                  </c:pt>
                  <c:pt idx="1">
                    <c:v>2.8433958885835131E-3</c:v>
                  </c:pt>
                  <c:pt idx="2">
                    <c:v>4.497640905504959E-3</c:v>
                  </c:pt>
                  <c:pt idx="3">
                    <c:v>1.0467380488889639E-2</c:v>
                  </c:pt>
                  <c:pt idx="4">
                    <c:v>3.4584395733327916E-3</c:v>
                  </c:pt>
                  <c:pt idx="5">
                    <c:v>2.8211241172592643E-2</c:v>
                  </c:pt>
                  <c:pt idx="6">
                    <c:v>2.9013744746299544E-2</c:v>
                  </c:pt>
                  <c:pt idx="7">
                    <c:v>4.9515448315260883E-2</c:v>
                  </c:pt>
                </c:numCache>
              </c:numRef>
            </c:minus>
          </c:errBars>
          <c:cat>
            <c:numRef>
              <c:f>Photometric1!$C$41:$C$48</c:f>
              <c:numCache>
                <c:formatCode>General</c:formatCode>
                <c:ptCount val="8"/>
                <c:pt idx="0">
                  <c:v>0</c:v>
                </c:pt>
                <c:pt idx="1">
                  <c:v>15.6</c:v>
                </c:pt>
                <c:pt idx="2">
                  <c:v>31.3</c:v>
                </c:pt>
                <c:pt idx="3">
                  <c:v>62.5</c:v>
                </c:pt>
                <c:pt idx="4">
                  <c:v>125</c:v>
                </c:pt>
                <c:pt idx="5">
                  <c:v>250</c:v>
                </c:pt>
                <c:pt idx="6">
                  <c:v>500</c:v>
                </c:pt>
                <c:pt idx="7">
                  <c:v>1000</c:v>
                </c:pt>
              </c:numCache>
            </c:numRef>
          </c:cat>
          <c:val>
            <c:numRef>
              <c:f>Photometric1!$G$41:$G$48</c:f>
              <c:numCache>
                <c:formatCode>0.000</c:formatCode>
                <c:ptCount val="8"/>
                <c:pt idx="0">
                  <c:v>0.1267904271276111</c:v>
                </c:pt>
                <c:pt idx="1">
                  <c:v>0.15285351796497257</c:v>
                </c:pt>
                <c:pt idx="2">
                  <c:v>0.16994534645339784</c:v>
                </c:pt>
                <c:pt idx="3">
                  <c:v>0.21086350101300846</c:v>
                </c:pt>
                <c:pt idx="4">
                  <c:v>0.27785018943147083</c:v>
                </c:pt>
                <c:pt idx="5">
                  <c:v>0.4485009869159054</c:v>
                </c:pt>
                <c:pt idx="6">
                  <c:v>0.68834898368124564</c:v>
                </c:pt>
                <c:pt idx="7">
                  <c:v>0.970669270750448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394-4462-8F0B-4C5F97BC7E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11757696"/>
        <c:axId val="1"/>
      </c:lineChart>
      <c:catAx>
        <c:axId val="1117576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0.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1175769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4804465231319769"/>
          <c:y val="0.10671756308239248"/>
          <c:w val="0.45530457341480968"/>
          <c:h val="0.17990251218597672"/>
        </c:manualLayout>
      </c:layout>
      <c:overlay val="0"/>
      <c:txPr>
        <a:bodyPr/>
        <a:lstStyle/>
        <a:p>
          <a:pPr>
            <a:defRPr sz="800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6.7638423137859172E-2"/>
          <c:y val="4.7250859106529208E-2"/>
          <c:w val="0.8780152957105507"/>
          <c:h val="0.8657145466352788"/>
        </c:manualLayout>
      </c:layout>
      <c:lineChart>
        <c:grouping val="standard"/>
        <c:varyColors val="0"/>
        <c:ser>
          <c:idx val="0"/>
          <c:order val="0"/>
          <c:tx>
            <c:strRef>
              <c:f>Photometric1!$C$45</c:f>
              <c:strCache>
                <c:ptCount val="1"/>
                <c:pt idx="0">
                  <c:v>no sMICA/B</c:v>
                </c:pt>
              </c:strCache>
            </c:strRef>
          </c:tx>
          <c:spPr>
            <a:ln w="12700"/>
          </c:spPr>
          <c:marker>
            <c:spPr>
              <a:ln w="12700"/>
            </c:spPr>
          </c:marker>
          <c:cat>
            <c:numRef>
              <c:f>Photometric1!$C$47:$C$54</c:f>
              <c:numCache>
                <c:formatCode>General</c:formatCode>
                <c:ptCount val="8"/>
                <c:pt idx="0">
                  <c:v>0</c:v>
                </c:pt>
                <c:pt idx="1">
                  <c:v>15.6</c:v>
                </c:pt>
                <c:pt idx="2">
                  <c:v>31.3</c:v>
                </c:pt>
                <c:pt idx="3">
                  <c:v>62.5</c:v>
                </c:pt>
                <c:pt idx="4">
                  <c:v>125</c:v>
                </c:pt>
                <c:pt idx="5">
                  <c:v>250</c:v>
                </c:pt>
                <c:pt idx="6">
                  <c:v>500</c:v>
                </c:pt>
                <c:pt idx="7">
                  <c:v>1000</c:v>
                </c:pt>
              </c:numCache>
            </c:numRef>
          </c:cat>
          <c:val>
            <c:numRef>
              <c:f>Photometric1!$D$47:$D$54</c:f>
              <c:numCache>
                <c:formatCode>0.000</c:formatCode>
                <c:ptCount val="8"/>
                <c:pt idx="0">
                  <c:v>0.13779844125571369</c:v>
                </c:pt>
                <c:pt idx="1">
                  <c:v>0.14189173990097748</c:v>
                </c:pt>
                <c:pt idx="2">
                  <c:v>0.14286016643306146</c:v>
                </c:pt>
                <c:pt idx="3">
                  <c:v>0.14067762762935154</c:v>
                </c:pt>
                <c:pt idx="4">
                  <c:v>0.13152886568268413</c:v>
                </c:pt>
                <c:pt idx="5">
                  <c:v>0.14016072380193215</c:v>
                </c:pt>
                <c:pt idx="6">
                  <c:v>0.14014284831352916</c:v>
                </c:pt>
                <c:pt idx="7">
                  <c:v>0.143936109585516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222-40E6-AABC-C37B4B188C71}"/>
            </c:ext>
          </c:extLst>
        </c:ser>
        <c:ser>
          <c:idx val="2"/>
          <c:order val="1"/>
          <c:tx>
            <c:strRef>
              <c:f>Photometric1!$F$45</c:f>
              <c:strCache>
                <c:ptCount val="1"/>
                <c:pt idx="0">
                  <c:v>sMICA 2ug/ml</c:v>
                </c:pt>
              </c:strCache>
            </c:strRef>
          </c:tx>
          <c:spPr>
            <a:ln w="12700">
              <a:solidFill>
                <a:srgbClr val="7030A0"/>
              </a:solidFill>
            </a:ln>
          </c:spPr>
          <c:marker>
            <c:symbol val="square"/>
            <c:size val="5"/>
            <c:spPr>
              <a:solidFill>
                <a:srgbClr val="7030A0"/>
              </a:solidFill>
              <a:ln w="12700">
                <a:solidFill>
                  <a:srgbClr val="7030A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hotometric1!$K$47:$K$54</c:f>
                <c:numCache>
                  <c:formatCode>General</c:formatCode>
                  <c:ptCount val="8"/>
                  <c:pt idx="0">
                    <c:v>1.799469209527586E-3</c:v>
                  </c:pt>
                  <c:pt idx="1">
                    <c:v>1.735050202601528E-2</c:v>
                  </c:pt>
                  <c:pt idx="2">
                    <c:v>2.1350519959027463E-2</c:v>
                  </c:pt>
                  <c:pt idx="3">
                    <c:v>3.1715106182661115E-2</c:v>
                  </c:pt>
                  <c:pt idx="4">
                    <c:v>3.661301862922433E-2</c:v>
                  </c:pt>
                  <c:pt idx="5">
                    <c:v>9.9715539816505938E-2</c:v>
                  </c:pt>
                  <c:pt idx="6">
                    <c:v>9.1451380775413135E-2</c:v>
                  </c:pt>
                  <c:pt idx="7">
                    <c:v>2.7937176729734978E-2</c:v>
                  </c:pt>
                </c:numCache>
              </c:numRef>
            </c:plus>
            <c:minus>
              <c:numRef>
                <c:f>Photometric1!$K$47:$K$54</c:f>
                <c:numCache>
                  <c:formatCode>General</c:formatCode>
                  <c:ptCount val="8"/>
                  <c:pt idx="0">
                    <c:v>1.799469209527586E-3</c:v>
                  </c:pt>
                  <c:pt idx="1">
                    <c:v>1.735050202601528E-2</c:v>
                  </c:pt>
                  <c:pt idx="2">
                    <c:v>2.1350519959027463E-2</c:v>
                  </c:pt>
                  <c:pt idx="3">
                    <c:v>3.1715106182661115E-2</c:v>
                  </c:pt>
                  <c:pt idx="4">
                    <c:v>3.661301862922433E-2</c:v>
                  </c:pt>
                  <c:pt idx="5">
                    <c:v>9.9715539816505938E-2</c:v>
                  </c:pt>
                  <c:pt idx="6">
                    <c:v>9.1451380775413135E-2</c:v>
                  </c:pt>
                  <c:pt idx="7">
                    <c:v>2.7937176729734978E-2</c:v>
                  </c:pt>
                </c:numCache>
              </c:numRef>
            </c:minus>
          </c:errBars>
          <c:cat>
            <c:numRef>
              <c:f>Photometric1!$C$47:$C$54</c:f>
              <c:numCache>
                <c:formatCode>General</c:formatCode>
                <c:ptCount val="8"/>
                <c:pt idx="0">
                  <c:v>0</c:v>
                </c:pt>
                <c:pt idx="1">
                  <c:v>15.6</c:v>
                </c:pt>
                <c:pt idx="2">
                  <c:v>31.3</c:v>
                </c:pt>
                <c:pt idx="3">
                  <c:v>62.5</c:v>
                </c:pt>
                <c:pt idx="4">
                  <c:v>125</c:v>
                </c:pt>
                <c:pt idx="5">
                  <c:v>250</c:v>
                </c:pt>
                <c:pt idx="6">
                  <c:v>500</c:v>
                </c:pt>
                <c:pt idx="7">
                  <c:v>1000</c:v>
                </c:pt>
              </c:numCache>
            </c:numRef>
          </c:cat>
          <c:val>
            <c:numRef>
              <c:f>Photometric1!$F$47:$F$54</c:f>
              <c:numCache>
                <c:formatCode>0.000</c:formatCode>
                <c:ptCount val="8"/>
                <c:pt idx="0">
                  <c:v>0.14610453950247496</c:v>
                </c:pt>
                <c:pt idx="1">
                  <c:v>0.21819320205950701</c:v>
                </c:pt>
                <c:pt idx="2">
                  <c:v>0.30030344830711381</c:v>
                </c:pt>
                <c:pt idx="3">
                  <c:v>0.39465117404488415</c:v>
                </c:pt>
                <c:pt idx="4">
                  <c:v>0.56557226001101946</c:v>
                </c:pt>
                <c:pt idx="5">
                  <c:v>0.84300683405834231</c:v>
                </c:pt>
                <c:pt idx="6">
                  <c:v>1.0144091727818223</c:v>
                </c:pt>
                <c:pt idx="7">
                  <c:v>1.00553471598286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222-40E6-AABC-C37B4B188C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65370064"/>
        <c:axId val="1"/>
      </c:lineChart>
      <c:catAx>
        <c:axId val="2653700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/>
        </c:spPr>
        <c:txPr>
          <a:bodyPr rot="0" vert="horz"/>
          <a:lstStyle/>
          <a:p>
            <a:pPr>
              <a:defRPr sz="800" b="0" i="0" u="none" strike="noStrike" baseline="0">
                <a:solidFill>
                  <a:srgbClr val="000000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defRPr>
            </a:pPr>
            <a:endParaRPr lang="en-US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0.0" sourceLinked="0"/>
        <c:majorTickMark val="out"/>
        <c:minorTickMark val="none"/>
        <c:tickLblPos val="nextTo"/>
        <c:spPr>
          <a:ln/>
        </c:spPr>
        <c:txPr>
          <a:bodyPr rot="0" vert="horz"/>
          <a:lstStyle/>
          <a:p>
            <a:pPr>
              <a:defRPr sz="800" b="0" i="0" u="none" strike="noStrike" baseline="0">
                <a:solidFill>
                  <a:srgbClr val="000000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defRPr>
            </a:pPr>
            <a:endParaRPr lang="en-US"/>
          </a:p>
        </c:txPr>
        <c:crossAx val="265370064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3783634589430357"/>
          <c:y val="7.8053886949698309E-2"/>
          <c:w val="0.43827576623403708"/>
          <c:h val="0.31580566016204503"/>
        </c:manualLayout>
      </c:layout>
      <c:overlay val="0"/>
      <c:txPr>
        <a:bodyPr/>
        <a:lstStyle/>
        <a:p>
          <a:pPr>
            <a:defRPr sz="800" b="0" i="0" u="none" strike="noStrike" baseline="0">
              <a:solidFill>
                <a:srgbClr val="000000"/>
              </a:solidFill>
              <a:latin typeface="Arial" panose="020B0604020202020204" pitchFamily="34" charset="0"/>
              <a:ea typeface="Calibri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2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6.7200003200819411E-2"/>
          <c:y val="9.3803951589384663E-2"/>
          <c:w val="0.87970040330324561"/>
          <c:h val="0.85527012248468937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ure S6'!$D$4:$D$10</c:f>
                <c:numCache>
                  <c:formatCode>General</c:formatCode>
                  <c:ptCount val="7"/>
                  <c:pt idx="0">
                    <c:v>0.6</c:v>
                  </c:pt>
                  <c:pt idx="1">
                    <c:v>1.2</c:v>
                  </c:pt>
                  <c:pt idx="2">
                    <c:v>2.9</c:v>
                  </c:pt>
                  <c:pt idx="3">
                    <c:v>0.6</c:v>
                  </c:pt>
                  <c:pt idx="4">
                    <c:v>1.1000000000000001</c:v>
                  </c:pt>
                  <c:pt idx="5">
                    <c:v>0.9</c:v>
                  </c:pt>
                  <c:pt idx="6">
                    <c:v>1.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Figure S6'!$C$4:$C$10</c:f>
              <c:numCache>
                <c:formatCode>General</c:formatCode>
                <c:ptCount val="7"/>
                <c:pt idx="0">
                  <c:v>9.5</c:v>
                </c:pt>
                <c:pt idx="1">
                  <c:v>22.1</c:v>
                </c:pt>
                <c:pt idx="2">
                  <c:v>36.9</c:v>
                </c:pt>
                <c:pt idx="3">
                  <c:v>11.5</c:v>
                </c:pt>
                <c:pt idx="4">
                  <c:v>24.8</c:v>
                </c:pt>
                <c:pt idx="5">
                  <c:v>14.7</c:v>
                </c:pt>
                <c:pt idx="6">
                  <c:v>24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ED0-49CB-8195-C258419C08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78361295"/>
        <c:axId val="336642079"/>
      </c:barChart>
      <c:catAx>
        <c:axId val="178361295"/>
        <c:scaling>
          <c:orientation val="maxMin"/>
        </c:scaling>
        <c:delete val="0"/>
        <c:axPos val="l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6642079"/>
        <c:crosses val="autoZero"/>
        <c:auto val="1"/>
        <c:lblAlgn val="ctr"/>
        <c:lblOffset val="100"/>
        <c:noMultiLvlLbl val="0"/>
      </c:catAx>
      <c:valAx>
        <c:axId val="336642079"/>
        <c:scaling>
          <c:orientation val="minMax"/>
          <c:max val="50"/>
          <c:min val="0"/>
        </c:scaling>
        <c:delete val="0"/>
        <c:axPos val="t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8361295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9337</cdr:x>
      <cdr:y>0.30662</cdr:y>
    </cdr:from>
    <cdr:to>
      <cdr:x>0.22163</cdr:x>
      <cdr:y>0.64062</cdr:y>
    </cdr:to>
    <cdr:sp macro="" textlink="">
      <cdr:nvSpPr>
        <cdr:cNvPr id="2" name="Down Arrow 171">
          <a:extLst xmlns:a="http://schemas.openxmlformats.org/drawingml/2006/main">
            <a:ext uri="{FF2B5EF4-FFF2-40B4-BE49-F238E27FC236}">
              <a16:creationId xmlns:a16="http://schemas.microsoft.com/office/drawing/2014/main" id="{A4A6D66B-A506-41BB-A927-4BFD9F7EC695}"/>
            </a:ext>
          </a:extLst>
        </cdr:cNvPr>
        <cdr:cNvSpPr/>
      </cdr:nvSpPr>
      <cdr:spPr>
        <a:xfrm xmlns:a="http://schemas.openxmlformats.org/drawingml/2006/main">
          <a:off x="449298" y="464326"/>
          <a:ext cx="65659" cy="505791"/>
        </a:xfrm>
        <a:prstGeom xmlns:a="http://schemas.openxmlformats.org/drawingml/2006/main" prst="downArrow">
          <a:avLst/>
        </a:prstGeom>
        <a:solidFill xmlns:a="http://schemas.openxmlformats.org/drawingml/2006/main">
          <a:srgbClr val="FF0000"/>
        </a:solidFill>
        <a:ln xmlns:a="http://schemas.openxmlformats.org/drawingml/2006/main">
          <a:solidFill>
            <a:srgbClr val="FF0000"/>
          </a:solidFill>
        </a:ln>
      </cdr:spPr>
      <cdr:style>
        <a:lnRef xmlns:a="http://schemas.openxmlformats.org/drawingml/2006/main" idx="2">
          <a:schemeClr val="dk1"/>
        </a:lnRef>
        <a:fillRef xmlns:a="http://schemas.openxmlformats.org/drawingml/2006/main" idx="1">
          <a:schemeClr val="lt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rtlCol="0" anchor="ctr"/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n-US" sz="80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18674</cdr:x>
      <cdr:y>0.31659</cdr:y>
    </cdr:from>
    <cdr:to>
      <cdr:x>0.21634</cdr:x>
      <cdr:y>0.67</cdr:y>
    </cdr:to>
    <cdr:sp macro="" textlink="">
      <cdr:nvSpPr>
        <cdr:cNvPr id="2" name="Down Arrow 171">
          <a:extLst xmlns:a="http://schemas.openxmlformats.org/drawingml/2006/main">
            <a:ext uri="{FF2B5EF4-FFF2-40B4-BE49-F238E27FC236}">
              <a16:creationId xmlns:a16="http://schemas.microsoft.com/office/drawing/2014/main" id="{EA915DE9-1DF7-44C1-865B-85F093C8610B}"/>
            </a:ext>
          </a:extLst>
        </cdr:cNvPr>
        <cdr:cNvSpPr/>
      </cdr:nvSpPr>
      <cdr:spPr>
        <a:xfrm xmlns:a="http://schemas.openxmlformats.org/drawingml/2006/main">
          <a:off x="460426" y="453110"/>
          <a:ext cx="72974" cy="505791"/>
        </a:xfrm>
        <a:prstGeom xmlns:a="http://schemas.openxmlformats.org/drawingml/2006/main" prst="downArrow">
          <a:avLst/>
        </a:prstGeom>
        <a:solidFill xmlns:a="http://schemas.openxmlformats.org/drawingml/2006/main">
          <a:srgbClr val="FF0000"/>
        </a:solidFill>
        <a:ln xmlns:a="http://schemas.openxmlformats.org/drawingml/2006/main">
          <a:solidFill>
            <a:srgbClr val="FF0000"/>
          </a:solidFill>
        </a:ln>
      </cdr:spPr>
      <cdr:style>
        <a:lnRef xmlns:a="http://schemas.openxmlformats.org/drawingml/2006/main" idx="2">
          <a:schemeClr val="dk1"/>
        </a:lnRef>
        <a:fillRef xmlns:a="http://schemas.openxmlformats.org/drawingml/2006/main" idx="1">
          <a:schemeClr val="lt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n-US" sz="80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18932</cdr:x>
      <cdr:y>0.34847</cdr:y>
    </cdr:from>
    <cdr:to>
      <cdr:x>0.2165</cdr:x>
      <cdr:y>0.71055</cdr:y>
    </cdr:to>
    <cdr:sp macro="" textlink="">
      <cdr:nvSpPr>
        <cdr:cNvPr id="2" name="Down Arrow 171">
          <a:extLst xmlns:a="http://schemas.openxmlformats.org/drawingml/2006/main">
            <a:ext uri="{FF2B5EF4-FFF2-40B4-BE49-F238E27FC236}">
              <a16:creationId xmlns:a16="http://schemas.microsoft.com/office/drawing/2014/main" id="{A58B594A-9C15-454C-BC61-1C207DFE3004}"/>
            </a:ext>
          </a:extLst>
        </cdr:cNvPr>
        <cdr:cNvSpPr/>
      </cdr:nvSpPr>
      <cdr:spPr>
        <a:xfrm xmlns:a="http://schemas.openxmlformats.org/drawingml/2006/main">
          <a:off x="457200" y="486777"/>
          <a:ext cx="65659" cy="505791"/>
        </a:xfrm>
        <a:prstGeom xmlns:a="http://schemas.openxmlformats.org/drawingml/2006/main" prst="downArrow">
          <a:avLst/>
        </a:prstGeom>
        <a:solidFill xmlns:a="http://schemas.openxmlformats.org/drawingml/2006/main">
          <a:srgbClr val="FF0000"/>
        </a:solidFill>
        <a:ln xmlns:a="http://schemas.openxmlformats.org/drawingml/2006/main">
          <a:solidFill>
            <a:srgbClr val="FF0000"/>
          </a:solidFill>
        </a:ln>
      </cdr:spPr>
      <cdr:style>
        <a:lnRef xmlns:a="http://schemas.openxmlformats.org/drawingml/2006/main" idx="2">
          <a:schemeClr val="dk1"/>
        </a:lnRef>
        <a:fillRef xmlns:a="http://schemas.openxmlformats.org/drawingml/2006/main" idx="1">
          <a:schemeClr val="lt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n-US" sz="80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19171</cdr:x>
      <cdr:y>0.33104</cdr:y>
    </cdr:from>
    <cdr:to>
      <cdr:x>0.22138</cdr:x>
      <cdr:y>0.64271</cdr:y>
    </cdr:to>
    <cdr:sp macro="" textlink="">
      <cdr:nvSpPr>
        <cdr:cNvPr id="2" name="Down Arrow 171">
          <a:extLst xmlns:a="http://schemas.openxmlformats.org/drawingml/2006/main">
            <a:ext uri="{FF2B5EF4-FFF2-40B4-BE49-F238E27FC236}">
              <a16:creationId xmlns:a16="http://schemas.microsoft.com/office/drawing/2014/main" id="{EA915DE9-1DF7-44C1-865B-85F093C8610B}"/>
            </a:ext>
          </a:extLst>
        </cdr:cNvPr>
        <cdr:cNvSpPr/>
      </cdr:nvSpPr>
      <cdr:spPr>
        <a:xfrm xmlns:a="http://schemas.openxmlformats.org/drawingml/2006/main">
          <a:off x="424359" y="537225"/>
          <a:ext cx="65659" cy="505791"/>
        </a:xfrm>
        <a:prstGeom xmlns:a="http://schemas.openxmlformats.org/drawingml/2006/main" prst="downArrow">
          <a:avLst/>
        </a:prstGeom>
        <a:solidFill xmlns:a="http://schemas.openxmlformats.org/drawingml/2006/main">
          <a:srgbClr val="FF0000"/>
        </a:solidFill>
        <a:ln xmlns:a="http://schemas.openxmlformats.org/drawingml/2006/main">
          <a:solidFill>
            <a:srgbClr val="FF0000"/>
          </a:solidFill>
        </a:ln>
      </cdr:spPr>
      <cdr:style>
        <a:lnRef xmlns:a="http://schemas.openxmlformats.org/drawingml/2006/main" idx="2">
          <a:schemeClr val="dk1"/>
        </a:lnRef>
        <a:fillRef xmlns:a="http://schemas.openxmlformats.org/drawingml/2006/main" idx="1">
          <a:schemeClr val="lt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n-US" sz="80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3343" cy="465773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8132" y="0"/>
            <a:ext cx="3043343" cy="465773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r">
              <a:defRPr sz="1200"/>
            </a:lvl1pPr>
          </a:lstStyle>
          <a:p>
            <a:fld id="{28442BCB-09FA-4327-B050-5F4B9E928F97}" type="datetimeFigureOut">
              <a:rPr lang="en-US" smtClean="0"/>
              <a:t>6/22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01863" y="698500"/>
            <a:ext cx="2619375" cy="34909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46" tIns="46223" rIns="92446" bIns="4622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2310" y="4422461"/>
            <a:ext cx="5618480" cy="4188778"/>
          </a:xfrm>
          <a:prstGeom prst="rect">
            <a:avLst/>
          </a:prstGeom>
        </p:spPr>
        <p:txBody>
          <a:bodyPr vert="horz" lIns="92446" tIns="46223" rIns="92446" bIns="46223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1738"/>
            <a:ext cx="3043343" cy="465773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8132" y="8841738"/>
            <a:ext cx="3043343" cy="465773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r">
              <a:defRPr sz="1200"/>
            </a:lvl1pPr>
          </a:lstStyle>
          <a:p>
            <a:fld id="{E7410C09-355E-4B03-AA18-2EFECE611F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2334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7410C09-355E-4B03-AA18-2EFECE611F94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1626484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6637F-2AA1-48C1-A32E-F4C142865AAD}" type="datetimeFigureOut">
              <a:rPr lang="en-US" smtClean="0"/>
              <a:t>6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3CE6-1046-4311-9A21-7D0D5885C2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04184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6637F-2AA1-48C1-A32E-F4C142865AAD}" type="datetimeFigureOut">
              <a:rPr lang="en-US" smtClean="0"/>
              <a:t>6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3CE6-1046-4311-9A21-7D0D5885C2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65475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6637F-2AA1-48C1-A32E-F4C142865AAD}" type="datetimeFigureOut">
              <a:rPr lang="en-US" smtClean="0"/>
              <a:t>6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3CE6-1046-4311-9A21-7D0D5885C2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2193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6637F-2AA1-48C1-A32E-F4C142865AAD}" type="datetimeFigureOut">
              <a:rPr lang="en-US" smtClean="0"/>
              <a:t>6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3CE6-1046-4311-9A21-7D0D5885C2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44081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6637F-2AA1-48C1-A32E-F4C142865AAD}" type="datetimeFigureOut">
              <a:rPr lang="en-US" smtClean="0"/>
              <a:t>6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3CE6-1046-4311-9A21-7D0D5885C2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76622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6637F-2AA1-48C1-A32E-F4C142865AAD}" type="datetimeFigureOut">
              <a:rPr lang="en-US" smtClean="0"/>
              <a:t>6/2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3CE6-1046-4311-9A21-7D0D5885C2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4737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6637F-2AA1-48C1-A32E-F4C142865AAD}" type="datetimeFigureOut">
              <a:rPr lang="en-US" smtClean="0"/>
              <a:t>6/22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3CE6-1046-4311-9A21-7D0D5885C2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0218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6637F-2AA1-48C1-A32E-F4C142865AAD}" type="datetimeFigureOut">
              <a:rPr lang="en-US" smtClean="0"/>
              <a:t>6/22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3CE6-1046-4311-9A21-7D0D5885C2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19153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6637F-2AA1-48C1-A32E-F4C142865AAD}" type="datetimeFigureOut">
              <a:rPr lang="en-US" smtClean="0"/>
              <a:t>6/22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3CE6-1046-4311-9A21-7D0D5885C2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0639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6637F-2AA1-48C1-A32E-F4C142865AAD}" type="datetimeFigureOut">
              <a:rPr lang="en-US" smtClean="0"/>
              <a:t>6/2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3CE6-1046-4311-9A21-7D0D5885C2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62197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6637F-2AA1-48C1-A32E-F4C142865AAD}" type="datetimeFigureOut">
              <a:rPr lang="en-US" smtClean="0"/>
              <a:t>6/2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33CE6-1046-4311-9A21-7D0D5885C2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9942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66637F-2AA1-48C1-A32E-F4C142865AAD}" type="datetimeFigureOut">
              <a:rPr lang="en-US" smtClean="0"/>
              <a:t>6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933CE6-1046-4311-9A21-7D0D5885C2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53686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2.xml"/><Relationship Id="rId4" Type="http://schemas.openxmlformats.org/officeDocument/2006/relationships/chart" Target="../charts/char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.jpeg"/><Relationship Id="rId5" Type="http://schemas.openxmlformats.org/officeDocument/2006/relationships/chart" Target="../charts/chart6.xml"/><Relationship Id="rId4" Type="http://schemas.openxmlformats.org/officeDocument/2006/relationships/chart" Target="../charts/chart5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17.jpeg"/><Relationship Id="rId18" Type="http://schemas.microsoft.com/office/2007/relationships/hdphoto" Target="../media/hdphoto7.wdp"/><Relationship Id="rId26" Type="http://schemas.openxmlformats.org/officeDocument/2006/relationships/chart" Target="../charts/chart9.xml"/><Relationship Id="rId3" Type="http://schemas.openxmlformats.org/officeDocument/2006/relationships/image" Target="../media/image11.jpeg"/><Relationship Id="rId21" Type="http://schemas.openxmlformats.org/officeDocument/2006/relationships/image" Target="../media/image21.jpeg"/><Relationship Id="rId7" Type="http://schemas.openxmlformats.org/officeDocument/2006/relationships/image" Target="../media/image13.png"/><Relationship Id="rId12" Type="http://schemas.microsoft.com/office/2007/relationships/hdphoto" Target="../media/hdphoto4.wdp"/><Relationship Id="rId17" Type="http://schemas.openxmlformats.org/officeDocument/2006/relationships/image" Target="../media/image19.jpeg"/><Relationship Id="rId25" Type="http://schemas.openxmlformats.org/officeDocument/2006/relationships/image" Target="../media/image23.jpeg"/><Relationship Id="rId2" Type="http://schemas.openxmlformats.org/officeDocument/2006/relationships/image" Target="../media/image10.jpeg"/><Relationship Id="rId16" Type="http://schemas.microsoft.com/office/2007/relationships/hdphoto" Target="../media/hdphoto6.wdp"/><Relationship Id="rId20" Type="http://schemas.microsoft.com/office/2007/relationships/hdphoto" Target="../media/hdphoto8.wdp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16.png"/><Relationship Id="rId24" Type="http://schemas.microsoft.com/office/2007/relationships/hdphoto" Target="../media/hdphoto10.wdp"/><Relationship Id="rId5" Type="http://schemas.openxmlformats.org/officeDocument/2006/relationships/image" Target="../media/image12.png"/><Relationship Id="rId15" Type="http://schemas.openxmlformats.org/officeDocument/2006/relationships/image" Target="../media/image18.jpeg"/><Relationship Id="rId23" Type="http://schemas.openxmlformats.org/officeDocument/2006/relationships/image" Target="../media/image22.jpeg"/><Relationship Id="rId28" Type="http://schemas.openxmlformats.org/officeDocument/2006/relationships/chart" Target="../charts/chart11.xml"/><Relationship Id="rId10" Type="http://schemas.openxmlformats.org/officeDocument/2006/relationships/image" Target="../media/image15.jpeg"/><Relationship Id="rId19" Type="http://schemas.openxmlformats.org/officeDocument/2006/relationships/image" Target="../media/image20.jpeg"/><Relationship Id="rId4" Type="http://schemas.microsoft.com/office/2007/relationships/hdphoto" Target="../media/hdphoto1.wdp"/><Relationship Id="rId9" Type="http://schemas.openxmlformats.org/officeDocument/2006/relationships/image" Target="../media/image14.jpeg"/><Relationship Id="rId14" Type="http://schemas.microsoft.com/office/2007/relationships/hdphoto" Target="../media/hdphoto5.wdp"/><Relationship Id="rId22" Type="http://schemas.microsoft.com/office/2007/relationships/hdphoto" Target="../media/hdphoto9.wdp"/><Relationship Id="rId27" Type="http://schemas.openxmlformats.org/officeDocument/2006/relationships/chart" Target="../charts/chart10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3" Type="http://schemas.openxmlformats.org/officeDocument/2006/relationships/image" Target="../media/image25.jpeg"/><Relationship Id="rId7" Type="http://schemas.openxmlformats.org/officeDocument/2006/relationships/image" Target="../media/image29.png"/><Relationship Id="rId2" Type="http://schemas.openxmlformats.org/officeDocument/2006/relationships/image" Target="../media/image24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jpeg"/><Relationship Id="rId11" Type="http://schemas.openxmlformats.org/officeDocument/2006/relationships/chart" Target="../charts/chart13.xml"/><Relationship Id="rId5" Type="http://schemas.openxmlformats.org/officeDocument/2006/relationships/image" Target="../media/image27.jpeg"/><Relationship Id="rId10" Type="http://schemas.openxmlformats.org/officeDocument/2006/relationships/chart" Target="../charts/chart12.xml"/><Relationship Id="rId4" Type="http://schemas.openxmlformats.org/officeDocument/2006/relationships/image" Target="../media/image26.jpeg"/><Relationship Id="rId9" Type="http://schemas.openxmlformats.org/officeDocument/2006/relationships/image" Target="../media/image3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Rectangle 101">
            <a:extLst>
              <a:ext uri="{FF2B5EF4-FFF2-40B4-BE49-F238E27FC236}">
                <a16:creationId xmlns:a16="http://schemas.microsoft.com/office/drawing/2014/main" id="{7C2148C1-EA99-4A7C-BF0B-FFE479C7FB67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1261011" y="2658021"/>
            <a:ext cx="127599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erum </a:t>
            </a:r>
            <a:r>
              <a:rPr kumimoji="0" lang="en-US" altLang="en-US" sz="80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MIC</a:t>
            </a:r>
            <a:r>
              <a:rPr kumimoji="0" lang="en-US" altLang="en-US" sz="8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prior to therapy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800" dirty="0">
                <a:solidFill>
                  <a:srgbClr val="000000"/>
                </a:solidFill>
              </a:rPr>
              <a:t>                (ng/ml)</a:t>
            </a:r>
            <a:endParaRPr kumimoji="0" lang="en-US" altLang="en-US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1193425" y="4423331"/>
            <a:ext cx="5311647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1. Serum levels of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sMICB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in animal cohorts at pre-treatment baseline. </a:t>
            </a:r>
            <a:r>
              <a:rPr lang="en-US" sz="1100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Serum levels of </a:t>
            </a:r>
            <a:r>
              <a:rPr lang="en-US" sz="1100" dirty="0" err="1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sMICB</a:t>
            </a:r>
            <a:r>
              <a:rPr lang="en-US" sz="1100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 was assayed using Serum levels of </a:t>
            </a:r>
            <a:r>
              <a:rPr lang="en-US" sz="1100" dirty="0" err="1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sMICB</a:t>
            </a:r>
            <a:endParaRPr lang="en-US" sz="1100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dirty="0" err="1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Duoset</a:t>
            </a:r>
            <a:r>
              <a:rPr lang="en-US" sz="1100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 Sandwich ELISA kit (DY1599) from R&amp;D Systems, following manufacture’s instructions.</a:t>
            </a:r>
            <a:r>
              <a:rPr lang="en-US" sz="1100" b="1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Blood was collected one day before the treatment initiation. Data shown are mean value of triplicates. No significant levels of </a:t>
            </a:r>
            <a:r>
              <a:rPr lang="en-US" sz="1100" dirty="0" err="1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sMICB</a:t>
            </a:r>
            <a:r>
              <a:rPr lang="en-US" sz="1100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 was detected in single transgenic MICB/B6 mice. 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CC436F35-0E6C-441B-B176-549E0D592E3A}"/>
              </a:ext>
            </a:extLst>
          </p:cNvPr>
          <p:cNvSpPr txBox="1"/>
          <p:nvPr/>
        </p:nvSpPr>
        <p:spPr>
          <a:xfrm>
            <a:off x="2657729" y="304800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grpSp>
        <p:nvGrpSpPr>
          <p:cNvPr id="132" name="Group 131">
            <a:extLst>
              <a:ext uri="{FF2B5EF4-FFF2-40B4-BE49-F238E27FC236}">
                <a16:creationId xmlns:a16="http://schemas.microsoft.com/office/drawing/2014/main" id="{D9817E45-48B0-4193-B68C-8CC76F9A30EE}"/>
              </a:ext>
            </a:extLst>
          </p:cNvPr>
          <p:cNvGrpSpPr/>
          <p:nvPr/>
        </p:nvGrpSpPr>
        <p:grpSpPr>
          <a:xfrm>
            <a:off x="2112962" y="2070656"/>
            <a:ext cx="2656336" cy="2007314"/>
            <a:chOff x="2112962" y="2070656"/>
            <a:chExt cx="2656336" cy="2007314"/>
          </a:xfrm>
        </p:grpSpPr>
        <p:sp>
          <p:nvSpPr>
            <p:cNvPr id="4" name="Rectangle 5">
              <a:extLst>
                <a:ext uri="{FF2B5EF4-FFF2-40B4-BE49-F238E27FC236}">
                  <a16:creationId xmlns:a16="http://schemas.microsoft.com/office/drawing/2014/main" id="{54CE905D-A00A-441D-AD1D-473F375385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6174" y="3504168"/>
              <a:ext cx="2180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IgG</a:t>
              </a:r>
              <a:endParaRPr kumimoji="0" lang="en-US" altLang="en-US" sz="18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" name="Rectangle 6">
              <a:extLst>
                <a:ext uri="{FF2B5EF4-FFF2-40B4-BE49-F238E27FC236}">
                  <a16:creationId xmlns:a16="http://schemas.microsoft.com/office/drawing/2014/main" id="{29079690-4F53-49CD-A3BD-0B7322CCFB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0512" y="3504168"/>
              <a:ext cx="35426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800" dirty="0">
                  <a:solidFill>
                    <a:srgbClr val="000000"/>
                  </a:solidFill>
                  <a:latin typeface="Symbol" panose="05050102010706020507" pitchFamily="18" charset="2"/>
                </a:rPr>
                <a:t>a</a:t>
              </a:r>
              <a:r>
                <a:rPr kumimoji="0" lang="en-US" altLang="en-US" sz="8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PDL1</a:t>
              </a:r>
              <a:endParaRPr kumimoji="0" lang="en-US" altLang="en-US" sz="1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" name="Rectangle 7">
              <a:extLst>
                <a:ext uri="{FF2B5EF4-FFF2-40B4-BE49-F238E27FC236}">
                  <a16:creationId xmlns:a16="http://schemas.microsoft.com/office/drawing/2014/main" id="{7798477A-5DB0-45C4-ABDF-C70D563F15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7713" y="3504168"/>
              <a:ext cx="33663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800" dirty="0">
                  <a:solidFill>
                    <a:srgbClr val="000000"/>
                  </a:solidFill>
                  <a:latin typeface="Symbol" panose="05050102010706020507" pitchFamily="18" charset="2"/>
                </a:rPr>
                <a:t>a</a:t>
              </a:r>
              <a:r>
                <a:rPr lang="en-US" altLang="en-US" sz="800" dirty="0">
                  <a:solidFill>
                    <a:srgbClr val="000000"/>
                  </a:solidFill>
                </a:rPr>
                <a:t>-</a:t>
              </a:r>
              <a:r>
                <a:rPr lang="en-US" altLang="en-US" sz="800" dirty="0" err="1">
                  <a:solidFill>
                    <a:srgbClr val="000000"/>
                  </a:solidFill>
                </a:rPr>
                <a:t>sMIC</a:t>
              </a:r>
              <a:endParaRPr kumimoji="0" lang="en-US" altLang="en-US" sz="1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" name="Rectangle 8">
              <a:extLst>
                <a:ext uri="{FF2B5EF4-FFF2-40B4-BE49-F238E27FC236}">
                  <a16:creationId xmlns:a16="http://schemas.microsoft.com/office/drawing/2014/main" id="{20E287EA-6DA2-4A12-A1E2-1E47EEBE4C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3013" y="3504168"/>
              <a:ext cx="6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1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" name="Rectangle 10">
              <a:extLst>
                <a:ext uri="{FF2B5EF4-FFF2-40B4-BE49-F238E27FC236}">
                  <a16:creationId xmlns:a16="http://schemas.microsoft.com/office/drawing/2014/main" id="{7389A548-F128-48A3-A4EA-6BB6C47F29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66937" y="3394631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n-US" altLang="en-US" sz="1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" name="Rectangle 11">
              <a:extLst>
                <a:ext uri="{FF2B5EF4-FFF2-40B4-BE49-F238E27FC236}">
                  <a16:creationId xmlns:a16="http://schemas.microsoft.com/office/drawing/2014/main" id="{A2E59F35-6C10-4613-A2D8-61596730E3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66937" y="2953306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en-US" altLang="en-US" sz="18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1" name="Rectangle 12">
              <a:extLst>
                <a:ext uri="{FF2B5EF4-FFF2-40B4-BE49-F238E27FC236}">
                  <a16:creationId xmlns:a16="http://schemas.microsoft.com/office/drawing/2014/main" id="{610C8F93-FB04-4F91-B3E4-E583C35193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2962" y="2511981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</a:t>
              </a:r>
              <a:endParaRPr kumimoji="0" lang="en-US" altLang="en-US" sz="18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" name="Rectangle 13">
              <a:extLst>
                <a:ext uri="{FF2B5EF4-FFF2-40B4-BE49-F238E27FC236}">
                  <a16:creationId xmlns:a16="http://schemas.microsoft.com/office/drawing/2014/main" id="{86AEA6E2-4D65-40BA-81A2-2C65B5AF01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2962" y="2070656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5</a:t>
              </a:r>
              <a:endParaRPr kumimoji="0" lang="en-US" altLang="en-US" sz="18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3" name="Freeform 14">
              <a:extLst>
                <a:ext uri="{FF2B5EF4-FFF2-40B4-BE49-F238E27FC236}">
                  <a16:creationId xmlns:a16="http://schemas.microsoft.com/office/drawing/2014/main" id="{6354CB64-0867-47E4-AA18-4D00FDDDCA4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236786" y="2124632"/>
              <a:ext cx="46358" cy="1336171"/>
            </a:xfrm>
            <a:custGeom>
              <a:avLst/>
              <a:gdLst>
                <a:gd name="T0" fmla="*/ 24 w 24"/>
                <a:gd name="T1" fmla="*/ 842 h 842"/>
                <a:gd name="T2" fmla="*/ 24 w 24"/>
                <a:gd name="T3" fmla="*/ 0 h 842"/>
                <a:gd name="T4" fmla="*/ 24 w 24"/>
                <a:gd name="T5" fmla="*/ 838 h 842"/>
                <a:gd name="T6" fmla="*/ 0 w 24"/>
                <a:gd name="T7" fmla="*/ 838 h 842"/>
                <a:gd name="T8" fmla="*/ 24 w 24"/>
                <a:gd name="T9" fmla="*/ 560 h 842"/>
                <a:gd name="T10" fmla="*/ 0 w 24"/>
                <a:gd name="T11" fmla="*/ 560 h 842"/>
                <a:gd name="T12" fmla="*/ 24 w 24"/>
                <a:gd name="T13" fmla="*/ 283 h 842"/>
                <a:gd name="T14" fmla="*/ 0 w 24"/>
                <a:gd name="T15" fmla="*/ 283 h 842"/>
                <a:gd name="T16" fmla="*/ 24 w 24"/>
                <a:gd name="T17" fmla="*/ 5 h 842"/>
                <a:gd name="T18" fmla="*/ 0 w 24"/>
                <a:gd name="T19" fmla="*/ 5 h 8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24" h="842">
                  <a:moveTo>
                    <a:pt x="24" y="842"/>
                  </a:moveTo>
                  <a:lnTo>
                    <a:pt x="24" y="0"/>
                  </a:lnTo>
                  <a:moveTo>
                    <a:pt x="24" y="838"/>
                  </a:moveTo>
                  <a:lnTo>
                    <a:pt x="0" y="838"/>
                  </a:lnTo>
                  <a:moveTo>
                    <a:pt x="24" y="560"/>
                  </a:moveTo>
                  <a:lnTo>
                    <a:pt x="0" y="560"/>
                  </a:lnTo>
                  <a:moveTo>
                    <a:pt x="24" y="283"/>
                  </a:moveTo>
                  <a:lnTo>
                    <a:pt x="0" y="283"/>
                  </a:lnTo>
                  <a:moveTo>
                    <a:pt x="24" y="5"/>
                  </a:moveTo>
                  <a:lnTo>
                    <a:pt x="0" y="5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Oval 15">
              <a:extLst>
                <a:ext uri="{FF2B5EF4-FFF2-40B4-BE49-F238E27FC236}">
                  <a16:creationId xmlns:a16="http://schemas.microsoft.com/office/drawing/2014/main" id="{E9591916-1196-4031-B805-E91DCF5906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5549" y="2943781"/>
              <a:ext cx="53975" cy="5238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" name="Oval 16">
              <a:extLst>
                <a:ext uri="{FF2B5EF4-FFF2-40B4-BE49-F238E27FC236}">
                  <a16:creationId xmlns:a16="http://schemas.microsoft.com/office/drawing/2014/main" id="{68D00E4C-6ABD-4427-ABBE-A7C9D2C609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5549" y="2943781"/>
              <a:ext cx="53975" cy="52388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" name="Oval 17">
              <a:extLst>
                <a:ext uri="{FF2B5EF4-FFF2-40B4-BE49-F238E27FC236}">
                  <a16:creationId xmlns:a16="http://schemas.microsoft.com/office/drawing/2014/main" id="{42FB1247-82C2-4812-B028-E7EACB073D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4924" y="2740581"/>
              <a:ext cx="53975" cy="5238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" name="Oval 18">
              <a:extLst>
                <a:ext uri="{FF2B5EF4-FFF2-40B4-BE49-F238E27FC236}">
                  <a16:creationId xmlns:a16="http://schemas.microsoft.com/office/drawing/2014/main" id="{B04949DA-2E43-419A-AFE6-BE8D9093E5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4924" y="2740581"/>
              <a:ext cx="53975" cy="52388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" name="Oval 19">
              <a:extLst>
                <a:ext uri="{FF2B5EF4-FFF2-40B4-BE49-F238E27FC236}">
                  <a16:creationId xmlns:a16="http://schemas.microsoft.com/office/drawing/2014/main" id="{53239198-FC7E-404F-AC50-0EE8A9441D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5549" y="2458006"/>
              <a:ext cx="53975" cy="5238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" name="Oval 20">
              <a:extLst>
                <a:ext uri="{FF2B5EF4-FFF2-40B4-BE49-F238E27FC236}">
                  <a16:creationId xmlns:a16="http://schemas.microsoft.com/office/drawing/2014/main" id="{3F506417-AC05-4A82-88E6-C987977D85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5549" y="2458006"/>
              <a:ext cx="53975" cy="52388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" name="Oval 21">
              <a:extLst>
                <a:ext uri="{FF2B5EF4-FFF2-40B4-BE49-F238E27FC236}">
                  <a16:creationId xmlns:a16="http://schemas.microsoft.com/office/drawing/2014/main" id="{34816CB3-04B6-4CF8-8DCF-3DDC272BB5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7449" y="3234293"/>
              <a:ext cx="52388" cy="539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" name="Oval 22">
              <a:extLst>
                <a:ext uri="{FF2B5EF4-FFF2-40B4-BE49-F238E27FC236}">
                  <a16:creationId xmlns:a16="http://schemas.microsoft.com/office/drawing/2014/main" id="{0AC6E619-32EE-46D0-8379-EC4384ED65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7449" y="3234293"/>
              <a:ext cx="52388" cy="5397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" name="Oval 23">
              <a:extLst>
                <a:ext uri="{FF2B5EF4-FFF2-40B4-BE49-F238E27FC236}">
                  <a16:creationId xmlns:a16="http://schemas.microsoft.com/office/drawing/2014/main" id="{EAFD4B8F-1609-4F65-844D-F045AC61DE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5549" y="2281793"/>
              <a:ext cx="53975" cy="5238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" name="Oval 24">
              <a:extLst>
                <a:ext uri="{FF2B5EF4-FFF2-40B4-BE49-F238E27FC236}">
                  <a16:creationId xmlns:a16="http://schemas.microsoft.com/office/drawing/2014/main" id="{57556383-14C6-464B-B3A7-2DA714EEFD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5549" y="2281793"/>
              <a:ext cx="53975" cy="52388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" name="Oval 25">
              <a:extLst>
                <a:ext uri="{FF2B5EF4-FFF2-40B4-BE49-F238E27FC236}">
                  <a16:creationId xmlns:a16="http://schemas.microsoft.com/office/drawing/2014/main" id="{389BC007-6F34-4766-99B7-9BF1EA568E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7449" y="3067606"/>
              <a:ext cx="52388" cy="539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" name="Oval 26">
              <a:extLst>
                <a:ext uri="{FF2B5EF4-FFF2-40B4-BE49-F238E27FC236}">
                  <a16:creationId xmlns:a16="http://schemas.microsoft.com/office/drawing/2014/main" id="{72C64EA6-EE04-4CF4-A814-D1A159D0AD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7449" y="3067606"/>
              <a:ext cx="52388" cy="5397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" name="Oval 27">
              <a:extLst>
                <a:ext uri="{FF2B5EF4-FFF2-40B4-BE49-F238E27FC236}">
                  <a16:creationId xmlns:a16="http://schemas.microsoft.com/office/drawing/2014/main" id="{3B2C4DFF-BB48-4892-ADBA-CCE7220C4E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5237" y="3040618"/>
              <a:ext cx="53975" cy="5238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" name="Oval 28">
              <a:extLst>
                <a:ext uri="{FF2B5EF4-FFF2-40B4-BE49-F238E27FC236}">
                  <a16:creationId xmlns:a16="http://schemas.microsoft.com/office/drawing/2014/main" id="{9021A8AA-D3D3-498D-90FA-944279950C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5237" y="3040618"/>
              <a:ext cx="53975" cy="52388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" name="Oval 29">
              <a:extLst>
                <a:ext uri="{FF2B5EF4-FFF2-40B4-BE49-F238E27FC236}">
                  <a16:creationId xmlns:a16="http://schemas.microsoft.com/office/drawing/2014/main" id="{3319DE97-BFDA-44FF-9325-E7410EFFD8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5549" y="2794556"/>
              <a:ext cx="53975" cy="5238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" name="Oval 30">
              <a:extLst>
                <a:ext uri="{FF2B5EF4-FFF2-40B4-BE49-F238E27FC236}">
                  <a16:creationId xmlns:a16="http://schemas.microsoft.com/office/drawing/2014/main" id="{255A1949-9A7A-41F0-BB82-56CFFC07FA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5549" y="2794556"/>
              <a:ext cx="53975" cy="52388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" name="Oval 31">
              <a:extLst>
                <a:ext uri="{FF2B5EF4-FFF2-40B4-BE49-F238E27FC236}">
                  <a16:creationId xmlns:a16="http://schemas.microsoft.com/office/drawing/2014/main" id="{8B1BE0D4-8CF6-4C48-8032-7C5467C08B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6174" y="2723118"/>
              <a:ext cx="53975" cy="5238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" name="Oval 32">
              <a:extLst>
                <a:ext uri="{FF2B5EF4-FFF2-40B4-BE49-F238E27FC236}">
                  <a16:creationId xmlns:a16="http://schemas.microsoft.com/office/drawing/2014/main" id="{4D28A8E4-8D79-447C-AB08-35728AB8AC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6174" y="2723118"/>
              <a:ext cx="53975" cy="52388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" name="Oval 33">
              <a:extLst>
                <a:ext uri="{FF2B5EF4-FFF2-40B4-BE49-F238E27FC236}">
                  <a16:creationId xmlns:a16="http://schemas.microsoft.com/office/drawing/2014/main" id="{0B2B2161-55AE-4376-824F-8DE7D39E36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6174" y="2891393"/>
              <a:ext cx="53975" cy="5238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3" name="Oval 34">
              <a:extLst>
                <a:ext uri="{FF2B5EF4-FFF2-40B4-BE49-F238E27FC236}">
                  <a16:creationId xmlns:a16="http://schemas.microsoft.com/office/drawing/2014/main" id="{D6D1D9E2-9DCC-4289-A5EB-8F29C1DE78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6174" y="2891393"/>
              <a:ext cx="53975" cy="52388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4" name="Oval 35">
              <a:extLst>
                <a:ext uri="{FF2B5EF4-FFF2-40B4-BE49-F238E27FC236}">
                  <a16:creationId xmlns:a16="http://schemas.microsoft.com/office/drawing/2014/main" id="{3822683F-8902-40A7-A3C1-DDE55829AA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4924" y="2864406"/>
              <a:ext cx="53975" cy="5238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5" name="Oval 36">
              <a:extLst>
                <a:ext uri="{FF2B5EF4-FFF2-40B4-BE49-F238E27FC236}">
                  <a16:creationId xmlns:a16="http://schemas.microsoft.com/office/drawing/2014/main" id="{7E2C9645-D17A-4DE1-B4E5-2CDF5A8C72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4924" y="2864406"/>
              <a:ext cx="53975" cy="52388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6" name="Oval 37">
              <a:extLst>
                <a:ext uri="{FF2B5EF4-FFF2-40B4-BE49-F238E27FC236}">
                  <a16:creationId xmlns:a16="http://schemas.microsoft.com/office/drawing/2014/main" id="{686387BC-6B0C-422A-863E-7CA1384D76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9999" y="3167142"/>
              <a:ext cx="53975" cy="539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7" name="Oval 38">
              <a:extLst>
                <a:ext uri="{FF2B5EF4-FFF2-40B4-BE49-F238E27FC236}">
                  <a16:creationId xmlns:a16="http://schemas.microsoft.com/office/drawing/2014/main" id="{E44DBA6A-FBB2-4C23-A11C-5ADD9344B4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9999" y="3167142"/>
              <a:ext cx="53975" cy="5397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8" name="Oval 39">
              <a:extLst>
                <a:ext uri="{FF2B5EF4-FFF2-40B4-BE49-F238E27FC236}">
                  <a16:creationId xmlns:a16="http://schemas.microsoft.com/office/drawing/2014/main" id="{97F61FF5-3647-4484-8D82-482B345644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5237" y="3296206"/>
              <a:ext cx="53975" cy="539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9" name="Oval 40">
              <a:extLst>
                <a:ext uri="{FF2B5EF4-FFF2-40B4-BE49-F238E27FC236}">
                  <a16:creationId xmlns:a16="http://schemas.microsoft.com/office/drawing/2014/main" id="{09FB662F-8D47-46C1-B43F-5CD50260BB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5237" y="3296206"/>
              <a:ext cx="53975" cy="5397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0" name="Line 41">
              <a:extLst>
                <a:ext uri="{FF2B5EF4-FFF2-40B4-BE49-F238E27FC236}">
                  <a16:creationId xmlns:a16="http://schemas.microsoft.com/office/drawing/2014/main" id="{245BB8DF-450C-4DCD-88F6-6E716A2253E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57437" y="2931081"/>
              <a:ext cx="3302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" name="Freeform 42">
              <a:extLst>
                <a:ext uri="{FF2B5EF4-FFF2-40B4-BE49-F238E27FC236}">
                  <a16:creationId xmlns:a16="http://schemas.microsoft.com/office/drawing/2014/main" id="{AA04104F-5287-40E6-B9C4-1E999D010BF7}"/>
                </a:ext>
              </a:extLst>
            </p:cNvPr>
            <p:cNvSpPr>
              <a:spLocks/>
            </p:cNvSpPr>
            <p:nvPr/>
          </p:nvSpPr>
          <p:spPr bwMode="auto">
            <a:xfrm>
              <a:off x="2959100" y="3331131"/>
              <a:ext cx="53975" cy="53975"/>
            </a:xfrm>
            <a:custGeom>
              <a:avLst/>
              <a:gdLst>
                <a:gd name="T0" fmla="*/ 0 w 34"/>
                <a:gd name="T1" fmla="*/ 0 h 34"/>
                <a:gd name="T2" fmla="*/ 34 w 34"/>
                <a:gd name="T3" fmla="*/ 0 h 34"/>
                <a:gd name="T4" fmla="*/ 17 w 34"/>
                <a:gd name="T5" fmla="*/ 34 h 34"/>
                <a:gd name="T6" fmla="*/ 0 w 34"/>
                <a:gd name="T7" fmla="*/ 0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34">
                  <a:moveTo>
                    <a:pt x="0" y="0"/>
                  </a:moveTo>
                  <a:lnTo>
                    <a:pt x="34" y="0"/>
                  </a:lnTo>
                  <a:lnTo>
                    <a:pt x="17" y="3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" name="Freeform 43">
              <a:extLst>
                <a:ext uri="{FF2B5EF4-FFF2-40B4-BE49-F238E27FC236}">
                  <a16:creationId xmlns:a16="http://schemas.microsoft.com/office/drawing/2014/main" id="{816C73B7-400E-4D68-9107-5276EB9A5138}"/>
                </a:ext>
              </a:extLst>
            </p:cNvPr>
            <p:cNvSpPr>
              <a:spLocks/>
            </p:cNvSpPr>
            <p:nvPr/>
          </p:nvSpPr>
          <p:spPr bwMode="auto">
            <a:xfrm>
              <a:off x="2959100" y="3331131"/>
              <a:ext cx="53975" cy="53975"/>
            </a:xfrm>
            <a:custGeom>
              <a:avLst/>
              <a:gdLst>
                <a:gd name="T0" fmla="*/ 0 w 34"/>
                <a:gd name="T1" fmla="*/ 0 h 34"/>
                <a:gd name="T2" fmla="*/ 34 w 34"/>
                <a:gd name="T3" fmla="*/ 0 h 34"/>
                <a:gd name="T4" fmla="*/ 17 w 34"/>
                <a:gd name="T5" fmla="*/ 34 h 34"/>
                <a:gd name="T6" fmla="*/ 0 w 34"/>
                <a:gd name="T7" fmla="*/ 0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34">
                  <a:moveTo>
                    <a:pt x="0" y="0"/>
                  </a:moveTo>
                  <a:lnTo>
                    <a:pt x="34" y="0"/>
                  </a:lnTo>
                  <a:lnTo>
                    <a:pt x="17" y="3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" name="Freeform 44">
              <a:extLst>
                <a:ext uri="{FF2B5EF4-FFF2-40B4-BE49-F238E27FC236}">
                  <a16:creationId xmlns:a16="http://schemas.microsoft.com/office/drawing/2014/main" id="{3D360930-8F43-4336-8B58-857426749F6D}"/>
                </a:ext>
              </a:extLst>
            </p:cNvPr>
            <p:cNvSpPr>
              <a:spLocks/>
            </p:cNvSpPr>
            <p:nvPr/>
          </p:nvSpPr>
          <p:spPr bwMode="auto">
            <a:xfrm>
              <a:off x="2959100" y="3059668"/>
              <a:ext cx="53975" cy="52388"/>
            </a:xfrm>
            <a:custGeom>
              <a:avLst/>
              <a:gdLst>
                <a:gd name="T0" fmla="*/ 0 w 34"/>
                <a:gd name="T1" fmla="*/ 0 h 33"/>
                <a:gd name="T2" fmla="*/ 34 w 34"/>
                <a:gd name="T3" fmla="*/ 0 h 33"/>
                <a:gd name="T4" fmla="*/ 17 w 34"/>
                <a:gd name="T5" fmla="*/ 33 h 33"/>
                <a:gd name="T6" fmla="*/ 0 w 34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33">
                  <a:moveTo>
                    <a:pt x="0" y="0"/>
                  </a:moveTo>
                  <a:lnTo>
                    <a:pt x="34" y="0"/>
                  </a:lnTo>
                  <a:lnTo>
                    <a:pt x="17" y="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" name="Freeform 45">
              <a:extLst>
                <a:ext uri="{FF2B5EF4-FFF2-40B4-BE49-F238E27FC236}">
                  <a16:creationId xmlns:a16="http://schemas.microsoft.com/office/drawing/2014/main" id="{A306A5E5-7870-4532-B27B-D307C9254A7A}"/>
                </a:ext>
              </a:extLst>
            </p:cNvPr>
            <p:cNvSpPr>
              <a:spLocks/>
            </p:cNvSpPr>
            <p:nvPr/>
          </p:nvSpPr>
          <p:spPr bwMode="auto">
            <a:xfrm>
              <a:off x="2959100" y="3059668"/>
              <a:ext cx="53975" cy="52388"/>
            </a:xfrm>
            <a:custGeom>
              <a:avLst/>
              <a:gdLst>
                <a:gd name="T0" fmla="*/ 0 w 34"/>
                <a:gd name="T1" fmla="*/ 0 h 33"/>
                <a:gd name="T2" fmla="*/ 34 w 34"/>
                <a:gd name="T3" fmla="*/ 0 h 33"/>
                <a:gd name="T4" fmla="*/ 17 w 34"/>
                <a:gd name="T5" fmla="*/ 33 h 33"/>
                <a:gd name="T6" fmla="*/ 0 w 34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33">
                  <a:moveTo>
                    <a:pt x="0" y="0"/>
                  </a:moveTo>
                  <a:lnTo>
                    <a:pt x="34" y="0"/>
                  </a:lnTo>
                  <a:lnTo>
                    <a:pt x="17" y="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" name="Freeform 46">
              <a:extLst>
                <a:ext uri="{FF2B5EF4-FFF2-40B4-BE49-F238E27FC236}">
                  <a16:creationId xmlns:a16="http://schemas.microsoft.com/office/drawing/2014/main" id="{2019261E-73E0-4FD7-8218-D725288DDDDC}"/>
                </a:ext>
              </a:extLst>
            </p:cNvPr>
            <p:cNvSpPr>
              <a:spLocks/>
            </p:cNvSpPr>
            <p:nvPr/>
          </p:nvSpPr>
          <p:spPr bwMode="auto">
            <a:xfrm>
              <a:off x="2998787" y="3245406"/>
              <a:ext cx="52388" cy="52388"/>
            </a:xfrm>
            <a:custGeom>
              <a:avLst/>
              <a:gdLst>
                <a:gd name="T0" fmla="*/ 0 w 33"/>
                <a:gd name="T1" fmla="*/ 0 h 33"/>
                <a:gd name="T2" fmla="*/ 33 w 33"/>
                <a:gd name="T3" fmla="*/ 0 h 33"/>
                <a:gd name="T4" fmla="*/ 17 w 33"/>
                <a:gd name="T5" fmla="*/ 33 h 33"/>
                <a:gd name="T6" fmla="*/ 0 w 33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3" h="33">
                  <a:moveTo>
                    <a:pt x="0" y="0"/>
                  </a:moveTo>
                  <a:lnTo>
                    <a:pt x="33" y="0"/>
                  </a:lnTo>
                  <a:lnTo>
                    <a:pt x="17" y="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" name="Freeform 47">
              <a:extLst>
                <a:ext uri="{FF2B5EF4-FFF2-40B4-BE49-F238E27FC236}">
                  <a16:creationId xmlns:a16="http://schemas.microsoft.com/office/drawing/2014/main" id="{136FD1B2-0C72-4395-A50D-BDDD0B0952E7}"/>
                </a:ext>
              </a:extLst>
            </p:cNvPr>
            <p:cNvSpPr>
              <a:spLocks/>
            </p:cNvSpPr>
            <p:nvPr/>
          </p:nvSpPr>
          <p:spPr bwMode="auto">
            <a:xfrm>
              <a:off x="2998787" y="3245406"/>
              <a:ext cx="52388" cy="52388"/>
            </a:xfrm>
            <a:custGeom>
              <a:avLst/>
              <a:gdLst>
                <a:gd name="T0" fmla="*/ 0 w 33"/>
                <a:gd name="T1" fmla="*/ 0 h 33"/>
                <a:gd name="T2" fmla="*/ 33 w 33"/>
                <a:gd name="T3" fmla="*/ 0 h 33"/>
                <a:gd name="T4" fmla="*/ 17 w 33"/>
                <a:gd name="T5" fmla="*/ 33 h 33"/>
                <a:gd name="T6" fmla="*/ 0 w 33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3" h="33">
                  <a:moveTo>
                    <a:pt x="0" y="0"/>
                  </a:moveTo>
                  <a:lnTo>
                    <a:pt x="33" y="0"/>
                  </a:lnTo>
                  <a:lnTo>
                    <a:pt x="17" y="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" name="Freeform 48">
              <a:extLst>
                <a:ext uri="{FF2B5EF4-FFF2-40B4-BE49-F238E27FC236}">
                  <a16:creationId xmlns:a16="http://schemas.microsoft.com/office/drawing/2014/main" id="{61C910C0-C1E4-453C-95D8-F66D04FE1CA4}"/>
                </a:ext>
              </a:extLst>
            </p:cNvPr>
            <p:cNvSpPr>
              <a:spLocks/>
            </p:cNvSpPr>
            <p:nvPr/>
          </p:nvSpPr>
          <p:spPr bwMode="auto">
            <a:xfrm>
              <a:off x="2919412" y="3172381"/>
              <a:ext cx="52388" cy="53975"/>
            </a:xfrm>
            <a:custGeom>
              <a:avLst/>
              <a:gdLst>
                <a:gd name="T0" fmla="*/ 0 w 33"/>
                <a:gd name="T1" fmla="*/ 0 h 34"/>
                <a:gd name="T2" fmla="*/ 33 w 33"/>
                <a:gd name="T3" fmla="*/ 0 h 34"/>
                <a:gd name="T4" fmla="*/ 17 w 33"/>
                <a:gd name="T5" fmla="*/ 34 h 34"/>
                <a:gd name="T6" fmla="*/ 0 w 33"/>
                <a:gd name="T7" fmla="*/ 0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3" h="34">
                  <a:moveTo>
                    <a:pt x="0" y="0"/>
                  </a:moveTo>
                  <a:lnTo>
                    <a:pt x="33" y="0"/>
                  </a:lnTo>
                  <a:lnTo>
                    <a:pt x="17" y="3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8" name="Freeform 49">
              <a:extLst>
                <a:ext uri="{FF2B5EF4-FFF2-40B4-BE49-F238E27FC236}">
                  <a16:creationId xmlns:a16="http://schemas.microsoft.com/office/drawing/2014/main" id="{865A02B0-27F2-48A0-9672-FDD97C1A8AB9}"/>
                </a:ext>
              </a:extLst>
            </p:cNvPr>
            <p:cNvSpPr>
              <a:spLocks/>
            </p:cNvSpPr>
            <p:nvPr/>
          </p:nvSpPr>
          <p:spPr bwMode="auto">
            <a:xfrm>
              <a:off x="2919412" y="3172381"/>
              <a:ext cx="52388" cy="53975"/>
            </a:xfrm>
            <a:custGeom>
              <a:avLst/>
              <a:gdLst>
                <a:gd name="T0" fmla="*/ 0 w 33"/>
                <a:gd name="T1" fmla="*/ 0 h 34"/>
                <a:gd name="T2" fmla="*/ 33 w 33"/>
                <a:gd name="T3" fmla="*/ 0 h 34"/>
                <a:gd name="T4" fmla="*/ 17 w 33"/>
                <a:gd name="T5" fmla="*/ 34 h 34"/>
                <a:gd name="T6" fmla="*/ 0 w 33"/>
                <a:gd name="T7" fmla="*/ 0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3" h="34">
                  <a:moveTo>
                    <a:pt x="0" y="0"/>
                  </a:moveTo>
                  <a:lnTo>
                    <a:pt x="33" y="0"/>
                  </a:lnTo>
                  <a:lnTo>
                    <a:pt x="17" y="3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" name="Freeform 50">
              <a:extLst>
                <a:ext uri="{FF2B5EF4-FFF2-40B4-BE49-F238E27FC236}">
                  <a16:creationId xmlns:a16="http://schemas.microsoft.com/office/drawing/2014/main" id="{A0B3A314-89D7-4992-903B-9BC5FF920CA8}"/>
                </a:ext>
              </a:extLst>
            </p:cNvPr>
            <p:cNvSpPr>
              <a:spLocks/>
            </p:cNvSpPr>
            <p:nvPr/>
          </p:nvSpPr>
          <p:spPr bwMode="auto">
            <a:xfrm>
              <a:off x="2998787" y="2775506"/>
              <a:ext cx="52388" cy="53975"/>
            </a:xfrm>
            <a:custGeom>
              <a:avLst/>
              <a:gdLst>
                <a:gd name="T0" fmla="*/ 0 w 33"/>
                <a:gd name="T1" fmla="*/ 0 h 34"/>
                <a:gd name="T2" fmla="*/ 33 w 33"/>
                <a:gd name="T3" fmla="*/ 0 h 34"/>
                <a:gd name="T4" fmla="*/ 17 w 33"/>
                <a:gd name="T5" fmla="*/ 34 h 34"/>
                <a:gd name="T6" fmla="*/ 0 w 33"/>
                <a:gd name="T7" fmla="*/ 0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3" h="34">
                  <a:moveTo>
                    <a:pt x="0" y="0"/>
                  </a:moveTo>
                  <a:lnTo>
                    <a:pt x="33" y="0"/>
                  </a:lnTo>
                  <a:lnTo>
                    <a:pt x="17" y="3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0" name="Freeform 51">
              <a:extLst>
                <a:ext uri="{FF2B5EF4-FFF2-40B4-BE49-F238E27FC236}">
                  <a16:creationId xmlns:a16="http://schemas.microsoft.com/office/drawing/2014/main" id="{0525059A-EBA4-49FD-AFD4-414CA3F105AF}"/>
                </a:ext>
              </a:extLst>
            </p:cNvPr>
            <p:cNvSpPr>
              <a:spLocks/>
            </p:cNvSpPr>
            <p:nvPr/>
          </p:nvSpPr>
          <p:spPr bwMode="auto">
            <a:xfrm>
              <a:off x="2998787" y="2775506"/>
              <a:ext cx="52388" cy="53975"/>
            </a:xfrm>
            <a:custGeom>
              <a:avLst/>
              <a:gdLst>
                <a:gd name="T0" fmla="*/ 0 w 33"/>
                <a:gd name="T1" fmla="*/ 0 h 34"/>
                <a:gd name="T2" fmla="*/ 33 w 33"/>
                <a:gd name="T3" fmla="*/ 0 h 34"/>
                <a:gd name="T4" fmla="*/ 17 w 33"/>
                <a:gd name="T5" fmla="*/ 34 h 34"/>
                <a:gd name="T6" fmla="*/ 0 w 33"/>
                <a:gd name="T7" fmla="*/ 0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3" h="34">
                  <a:moveTo>
                    <a:pt x="0" y="0"/>
                  </a:moveTo>
                  <a:lnTo>
                    <a:pt x="33" y="0"/>
                  </a:lnTo>
                  <a:lnTo>
                    <a:pt x="17" y="3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" name="Freeform 52">
              <a:extLst>
                <a:ext uri="{FF2B5EF4-FFF2-40B4-BE49-F238E27FC236}">
                  <a16:creationId xmlns:a16="http://schemas.microsoft.com/office/drawing/2014/main" id="{8B308BA8-8950-4DCE-89B5-5D3A6CFA726D}"/>
                </a:ext>
              </a:extLst>
            </p:cNvPr>
            <p:cNvSpPr>
              <a:spLocks/>
            </p:cNvSpPr>
            <p:nvPr/>
          </p:nvSpPr>
          <p:spPr bwMode="auto">
            <a:xfrm>
              <a:off x="2959100" y="2678668"/>
              <a:ext cx="53975" cy="52388"/>
            </a:xfrm>
            <a:custGeom>
              <a:avLst/>
              <a:gdLst>
                <a:gd name="T0" fmla="*/ 0 w 34"/>
                <a:gd name="T1" fmla="*/ 0 h 33"/>
                <a:gd name="T2" fmla="*/ 34 w 34"/>
                <a:gd name="T3" fmla="*/ 0 h 33"/>
                <a:gd name="T4" fmla="*/ 17 w 34"/>
                <a:gd name="T5" fmla="*/ 33 h 33"/>
                <a:gd name="T6" fmla="*/ 0 w 34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33">
                  <a:moveTo>
                    <a:pt x="0" y="0"/>
                  </a:moveTo>
                  <a:lnTo>
                    <a:pt x="34" y="0"/>
                  </a:lnTo>
                  <a:lnTo>
                    <a:pt x="17" y="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" name="Freeform 53">
              <a:extLst>
                <a:ext uri="{FF2B5EF4-FFF2-40B4-BE49-F238E27FC236}">
                  <a16:creationId xmlns:a16="http://schemas.microsoft.com/office/drawing/2014/main" id="{90EE04C0-A5BB-475D-A654-5817E3E9B783}"/>
                </a:ext>
              </a:extLst>
            </p:cNvPr>
            <p:cNvSpPr>
              <a:spLocks/>
            </p:cNvSpPr>
            <p:nvPr/>
          </p:nvSpPr>
          <p:spPr bwMode="auto">
            <a:xfrm>
              <a:off x="2959100" y="2678668"/>
              <a:ext cx="53975" cy="52388"/>
            </a:xfrm>
            <a:custGeom>
              <a:avLst/>
              <a:gdLst>
                <a:gd name="T0" fmla="*/ 0 w 34"/>
                <a:gd name="T1" fmla="*/ 0 h 33"/>
                <a:gd name="T2" fmla="*/ 34 w 34"/>
                <a:gd name="T3" fmla="*/ 0 h 33"/>
                <a:gd name="T4" fmla="*/ 17 w 34"/>
                <a:gd name="T5" fmla="*/ 33 h 33"/>
                <a:gd name="T6" fmla="*/ 0 w 34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33">
                  <a:moveTo>
                    <a:pt x="0" y="0"/>
                  </a:moveTo>
                  <a:lnTo>
                    <a:pt x="34" y="0"/>
                  </a:lnTo>
                  <a:lnTo>
                    <a:pt x="17" y="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" name="Freeform 54">
              <a:extLst>
                <a:ext uri="{FF2B5EF4-FFF2-40B4-BE49-F238E27FC236}">
                  <a16:creationId xmlns:a16="http://schemas.microsoft.com/office/drawing/2014/main" id="{7F57F0AD-3325-4F00-8553-7E3FAC503D2A}"/>
                </a:ext>
              </a:extLst>
            </p:cNvPr>
            <p:cNvSpPr>
              <a:spLocks/>
            </p:cNvSpPr>
            <p:nvPr/>
          </p:nvSpPr>
          <p:spPr bwMode="auto">
            <a:xfrm>
              <a:off x="2959100" y="2537381"/>
              <a:ext cx="53975" cy="53975"/>
            </a:xfrm>
            <a:custGeom>
              <a:avLst/>
              <a:gdLst>
                <a:gd name="T0" fmla="*/ 0 w 34"/>
                <a:gd name="T1" fmla="*/ 0 h 34"/>
                <a:gd name="T2" fmla="*/ 34 w 34"/>
                <a:gd name="T3" fmla="*/ 0 h 34"/>
                <a:gd name="T4" fmla="*/ 17 w 34"/>
                <a:gd name="T5" fmla="*/ 34 h 34"/>
                <a:gd name="T6" fmla="*/ 0 w 34"/>
                <a:gd name="T7" fmla="*/ 0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34">
                  <a:moveTo>
                    <a:pt x="0" y="0"/>
                  </a:moveTo>
                  <a:lnTo>
                    <a:pt x="34" y="0"/>
                  </a:lnTo>
                  <a:lnTo>
                    <a:pt x="17" y="3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" name="Freeform 55">
              <a:extLst>
                <a:ext uri="{FF2B5EF4-FFF2-40B4-BE49-F238E27FC236}">
                  <a16:creationId xmlns:a16="http://schemas.microsoft.com/office/drawing/2014/main" id="{264DA9C6-0E39-43C8-A881-0833BFFA1864}"/>
                </a:ext>
              </a:extLst>
            </p:cNvPr>
            <p:cNvSpPr>
              <a:spLocks/>
            </p:cNvSpPr>
            <p:nvPr/>
          </p:nvSpPr>
          <p:spPr bwMode="auto">
            <a:xfrm>
              <a:off x="2959100" y="2537381"/>
              <a:ext cx="53975" cy="53975"/>
            </a:xfrm>
            <a:custGeom>
              <a:avLst/>
              <a:gdLst>
                <a:gd name="T0" fmla="*/ 0 w 34"/>
                <a:gd name="T1" fmla="*/ 0 h 34"/>
                <a:gd name="T2" fmla="*/ 34 w 34"/>
                <a:gd name="T3" fmla="*/ 0 h 34"/>
                <a:gd name="T4" fmla="*/ 17 w 34"/>
                <a:gd name="T5" fmla="*/ 34 h 34"/>
                <a:gd name="T6" fmla="*/ 0 w 34"/>
                <a:gd name="T7" fmla="*/ 0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34">
                  <a:moveTo>
                    <a:pt x="0" y="0"/>
                  </a:moveTo>
                  <a:lnTo>
                    <a:pt x="34" y="0"/>
                  </a:lnTo>
                  <a:lnTo>
                    <a:pt x="17" y="3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" name="Freeform 56">
              <a:extLst>
                <a:ext uri="{FF2B5EF4-FFF2-40B4-BE49-F238E27FC236}">
                  <a16:creationId xmlns:a16="http://schemas.microsoft.com/office/drawing/2014/main" id="{710C7903-A3EA-4841-A38E-747585F2A6FE}"/>
                </a:ext>
              </a:extLst>
            </p:cNvPr>
            <p:cNvSpPr>
              <a:spLocks/>
            </p:cNvSpPr>
            <p:nvPr/>
          </p:nvSpPr>
          <p:spPr bwMode="auto">
            <a:xfrm>
              <a:off x="2959100" y="2272268"/>
              <a:ext cx="53975" cy="53975"/>
            </a:xfrm>
            <a:custGeom>
              <a:avLst/>
              <a:gdLst>
                <a:gd name="T0" fmla="*/ 0 w 34"/>
                <a:gd name="T1" fmla="*/ 0 h 34"/>
                <a:gd name="T2" fmla="*/ 34 w 34"/>
                <a:gd name="T3" fmla="*/ 0 h 34"/>
                <a:gd name="T4" fmla="*/ 17 w 34"/>
                <a:gd name="T5" fmla="*/ 34 h 34"/>
                <a:gd name="T6" fmla="*/ 0 w 34"/>
                <a:gd name="T7" fmla="*/ 0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34">
                  <a:moveTo>
                    <a:pt x="0" y="0"/>
                  </a:moveTo>
                  <a:lnTo>
                    <a:pt x="34" y="0"/>
                  </a:lnTo>
                  <a:lnTo>
                    <a:pt x="17" y="3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6" name="Freeform 57">
              <a:extLst>
                <a:ext uri="{FF2B5EF4-FFF2-40B4-BE49-F238E27FC236}">
                  <a16:creationId xmlns:a16="http://schemas.microsoft.com/office/drawing/2014/main" id="{585D1041-FD8B-40D1-BADC-81A98191E3BF}"/>
                </a:ext>
              </a:extLst>
            </p:cNvPr>
            <p:cNvSpPr>
              <a:spLocks/>
            </p:cNvSpPr>
            <p:nvPr/>
          </p:nvSpPr>
          <p:spPr bwMode="auto">
            <a:xfrm>
              <a:off x="2959100" y="2272268"/>
              <a:ext cx="53975" cy="53975"/>
            </a:xfrm>
            <a:custGeom>
              <a:avLst/>
              <a:gdLst>
                <a:gd name="T0" fmla="*/ 0 w 34"/>
                <a:gd name="T1" fmla="*/ 0 h 34"/>
                <a:gd name="T2" fmla="*/ 34 w 34"/>
                <a:gd name="T3" fmla="*/ 0 h 34"/>
                <a:gd name="T4" fmla="*/ 17 w 34"/>
                <a:gd name="T5" fmla="*/ 34 h 34"/>
                <a:gd name="T6" fmla="*/ 0 w 34"/>
                <a:gd name="T7" fmla="*/ 0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34">
                  <a:moveTo>
                    <a:pt x="0" y="0"/>
                  </a:moveTo>
                  <a:lnTo>
                    <a:pt x="34" y="0"/>
                  </a:lnTo>
                  <a:lnTo>
                    <a:pt x="17" y="3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7" name="Freeform 58">
              <a:extLst>
                <a:ext uri="{FF2B5EF4-FFF2-40B4-BE49-F238E27FC236}">
                  <a16:creationId xmlns:a16="http://schemas.microsoft.com/office/drawing/2014/main" id="{B59D7181-0CD8-4334-8CDA-6A80612797EC}"/>
                </a:ext>
              </a:extLst>
            </p:cNvPr>
            <p:cNvSpPr>
              <a:spLocks/>
            </p:cNvSpPr>
            <p:nvPr/>
          </p:nvSpPr>
          <p:spPr bwMode="auto">
            <a:xfrm>
              <a:off x="2998787" y="2935843"/>
              <a:ext cx="52388" cy="52388"/>
            </a:xfrm>
            <a:custGeom>
              <a:avLst/>
              <a:gdLst>
                <a:gd name="T0" fmla="*/ 0 w 33"/>
                <a:gd name="T1" fmla="*/ 0 h 33"/>
                <a:gd name="T2" fmla="*/ 33 w 33"/>
                <a:gd name="T3" fmla="*/ 0 h 33"/>
                <a:gd name="T4" fmla="*/ 17 w 33"/>
                <a:gd name="T5" fmla="*/ 33 h 33"/>
                <a:gd name="T6" fmla="*/ 0 w 33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3" h="33">
                  <a:moveTo>
                    <a:pt x="0" y="0"/>
                  </a:moveTo>
                  <a:lnTo>
                    <a:pt x="33" y="0"/>
                  </a:lnTo>
                  <a:lnTo>
                    <a:pt x="17" y="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8" name="Freeform 59">
              <a:extLst>
                <a:ext uri="{FF2B5EF4-FFF2-40B4-BE49-F238E27FC236}">
                  <a16:creationId xmlns:a16="http://schemas.microsoft.com/office/drawing/2014/main" id="{238E51CD-389E-4709-ACB1-D24772C539DD}"/>
                </a:ext>
              </a:extLst>
            </p:cNvPr>
            <p:cNvSpPr>
              <a:spLocks/>
            </p:cNvSpPr>
            <p:nvPr/>
          </p:nvSpPr>
          <p:spPr bwMode="auto">
            <a:xfrm>
              <a:off x="2998787" y="2935843"/>
              <a:ext cx="52388" cy="52388"/>
            </a:xfrm>
            <a:custGeom>
              <a:avLst/>
              <a:gdLst>
                <a:gd name="T0" fmla="*/ 0 w 33"/>
                <a:gd name="T1" fmla="*/ 0 h 33"/>
                <a:gd name="T2" fmla="*/ 33 w 33"/>
                <a:gd name="T3" fmla="*/ 0 h 33"/>
                <a:gd name="T4" fmla="*/ 17 w 33"/>
                <a:gd name="T5" fmla="*/ 33 h 33"/>
                <a:gd name="T6" fmla="*/ 0 w 33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3" h="33">
                  <a:moveTo>
                    <a:pt x="0" y="0"/>
                  </a:moveTo>
                  <a:lnTo>
                    <a:pt x="33" y="0"/>
                  </a:lnTo>
                  <a:lnTo>
                    <a:pt x="17" y="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9" name="Freeform 60">
              <a:extLst>
                <a:ext uri="{FF2B5EF4-FFF2-40B4-BE49-F238E27FC236}">
                  <a16:creationId xmlns:a16="http://schemas.microsoft.com/office/drawing/2014/main" id="{03EF656F-D626-406C-A730-C288BC2C26B2}"/>
                </a:ext>
              </a:extLst>
            </p:cNvPr>
            <p:cNvSpPr>
              <a:spLocks/>
            </p:cNvSpPr>
            <p:nvPr/>
          </p:nvSpPr>
          <p:spPr bwMode="auto">
            <a:xfrm>
              <a:off x="2879725" y="2854881"/>
              <a:ext cx="52388" cy="53975"/>
            </a:xfrm>
            <a:custGeom>
              <a:avLst/>
              <a:gdLst>
                <a:gd name="T0" fmla="*/ 0 w 33"/>
                <a:gd name="T1" fmla="*/ 0 h 34"/>
                <a:gd name="T2" fmla="*/ 33 w 33"/>
                <a:gd name="T3" fmla="*/ 0 h 34"/>
                <a:gd name="T4" fmla="*/ 17 w 33"/>
                <a:gd name="T5" fmla="*/ 34 h 34"/>
                <a:gd name="T6" fmla="*/ 0 w 33"/>
                <a:gd name="T7" fmla="*/ 0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3" h="34">
                  <a:moveTo>
                    <a:pt x="0" y="0"/>
                  </a:moveTo>
                  <a:lnTo>
                    <a:pt x="33" y="0"/>
                  </a:lnTo>
                  <a:lnTo>
                    <a:pt x="17" y="3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0" name="Freeform 61">
              <a:extLst>
                <a:ext uri="{FF2B5EF4-FFF2-40B4-BE49-F238E27FC236}">
                  <a16:creationId xmlns:a16="http://schemas.microsoft.com/office/drawing/2014/main" id="{167C76A3-5585-4D35-A5B7-284F6CC8825F}"/>
                </a:ext>
              </a:extLst>
            </p:cNvPr>
            <p:cNvSpPr>
              <a:spLocks/>
            </p:cNvSpPr>
            <p:nvPr/>
          </p:nvSpPr>
          <p:spPr bwMode="auto">
            <a:xfrm>
              <a:off x="2879725" y="2854881"/>
              <a:ext cx="52388" cy="53975"/>
            </a:xfrm>
            <a:custGeom>
              <a:avLst/>
              <a:gdLst>
                <a:gd name="T0" fmla="*/ 0 w 33"/>
                <a:gd name="T1" fmla="*/ 0 h 34"/>
                <a:gd name="T2" fmla="*/ 33 w 33"/>
                <a:gd name="T3" fmla="*/ 0 h 34"/>
                <a:gd name="T4" fmla="*/ 17 w 33"/>
                <a:gd name="T5" fmla="*/ 34 h 34"/>
                <a:gd name="T6" fmla="*/ 0 w 33"/>
                <a:gd name="T7" fmla="*/ 0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3" h="34">
                  <a:moveTo>
                    <a:pt x="0" y="0"/>
                  </a:moveTo>
                  <a:lnTo>
                    <a:pt x="33" y="0"/>
                  </a:lnTo>
                  <a:lnTo>
                    <a:pt x="17" y="3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1" name="Freeform 62">
              <a:extLst>
                <a:ext uri="{FF2B5EF4-FFF2-40B4-BE49-F238E27FC236}">
                  <a16:creationId xmlns:a16="http://schemas.microsoft.com/office/drawing/2014/main" id="{8EE7D9EE-6B9C-4836-8CCE-5C7AAA621738}"/>
                </a:ext>
              </a:extLst>
            </p:cNvPr>
            <p:cNvSpPr>
              <a:spLocks/>
            </p:cNvSpPr>
            <p:nvPr/>
          </p:nvSpPr>
          <p:spPr bwMode="auto">
            <a:xfrm>
              <a:off x="2919412" y="2883456"/>
              <a:ext cx="52388" cy="52388"/>
            </a:xfrm>
            <a:custGeom>
              <a:avLst/>
              <a:gdLst>
                <a:gd name="T0" fmla="*/ 0 w 33"/>
                <a:gd name="T1" fmla="*/ 0 h 33"/>
                <a:gd name="T2" fmla="*/ 33 w 33"/>
                <a:gd name="T3" fmla="*/ 0 h 33"/>
                <a:gd name="T4" fmla="*/ 17 w 33"/>
                <a:gd name="T5" fmla="*/ 33 h 33"/>
                <a:gd name="T6" fmla="*/ 0 w 33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3" h="33">
                  <a:moveTo>
                    <a:pt x="0" y="0"/>
                  </a:moveTo>
                  <a:lnTo>
                    <a:pt x="33" y="0"/>
                  </a:lnTo>
                  <a:lnTo>
                    <a:pt x="17" y="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2" name="Freeform 63">
              <a:extLst>
                <a:ext uri="{FF2B5EF4-FFF2-40B4-BE49-F238E27FC236}">
                  <a16:creationId xmlns:a16="http://schemas.microsoft.com/office/drawing/2014/main" id="{A035B275-1494-4665-A49F-E3BDF8CCFCF2}"/>
                </a:ext>
              </a:extLst>
            </p:cNvPr>
            <p:cNvSpPr>
              <a:spLocks/>
            </p:cNvSpPr>
            <p:nvPr/>
          </p:nvSpPr>
          <p:spPr bwMode="auto">
            <a:xfrm>
              <a:off x="2919412" y="2883456"/>
              <a:ext cx="52388" cy="52388"/>
            </a:xfrm>
            <a:custGeom>
              <a:avLst/>
              <a:gdLst>
                <a:gd name="T0" fmla="*/ 0 w 33"/>
                <a:gd name="T1" fmla="*/ 0 h 33"/>
                <a:gd name="T2" fmla="*/ 33 w 33"/>
                <a:gd name="T3" fmla="*/ 0 h 33"/>
                <a:gd name="T4" fmla="*/ 17 w 33"/>
                <a:gd name="T5" fmla="*/ 33 h 33"/>
                <a:gd name="T6" fmla="*/ 0 w 33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3" h="33">
                  <a:moveTo>
                    <a:pt x="0" y="0"/>
                  </a:moveTo>
                  <a:lnTo>
                    <a:pt x="33" y="0"/>
                  </a:lnTo>
                  <a:lnTo>
                    <a:pt x="17" y="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3" name="Line 64">
              <a:extLst>
                <a:ext uri="{FF2B5EF4-FFF2-40B4-BE49-F238E27FC236}">
                  <a16:creationId xmlns:a16="http://schemas.microsoft.com/office/drawing/2014/main" id="{B83008E3-DA93-42F0-AE99-0182E0B3319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19400" y="2912031"/>
              <a:ext cx="331788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4" name="Rectangle 65">
              <a:extLst>
                <a:ext uri="{FF2B5EF4-FFF2-40B4-BE49-F238E27FC236}">
                  <a16:creationId xmlns:a16="http://schemas.microsoft.com/office/drawing/2014/main" id="{8A3D48D6-C8C6-4266-8C65-B0C63E4EF6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16300" y="3129518"/>
              <a:ext cx="52388" cy="5238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5" name="Rectangle 66">
              <a:extLst>
                <a:ext uri="{FF2B5EF4-FFF2-40B4-BE49-F238E27FC236}">
                  <a16:creationId xmlns:a16="http://schemas.microsoft.com/office/drawing/2014/main" id="{4AB93B80-F996-4C26-B6CC-B372250141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16300" y="3129518"/>
              <a:ext cx="52388" cy="52388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6" name="Rectangle 67">
              <a:extLst>
                <a:ext uri="{FF2B5EF4-FFF2-40B4-BE49-F238E27FC236}">
                  <a16:creationId xmlns:a16="http://schemas.microsoft.com/office/drawing/2014/main" id="{76A8AB13-A986-4C6B-B367-E0604F8029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16300" y="2846943"/>
              <a:ext cx="52388" cy="539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7" name="Rectangle 68">
              <a:extLst>
                <a:ext uri="{FF2B5EF4-FFF2-40B4-BE49-F238E27FC236}">
                  <a16:creationId xmlns:a16="http://schemas.microsoft.com/office/drawing/2014/main" id="{C41D579E-0BCB-4DA0-9C51-784A50CB54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16300" y="2846943"/>
              <a:ext cx="52388" cy="53975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8" name="Rectangle 69">
              <a:extLst>
                <a:ext uri="{FF2B5EF4-FFF2-40B4-BE49-F238E27FC236}">
                  <a16:creationId xmlns:a16="http://schemas.microsoft.com/office/drawing/2014/main" id="{65982145-57B3-41FF-A468-9F861DA413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76613" y="2713593"/>
              <a:ext cx="52388" cy="539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9" name="Rectangle 70">
              <a:extLst>
                <a:ext uri="{FF2B5EF4-FFF2-40B4-BE49-F238E27FC236}">
                  <a16:creationId xmlns:a16="http://schemas.microsoft.com/office/drawing/2014/main" id="{8C6B5CD9-C325-4A90-A3BF-7B37CBCF4C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76613" y="2713593"/>
              <a:ext cx="52388" cy="53975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0" name="Rectangle 71">
              <a:extLst>
                <a:ext uri="{FF2B5EF4-FFF2-40B4-BE49-F238E27FC236}">
                  <a16:creationId xmlns:a16="http://schemas.microsoft.com/office/drawing/2014/main" id="{88DCC010-638E-4C82-A21B-1E9367A6C3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16300" y="3331131"/>
              <a:ext cx="52388" cy="539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1" name="Rectangle 72">
              <a:extLst>
                <a:ext uri="{FF2B5EF4-FFF2-40B4-BE49-F238E27FC236}">
                  <a16:creationId xmlns:a16="http://schemas.microsoft.com/office/drawing/2014/main" id="{272B5ABC-E488-43B5-A24D-0CF3B0D999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16300" y="3331131"/>
              <a:ext cx="52388" cy="53975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2" name="Rectangle 73">
              <a:extLst>
                <a:ext uri="{FF2B5EF4-FFF2-40B4-BE49-F238E27FC236}">
                  <a16:creationId xmlns:a16="http://schemas.microsoft.com/office/drawing/2014/main" id="{2ECA1BAE-2320-48A9-8E48-77334648DC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76613" y="3183493"/>
              <a:ext cx="52388" cy="5238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3" name="Rectangle 74">
              <a:extLst>
                <a:ext uri="{FF2B5EF4-FFF2-40B4-BE49-F238E27FC236}">
                  <a16:creationId xmlns:a16="http://schemas.microsoft.com/office/drawing/2014/main" id="{1592ACD7-8AD7-422E-B3C5-1BA2424D6E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76613" y="3183493"/>
              <a:ext cx="52388" cy="52388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4" name="Rectangle 75">
              <a:extLst>
                <a:ext uri="{FF2B5EF4-FFF2-40B4-BE49-F238E27FC236}">
                  <a16:creationId xmlns:a16="http://schemas.microsoft.com/office/drawing/2014/main" id="{F4C87AA6-3A67-47DB-89BE-67163E5571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5988" y="2573893"/>
              <a:ext cx="52388" cy="5238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" name="Rectangle 76">
              <a:extLst>
                <a:ext uri="{FF2B5EF4-FFF2-40B4-BE49-F238E27FC236}">
                  <a16:creationId xmlns:a16="http://schemas.microsoft.com/office/drawing/2014/main" id="{C8783F37-EFF2-475A-A158-BA0544A4B3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5988" y="2573893"/>
              <a:ext cx="52388" cy="52388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" name="Rectangle 77">
              <a:extLst>
                <a:ext uri="{FF2B5EF4-FFF2-40B4-BE49-F238E27FC236}">
                  <a16:creationId xmlns:a16="http://schemas.microsoft.com/office/drawing/2014/main" id="{B8A7096F-4280-4E02-9614-C877371CF5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16300" y="2502456"/>
              <a:ext cx="52388" cy="5238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7" name="Rectangle 78">
              <a:extLst>
                <a:ext uri="{FF2B5EF4-FFF2-40B4-BE49-F238E27FC236}">
                  <a16:creationId xmlns:a16="http://schemas.microsoft.com/office/drawing/2014/main" id="{5E850724-21FB-44DB-B7A4-5DD072C23D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16300" y="2502456"/>
              <a:ext cx="52388" cy="52388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8" name="Rectangle 79">
              <a:extLst>
                <a:ext uri="{FF2B5EF4-FFF2-40B4-BE49-F238E27FC236}">
                  <a16:creationId xmlns:a16="http://schemas.microsoft.com/office/drawing/2014/main" id="{052915D5-E5BB-4CD7-9808-1D859FB3B6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16300" y="2970768"/>
              <a:ext cx="52388" cy="539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" name="Rectangle 80">
              <a:extLst>
                <a:ext uri="{FF2B5EF4-FFF2-40B4-BE49-F238E27FC236}">
                  <a16:creationId xmlns:a16="http://schemas.microsoft.com/office/drawing/2014/main" id="{32FBCBDA-8B83-4395-8777-84F68D45CD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16300" y="2970768"/>
              <a:ext cx="52388" cy="53975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0" name="Rectangle 81">
              <a:extLst>
                <a:ext uri="{FF2B5EF4-FFF2-40B4-BE49-F238E27FC236}">
                  <a16:creationId xmlns:a16="http://schemas.microsoft.com/office/drawing/2014/main" id="{D3A73D0C-159C-4D8E-A152-A87C6A3971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5988" y="3234293"/>
              <a:ext cx="52388" cy="539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1" name="Rectangle 82">
              <a:extLst>
                <a:ext uri="{FF2B5EF4-FFF2-40B4-BE49-F238E27FC236}">
                  <a16:creationId xmlns:a16="http://schemas.microsoft.com/office/drawing/2014/main" id="{5BB92D92-CB0A-413C-8084-48A1077AF0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5988" y="3234293"/>
              <a:ext cx="52388" cy="53975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2" name="Rectangle 83">
              <a:extLst>
                <a:ext uri="{FF2B5EF4-FFF2-40B4-BE49-F238E27FC236}">
                  <a16:creationId xmlns:a16="http://schemas.microsoft.com/office/drawing/2014/main" id="{1B4C6ECE-B9C6-475E-A7F9-A47657D66F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76613" y="2626281"/>
              <a:ext cx="52388" cy="5238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3" name="Rectangle 84">
              <a:extLst>
                <a:ext uri="{FF2B5EF4-FFF2-40B4-BE49-F238E27FC236}">
                  <a16:creationId xmlns:a16="http://schemas.microsoft.com/office/drawing/2014/main" id="{09530E60-44E5-4EFA-8BE6-162B5D46A3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76613" y="2626281"/>
              <a:ext cx="52388" cy="52388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4" name="Rectangle 85">
              <a:extLst>
                <a:ext uri="{FF2B5EF4-FFF2-40B4-BE49-F238E27FC236}">
                  <a16:creationId xmlns:a16="http://schemas.microsoft.com/office/drawing/2014/main" id="{AAD78E2E-E076-47C2-B99A-102F5292B9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5988" y="2750106"/>
              <a:ext cx="52388" cy="539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5" name="Rectangle 86">
              <a:extLst>
                <a:ext uri="{FF2B5EF4-FFF2-40B4-BE49-F238E27FC236}">
                  <a16:creationId xmlns:a16="http://schemas.microsoft.com/office/drawing/2014/main" id="{A9B58405-F413-40D7-9F7A-2E33168ACA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5988" y="2750106"/>
              <a:ext cx="52388" cy="53975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6" name="Rectangle 87">
              <a:extLst>
                <a:ext uri="{FF2B5EF4-FFF2-40B4-BE49-F238E27FC236}">
                  <a16:creationId xmlns:a16="http://schemas.microsoft.com/office/drawing/2014/main" id="{BE37F103-8071-455D-9108-FFB6646BE0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16300" y="2221468"/>
              <a:ext cx="52388" cy="5238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7" name="Rectangle 88">
              <a:extLst>
                <a:ext uri="{FF2B5EF4-FFF2-40B4-BE49-F238E27FC236}">
                  <a16:creationId xmlns:a16="http://schemas.microsoft.com/office/drawing/2014/main" id="{040AAE69-45D6-489A-AAC4-103EEBCE39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16300" y="2221468"/>
              <a:ext cx="52388" cy="52388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8" name="Line 89">
              <a:extLst>
                <a:ext uri="{FF2B5EF4-FFF2-40B4-BE49-F238E27FC236}">
                  <a16:creationId xmlns:a16="http://schemas.microsoft.com/office/drawing/2014/main" id="{BD42596C-81C8-431D-8BD9-99CCB32E6B7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76600" y="2865993"/>
              <a:ext cx="331788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" name="Freeform 90">
              <a:extLst>
                <a:ext uri="{FF2B5EF4-FFF2-40B4-BE49-F238E27FC236}">
                  <a16:creationId xmlns:a16="http://schemas.microsoft.com/office/drawing/2014/main" id="{A8755376-D9C7-4E9F-BCA7-429EB3919DFE}"/>
                </a:ext>
              </a:extLst>
            </p:cNvPr>
            <p:cNvSpPr>
              <a:spLocks/>
            </p:cNvSpPr>
            <p:nvPr/>
          </p:nvSpPr>
          <p:spPr bwMode="auto">
            <a:xfrm>
              <a:off x="3911600" y="2996168"/>
              <a:ext cx="53975" cy="53975"/>
            </a:xfrm>
            <a:custGeom>
              <a:avLst/>
              <a:gdLst>
                <a:gd name="T0" fmla="*/ 17 w 34"/>
                <a:gd name="T1" fmla="*/ 0 h 34"/>
                <a:gd name="T2" fmla="*/ 34 w 34"/>
                <a:gd name="T3" fmla="*/ 34 h 34"/>
                <a:gd name="T4" fmla="*/ 0 w 34"/>
                <a:gd name="T5" fmla="*/ 34 h 34"/>
                <a:gd name="T6" fmla="*/ 17 w 34"/>
                <a:gd name="T7" fmla="*/ 0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34">
                  <a:moveTo>
                    <a:pt x="17" y="0"/>
                  </a:moveTo>
                  <a:lnTo>
                    <a:pt x="34" y="34"/>
                  </a:lnTo>
                  <a:lnTo>
                    <a:pt x="0" y="34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0" name="Freeform 91">
              <a:extLst>
                <a:ext uri="{FF2B5EF4-FFF2-40B4-BE49-F238E27FC236}">
                  <a16:creationId xmlns:a16="http://schemas.microsoft.com/office/drawing/2014/main" id="{E42567A6-96EA-4D76-8EE0-3968E6A3908C}"/>
                </a:ext>
              </a:extLst>
            </p:cNvPr>
            <p:cNvSpPr>
              <a:spLocks/>
            </p:cNvSpPr>
            <p:nvPr/>
          </p:nvSpPr>
          <p:spPr bwMode="auto">
            <a:xfrm>
              <a:off x="3871913" y="2705656"/>
              <a:ext cx="53975" cy="53975"/>
            </a:xfrm>
            <a:custGeom>
              <a:avLst/>
              <a:gdLst>
                <a:gd name="T0" fmla="*/ 17 w 34"/>
                <a:gd name="T1" fmla="*/ 0 h 34"/>
                <a:gd name="T2" fmla="*/ 34 w 34"/>
                <a:gd name="T3" fmla="*/ 34 h 34"/>
                <a:gd name="T4" fmla="*/ 0 w 34"/>
                <a:gd name="T5" fmla="*/ 34 h 34"/>
                <a:gd name="T6" fmla="*/ 17 w 34"/>
                <a:gd name="T7" fmla="*/ 0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34">
                  <a:moveTo>
                    <a:pt x="17" y="0"/>
                  </a:moveTo>
                  <a:lnTo>
                    <a:pt x="34" y="34"/>
                  </a:lnTo>
                  <a:lnTo>
                    <a:pt x="0" y="34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" name="Freeform 92">
              <a:extLst>
                <a:ext uri="{FF2B5EF4-FFF2-40B4-BE49-F238E27FC236}">
                  <a16:creationId xmlns:a16="http://schemas.microsoft.com/office/drawing/2014/main" id="{7B3B8C28-1B7B-4709-B79E-857782C45404}"/>
                </a:ext>
              </a:extLst>
            </p:cNvPr>
            <p:cNvSpPr>
              <a:spLocks/>
            </p:cNvSpPr>
            <p:nvPr/>
          </p:nvSpPr>
          <p:spPr bwMode="auto">
            <a:xfrm>
              <a:off x="3911600" y="2556431"/>
              <a:ext cx="53975" cy="52388"/>
            </a:xfrm>
            <a:custGeom>
              <a:avLst/>
              <a:gdLst>
                <a:gd name="T0" fmla="*/ 17 w 34"/>
                <a:gd name="T1" fmla="*/ 0 h 33"/>
                <a:gd name="T2" fmla="*/ 34 w 34"/>
                <a:gd name="T3" fmla="*/ 33 h 33"/>
                <a:gd name="T4" fmla="*/ 0 w 34"/>
                <a:gd name="T5" fmla="*/ 33 h 33"/>
                <a:gd name="T6" fmla="*/ 17 w 34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33">
                  <a:moveTo>
                    <a:pt x="17" y="0"/>
                  </a:moveTo>
                  <a:lnTo>
                    <a:pt x="34" y="33"/>
                  </a:lnTo>
                  <a:lnTo>
                    <a:pt x="0" y="33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2" name="Freeform 93">
              <a:extLst>
                <a:ext uri="{FF2B5EF4-FFF2-40B4-BE49-F238E27FC236}">
                  <a16:creationId xmlns:a16="http://schemas.microsoft.com/office/drawing/2014/main" id="{1EE24F5A-8D69-495D-9A23-D67C5153C095}"/>
                </a:ext>
              </a:extLst>
            </p:cNvPr>
            <p:cNvSpPr>
              <a:spLocks/>
            </p:cNvSpPr>
            <p:nvPr/>
          </p:nvSpPr>
          <p:spPr bwMode="auto">
            <a:xfrm>
              <a:off x="3990975" y="3172381"/>
              <a:ext cx="53975" cy="53975"/>
            </a:xfrm>
            <a:custGeom>
              <a:avLst/>
              <a:gdLst>
                <a:gd name="T0" fmla="*/ 17 w 34"/>
                <a:gd name="T1" fmla="*/ 0 h 34"/>
                <a:gd name="T2" fmla="*/ 34 w 34"/>
                <a:gd name="T3" fmla="*/ 34 h 34"/>
                <a:gd name="T4" fmla="*/ 0 w 34"/>
                <a:gd name="T5" fmla="*/ 34 h 34"/>
                <a:gd name="T6" fmla="*/ 17 w 34"/>
                <a:gd name="T7" fmla="*/ 0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34">
                  <a:moveTo>
                    <a:pt x="17" y="0"/>
                  </a:moveTo>
                  <a:lnTo>
                    <a:pt x="34" y="34"/>
                  </a:lnTo>
                  <a:lnTo>
                    <a:pt x="0" y="34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3" name="Freeform 94">
              <a:extLst>
                <a:ext uri="{FF2B5EF4-FFF2-40B4-BE49-F238E27FC236}">
                  <a16:creationId xmlns:a16="http://schemas.microsoft.com/office/drawing/2014/main" id="{0B0809A8-07A2-41BC-8FFB-27876A9B33C6}"/>
                </a:ext>
              </a:extLst>
            </p:cNvPr>
            <p:cNvSpPr>
              <a:spLocks/>
            </p:cNvSpPr>
            <p:nvPr/>
          </p:nvSpPr>
          <p:spPr bwMode="auto">
            <a:xfrm>
              <a:off x="3871913" y="2361168"/>
              <a:ext cx="53975" cy="52388"/>
            </a:xfrm>
            <a:custGeom>
              <a:avLst/>
              <a:gdLst>
                <a:gd name="T0" fmla="*/ 17 w 34"/>
                <a:gd name="T1" fmla="*/ 0 h 33"/>
                <a:gd name="T2" fmla="*/ 34 w 34"/>
                <a:gd name="T3" fmla="*/ 33 h 33"/>
                <a:gd name="T4" fmla="*/ 0 w 34"/>
                <a:gd name="T5" fmla="*/ 33 h 33"/>
                <a:gd name="T6" fmla="*/ 17 w 34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33">
                  <a:moveTo>
                    <a:pt x="17" y="0"/>
                  </a:moveTo>
                  <a:lnTo>
                    <a:pt x="34" y="33"/>
                  </a:lnTo>
                  <a:lnTo>
                    <a:pt x="0" y="33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4" name="Freeform 95">
              <a:extLst>
                <a:ext uri="{FF2B5EF4-FFF2-40B4-BE49-F238E27FC236}">
                  <a16:creationId xmlns:a16="http://schemas.microsoft.com/office/drawing/2014/main" id="{D9ED62F5-FDC8-4649-B8F5-52E1B8826B25}"/>
                </a:ext>
              </a:extLst>
            </p:cNvPr>
            <p:cNvSpPr>
              <a:spLocks/>
            </p:cNvSpPr>
            <p:nvPr/>
          </p:nvSpPr>
          <p:spPr bwMode="auto">
            <a:xfrm>
              <a:off x="3871913" y="3146981"/>
              <a:ext cx="53975" cy="52388"/>
            </a:xfrm>
            <a:custGeom>
              <a:avLst/>
              <a:gdLst>
                <a:gd name="T0" fmla="*/ 17 w 34"/>
                <a:gd name="T1" fmla="*/ 0 h 33"/>
                <a:gd name="T2" fmla="*/ 34 w 34"/>
                <a:gd name="T3" fmla="*/ 33 h 33"/>
                <a:gd name="T4" fmla="*/ 0 w 34"/>
                <a:gd name="T5" fmla="*/ 33 h 33"/>
                <a:gd name="T6" fmla="*/ 17 w 34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33">
                  <a:moveTo>
                    <a:pt x="17" y="0"/>
                  </a:moveTo>
                  <a:lnTo>
                    <a:pt x="34" y="33"/>
                  </a:lnTo>
                  <a:lnTo>
                    <a:pt x="0" y="33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5" name="Freeform 96">
              <a:extLst>
                <a:ext uri="{FF2B5EF4-FFF2-40B4-BE49-F238E27FC236}">
                  <a16:creationId xmlns:a16="http://schemas.microsoft.com/office/drawing/2014/main" id="{F51E91DD-E59C-4931-BA79-EC6AE7286A54}"/>
                </a:ext>
              </a:extLst>
            </p:cNvPr>
            <p:cNvSpPr>
              <a:spLocks/>
            </p:cNvSpPr>
            <p:nvPr/>
          </p:nvSpPr>
          <p:spPr bwMode="auto">
            <a:xfrm>
              <a:off x="3951288" y="2767568"/>
              <a:ext cx="53975" cy="52388"/>
            </a:xfrm>
            <a:custGeom>
              <a:avLst/>
              <a:gdLst>
                <a:gd name="T0" fmla="*/ 17 w 34"/>
                <a:gd name="T1" fmla="*/ 0 h 33"/>
                <a:gd name="T2" fmla="*/ 34 w 34"/>
                <a:gd name="T3" fmla="*/ 33 h 33"/>
                <a:gd name="T4" fmla="*/ 0 w 34"/>
                <a:gd name="T5" fmla="*/ 33 h 33"/>
                <a:gd name="T6" fmla="*/ 17 w 34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33">
                  <a:moveTo>
                    <a:pt x="17" y="0"/>
                  </a:moveTo>
                  <a:lnTo>
                    <a:pt x="34" y="33"/>
                  </a:lnTo>
                  <a:lnTo>
                    <a:pt x="0" y="33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6" name="Freeform 97">
              <a:extLst>
                <a:ext uri="{FF2B5EF4-FFF2-40B4-BE49-F238E27FC236}">
                  <a16:creationId xmlns:a16="http://schemas.microsoft.com/office/drawing/2014/main" id="{45FEE92B-AE8F-4BCC-88A3-93CA665B4B27}"/>
                </a:ext>
              </a:extLst>
            </p:cNvPr>
            <p:cNvSpPr>
              <a:spLocks/>
            </p:cNvSpPr>
            <p:nvPr/>
          </p:nvSpPr>
          <p:spPr bwMode="auto">
            <a:xfrm>
              <a:off x="3951288" y="3245406"/>
              <a:ext cx="53975" cy="52388"/>
            </a:xfrm>
            <a:custGeom>
              <a:avLst/>
              <a:gdLst>
                <a:gd name="T0" fmla="*/ 17 w 34"/>
                <a:gd name="T1" fmla="*/ 0 h 33"/>
                <a:gd name="T2" fmla="*/ 34 w 34"/>
                <a:gd name="T3" fmla="*/ 33 h 33"/>
                <a:gd name="T4" fmla="*/ 0 w 34"/>
                <a:gd name="T5" fmla="*/ 33 h 33"/>
                <a:gd name="T6" fmla="*/ 17 w 34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33">
                  <a:moveTo>
                    <a:pt x="17" y="0"/>
                  </a:moveTo>
                  <a:lnTo>
                    <a:pt x="34" y="33"/>
                  </a:lnTo>
                  <a:lnTo>
                    <a:pt x="0" y="33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" name="Freeform 98">
              <a:extLst>
                <a:ext uri="{FF2B5EF4-FFF2-40B4-BE49-F238E27FC236}">
                  <a16:creationId xmlns:a16="http://schemas.microsoft.com/office/drawing/2014/main" id="{B420A26A-BF10-4B43-B46A-75609A08C87B}"/>
                </a:ext>
              </a:extLst>
            </p:cNvPr>
            <p:cNvSpPr>
              <a:spLocks/>
            </p:cNvSpPr>
            <p:nvPr/>
          </p:nvSpPr>
          <p:spPr bwMode="auto">
            <a:xfrm>
              <a:off x="3871913" y="3296206"/>
              <a:ext cx="53975" cy="53975"/>
            </a:xfrm>
            <a:custGeom>
              <a:avLst/>
              <a:gdLst>
                <a:gd name="T0" fmla="*/ 17 w 34"/>
                <a:gd name="T1" fmla="*/ 0 h 34"/>
                <a:gd name="T2" fmla="*/ 34 w 34"/>
                <a:gd name="T3" fmla="*/ 34 h 34"/>
                <a:gd name="T4" fmla="*/ 0 w 34"/>
                <a:gd name="T5" fmla="*/ 34 h 34"/>
                <a:gd name="T6" fmla="*/ 17 w 34"/>
                <a:gd name="T7" fmla="*/ 0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34">
                  <a:moveTo>
                    <a:pt x="17" y="0"/>
                  </a:moveTo>
                  <a:lnTo>
                    <a:pt x="34" y="34"/>
                  </a:lnTo>
                  <a:lnTo>
                    <a:pt x="0" y="34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8" name="Freeform 99">
              <a:extLst>
                <a:ext uri="{FF2B5EF4-FFF2-40B4-BE49-F238E27FC236}">
                  <a16:creationId xmlns:a16="http://schemas.microsoft.com/office/drawing/2014/main" id="{DA232D8F-6C5E-4288-BC25-D349B43F1FE5}"/>
                </a:ext>
              </a:extLst>
            </p:cNvPr>
            <p:cNvSpPr>
              <a:spLocks/>
            </p:cNvSpPr>
            <p:nvPr/>
          </p:nvSpPr>
          <p:spPr bwMode="auto">
            <a:xfrm>
              <a:off x="3951288" y="2380218"/>
              <a:ext cx="53975" cy="52388"/>
            </a:xfrm>
            <a:custGeom>
              <a:avLst/>
              <a:gdLst>
                <a:gd name="T0" fmla="*/ 17 w 34"/>
                <a:gd name="T1" fmla="*/ 0 h 33"/>
                <a:gd name="T2" fmla="*/ 34 w 34"/>
                <a:gd name="T3" fmla="*/ 33 h 33"/>
                <a:gd name="T4" fmla="*/ 0 w 34"/>
                <a:gd name="T5" fmla="*/ 33 h 33"/>
                <a:gd name="T6" fmla="*/ 17 w 34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33">
                  <a:moveTo>
                    <a:pt x="17" y="0"/>
                  </a:moveTo>
                  <a:lnTo>
                    <a:pt x="34" y="33"/>
                  </a:lnTo>
                  <a:lnTo>
                    <a:pt x="0" y="33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9" name="Line 100">
              <a:extLst>
                <a:ext uri="{FF2B5EF4-FFF2-40B4-BE49-F238E27FC236}">
                  <a16:creationId xmlns:a16="http://schemas.microsoft.com/office/drawing/2014/main" id="{B1B80FDF-C44C-446C-B41E-4706932C664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73488" y="2889806"/>
              <a:ext cx="3302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1" name="Rectangle 6">
              <a:extLst>
                <a:ext uri="{FF2B5EF4-FFF2-40B4-BE49-F238E27FC236}">
                  <a16:creationId xmlns:a16="http://schemas.microsoft.com/office/drawing/2014/main" id="{D7C3E245-B3DB-426D-BE9F-AFDA21680D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31454" y="3514596"/>
              <a:ext cx="35586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800" dirty="0">
                  <a:solidFill>
                    <a:srgbClr val="000000"/>
                  </a:solidFill>
                  <a:latin typeface="Symbol" panose="05050102010706020507" pitchFamily="18" charset="2"/>
                </a:rPr>
                <a:t>a</a:t>
              </a:r>
              <a:r>
                <a:rPr kumimoji="0" lang="en-US" altLang="en-US" sz="8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PDL1</a:t>
              </a:r>
              <a:endParaRPr kumimoji="0" lang="en-US" altLang="en-US" sz="1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" name="Rectangle 7">
              <a:extLst>
                <a:ext uri="{FF2B5EF4-FFF2-40B4-BE49-F238E27FC236}">
                  <a16:creationId xmlns:a16="http://schemas.microsoft.com/office/drawing/2014/main" id="{AD12341A-B4AF-4542-BE74-C9C154857A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43284" y="3650772"/>
              <a:ext cx="41838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+</a:t>
              </a:r>
              <a:r>
                <a:rPr lang="en-US" altLang="en-US" sz="800" dirty="0">
                  <a:solidFill>
                    <a:srgbClr val="000000"/>
                  </a:solidFill>
                  <a:latin typeface="Symbol" panose="05050102010706020507" pitchFamily="18" charset="2"/>
                </a:rPr>
                <a:t> a</a:t>
              </a:r>
              <a:r>
                <a:rPr lang="en-US" altLang="en-US" sz="800" dirty="0">
                  <a:solidFill>
                    <a:srgbClr val="000000"/>
                  </a:solidFill>
                </a:rPr>
                <a:t>-</a:t>
              </a:r>
              <a:r>
                <a:rPr lang="en-US" altLang="en-US" sz="800" dirty="0" err="1">
                  <a:solidFill>
                    <a:srgbClr val="000000"/>
                  </a:solidFill>
                </a:rPr>
                <a:t>sMIC</a:t>
              </a:r>
              <a:endParaRPr kumimoji="0" lang="en-US" altLang="en-US" sz="1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" name="Oval 22">
              <a:extLst>
                <a:ext uri="{FF2B5EF4-FFF2-40B4-BE49-F238E27FC236}">
                  <a16:creationId xmlns:a16="http://schemas.microsoft.com/office/drawing/2014/main" id="{9C851440-49A6-4429-9568-1B0F18DD54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76107" y="3356364"/>
              <a:ext cx="52388" cy="5397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0" name="Oval 26">
              <a:extLst>
                <a:ext uri="{FF2B5EF4-FFF2-40B4-BE49-F238E27FC236}">
                  <a16:creationId xmlns:a16="http://schemas.microsoft.com/office/drawing/2014/main" id="{5EC62E84-2603-4366-9003-C0CE91112B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52452" y="3369466"/>
              <a:ext cx="52388" cy="5397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2" name="Oval 28">
              <a:extLst>
                <a:ext uri="{FF2B5EF4-FFF2-40B4-BE49-F238E27FC236}">
                  <a16:creationId xmlns:a16="http://schemas.microsoft.com/office/drawing/2014/main" id="{D7CF5304-8837-46AF-84F1-01E757D360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16749" y="3360490"/>
              <a:ext cx="53975" cy="52388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4" name="Oval 38">
              <a:extLst>
                <a:ext uri="{FF2B5EF4-FFF2-40B4-BE49-F238E27FC236}">
                  <a16:creationId xmlns:a16="http://schemas.microsoft.com/office/drawing/2014/main" id="{956808B4-2B0A-4B01-8220-22BD0DC517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84995" y="3395674"/>
              <a:ext cx="53975" cy="5397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6" name="Oval 40">
              <a:extLst>
                <a:ext uri="{FF2B5EF4-FFF2-40B4-BE49-F238E27FC236}">
                  <a16:creationId xmlns:a16="http://schemas.microsoft.com/office/drawing/2014/main" id="{F774280B-25A6-473D-BC45-61C838BFB4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08650" y="3391102"/>
              <a:ext cx="53975" cy="5397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cxnSp>
          <p:nvCxnSpPr>
            <p:cNvPr id="121" name="Straight Connector 120">
              <a:extLst>
                <a:ext uri="{FF2B5EF4-FFF2-40B4-BE49-F238E27FC236}">
                  <a16:creationId xmlns:a16="http://schemas.microsoft.com/office/drawing/2014/main" id="{B24F2AE8-70FF-4244-AFFA-0E9D58DA1FD0}"/>
                </a:ext>
              </a:extLst>
            </p:cNvPr>
            <p:cNvCxnSpPr>
              <a:cxnSpLocks/>
            </p:cNvCxnSpPr>
            <p:nvPr/>
          </p:nvCxnSpPr>
          <p:spPr>
            <a:xfrm>
              <a:off x="2274887" y="3452326"/>
              <a:ext cx="2297113" cy="123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2" name="Oval 28">
              <a:extLst>
                <a:ext uri="{FF2B5EF4-FFF2-40B4-BE49-F238E27FC236}">
                  <a16:creationId xmlns:a16="http://schemas.microsoft.com/office/drawing/2014/main" id="{6F72D8A3-FD4F-4F5B-B724-3D6214E672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38970" y="3391102"/>
              <a:ext cx="53975" cy="52388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3" name="Oval 28">
              <a:extLst>
                <a:ext uri="{FF2B5EF4-FFF2-40B4-BE49-F238E27FC236}">
                  <a16:creationId xmlns:a16="http://schemas.microsoft.com/office/drawing/2014/main" id="{ABEE9DC0-BB17-48E8-A2D6-ABE584A01E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39433" y="3399095"/>
              <a:ext cx="53975" cy="52388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4" name="Oval 28">
              <a:extLst>
                <a:ext uri="{FF2B5EF4-FFF2-40B4-BE49-F238E27FC236}">
                  <a16:creationId xmlns:a16="http://schemas.microsoft.com/office/drawing/2014/main" id="{40F01183-2E12-4753-B755-4E1A33B372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28644" y="3371489"/>
              <a:ext cx="53975" cy="52388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6C5CCC20-3CDC-42D6-A34B-7C14042B3D81}"/>
                </a:ext>
              </a:extLst>
            </p:cNvPr>
            <p:cNvSpPr txBox="1"/>
            <p:nvPr/>
          </p:nvSpPr>
          <p:spPr>
            <a:xfrm>
              <a:off x="4172660" y="3435484"/>
              <a:ext cx="5966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33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CB/B6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7BBF93A5-5687-466E-85A6-BA7E628D83A0}"/>
                </a:ext>
              </a:extLst>
            </p:cNvPr>
            <p:cNvSpPr txBox="1"/>
            <p:nvPr/>
          </p:nvSpPr>
          <p:spPr>
            <a:xfrm>
              <a:off x="2879725" y="3831749"/>
              <a:ext cx="100540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RAMP/MICB</a:t>
              </a:r>
            </a:p>
          </p:txBody>
        </p:sp>
        <p:sp>
          <p:nvSpPr>
            <p:cNvPr id="131" name="Right Bracket 130">
              <a:extLst>
                <a:ext uri="{FF2B5EF4-FFF2-40B4-BE49-F238E27FC236}">
                  <a16:creationId xmlns:a16="http://schemas.microsoft.com/office/drawing/2014/main" id="{F25FE5E4-010B-4CC6-9E6D-7B3B195EAC98}"/>
                </a:ext>
              </a:extLst>
            </p:cNvPr>
            <p:cNvSpPr/>
            <p:nvPr/>
          </p:nvSpPr>
          <p:spPr>
            <a:xfrm rot="5400000">
              <a:off x="3249002" y="3063605"/>
              <a:ext cx="51905" cy="1539990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4345334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6" name="TextBox 375"/>
          <p:cNvSpPr txBox="1"/>
          <p:nvPr/>
        </p:nvSpPr>
        <p:spPr>
          <a:xfrm>
            <a:off x="2623017" y="123264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ure S2</a:t>
            </a:r>
          </a:p>
        </p:txBody>
      </p:sp>
      <p:sp>
        <p:nvSpPr>
          <p:cNvPr id="118" name="TextBox 117"/>
          <p:cNvSpPr txBox="1"/>
          <p:nvPr/>
        </p:nvSpPr>
        <p:spPr>
          <a:xfrm>
            <a:off x="3323500" y="2143767"/>
            <a:ext cx="321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76" name="TextBox 175"/>
          <p:cNvSpPr txBox="1"/>
          <p:nvPr/>
        </p:nvSpPr>
        <p:spPr>
          <a:xfrm>
            <a:off x="524161" y="580913"/>
            <a:ext cx="321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41" name="AutoShape 4"/>
          <p:cNvSpPr>
            <a:spLocks noChangeAspect="1" noChangeArrowheads="1" noTextEdit="1"/>
          </p:cNvSpPr>
          <p:nvPr/>
        </p:nvSpPr>
        <p:spPr bwMode="auto">
          <a:xfrm>
            <a:off x="1386014" y="1607915"/>
            <a:ext cx="3168650" cy="4261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07" name="TextBox 206"/>
          <p:cNvSpPr txBox="1"/>
          <p:nvPr/>
        </p:nvSpPr>
        <p:spPr>
          <a:xfrm>
            <a:off x="586080" y="2110757"/>
            <a:ext cx="3287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.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6083887C-431D-4264-9227-2AE86CDB7735}"/>
              </a:ext>
            </a:extLst>
          </p:cNvPr>
          <p:cNvGrpSpPr/>
          <p:nvPr/>
        </p:nvGrpSpPr>
        <p:grpSpPr>
          <a:xfrm>
            <a:off x="846982" y="704897"/>
            <a:ext cx="3680867" cy="1379917"/>
            <a:chOff x="890462" y="491853"/>
            <a:chExt cx="3680867" cy="1379917"/>
          </a:xfrm>
        </p:grpSpPr>
        <p:grpSp>
          <p:nvGrpSpPr>
            <p:cNvPr id="156" name="Group 155"/>
            <p:cNvGrpSpPr/>
            <p:nvPr/>
          </p:nvGrpSpPr>
          <p:grpSpPr>
            <a:xfrm>
              <a:off x="1099806" y="491853"/>
              <a:ext cx="3471523" cy="1085038"/>
              <a:chOff x="302724" y="7071536"/>
              <a:chExt cx="3471523" cy="1085038"/>
            </a:xfrm>
          </p:grpSpPr>
          <p:grpSp>
            <p:nvGrpSpPr>
              <p:cNvPr id="157" name="Group 156"/>
              <p:cNvGrpSpPr/>
              <p:nvPr/>
            </p:nvGrpSpPr>
            <p:grpSpPr>
              <a:xfrm>
                <a:off x="577493" y="7383702"/>
                <a:ext cx="3196754" cy="772872"/>
                <a:chOff x="517951" y="762054"/>
                <a:chExt cx="3196754" cy="772872"/>
              </a:xfrm>
            </p:grpSpPr>
            <p:cxnSp>
              <p:nvCxnSpPr>
                <p:cNvPr id="160" name="Straight Arrow Connector 159"/>
                <p:cNvCxnSpPr/>
                <p:nvPr/>
              </p:nvCxnSpPr>
              <p:spPr>
                <a:xfrm flipV="1">
                  <a:off x="818358" y="1462911"/>
                  <a:ext cx="2381220" cy="2647"/>
                </a:xfrm>
                <a:prstGeom prst="straightConnector1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  <a:tailEnd type="triangle"/>
                </a:ln>
                <a:effectLst/>
              </p:spPr>
            </p:cxnSp>
            <p:cxnSp>
              <p:nvCxnSpPr>
                <p:cNvPr id="161" name="Straight Connector 160"/>
                <p:cNvCxnSpPr/>
                <p:nvPr/>
              </p:nvCxnSpPr>
              <p:spPr>
                <a:xfrm>
                  <a:off x="818358" y="1396193"/>
                  <a:ext cx="0" cy="138733"/>
                </a:xfrm>
                <a:prstGeom prst="line">
                  <a:avLst/>
                </a:prstGeom>
                <a:noFill/>
                <a:ln w="317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162" name="Straight Connector 161"/>
                <p:cNvCxnSpPr/>
                <p:nvPr/>
              </p:nvCxnSpPr>
              <p:spPr>
                <a:xfrm>
                  <a:off x="1707546" y="1396193"/>
                  <a:ext cx="0" cy="138733"/>
                </a:xfrm>
                <a:prstGeom prst="line">
                  <a:avLst/>
                </a:prstGeom>
                <a:noFill/>
                <a:ln w="254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166" name="Straight Connector 165"/>
                <p:cNvCxnSpPr/>
                <p:nvPr/>
              </p:nvCxnSpPr>
              <p:spPr>
                <a:xfrm>
                  <a:off x="3199578" y="1405762"/>
                  <a:ext cx="0" cy="11430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pic>
              <p:nvPicPr>
                <p:cNvPr id="169" name="Picture 3" descr="C:\Users\Shengjun LU\Desktop\F7_large.jpg"/>
                <p:cNvPicPr>
                  <a:picLocks noChangeAspect="1" noChangeArrowheads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6238" t="5801" r="50000" b="88397"/>
                <a:stretch/>
              </p:blipFill>
              <p:spPr bwMode="auto">
                <a:xfrm>
                  <a:off x="517951" y="1064184"/>
                  <a:ext cx="579342" cy="403605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72" name="Down Arrow 171"/>
                <p:cNvSpPr/>
                <p:nvPr/>
              </p:nvSpPr>
              <p:spPr>
                <a:xfrm>
                  <a:off x="1678164" y="1182419"/>
                  <a:ext cx="45719" cy="132970"/>
                </a:xfrm>
                <a:prstGeom prst="downArrow">
                  <a:avLst/>
                </a:prstGeom>
                <a:ln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4" name="TextBox 173"/>
                <p:cNvSpPr txBox="1"/>
                <p:nvPr/>
              </p:nvSpPr>
              <p:spPr>
                <a:xfrm>
                  <a:off x="2737333" y="762054"/>
                  <a:ext cx="977372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nd point </a:t>
                  </a:r>
                </a:p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(1000mm3)</a:t>
                  </a:r>
                </a:p>
              </p:txBody>
            </p:sp>
            <p:sp>
              <p:nvSpPr>
                <p:cNvPr id="175" name="Down Arrow 174"/>
                <p:cNvSpPr/>
                <p:nvPr/>
              </p:nvSpPr>
              <p:spPr>
                <a:xfrm>
                  <a:off x="3154681" y="1182419"/>
                  <a:ext cx="45719" cy="132970"/>
                </a:xfrm>
                <a:prstGeom prst="downArrow">
                  <a:avLst/>
                </a:prstGeom>
                <a:ln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8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59" name="TextBox 158"/>
              <p:cNvSpPr txBox="1"/>
              <p:nvPr/>
            </p:nvSpPr>
            <p:spPr>
              <a:xfrm>
                <a:off x="302724" y="7071536"/>
                <a:ext cx="243967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RAMP-C2 (TC2) </a:t>
                </a:r>
              </a:p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or TRAMP-C2-sMICB (TC2-sMICB) cells</a:t>
                </a:r>
              </a:p>
            </p:txBody>
          </p:sp>
        </p:grpSp>
        <p:sp>
          <p:nvSpPr>
            <p:cNvPr id="142" name="Rectangle 6"/>
            <p:cNvSpPr>
              <a:spLocks noChangeArrowheads="1"/>
            </p:cNvSpPr>
            <p:nvPr/>
          </p:nvSpPr>
          <p:spPr bwMode="auto">
            <a:xfrm>
              <a:off x="890462" y="1228224"/>
              <a:ext cx="3168650" cy="2958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98" name="Left Brace 197"/>
            <p:cNvSpPr/>
            <p:nvPr/>
          </p:nvSpPr>
          <p:spPr>
            <a:xfrm rot="5400000" flipH="1">
              <a:off x="3293421" y="886204"/>
              <a:ext cx="53318" cy="1501727"/>
            </a:xfrm>
            <a:prstGeom prst="leftBrace">
              <a:avLst/>
            </a:prstGeom>
            <a:solidFill>
              <a:schemeClr val="tx1"/>
            </a:solidFill>
            <a:ln w="6350" cap="flat" cmpd="sng" algn="ctr">
              <a:solidFill>
                <a:schemeClr val="tx1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970484" y="1656326"/>
              <a:ext cx="12690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Therapy, </a:t>
              </a:r>
              <a:r>
                <a:rPr kumimoji="0" lang="en-US" sz="8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i.p.</a:t>
              </a:r>
              <a:r>
                <a:rPr kumimoji="0" 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2155724" y="952588"/>
              <a:ext cx="10706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(50-100 mm3) </a:t>
              </a:r>
            </a:p>
          </p:txBody>
        </p:sp>
        <p:grpSp>
          <p:nvGrpSpPr>
            <p:cNvPr id="723" name="Group 722"/>
            <p:cNvGrpSpPr/>
            <p:nvPr/>
          </p:nvGrpSpPr>
          <p:grpSpPr>
            <a:xfrm rot="2739784">
              <a:off x="1787163" y="837011"/>
              <a:ext cx="127898" cy="379314"/>
              <a:chOff x="5010320" y="600992"/>
              <a:chExt cx="387690" cy="830602"/>
            </a:xfrm>
          </p:grpSpPr>
          <p:sp>
            <p:nvSpPr>
              <p:cNvPr id="11" name="Rounded Rectangle 10"/>
              <p:cNvSpPr/>
              <p:nvPr/>
            </p:nvSpPr>
            <p:spPr>
              <a:xfrm>
                <a:off x="5152246" y="724102"/>
                <a:ext cx="138964" cy="558670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cxnSp>
            <p:nvCxnSpPr>
              <p:cNvPr id="707" name="Straight Connector 706"/>
              <p:cNvCxnSpPr/>
              <p:nvPr/>
            </p:nvCxnSpPr>
            <p:spPr>
              <a:xfrm>
                <a:off x="5150731" y="861717"/>
                <a:ext cx="5740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2" name="Straight Connector 201"/>
              <p:cNvCxnSpPr/>
              <p:nvPr/>
            </p:nvCxnSpPr>
            <p:spPr>
              <a:xfrm>
                <a:off x="5146375" y="1014117"/>
                <a:ext cx="5740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7" name="Straight Connector 216"/>
              <p:cNvCxnSpPr/>
              <p:nvPr/>
            </p:nvCxnSpPr>
            <p:spPr>
              <a:xfrm>
                <a:off x="5159438" y="1118621"/>
                <a:ext cx="5740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9" name="Straight Connector 708"/>
              <p:cNvCxnSpPr/>
              <p:nvPr/>
            </p:nvCxnSpPr>
            <p:spPr>
              <a:xfrm>
                <a:off x="5094848" y="600992"/>
                <a:ext cx="2306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3" name="Straight Connector 712"/>
              <p:cNvCxnSpPr>
                <a:endCxn id="11" idx="0"/>
              </p:cNvCxnSpPr>
              <p:nvPr/>
            </p:nvCxnSpPr>
            <p:spPr>
              <a:xfrm flipH="1">
                <a:off x="5221728" y="600992"/>
                <a:ext cx="11077" cy="12311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9" name="Straight Connector 718"/>
              <p:cNvCxnSpPr>
                <a:stCxn id="11" idx="2"/>
              </p:cNvCxnSpPr>
              <p:nvPr/>
            </p:nvCxnSpPr>
            <p:spPr>
              <a:xfrm>
                <a:off x="5221728" y="1282772"/>
                <a:ext cx="5538" cy="14882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1" name="Straight Connector 720"/>
              <p:cNvCxnSpPr/>
              <p:nvPr/>
            </p:nvCxnSpPr>
            <p:spPr>
              <a:xfrm>
                <a:off x="5010320" y="724102"/>
                <a:ext cx="38769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490" name="Rectangle 110"/>
          <p:cNvSpPr>
            <a:spLocks noChangeArrowheads="1"/>
          </p:cNvSpPr>
          <p:nvPr/>
        </p:nvSpPr>
        <p:spPr bwMode="auto">
          <a:xfrm rot="16200000">
            <a:off x="553421" y="5384502"/>
            <a:ext cx="147146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0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Percent survival (%)</a:t>
            </a:r>
            <a:endParaRPr kumimoji="0" lang="en-US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34FDD42-3503-4EDC-A25B-46A764F72796}"/>
              </a:ext>
            </a:extLst>
          </p:cNvPr>
          <p:cNvSpPr txBox="1"/>
          <p:nvPr/>
        </p:nvSpPr>
        <p:spPr>
          <a:xfrm>
            <a:off x="309756" y="6985614"/>
            <a:ext cx="6420057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igure S2. </a:t>
            </a:r>
            <a:r>
              <a:rPr kumimoji="0" lang="en-US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MIC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expressing tumor cells elicited impaired response to anti-PDL1 therapy. </a:t>
            </a:r>
            <a:r>
              <a:rPr kumimoji="0" lang="en-US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</a:t>
            </a: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Depiction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of anti-PDL1 therapy in the syngeneic models. 5x10</a:t>
            </a:r>
            <a:r>
              <a:rPr kumimoji="0" lang="en-US" sz="12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5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TRAMP-C2 (TC2) or engineered </a:t>
            </a: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MICB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-expressing TRAMP-C2 cells (TC2-sMICB) cells were implanted in prostate-specific MICB transgenic MB481 mice. When tumor volume reached 50 to 100 mm3, therapy with </a:t>
            </a: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IgG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or anti-PDL1 antibody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highlight>
                  <a:srgbClr val="FFFF00"/>
                </a:highlight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6 mg/</a:t>
            </a:r>
            <a:r>
              <a:rPr lang="en-US" sz="1200" dirty="0">
                <a:solidFill>
                  <a:prstClr val="black"/>
                </a:solidFill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KG, clone </a:t>
            </a:r>
            <a:r>
              <a:rPr lang="en-US" sz="1200" dirty="0">
                <a:highlight>
                  <a:srgbClr val="FFFF00"/>
                </a:highlight>
                <a:latin typeface="Times New Roman" panose="02020603050405020304" pitchFamily="18" charset="0"/>
                <a:ea typeface="Calibri" panose="020F0502020204030204" pitchFamily="34" charset="0"/>
              </a:rPr>
              <a:t>10F.9G2, </a:t>
            </a:r>
            <a:r>
              <a:rPr lang="en-US" sz="1200" dirty="0" err="1">
                <a:highlight>
                  <a:srgbClr val="FFFF00"/>
                </a:highlight>
                <a:latin typeface="Times New Roman" panose="02020603050405020304" pitchFamily="18" charset="0"/>
                <a:ea typeface="Calibri" panose="020F0502020204030204" pitchFamily="34" charset="0"/>
              </a:rPr>
              <a:t>BioXcell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highlight>
                  <a:srgbClr val="FFFF00"/>
                </a:highlight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wice weekly began. Tumor volume of 1300mm</a:t>
            </a:r>
            <a:r>
              <a:rPr kumimoji="0" lang="en-US" sz="12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3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was defined as survival endpoint.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and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 Tumor growth curve of with or without α-PD-L1 (Clone 10F.9G2, </a:t>
            </a: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ioxcell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, Cat # BP0101) therapy.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d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 Kaplan-Meier survival curve.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te, tumor growth curve only plotted when all animals are alive. *p&lt;0.05. ns, not significant.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</a:p>
        </p:txBody>
      </p:sp>
      <p:graphicFrame>
        <p:nvGraphicFramePr>
          <p:cNvPr id="167" name="Chart 166">
            <a:extLst>
              <a:ext uri="{FF2B5EF4-FFF2-40B4-BE49-F238E27FC236}">
                <a16:creationId xmlns:a16="http://schemas.microsoft.com/office/drawing/2014/main" id="{0AFE4FA6-5E47-48C1-9A4A-30AE94B0444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0231172"/>
              </p:ext>
            </p:extLst>
          </p:nvPr>
        </p:nvGraphicFramePr>
        <p:xfrm>
          <a:off x="3661170" y="2201519"/>
          <a:ext cx="1870411" cy="16704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68" name="Chart 167">
            <a:extLst>
              <a:ext uri="{FF2B5EF4-FFF2-40B4-BE49-F238E27FC236}">
                <a16:creationId xmlns:a16="http://schemas.microsoft.com/office/drawing/2014/main" id="{35A147DA-F60B-45DD-9ED9-7A49B40B8A1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02467098"/>
              </p:ext>
            </p:extLst>
          </p:nvPr>
        </p:nvGraphicFramePr>
        <p:xfrm>
          <a:off x="1491679" y="2213234"/>
          <a:ext cx="1598416" cy="17245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70" name="TextBox 169">
            <a:extLst>
              <a:ext uri="{FF2B5EF4-FFF2-40B4-BE49-F238E27FC236}">
                <a16:creationId xmlns:a16="http://schemas.microsoft.com/office/drawing/2014/main" id="{1194DB14-DBAA-4864-9FA7-A0CC421BE7E3}"/>
              </a:ext>
            </a:extLst>
          </p:cNvPr>
          <p:cNvSpPr txBox="1"/>
          <p:nvPr/>
        </p:nvSpPr>
        <p:spPr>
          <a:xfrm>
            <a:off x="1690559" y="3985683"/>
            <a:ext cx="14814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ays of treatment</a:t>
            </a: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F589C2EB-17A7-478A-803D-E69B49EBBA5C}"/>
              </a:ext>
            </a:extLst>
          </p:cNvPr>
          <p:cNvSpPr txBox="1"/>
          <p:nvPr/>
        </p:nvSpPr>
        <p:spPr>
          <a:xfrm rot="16200000">
            <a:off x="470369" y="2997586"/>
            <a:ext cx="17105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umor volume (mm</a:t>
            </a:r>
            <a:r>
              <a:rPr lang="en-US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83" name="Rectangle 61">
            <a:extLst>
              <a:ext uri="{FF2B5EF4-FFF2-40B4-BE49-F238E27FC236}">
                <a16:creationId xmlns:a16="http://schemas.microsoft.com/office/drawing/2014/main" id="{0B795770-E357-4945-9E1C-419A30366F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38376" y="6583338"/>
            <a:ext cx="118942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Days of treatment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706" name="Rectangle 254">
            <a:extLst>
              <a:ext uri="{FF2B5EF4-FFF2-40B4-BE49-F238E27FC236}">
                <a16:creationId xmlns:a16="http://schemas.microsoft.com/office/drawing/2014/main" id="{A2AA1945-F661-49E1-B497-B96568AF9A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68752" y="5394326"/>
            <a:ext cx="639762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TC2 control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08" name="Freeform 255">
            <a:extLst>
              <a:ext uri="{FF2B5EF4-FFF2-40B4-BE49-F238E27FC236}">
                <a16:creationId xmlns:a16="http://schemas.microsoft.com/office/drawing/2014/main" id="{41124BDE-FD23-4B96-8F3C-3F7E2EA33034}"/>
              </a:ext>
            </a:extLst>
          </p:cNvPr>
          <p:cNvSpPr>
            <a:spLocks noEditPoints="1"/>
          </p:cNvSpPr>
          <p:nvPr/>
        </p:nvSpPr>
        <p:spPr bwMode="auto">
          <a:xfrm>
            <a:off x="4665540" y="5445126"/>
            <a:ext cx="195262" cy="19050"/>
          </a:xfrm>
          <a:custGeom>
            <a:avLst/>
            <a:gdLst>
              <a:gd name="T0" fmla="*/ 0 w 328"/>
              <a:gd name="T1" fmla="*/ 0 h 30"/>
              <a:gd name="T2" fmla="*/ 62 w 328"/>
              <a:gd name="T3" fmla="*/ 0 h 30"/>
              <a:gd name="T4" fmla="*/ 77 w 328"/>
              <a:gd name="T5" fmla="*/ 15 h 30"/>
              <a:gd name="T6" fmla="*/ 62 w 328"/>
              <a:gd name="T7" fmla="*/ 30 h 30"/>
              <a:gd name="T8" fmla="*/ 0 w 328"/>
              <a:gd name="T9" fmla="*/ 30 h 30"/>
              <a:gd name="T10" fmla="*/ 0 w 328"/>
              <a:gd name="T11" fmla="*/ 0 h 30"/>
              <a:gd name="T12" fmla="*/ 154 w 328"/>
              <a:gd name="T13" fmla="*/ 0 h 30"/>
              <a:gd name="T14" fmla="*/ 215 w 328"/>
              <a:gd name="T15" fmla="*/ 0 h 30"/>
              <a:gd name="T16" fmla="*/ 231 w 328"/>
              <a:gd name="T17" fmla="*/ 15 h 30"/>
              <a:gd name="T18" fmla="*/ 215 w 328"/>
              <a:gd name="T19" fmla="*/ 30 h 30"/>
              <a:gd name="T20" fmla="*/ 154 w 328"/>
              <a:gd name="T21" fmla="*/ 30 h 30"/>
              <a:gd name="T22" fmla="*/ 139 w 328"/>
              <a:gd name="T23" fmla="*/ 15 h 30"/>
              <a:gd name="T24" fmla="*/ 154 w 328"/>
              <a:gd name="T25" fmla="*/ 0 h 30"/>
              <a:gd name="T26" fmla="*/ 308 w 328"/>
              <a:gd name="T27" fmla="*/ 0 h 30"/>
              <a:gd name="T28" fmla="*/ 328 w 328"/>
              <a:gd name="T29" fmla="*/ 0 h 30"/>
              <a:gd name="T30" fmla="*/ 328 w 328"/>
              <a:gd name="T31" fmla="*/ 30 h 30"/>
              <a:gd name="T32" fmla="*/ 308 w 328"/>
              <a:gd name="T33" fmla="*/ 30 h 30"/>
              <a:gd name="T34" fmla="*/ 292 w 328"/>
              <a:gd name="T35" fmla="*/ 15 h 30"/>
              <a:gd name="T36" fmla="*/ 308 w 328"/>
              <a:gd name="T37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</a:cxnLst>
            <a:rect l="0" t="0" r="r" b="b"/>
            <a:pathLst>
              <a:path w="328" h="30">
                <a:moveTo>
                  <a:pt x="0" y="0"/>
                </a:moveTo>
                <a:lnTo>
                  <a:pt x="62" y="0"/>
                </a:lnTo>
                <a:cubicBezTo>
                  <a:pt x="70" y="0"/>
                  <a:pt x="77" y="6"/>
                  <a:pt x="77" y="15"/>
                </a:cubicBezTo>
                <a:cubicBezTo>
                  <a:pt x="77" y="23"/>
                  <a:pt x="70" y="30"/>
                  <a:pt x="62" y="30"/>
                </a:cubicBezTo>
                <a:lnTo>
                  <a:pt x="0" y="30"/>
                </a:lnTo>
                <a:lnTo>
                  <a:pt x="0" y="0"/>
                </a:lnTo>
                <a:close/>
                <a:moveTo>
                  <a:pt x="154" y="0"/>
                </a:moveTo>
                <a:lnTo>
                  <a:pt x="215" y="0"/>
                </a:lnTo>
                <a:cubicBezTo>
                  <a:pt x="224" y="0"/>
                  <a:pt x="231" y="6"/>
                  <a:pt x="231" y="15"/>
                </a:cubicBezTo>
                <a:cubicBezTo>
                  <a:pt x="231" y="23"/>
                  <a:pt x="224" y="30"/>
                  <a:pt x="215" y="30"/>
                </a:cubicBezTo>
                <a:lnTo>
                  <a:pt x="154" y="30"/>
                </a:lnTo>
                <a:cubicBezTo>
                  <a:pt x="146" y="30"/>
                  <a:pt x="139" y="23"/>
                  <a:pt x="139" y="15"/>
                </a:cubicBezTo>
                <a:cubicBezTo>
                  <a:pt x="139" y="6"/>
                  <a:pt x="146" y="0"/>
                  <a:pt x="154" y="0"/>
                </a:cubicBezTo>
                <a:close/>
                <a:moveTo>
                  <a:pt x="308" y="0"/>
                </a:moveTo>
                <a:lnTo>
                  <a:pt x="328" y="0"/>
                </a:lnTo>
                <a:lnTo>
                  <a:pt x="328" y="30"/>
                </a:lnTo>
                <a:lnTo>
                  <a:pt x="308" y="30"/>
                </a:lnTo>
                <a:cubicBezTo>
                  <a:pt x="299" y="30"/>
                  <a:pt x="292" y="23"/>
                  <a:pt x="292" y="15"/>
                </a:cubicBezTo>
                <a:cubicBezTo>
                  <a:pt x="292" y="6"/>
                  <a:pt x="299" y="0"/>
                  <a:pt x="308" y="0"/>
                </a:cubicBezTo>
                <a:close/>
              </a:path>
            </a:pathLst>
          </a:custGeom>
          <a:solidFill>
            <a:srgbClr val="0000C0"/>
          </a:solidFill>
          <a:ln w="1588" cap="flat">
            <a:solidFill>
              <a:srgbClr val="0000C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710" name="Line 256">
            <a:extLst>
              <a:ext uri="{FF2B5EF4-FFF2-40B4-BE49-F238E27FC236}">
                <a16:creationId xmlns:a16="http://schemas.microsoft.com/office/drawing/2014/main" id="{6E542407-8137-411F-AB5A-E374F3735E71}"/>
              </a:ext>
            </a:extLst>
          </p:cNvPr>
          <p:cNvSpPr>
            <a:spLocks noChangeShapeType="1"/>
          </p:cNvSpPr>
          <p:nvPr/>
        </p:nvSpPr>
        <p:spPr bwMode="auto">
          <a:xfrm>
            <a:off x="4762377" y="5418138"/>
            <a:ext cx="0" cy="36513"/>
          </a:xfrm>
          <a:prstGeom prst="line">
            <a:avLst/>
          </a:prstGeom>
          <a:noFill/>
          <a:ln w="19050" cap="flat">
            <a:solidFill>
              <a:srgbClr val="000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711" name="Rectangle 257">
            <a:extLst>
              <a:ext uri="{FF2B5EF4-FFF2-40B4-BE49-F238E27FC236}">
                <a16:creationId xmlns:a16="http://schemas.microsoft.com/office/drawing/2014/main" id="{9FBFF545-AD8E-4BB8-A259-9C7BBC3899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68752" y="5605463"/>
            <a:ext cx="877887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TC2 with aPDL1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12" name="Freeform 258">
            <a:extLst>
              <a:ext uri="{FF2B5EF4-FFF2-40B4-BE49-F238E27FC236}">
                <a16:creationId xmlns:a16="http://schemas.microsoft.com/office/drawing/2014/main" id="{F43D084E-C3DD-4DDB-99A1-79C0EB5FF480}"/>
              </a:ext>
            </a:extLst>
          </p:cNvPr>
          <p:cNvSpPr>
            <a:spLocks noEditPoints="1"/>
          </p:cNvSpPr>
          <p:nvPr/>
        </p:nvSpPr>
        <p:spPr bwMode="auto">
          <a:xfrm>
            <a:off x="4665540" y="5656263"/>
            <a:ext cx="195262" cy="19050"/>
          </a:xfrm>
          <a:custGeom>
            <a:avLst/>
            <a:gdLst>
              <a:gd name="T0" fmla="*/ 0 w 328"/>
              <a:gd name="T1" fmla="*/ 0 h 31"/>
              <a:gd name="T2" fmla="*/ 62 w 328"/>
              <a:gd name="T3" fmla="*/ 0 h 31"/>
              <a:gd name="T4" fmla="*/ 77 w 328"/>
              <a:gd name="T5" fmla="*/ 15 h 31"/>
              <a:gd name="T6" fmla="*/ 62 w 328"/>
              <a:gd name="T7" fmla="*/ 31 h 31"/>
              <a:gd name="T8" fmla="*/ 0 w 328"/>
              <a:gd name="T9" fmla="*/ 31 h 31"/>
              <a:gd name="T10" fmla="*/ 0 w 328"/>
              <a:gd name="T11" fmla="*/ 0 h 31"/>
              <a:gd name="T12" fmla="*/ 154 w 328"/>
              <a:gd name="T13" fmla="*/ 0 h 31"/>
              <a:gd name="T14" fmla="*/ 215 w 328"/>
              <a:gd name="T15" fmla="*/ 0 h 31"/>
              <a:gd name="T16" fmla="*/ 231 w 328"/>
              <a:gd name="T17" fmla="*/ 15 h 31"/>
              <a:gd name="T18" fmla="*/ 215 w 328"/>
              <a:gd name="T19" fmla="*/ 31 h 31"/>
              <a:gd name="T20" fmla="*/ 154 w 328"/>
              <a:gd name="T21" fmla="*/ 31 h 31"/>
              <a:gd name="T22" fmla="*/ 139 w 328"/>
              <a:gd name="T23" fmla="*/ 15 h 31"/>
              <a:gd name="T24" fmla="*/ 154 w 328"/>
              <a:gd name="T25" fmla="*/ 0 h 31"/>
              <a:gd name="T26" fmla="*/ 308 w 328"/>
              <a:gd name="T27" fmla="*/ 0 h 31"/>
              <a:gd name="T28" fmla="*/ 328 w 328"/>
              <a:gd name="T29" fmla="*/ 0 h 31"/>
              <a:gd name="T30" fmla="*/ 328 w 328"/>
              <a:gd name="T31" fmla="*/ 31 h 31"/>
              <a:gd name="T32" fmla="*/ 308 w 328"/>
              <a:gd name="T33" fmla="*/ 31 h 31"/>
              <a:gd name="T34" fmla="*/ 292 w 328"/>
              <a:gd name="T35" fmla="*/ 15 h 31"/>
              <a:gd name="T36" fmla="*/ 308 w 328"/>
              <a:gd name="T37" fmla="*/ 0 h 3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</a:cxnLst>
            <a:rect l="0" t="0" r="r" b="b"/>
            <a:pathLst>
              <a:path w="328" h="31">
                <a:moveTo>
                  <a:pt x="0" y="0"/>
                </a:moveTo>
                <a:lnTo>
                  <a:pt x="62" y="0"/>
                </a:lnTo>
                <a:cubicBezTo>
                  <a:pt x="70" y="0"/>
                  <a:pt x="77" y="7"/>
                  <a:pt x="77" y="15"/>
                </a:cubicBezTo>
                <a:cubicBezTo>
                  <a:pt x="77" y="24"/>
                  <a:pt x="70" y="31"/>
                  <a:pt x="62" y="31"/>
                </a:cubicBezTo>
                <a:lnTo>
                  <a:pt x="0" y="31"/>
                </a:lnTo>
                <a:lnTo>
                  <a:pt x="0" y="0"/>
                </a:lnTo>
                <a:close/>
                <a:moveTo>
                  <a:pt x="154" y="0"/>
                </a:moveTo>
                <a:lnTo>
                  <a:pt x="215" y="0"/>
                </a:lnTo>
                <a:cubicBezTo>
                  <a:pt x="224" y="0"/>
                  <a:pt x="231" y="7"/>
                  <a:pt x="231" y="15"/>
                </a:cubicBezTo>
                <a:cubicBezTo>
                  <a:pt x="231" y="24"/>
                  <a:pt x="224" y="31"/>
                  <a:pt x="215" y="31"/>
                </a:cubicBezTo>
                <a:lnTo>
                  <a:pt x="154" y="31"/>
                </a:lnTo>
                <a:cubicBezTo>
                  <a:pt x="146" y="31"/>
                  <a:pt x="139" y="24"/>
                  <a:pt x="139" y="15"/>
                </a:cubicBezTo>
                <a:cubicBezTo>
                  <a:pt x="139" y="7"/>
                  <a:pt x="146" y="0"/>
                  <a:pt x="154" y="0"/>
                </a:cubicBezTo>
                <a:close/>
                <a:moveTo>
                  <a:pt x="308" y="0"/>
                </a:moveTo>
                <a:lnTo>
                  <a:pt x="328" y="0"/>
                </a:lnTo>
                <a:lnTo>
                  <a:pt x="328" y="31"/>
                </a:lnTo>
                <a:lnTo>
                  <a:pt x="308" y="31"/>
                </a:lnTo>
                <a:cubicBezTo>
                  <a:pt x="299" y="31"/>
                  <a:pt x="292" y="24"/>
                  <a:pt x="292" y="15"/>
                </a:cubicBezTo>
                <a:cubicBezTo>
                  <a:pt x="292" y="7"/>
                  <a:pt x="299" y="0"/>
                  <a:pt x="308" y="0"/>
                </a:cubicBezTo>
                <a:close/>
              </a:path>
            </a:pathLst>
          </a:custGeom>
          <a:solidFill>
            <a:srgbClr val="FF0000"/>
          </a:solidFill>
          <a:ln w="1588" cap="flat">
            <a:solidFill>
              <a:srgbClr val="FF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714" name="Line 259">
            <a:extLst>
              <a:ext uri="{FF2B5EF4-FFF2-40B4-BE49-F238E27FC236}">
                <a16:creationId xmlns:a16="http://schemas.microsoft.com/office/drawing/2014/main" id="{F7330716-1816-4B3B-821E-7B98D834C0A5}"/>
              </a:ext>
            </a:extLst>
          </p:cNvPr>
          <p:cNvSpPr>
            <a:spLocks noChangeShapeType="1"/>
          </p:cNvSpPr>
          <p:nvPr/>
        </p:nvSpPr>
        <p:spPr bwMode="auto">
          <a:xfrm>
            <a:off x="4762377" y="5629276"/>
            <a:ext cx="0" cy="36513"/>
          </a:xfrm>
          <a:prstGeom prst="line">
            <a:avLst/>
          </a:prstGeom>
          <a:noFill/>
          <a:ln w="1905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715" name="Rectangle 260">
            <a:extLst>
              <a:ext uri="{FF2B5EF4-FFF2-40B4-BE49-F238E27FC236}">
                <a16:creationId xmlns:a16="http://schemas.microsoft.com/office/drawing/2014/main" id="{EE5498AB-0CB0-4700-9505-7B1976B2CB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68752" y="5184776"/>
            <a:ext cx="1184275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TC2-sMIC with aPDL1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16" name="Line 261">
            <a:extLst>
              <a:ext uri="{FF2B5EF4-FFF2-40B4-BE49-F238E27FC236}">
                <a16:creationId xmlns:a16="http://schemas.microsoft.com/office/drawing/2014/main" id="{3BD03C24-74A6-4CCD-996A-74181CA5544D}"/>
              </a:ext>
            </a:extLst>
          </p:cNvPr>
          <p:cNvSpPr>
            <a:spLocks noChangeShapeType="1"/>
          </p:cNvSpPr>
          <p:nvPr/>
        </p:nvSpPr>
        <p:spPr bwMode="auto">
          <a:xfrm>
            <a:off x="4665540" y="5243513"/>
            <a:ext cx="195262" cy="0"/>
          </a:xfrm>
          <a:prstGeom prst="line">
            <a:avLst/>
          </a:prstGeom>
          <a:noFill/>
          <a:ln w="1905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717" name="Line 262">
            <a:extLst>
              <a:ext uri="{FF2B5EF4-FFF2-40B4-BE49-F238E27FC236}">
                <a16:creationId xmlns:a16="http://schemas.microsoft.com/office/drawing/2014/main" id="{C7DBEE3D-396A-4E74-8CF6-82D983A44B78}"/>
              </a:ext>
            </a:extLst>
          </p:cNvPr>
          <p:cNvSpPr>
            <a:spLocks noChangeShapeType="1"/>
          </p:cNvSpPr>
          <p:nvPr/>
        </p:nvSpPr>
        <p:spPr bwMode="auto">
          <a:xfrm>
            <a:off x="4762377" y="5207001"/>
            <a:ext cx="0" cy="36513"/>
          </a:xfrm>
          <a:prstGeom prst="line">
            <a:avLst/>
          </a:prstGeom>
          <a:noFill/>
          <a:ln w="9525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718" name="Rectangle 263">
            <a:extLst>
              <a:ext uri="{FF2B5EF4-FFF2-40B4-BE49-F238E27FC236}">
                <a16:creationId xmlns:a16="http://schemas.microsoft.com/office/drawing/2014/main" id="{8A69E6C2-3D57-49DB-8B5E-A8B5EB5486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68752" y="4973638"/>
            <a:ext cx="944562" cy="14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TC2-sMIC control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20" name="Line 264">
            <a:extLst>
              <a:ext uri="{FF2B5EF4-FFF2-40B4-BE49-F238E27FC236}">
                <a16:creationId xmlns:a16="http://schemas.microsoft.com/office/drawing/2014/main" id="{424CF0E5-CA94-46F5-91A8-A03CBD4773A2}"/>
              </a:ext>
            </a:extLst>
          </p:cNvPr>
          <p:cNvSpPr>
            <a:spLocks noChangeShapeType="1"/>
          </p:cNvSpPr>
          <p:nvPr/>
        </p:nvSpPr>
        <p:spPr bwMode="auto">
          <a:xfrm>
            <a:off x="4665540" y="5032376"/>
            <a:ext cx="195262" cy="0"/>
          </a:xfrm>
          <a:prstGeom prst="line">
            <a:avLst/>
          </a:prstGeom>
          <a:noFill/>
          <a:ln w="19050" cap="flat">
            <a:solidFill>
              <a:srgbClr val="000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722" name="Line 265">
            <a:extLst>
              <a:ext uri="{FF2B5EF4-FFF2-40B4-BE49-F238E27FC236}">
                <a16:creationId xmlns:a16="http://schemas.microsoft.com/office/drawing/2014/main" id="{8B6339EE-AEF5-43F1-B4A5-C8C1FA7874F6}"/>
              </a:ext>
            </a:extLst>
          </p:cNvPr>
          <p:cNvSpPr>
            <a:spLocks noChangeShapeType="1"/>
          </p:cNvSpPr>
          <p:nvPr/>
        </p:nvSpPr>
        <p:spPr bwMode="auto">
          <a:xfrm>
            <a:off x="4762377" y="4995863"/>
            <a:ext cx="0" cy="36513"/>
          </a:xfrm>
          <a:prstGeom prst="line">
            <a:avLst/>
          </a:prstGeom>
          <a:noFill/>
          <a:ln w="9525" cap="flat">
            <a:solidFill>
              <a:srgbClr val="0000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12" name="TextBox 511">
            <a:extLst>
              <a:ext uri="{FF2B5EF4-FFF2-40B4-BE49-F238E27FC236}">
                <a16:creationId xmlns:a16="http://schemas.microsoft.com/office/drawing/2014/main" id="{BAF9C826-C154-41C5-A9DF-8A27C1803334}"/>
              </a:ext>
            </a:extLst>
          </p:cNvPr>
          <p:cNvSpPr txBox="1"/>
          <p:nvPr/>
        </p:nvSpPr>
        <p:spPr>
          <a:xfrm>
            <a:off x="580858" y="4409685"/>
            <a:ext cx="321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.</a:t>
            </a:r>
          </a:p>
        </p:txBody>
      </p:sp>
      <p:grpSp>
        <p:nvGrpSpPr>
          <p:cNvPr id="731" name="Group 730">
            <a:extLst>
              <a:ext uri="{FF2B5EF4-FFF2-40B4-BE49-F238E27FC236}">
                <a16:creationId xmlns:a16="http://schemas.microsoft.com/office/drawing/2014/main" id="{3FB9C4A8-92C9-43A4-80A6-470A85ABC146}"/>
              </a:ext>
            </a:extLst>
          </p:cNvPr>
          <p:cNvGrpSpPr/>
          <p:nvPr/>
        </p:nvGrpSpPr>
        <p:grpSpPr>
          <a:xfrm>
            <a:off x="2975796" y="2743200"/>
            <a:ext cx="181742" cy="530139"/>
            <a:chOff x="2975796" y="2743200"/>
            <a:chExt cx="181742" cy="530139"/>
          </a:xfrm>
        </p:grpSpPr>
        <p:cxnSp>
          <p:nvCxnSpPr>
            <p:cNvPr id="728" name="Straight Connector 727">
              <a:extLst>
                <a:ext uri="{FF2B5EF4-FFF2-40B4-BE49-F238E27FC236}">
                  <a16:creationId xmlns:a16="http://schemas.microsoft.com/office/drawing/2014/main" id="{57B73CF9-C44E-47A3-921E-FB381290D19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048793" y="2743200"/>
              <a:ext cx="1" cy="53013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30" name="TextBox 729">
              <a:extLst>
                <a:ext uri="{FF2B5EF4-FFF2-40B4-BE49-F238E27FC236}">
                  <a16:creationId xmlns:a16="http://schemas.microsoft.com/office/drawing/2014/main" id="{62EDF102-DAF3-4351-B888-DF4855CDF219}"/>
                </a:ext>
              </a:extLst>
            </p:cNvPr>
            <p:cNvSpPr txBox="1"/>
            <p:nvPr/>
          </p:nvSpPr>
          <p:spPr>
            <a:xfrm>
              <a:off x="2975796" y="2894966"/>
              <a:ext cx="1817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*</a:t>
              </a:r>
            </a:p>
          </p:txBody>
        </p:sp>
      </p:grpSp>
      <p:grpSp>
        <p:nvGrpSpPr>
          <p:cNvPr id="513" name="Group 512">
            <a:extLst>
              <a:ext uri="{FF2B5EF4-FFF2-40B4-BE49-F238E27FC236}">
                <a16:creationId xmlns:a16="http://schemas.microsoft.com/office/drawing/2014/main" id="{607658BF-F9E1-4C3F-B73D-54AFA60AEE8E}"/>
              </a:ext>
            </a:extLst>
          </p:cNvPr>
          <p:cNvGrpSpPr/>
          <p:nvPr/>
        </p:nvGrpSpPr>
        <p:grpSpPr>
          <a:xfrm rot="16200000">
            <a:off x="3842167" y="5938500"/>
            <a:ext cx="259754" cy="386062"/>
            <a:chOff x="3014598" y="2743200"/>
            <a:chExt cx="170427" cy="530139"/>
          </a:xfrm>
        </p:grpSpPr>
        <p:cxnSp>
          <p:nvCxnSpPr>
            <p:cNvPr id="514" name="Straight Connector 513">
              <a:extLst>
                <a:ext uri="{FF2B5EF4-FFF2-40B4-BE49-F238E27FC236}">
                  <a16:creationId xmlns:a16="http://schemas.microsoft.com/office/drawing/2014/main" id="{CFCA4452-781C-4559-B788-55B31AE8EEE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048793" y="2743200"/>
              <a:ext cx="1" cy="53013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15" name="TextBox 514">
              <a:extLst>
                <a:ext uri="{FF2B5EF4-FFF2-40B4-BE49-F238E27FC236}">
                  <a16:creationId xmlns:a16="http://schemas.microsoft.com/office/drawing/2014/main" id="{C33AA0A3-9EEB-49CB-8E0D-512266A4E6D4}"/>
                </a:ext>
              </a:extLst>
            </p:cNvPr>
            <p:cNvSpPr txBox="1"/>
            <p:nvPr/>
          </p:nvSpPr>
          <p:spPr>
            <a:xfrm>
              <a:off x="3014598" y="2852776"/>
              <a:ext cx="170427" cy="3592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*</a:t>
              </a:r>
            </a:p>
          </p:txBody>
        </p:sp>
      </p:grpSp>
      <p:cxnSp>
        <p:nvCxnSpPr>
          <p:cNvPr id="517" name="Straight Connector 516">
            <a:extLst>
              <a:ext uri="{FF2B5EF4-FFF2-40B4-BE49-F238E27FC236}">
                <a16:creationId xmlns:a16="http://schemas.microsoft.com/office/drawing/2014/main" id="{E2490AF2-DF71-4426-8995-628EE44AD5FF}"/>
              </a:ext>
            </a:extLst>
          </p:cNvPr>
          <p:cNvCxnSpPr>
            <a:cxnSpLocks/>
          </p:cNvCxnSpPr>
          <p:nvPr/>
        </p:nvCxnSpPr>
        <p:spPr>
          <a:xfrm flipH="1">
            <a:off x="5260815" y="2702314"/>
            <a:ext cx="1" cy="21236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8" name="TextBox 517">
            <a:extLst>
              <a:ext uri="{FF2B5EF4-FFF2-40B4-BE49-F238E27FC236}">
                <a16:creationId xmlns:a16="http://schemas.microsoft.com/office/drawing/2014/main" id="{A66F69B6-EB39-43DC-9AE1-960F25939407}"/>
              </a:ext>
            </a:extLst>
          </p:cNvPr>
          <p:cNvSpPr txBox="1"/>
          <p:nvPr/>
        </p:nvSpPr>
        <p:spPr>
          <a:xfrm>
            <a:off x="5203205" y="2656947"/>
            <a:ext cx="3262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ns</a:t>
            </a:r>
          </a:p>
        </p:txBody>
      </p:sp>
      <p:grpSp>
        <p:nvGrpSpPr>
          <p:cNvPr id="571" name="Group 570">
            <a:extLst>
              <a:ext uri="{FF2B5EF4-FFF2-40B4-BE49-F238E27FC236}">
                <a16:creationId xmlns:a16="http://schemas.microsoft.com/office/drawing/2014/main" id="{60CAB711-6D3E-4CE0-BDAA-55C4D6CA743E}"/>
              </a:ext>
            </a:extLst>
          </p:cNvPr>
          <p:cNvGrpSpPr/>
          <p:nvPr/>
        </p:nvGrpSpPr>
        <p:grpSpPr>
          <a:xfrm>
            <a:off x="1418399" y="4865606"/>
            <a:ext cx="3121025" cy="1670050"/>
            <a:chOff x="-3651250" y="4959350"/>
            <a:chExt cx="3121025" cy="1670050"/>
          </a:xfrm>
        </p:grpSpPr>
        <p:sp>
          <p:nvSpPr>
            <p:cNvPr id="735" name="Rectangle 269">
              <a:extLst>
                <a:ext uri="{FF2B5EF4-FFF2-40B4-BE49-F238E27FC236}">
                  <a16:creationId xmlns:a16="http://schemas.microsoft.com/office/drawing/2014/main" id="{5CD481E2-3853-456A-B1BC-619BDB88B4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3411537" y="6486525"/>
              <a:ext cx="114300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6" name="Rectangle 270">
              <a:extLst>
                <a:ext uri="{FF2B5EF4-FFF2-40B4-BE49-F238E27FC236}">
                  <a16:creationId xmlns:a16="http://schemas.microsoft.com/office/drawing/2014/main" id="{97483EE3-240D-4464-AB1F-103445FA38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3221037" y="6486525"/>
              <a:ext cx="114300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7" name="Rectangle 271">
              <a:extLst>
                <a:ext uri="{FF2B5EF4-FFF2-40B4-BE49-F238E27FC236}">
                  <a16:creationId xmlns:a16="http://schemas.microsoft.com/office/drawing/2014/main" id="{EA1DACF7-E9DA-4A61-B5DE-947DFE50F0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3021012" y="6486525"/>
              <a:ext cx="114300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8" name="Rectangle 272">
              <a:extLst>
                <a:ext uri="{FF2B5EF4-FFF2-40B4-BE49-F238E27FC236}">
                  <a16:creationId xmlns:a16="http://schemas.microsoft.com/office/drawing/2014/main" id="{DA16FB8A-23FC-424A-BA4D-B7A3A9E5B1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2859087" y="6486525"/>
              <a:ext cx="171450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9" name="Rectangle 273">
              <a:extLst>
                <a:ext uri="{FF2B5EF4-FFF2-40B4-BE49-F238E27FC236}">
                  <a16:creationId xmlns:a16="http://schemas.microsoft.com/office/drawing/2014/main" id="{F2195D45-C030-4BE0-B842-41FC83027C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2657475" y="6486525"/>
              <a:ext cx="171450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0" name="Rectangle 274">
              <a:extLst>
                <a:ext uri="{FF2B5EF4-FFF2-40B4-BE49-F238E27FC236}">
                  <a16:creationId xmlns:a16="http://schemas.microsoft.com/office/drawing/2014/main" id="{579E9C88-84CA-4EEA-B672-E1CB04C852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2466975" y="6486525"/>
              <a:ext cx="171450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1" name="Rectangle 275">
              <a:extLst>
                <a:ext uri="{FF2B5EF4-FFF2-40B4-BE49-F238E27FC236}">
                  <a16:creationId xmlns:a16="http://schemas.microsoft.com/office/drawing/2014/main" id="{17A59AF5-9EC9-4F01-83B6-5C4224E8EF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2266950" y="6486525"/>
              <a:ext cx="171450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2" name="Rectangle 276">
              <a:extLst>
                <a:ext uri="{FF2B5EF4-FFF2-40B4-BE49-F238E27FC236}">
                  <a16:creationId xmlns:a16="http://schemas.microsoft.com/office/drawing/2014/main" id="{2E1DF6AD-AB70-4EF4-B5E1-C7E1417BD7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2076450" y="6486525"/>
              <a:ext cx="171450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3" name="Rectangle 277">
              <a:extLst>
                <a:ext uri="{FF2B5EF4-FFF2-40B4-BE49-F238E27FC236}">
                  <a16:creationId xmlns:a16="http://schemas.microsoft.com/office/drawing/2014/main" id="{BA7C5703-B693-47B6-ACD2-6F47D620AB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874837" y="6486525"/>
              <a:ext cx="171450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7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4" name="Rectangle 278">
              <a:extLst>
                <a:ext uri="{FF2B5EF4-FFF2-40B4-BE49-F238E27FC236}">
                  <a16:creationId xmlns:a16="http://schemas.microsoft.com/office/drawing/2014/main" id="{C7DC2981-1325-4B83-BD1A-24B16CECE7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674812" y="6486525"/>
              <a:ext cx="171450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5" name="Rectangle 279">
              <a:extLst>
                <a:ext uri="{FF2B5EF4-FFF2-40B4-BE49-F238E27FC236}">
                  <a16:creationId xmlns:a16="http://schemas.microsoft.com/office/drawing/2014/main" id="{1ADD595B-F8D3-4384-B523-4DE43B0A1C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484312" y="6486525"/>
              <a:ext cx="171450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3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6" name="Rectangle 280">
              <a:extLst>
                <a:ext uri="{FF2B5EF4-FFF2-40B4-BE49-F238E27FC236}">
                  <a16:creationId xmlns:a16="http://schemas.microsoft.com/office/drawing/2014/main" id="{D7067938-945F-4086-886F-0E85D2F956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282700" y="6486525"/>
              <a:ext cx="171450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7" name="Rectangle 281">
              <a:extLst>
                <a:ext uri="{FF2B5EF4-FFF2-40B4-BE49-F238E27FC236}">
                  <a16:creationId xmlns:a16="http://schemas.microsoft.com/office/drawing/2014/main" id="{7C6BF12F-5081-43A0-91EF-E78BC469E0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092200" y="6486525"/>
              <a:ext cx="171450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8" name="Rectangle 282">
              <a:extLst>
                <a:ext uri="{FF2B5EF4-FFF2-40B4-BE49-F238E27FC236}">
                  <a16:creationId xmlns:a16="http://schemas.microsoft.com/office/drawing/2014/main" id="{2209A810-C577-4F81-88C7-D08E3E597A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892175" y="6486525"/>
              <a:ext cx="171450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9" name="Rectangle 283">
              <a:extLst>
                <a:ext uri="{FF2B5EF4-FFF2-40B4-BE49-F238E27FC236}">
                  <a16:creationId xmlns:a16="http://schemas.microsoft.com/office/drawing/2014/main" id="{276C3B06-4797-4865-8213-D24F8FF24C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701675" y="6486525"/>
              <a:ext cx="171450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0" name="Freeform 284">
              <a:extLst>
                <a:ext uri="{FF2B5EF4-FFF2-40B4-BE49-F238E27FC236}">
                  <a16:creationId xmlns:a16="http://schemas.microsoft.com/office/drawing/2014/main" id="{DD0A235A-0990-4921-B270-E70F06E4CC8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-3389312" y="6416675"/>
              <a:ext cx="2767013" cy="50800"/>
            </a:xfrm>
            <a:custGeom>
              <a:avLst/>
              <a:gdLst>
                <a:gd name="T0" fmla="*/ 0 w 1743"/>
                <a:gd name="T1" fmla="*/ 0 h 32"/>
                <a:gd name="T2" fmla="*/ 1743 w 1743"/>
                <a:gd name="T3" fmla="*/ 0 h 32"/>
                <a:gd name="T4" fmla="*/ 6 w 1743"/>
                <a:gd name="T5" fmla="*/ 0 h 32"/>
                <a:gd name="T6" fmla="*/ 6 w 1743"/>
                <a:gd name="T7" fmla="*/ 32 h 32"/>
                <a:gd name="T8" fmla="*/ 129 w 1743"/>
                <a:gd name="T9" fmla="*/ 0 h 32"/>
                <a:gd name="T10" fmla="*/ 129 w 1743"/>
                <a:gd name="T11" fmla="*/ 32 h 32"/>
                <a:gd name="T12" fmla="*/ 253 w 1743"/>
                <a:gd name="T13" fmla="*/ 0 h 32"/>
                <a:gd name="T14" fmla="*/ 253 w 1743"/>
                <a:gd name="T15" fmla="*/ 32 h 32"/>
                <a:gd name="T16" fmla="*/ 376 w 1743"/>
                <a:gd name="T17" fmla="*/ 0 h 32"/>
                <a:gd name="T18" fmla="*/ 376 w 1743"/>
                <a:gd name="T19" fmla="*/ 32 h 32"/>
                <a:gd name="T20" fmla="*/ 500 w 1743"/>
                <a:gd name="T21" fmla="*/ 0 h 32"/>
                <a:gd name="T22" fmla="*/ 500 w 1743"/>
                <a:gd name="T23" fmla="*/ 32 h 32"/>
                <a:gd name="T24" fmla="*/ 623 w 1743"/>
                <a:gd name="T25" fmla="*/ 0 h 32"/>
                <a:gd name="T26" fmla="*/ 623 w 1743"/>
                <a:gd name="T27" fmla="*/ 32 h 32"/>
                <a:gd name="T28" fmla="*/ 747 w 1743"/>
                <a:gd name="T29" fmla="*/ 0 h 32"/>
                <a:gd name="T30" fmla="*/ 747 w 1743"/>
                <a:gd name="T31" fmla="*/ 32 h 32"/>
                <a:gd name="T32" fmla="*/ 871 w 1743"/>
                <a:gd name="T33" fmla="*/ 0 h 32"/>
                <a:gd name="T34" fmla="*/ 871 w 1743"/>
                <a:gd name="T35" fmla="*/ 32 h 32"/>
                <a:gd name="T36" fmla="*/ 995 w 1743"/>
                <a:gd name="T37" fmla="*/ 0 h 32"/>
                <a:gd name="T38" fmla="*/ 995 w 1743"/>
                <a:gd name="T39" fmla="*/ 32 h 32"/>
                <a:gd name="T40" fmla="*/ 1119 w 1743"/>
                <a:gd name="T41" fmla="*/ 0 h 32"/>
                <a:gd name="T42" fmla="*/ 1119 w 1743"/>
                <a:gd name="T43" fmla="*/ 32 h 32"/>
                <a:gd name="T44" fmla="*/ 1242 w 1743"/>
                <a:gd name="T45" fmla="*/ 0 h 32"/>
                <a:gd name="T46" fmla="*/ 1242 w 1743"/>
                <a:gd name="T47" fmla="*/ 32 h 32"/>
                <a:gd name="T48" fmla="*/ 1366 w 1743"/>
                <a:gd name="T49" fmla="*/ 0 h 32"/>
                <a:gd name="T50" fmla="*/ 1366 w 1743"/>
                <a:gd name="T51" fmla="*/ 32 h 32"/>
                <a:gd name="T52" fmla="*/ 1489 w 1743"/>
                <a:gd name="T53" fmla="*/ 0 h 32"/>
                <a:gd name="T54" fmla="*/ 1489 w 1743"/>
                <a:gd name="T55" fmla="*/ 32 h 32"/>
                <a:gd name="T56" fmla="*/ 1613 w 1743"/>
                <a:gd name="T57" fmla="*/ 0 h 32"/>
                <a:gd name="T58" fmla="*/ 1613 w 1743"/>
                <a:gd name="T59" fmla="*/ 32 h 32"/>
                <a:gd name="T60" fmla="*/ 1737 w 1743"/>
                <a:gd name="T61" fmla="*/ 0 h 32"/>
                <a:gd name="T62" fmla="*/ 1737 w 1743"/>
                <a:gd name="T63" fmla="*/ 32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</a:cxnLst>
              <a:rect l="0" t="0" r="r" b="b"/>
              <a:pathLst>
                <a:path w="1743" h="32">
                  <a:moveTo>
                    <a:pt x="0" y="0"/>
                  </a:moveTo>
                  <a:lnTo>
                    <a:pt x="1743" y="0"/>
                  </a:lnTo>
                  <a:moveTo>
                    <a:pt x="6" y="0"/>
                  </a:moveTo>
                  <a:lnTo>
                    <a:pt x="6" y="32"/>
                  </a:lnTo>
                  <a:moveTo>
                    <a:pt x="129" y="0"/>
                  </a:moveTo>
                  <a:lnTo>
                    <a:pt x="129" y="32"/>
                  </a:lnTo>
                  <a:moveTo>
                    <a:pt x="253" y="0"/>
                  </a:moveTo>
                  <a:lnTo>
                    <a:pt x="253" y="32"/>
                  </a:lnTo>
                  <a:moveTo>
                    <a:pt x="376" y="0"/>
                  </a:moveTo>
                  <a:lnTo>
                    <a:pt x="376" y="32"/>
                  </a:lnTo>
                  <a:moveTo>
                    <a:pt x="500" y="0"/>
                  </a:moveTo>
                  <a:lnTo>
                    <a:pt x="500" y="32"/>
                  </a:lnTo>
                  <a:moveTo>
                    <a:pt x="623" y="0"/>
                  </a:moveTo>
                  <a:lnTo>
                    <a:pt x="623" y="32"/>
                  </a:lnTo>
                  <a:moveTo>
                    <a:pt x="747" y="0"/>
                  </a:moveTo>
                  <a:lnTo>
                    <a:pt x="747" y="32"/>
                  </a:lnTo>
                  <a:moveTo>
                    <a:pt x="871" y="0"/>
                  </a:moveTo>
                  <a:lnTo>
                    <a:pt x="871" y="32"/>
                  </a:lnTo>
                  <a:moveTo>
                    <a:pt x="995" y="0"/>
                  </a:moveTo>
                  <a:lnTo>
                    <a:pt x="995" y="32"/>
                  </a:lnTo>
                  <a:moveTo>
                    <a:pt x="1119" y="0"/>
                  </a:moveTo>
                  <a:lnTo>
                    <a:pt x="1119" y="32"/>
                  </a:lnTo>
                  <a:moveTo>
                    <a:pt x="1242" y="0"/>
                  </a:moveTo>
                  <a:lnTo>
                    <a:pt x="1242" y="32"/>
                  </a:lnTo>
                  <a:moveTo>
                    <a:pt x="1366" y="0"/>
                  </a:moveTo>
                  <a:lnTo>
                    <a:pt x="1366" y="32"/>
                  </a:lnTo>
                  <a:moveTo>
                    <a:pt x="1489" y="0"/>
                  </a:moveTo>
                  <a:lnTo>
                    <a:pt x="1489" y="32"/>
                  </a:lnTo>
                  <a:moveTo>
                    <a:pt x="1613" y="0"/>
                  </a:moveTo>
                  <a:lnTo>
                    <a:pt x="1613" y="32"/>
                  </a:lnTo>
                  <a:moveTo>
                    <a:pt x="1737" y="0"/>
                  </a:moveTo>
                  <a:lnTo>
                    <a:pt x="1737" y="32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1" name="Rectangle 285">
              <a:extLst>
                <a:ext uri="{FF2B5EF4-FFF2-40B4-BE49-F238E27FC236}">
                  <a16:creationId xmlns:a16="http://schemas.microsoft.com/office/drawing/2014/main" id="{D8D4B00C-52C6-43B8-8435-04ECDB8CA5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3516312" y="6343650"/>
              <a:ext cx="114300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2" name="Rectangle 286">
              <a:extLst>
                <a:ext uri="{FF2B5EF4-FFF2-40B4-BE49-F238E27FC236}">
                  <a16:creationId xmlns:a16="http://schemas.microsoft.com/office/drawing/2014/main" id="{067AEC4A-2B48-4D84-86F0-DB5689048B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3582987" y="5646738"/>
              <a:ext cx="171450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3" name="Rectangle 287">
              <a:extLst>
                <a:ext uri="{FF2B5EF4-FFF2-40B4-BE49-F238E27FC236}">
                  <a16:creationId xmlns:a16="http://schemas.microsoft.com/office/drawing/2014/main" id="{08078293-D302-4C9C-918E-CDF219543E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3651250" y="4959350"/>
              <a:ext cx="238125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4" name="Freeform 288">
              <a:extLst>
                <a:ext uri="{FF2B5EF4-FFF2-40B4-BE49-F238E27FC236}">
                  <a16:creationId xmlns:a16="http://schemas.microsoft.com/office/drawing/2014/main" id="{16DED39B-42E2-496B-9B58-056D6735AC1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-3432175" y="5022850"/>
              <a:ext cx="52388" cy="1401762"/>
            </a:xfrm>
            <a:custGeom>
              <a:avLst/>
              <a:gdLst>
                <a:gd name="T0" fmla="*/ 33 w 33"/>
                <a:gd name="T1" fmla="*/ 883 h 883"/>
                <a:gd name="T2" fmla="*/ 33 w 33"/>
                <a:gd name="T3" fmla="*/ 0 h 883"/>
                <a:gd name="T4" fmla="*/ 33 w 33"/>
                <a:gd name="T5" fmla="*/ 878 h 883"/>
                <a:gd name="T6" fmla="*/ 0 w 33"/>
                <a:gd name="T7" fmla="*/ 878 h 883"/>
                <a:gd name="T8" fmla="*/ 33 w 33"/>
                <a:gd name="T9" fmla="*/ 442 h 883"/>
                <a:gd name="T10" fmla="*/ 0 w 33"/>
                <a:gd name="T11" fmla="*/ 442 h 883"/>
                <a:gd name="T12" fmla="*/ 33 w 33"/>
                <a:gd name="T13" fmla="*/ 6 h 883"/>
                <a:gd name="T14" fmla="*/ 0 w 33"/>
                <a:gd name="T15" fmla="*/ 6 h 8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3" h="883">
                  <a:moveTo>
                    <a:pt x="33" y="883"/>
                  </a:moveTo>
                  <a:lnTo>
                    <a:pt x="33" y="0"/>
                  </a:lnTo>
                  <a:moveTo>
                    <a:pt x="33" y="878"/>
                  </a:moveTo>
                  <a:lnTo>
                    <a:pt x="0" y="878"/>
                  </a:lnTo>
                  <a:moveTo>
                    <a:pt x="33" y="442"/>
                  </a:moveTo>
                  <a:lnTo>
                    <a:pt x="0" y="442"/>
                  </a:lnTo>
                  <a:moveTo>
                    <a:pt x="33" y="6"/>
                  </a:moveTo>
                  <a:lnTo>
                    <a:pt x="0" y="6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5" name="Freeform 289">
              <a:extLst>
                <a:ext uri="{FF2B5EF4-FFF2-40B4-BE49-F238E27FC236}">
                  <a16:creationId xmlns:a16="http://schemas.microsoft.com/office/drawing/2014/main" id="{50B916D7-38BF-4971-87FA-3D453CF4FED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-3379787" y="5022850"/>
              <a:ext cx="2560638" cy="1352550"/>
            </a:xfrm>
            <a:custGeom>
              <a:avLst/>
              <a:gdLst>
                <a:gd name="T0" fmla="*/ 0 w 4293"/>
                <a:gd name="T1" fmla="*/ 0 h 2266"/>
                <a:gd name="T2" fmla="*/ 138 w 4293"/>
                <a:gd name="T3" fmla="*/ 16 h 2266"/>
                <a:gd name="T4" fmla="*/ 307 w 4293"/>
                <a:gd name="T5" fmla="*/ 31 h 2266"/>
                <a:gd name="T6" fmla="*/ 522 w 4293"/>
                <a:gd name="T7" fmla="*/ 31 h 2266"/>
                <a:gd name="T8" fmla="*/ 691 w 4293"/>
                <a:gd name="T9" fmla="*/ 16 h 2266"/>
                <a:gd name="T10" fmla="*/ 829 w 4293"/>
                <a:gd name="T11" fmla="*/ 0 h 2266"/>
                <a:gd name="T12" fmla="*/ 922 w 4293"/>
                <a:gd name="T13" fmla="*/ 0 h 2266"/>
                <a:gd name="T14" fmla="*/ 922 w 4293"/>
                <a:gd name="T15" fmla="*/ 0 h 2266"/>
                <a:gd name="T16" fmla="*/ 1060 w 4293"/>
                <a:gd name="T17" fmla="*/ 16 h 2266"/>
                <a:gd name="T18" fmla="*/ 1229 w 4293"/>
                <a:gd name="T19" fmla="*/ 31 h 2266"/>
                <a:gd name="T20" fmla="*/ 1444 w 4293"/>
                <a:gd name="T21" fmla="*/ 31 h 2266"/>
                <a:gd name="T22" fmla="*/ 1613 w 4293"/>
                <a:gd name="T23" fmla="*/ 16 h 2266"/>
                <a:gd name="T24" fmla="*/ 1751 w 4293"/>
                <a:gd name="T25" fmla="*/ 0 h 2266"/>
                <a:gd name="T26" fmla="*/ 1843 w 4293"/>
                <a:gd name="T27" fmla="*/ 0 h 2266"/>
                <a:gd name="T28" fmla="*/ 1843 w 4293"/>
                <a:gd name="T29" fmla="*/ 0 h 2266"/>
                <a:gd name="T30" fmla="*/ 1981 w 4293"/>
                <a:gd name="T31" fmla="*/ 16 h 2266"/>
                <a:gd name="T32" fmla="*/ 2150 w 4293"/>
                <a:gd name="T33" fmla="*/ 31 h 2266"/>
                <a:gd name="T34" fmla="*/ 2212 w 4293"/>
                <a:gd name="T35" fmla="*/ 31 h 2266"/>
                <a:gd name="T36" fmla="*/ 2381 w 4293"/>
                <a:gd name="T37" fmla="*/ 16 h 2266"/>
                <a:gd name="T38" fmla="*/ 2519 w 4293"/>
                <a:gd name="T39" fmla="*/ 0 h 2266"/>
                <a:gd name="T40" fmla="*/ 2611 w 4293"/>
                <a:gd name="T41" fmla="*/ 0 h 2266"/>
                <a:gd name="T42" fmla="*/ 2632 w 4293"/>
                <a:gd name="T43" fmla="*/ 31 h 2266"/>
                <a:gd name="T44" fmla="*/ 2711 w 4293"/>
                <a:gd name="T45" fmla="*/ 146 h 2266"/>
                <a:gd name="T46" fmla="*/ 2849 w 4293"/>
                <a:gd name="T47" fmla="*/ 131 h 2266"/>
                <a:gd name="T48" fmla="*/ 2941 w 4293"/>
                <a:gd name="T49" fmla="*/ 131 h 2266"/>
                <a:gd name="T50" fmla="*/ 2962 w 4293"/>
                <a:gd name="T51" fmla="*/ 162 h 2266"/>
                <a:gd name="T52" fmla="*/ 2962 w 4293"/>
                <a:gd name="T53" fmla="*/ 343 h 2266"/>
                <a:gd name="T54" fmla="*/ 2975 w 4293"/>
                <a:gd name="T55" fmla="*/ 313 h 2266"/>
                <a:gd name="T56" fmla="*/ 3067 w 4293"/>
                <a:gd name="T57" fmla="*/ 313 h 2266"/>
                <a:gd name="T58" fmla="*/ 3067 w 4293"/>
                <a:gd name="T59" fmla="*/ 313 h 2266"/>
                <a:gd name="T60" fmla="*/ 3205 w 4293"/>
                <a:gd name="T61" fmla="*/ 328 h 2266"/>
                <a:gd name="T62" fmla="*/ 3274 w 4293"/>
                <a:gd name="T63" fmla="*/ 413 h 2266"/>
                <a:gd name="T64" fmla="*/ 3274 w 4293"/>
                <a:gd name="T65" fmla="*/ 579 h 2266"/>
                <a:gd name="T66" fmla="*/ 3354 w 4293"/>
                <a:gd name="T67" fmla="*/ 579 h 2266"/>
                <a:gd name="T68" fmla="*/ 3492 w 4293"/>
                <a:gd name="T69" fmla="*/ 564 h 2266"/>
                <a:gd name="T70" fmla="*/ 3584 w 4293"/>
                <a:gd name="T71" fmla="*/ 564 h 2266"/>
                <a:gd name="T72" fmla="*/ 3584 w 4293"/>
                <a:gd name="T73" fmla="*/ 564 h 2266"/>
                <a:gd name="T74" fmla="*/ 3722 w 4293"/>
                <a:gd name="T75" fmla="*/ 579 h 2266"/>
                <a:gd name="T76" fmla="*/ 3932 w 4293"/>
                <a:gd name="T77" fmla="*/ 584 h 2266"/>
                <a:gd name="T78" fmla="*/ 3963 w 4293"/>
                <a:gd name="T79" fmla="*/ 676 h 2266"/>
                <a:gd name="T80" fmla="*/ 3963 w 4293"/>
                <a:gd name="T81" fmla="*/ 676 h 2266"/>
                <a:gd name="T82" fmla="*/ 3947 w 4293"/>
                <a:gd name="T83" fmla="*/ 814 h 2266"/>
                <a:gd name="T84" fmla="*/ 3932 w 4293"/>
                <a:gd name="T85" fmla="*/ 983 h 2266"/>
                <a:gd name="T86" fmla="*/ 3973 w 4293"/>
                <a:gd name="T87" fmla="*/ 1035 h 2266"/>
                <a:gd name="T88" fmla="*/ 4058 w 4293"/>
                <a:gd name="T89" fmla="*/ 1104 h 2266"/>
                <a:gd name="T90" fmla="*/ 4073 w 4293"/>
                <a:gd name="T91" fmla="*/ 1242 h 2266"/>
                <a:gd name="T92" fmla="*/ 4073 w 4293"/>
                <a:gd name="T93" fmla="*/ 1334 h 2266"/>
                <a:gd name="T94" fmla="*/ 4073 w 4293"/>
                <a:gd name="T95" fmla="*/ 1334 h 2266"/>
                <a:gd name="T96" fmla="*/ 4073 w 4293"/>
                <a:gd name="T97" fmla="*/ 1457 h 2266"/>
                <a:gd name="T98" fmla="*/ 4262 w 4293"/>
                <a:gd name="T99" fmla="*/ 1483 h 2266"/>
                <a:gd name="T100" fmla="*/ 4293 w 4293"/>
                <a:gd name="T101" fmla="*/ 1575 h 2266"/>
                <a:gd name="T102" fmla="*/ 4293 w 4293"/>
                <a:gd name="T103" fmla="*/ 1575 h 2266"/>
                <a:gd name="T104" fmla="*/ 4278 w 4293"/>
                <a:gd name="T105" fmla="*/ 1713 h 2266"/>
                <a:gd name="T106" fmla="*/ 4262 w 4293"/>
                <a:gd name="T107" fmla="*/ 1882 h 2266"/>
                <a:gd name="T108" fmla="*/ 4262 w 4293"/>
                <a:gd name="T109" fmla="*/ 2097 h 2266"/>
                <a:gd name="T110" fmla="*/ 4278 w 4293"/>
                <a:gd name="T111" fmla="*/ 2266 h 22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4293" h="2266">
                  <a:moveTo>
                    <a:pt x="0" y="0"/>
                  </a:moveTo>
                  <a:lnTo>
                    <a:pt x="61" y="0"/>
                  </a:lnTo>
                  <a:cubicBezTo>
                    <a:pt x="70" y="0"/>
                    <a:pt x="77" y="7"/>
                    <a:pt x="77" y="16"/>
                  </a:cubicBezTo>
                  <a:cubicBezTo>
                    <a:pt x="77" y="24"/>
                    <a:pt x="70" y="31"/>
                    <a:pt x="61" y="31"/>
                  </a:cubicBezTo>
                  <a:lnTo>
                    <a:pt x="0" y="31"/>
                  </a:lnTo>
                  <a:lnTo>
                    <a:pt x="0" y="0"/>
                  </a:lnTo>
                  <a:close/>
                  <a:moveTo>
                    <a:pt x="154" y="0"/>
                  </a:moveTo>
                  <a:lnTo>
                    <a:pt x="215" y="0"/>
                  </a:lnTo>
                  <a:cubicBezTo>
                    <a:pt x="223" y="0"/>
                    <a:pt x="230" y="7"/>
                    <a:pt x="230" y="16"/>
                  </a:cubicBezTo>
                  <a:cubicBezTo>
                    <a:pt x="230" y="24"/>
                    <a:pt x="223" y="31"/>
                    <a:pt x="215" y="31"/>
                  </a:cubicBezTo>
                  <a:lnTo>
                    <a:pt x="154" y="31"/>
                  </a:lnTo>
                  <a:cubicBezTo>
                    <a:pt x="145" y="31"/>
                    <a:pt x="138" y="24"/>
                    <a:pt x="138" y="16"/>
                  </a:cubicBezTo>
                  <a:cubicBezTo>
                    <a:pt x="138" y="7"/>
                    <a:pt x="145" y="0"/>
                    <a:pt x="154" y="0"/>
                  </a:cubicBezTo>
                  <a:close/>
                  <a:moveTo>
                    <a:pt x="307" y="0"/>
                  </a:moveTo>
                  <a:lnTo>
                    <a:pt x="369" y="0"/>
                  </a:lnTo>
                  <a:cubicBezTo>
                    <a:pt x="377" y="0"/>
                    <a:pt x="384" y="7"/>
                    <a:pt x="384" y="16"/>
                  </a:cubicBezTo>
                  <a:cubicBezTo>
                    <a:pt x="384" y="24"/>
                    <a:pt x="377" y="31"/>
                    <a:pt x="369" y="31"/>
                  </a:cubicBezTo>
                  <a:lnTo>
                    <a:pt x="307" y="31"/>
                  </a:lnTo>
                  <a:cubicBezTo>
                    <a:pt x="299" y="31"/>
                    <a:pt x="292" y="24"/>
                    <a:pt x="292" y="16"/>
                  </a:cubicBezTo>
                  <a:cubicBezTo>
                    <a:pt x="292" y="7"/>
                    <a:pt x="299" y="0"/>
                    <a:pt x="307" y="0"/>
                  </a:cubicBezTo>
                  <a:close/>
                  <a:moveTo>
                    <a:pt x="461" y="0"/>
                  </a:moveTo>
                  <a:lnTo>
                    <a:pt x="522" y="0"/>
                  </a:lnTo>
                  <a:cubicBezTo>
                    <a:pt x="531" y="0"/>
                    <a:pt x="538" y="7"/>
                    <a:pt x="538" y="16"/>
                  </a:cubicBezTo>
                  <a:cubicBezTo>
                    <a:pt x="538" y="24"/>
                    <a:pt x="531" y="31"/>
                    <a:pt x="522" y="31"/>
                  </a:cubicBezTo>
                  <a:lnTo>
                    <a:pt x="461" y="31"/>
                  </a:lnTo>
                  <a:cubicBezTo>
                    <a:pt x="452" y="31"/>
                    <a:pt x="445" y="24"/>
                    <a:pt x="445" y="16"/>
                  </a:cubicBezTo>
                  <a:cubicBezTo>
                    <a:pt x="445" y="7"/>
                    <a:pt x="452" y="0"/>
                    <a:pt x="461" y="0"/>
                  </a:cubicBezTo>
                  <a:close/>
                  <a:moveTo>
                    <a:pt x="614" y="0"/>
                  </a:moveTo>
                  <a:lnTo>
                    <a:pt x="676" y="0"/>
                  </a:lnTo>
                  <a:cubicBezTo>
                    <a:pt x="684" y="0"/>
                    <a:pt x="691" y="7"/>
                    <a:pt x="691" y="16"/>
                  </a:cubicBezTo>
                  <a:cubicBezTo>
                    <a:pt x="691" y="24"/>
                    <a:pt x="684" y="31"/>
                    <a:pt x="676" y="31"/>
                  </a:cubicBezTo>
                  <a:lnTo>
                    <a:pt x="614" y="31"/>
                  </a:lnTo>
                  <a:cubicBezTo>
                    <a:pt x="606" y="31"/>
                    <a:pt x="599" y="24"/>
                    <a:pt x="599" y="16"/>
                  </a:cubicBezTo>
                  <a:cubicBezTo>
                    <a:pt x="599" y="7"/>
                    <a:pt x="606" y="0"/>
                    <a:pt x="614" y="0"/>
                  </a:cubicBezTo>
                  <a:close/>
                  <a:moveTo>
                    <a:pt x="768" y="0"/>
                  </a:moveTo>
                  <a:lnTo>
                    <a:pt x="829" y="0"/>
                  </a:lnTo>
                  <a:cubicBezTo>
                    <a:pt x="838" y="0"/>
                    <a:pt x="845" y="7"/>
                    <a:pt x="845" y="16"/>
                  </a:cubicBezTo>
                  <a:cubicBezTo>
                    <a:pt x="845" y="24"/>
                    <a:pt x="838" y="31"/>
                    <a:pt x="829" y="31"/>
                  </a:cubicBezTo>
                  <a:lnTo>
                    <a:pt x="768" y="31"/>
                  </a:lnTo>
                  <a:cubicBezTo>
                    <a:pt x="759" y="31"/>
                    <a:pt x="753" y="24"/>
                    <a:pt x="753" y="16"/>
                  </a:cubicBezTo>
                  <a:cubicBezTo>
                    <a:pt x="753" y="7"/>
                    <a:pt x="759" y="0"/>
                    <a:pt x="768" y="0"/>
                  </a:cubicBezTo>
                  <a:close/>
                  <a:moveTo>
                    <a:pt x="922" y="0"/>
                  </a:moveTo>
                  <a:lnTo>
                    <a:pt x="983" y="0"/>
                  </a:lnTo>
                  <a:cubicBezTo>
                    <a:pt x="991" y="0"/>
                    <a:pt x="998" y="7"/>
                    <a:pt x="998" y="16"/>
                  </a:cubicBezTo>
                  <a:cubicBezTo>
                    <a:pt x="998" y="24"/>
                    <a:pt x="991" y="31"/>
                    <a:pt x="983" y="31"/>
                  </a:cubicBezTo>
                  <a:lnTo>
                    <a:pt x="922" y="31"/>
                  </a:lnTo>
                  <a:cubicBezTo>
                    <a:pt x="913" y="31"/>
                    <a:pt x="906" y="24"/>
                    <a:pt x="906" y="16"/>
                  </a:cubicBezTo>
                  <a:cubicBezTo>
                    <a:pt x="906" y="7"/>
                    <a:pt x="913" y="0"/>
                    <a:pt x="922" y="0"/>
                  </a:cubicBezTo>
                  <a:close/>
                  <a:moveTo>
                    <a:pt x="1075" y="0"/>
                  </a:moveTo>
                  <a:lnTo>
                    <a:pt x="1137" y="0"/>
                  </a:lnTo>
                  <a:cubicBezTo>
                    <a:pt x="1145" y="0"/>
                    <a:pt x="1152" y="7"/>
                    <a:pt x="1152" y="16"/>
                  </a:cubicBezTo>
                  <a:cubicBezTo>
                    <a:pt x="1152" y="24"/>
                    <a:pt x="1145" y="31"/>
                    <a:pt x="1137" y="31"/>
                  </a:cubicBezTo>
                  <a:lnTo>
                    <a:pt x="1075" y="31"/>
                  </a:lnTo>
                  <a:cubicBezTo>
                    <a:pt x="1067" y="31"/>
                    <a:pt x="1060" y="24"/>
                    <a:pt x="1060" y="16"/>
                  </a:cubicBezTo>
                  <a:cubicBezTo>
                    <a:pt x="1060" y="7"/>
                    <a:pt x="1067" y="0"/>
                    <a:pt x="1075" y="0"/>
                  </a:cubicBezTo>
                  <a:close/>
                  <a:moveTo>
                    <a:pt x="1229" y="0"/>
                  </a:moveTo>
                  <a:lnTo>
                    <a:pt x="1290" y="0"/>
                  </a:lnTo>
                  <a:cubicBezTo>
                    <a:pt x="1299" y="0"/>
                    <a:pt x="1306" y="7"/>
                    <a:pt x="1306" y="16"/>
                  </a:cubicBezTo>
                  <a:cubicBezTo>
                    <a:pt x="1306" y="24"/>
                    <a:pt x="1299" y="31"/>
                    <a:pt x="1290" y="31"/>
                  </a:cubicBezTo>
                  <a:lnTo>
                    <a:pt x="1229" y="31"/>
                  </a:lnTo>
                  <a:cubicBezTo>
                    <a:pt x="1220" y="31"/>
                    <a:pt x="1213" y="24"/>
                    <a:pt x="1213" y="16"/>
                  </a:cubicBezTo>
                  <a:cubicBezTo>
                    <a:pt x="1213" y="7"/>
                    <a:pt x="1220" y="0"/>
                    <a:pt x="1229" y="0"/>
                  </a:cubicBezTo>
                  <a:close/>
                  <a:moveTo>
                    <a:pt x="1382" y="0"/>
                  </a:moveTo>
                  <a:lnTo>
                    <a:pt x="1444" y="0"/>
                  </a:lnTo>
                  <a:cubicBezTo>
                    <a:pt x="1452" y="0"/>
                    <a:pt x="1459" y="7"/>
                    <a:pt x="1459" y="16"/>
                  </a:cubicBezTo>
                  <a:cubicBezTo>
                    <a:pt x="1459" y="24"/>
                    <a:pt x="1452" y="31"/>
                    <a:pt x="1444" y="31"/>
                  </a:cubicBezTo>
                  <a:lnTo>
                    <a:pt x="1382" y="31"/>
                  </a:lnTo>
                  <a:cubicBezTo>
                    <a:pt x="1374" y="31"/>
                    <a:pt x="1367" y="24"/>
                    <a:pt x="1367" y="16"/>
                  </a:cubicBezTo>
                  <a:cubicBezTo>
                    <a:pt x="1367" y="7"/>
                    <a:pt x="1374" y="0"/>
                    <a:pt x="1382" y="0"/>
                  </a:cubicBezTo>
                  <a:close/>
                  <a:moveTo>
                    <a:pt x="1536" y="0"/>
                  </a:moveTo>
                  <a:lnTo>
                    <a:pt x="1597" y="0"/>
                  </a:lnTo>
                  <a:cubicBezTo>
                    <a:pt x="1606" y="0"/>
                    <a:pt x="1613" y="7"/>
                    <a:pt x="1613" y="16"/>
                  </a:cubicBezTo>
                  <a:cubicBezTo>
                    <a:pt x="1613" y="24"/>
                    <a:pt x="1606" y="31"/>
                    <a:pt x="1597" y="31"/>
                  </a:cubicBezTo>
                  <a:lnTo>
                    <a:pt x="1536" y="31"/>
                  </a:lnTo>
                  <a:cubicBezTo>
                    <a:pt x="1527" y="31"/>
                    <a:pt x="1521" y="24"/>
                    <a:pt x="1521" y="16"/>
                  </a:cubicBezTo>
                  <a:cubicBezTo>
                    <a:pt x="1521" y="7"/>
                    <a:pt x="1527" y="0"/>
                    <a:pt x="1536" y="0"/>
                  </a:cubicBezTo>
                  <a:close/>
                  <a:moveTo>
                    <a:pt x="1690" y="0"/>
                  </a:moveTo>
                  <a:lnTo>
                    <a:pt x="1751" y="0"/>
                  </a:lnTo>
                  <a:cubicBezTo>
                    <a:pt x="1759" y="0"/>
                    <a:pt x="1766" y="7"/>
                    <a:pt x="1766" y="16"/>
                  </a:cubicBezTo>
                  <a:cubicBezTo>
                    <a:pt x="1766" y="24"/>
                    <a:pt x="1759" y="31"/>
                    <a:pt x="1751" y="31"/>
                  </a:cubicBezTo>
                  <a:lnTo>
                    <a:pt x="1690" y="31"/>
                  </a:lnTo>
                  <a:cubicBezTo>
                    <a:pt x="1681" y="31"/>
                    <a:pt x="1674" y="24"/>
                    <a:pt x="1674" y="16"/>
                  </a:cubicBezTo>
                  <a:cubicBezTo>
                    <a:pt x="1674" y="7"/>
                    <a:pt x="1681" y="0"/>
                    <a:pt x="1690" y="0"/>
                  </a:cubicBezTo>
                  <a:close/>
                  <a:moveTo>
                    <a:pt x="1843" y="0"/>
                  </a:moveTo>
                  <a:lnTo>
                    <a:pt x="1905" y="0"/>
                  </a:lnTo>
                  <a:cubicBezTo>
                    <a:pt x="1913" y="0"/>
                    <a:pt x="1920" y="7"/>
                    <a:pt x="1920" y="16"/>
                  </a:cubicBezTo>
                  <a:cubicBezTo>
                    <a:pt x="1920" y="24"/>
                    <a:pt x="1913" y="31"/>
                    <a:pt x="1905" y="31"/>
                  </a:cubicBezTo>
                  <a:lnTo>
                    <a:pt x="1843" y="31"/>
                  </a:lnTo>
                  <a:cubicBezTo>
                    <a:pt x="1835" y="31"/>
                    <a:pt x="1828" y="24"/>
                    <a:pt x="1828" y="16"/>
                  </a:cubicBezTo>
                  <a:cubicBezTo>
                    <a:pt x="1828" y="7"/>
                    <a:pt x="1835" y="0"/>
                    <a:pt x="1843" y="0"/>
                  </a:cubicBezTo>
                  <a:close/>
                  <a:moveTo>
                    <a:pt x="1997" y="0"/>
                  </a:moveTo>
                  <a:lnTo>
                    <a:pt x="2058" y="0"/>
                  </a:lnTo>
                  <a:cubicBezTo>
                    <a:pt x="2067" y="0"/>
                    <a:pt x="2074" y="7"/>
                    <a:pt x="2074" y="16"/>
                  </a:cubicBezTo>
                  <a:cubicBezTo>
                    <a:pt x="2074" y="24"/>
                    <a:pt x="2067" y="31"/>
                    <a:pt x="2058" y="31"/>
                  </a:cubicBezTo>
                  <a:lnTo>
                    <a:pt x="1997" y="31"/>
                  </a:lnTo>
                  <a:cubicBezTo>
                    <a:pt x="1988" y="31"/>
                    <a:pt x="1981" y="24"/>
                    <a:pt x="1981" y="16"/>
                  </a:cubicBezTo>
                  <a:cubicBezTo>
                    <a:pt x="1981" y="7"/>
                    <a:pt x="1988" y="0"/>
                    <a:pt x="1997" y="0"/>
                  </a:cubicBezTo>
                  <a:close/>
                  <a:moveTo>
                    <a:pt x="2150" y="0"/>
                  </a:moveTo>
                  <a:lnTo>
                    <a:pt x="2194" y="0"/>
                  </a:lnTo>
                  <a:cubicBezTo>
                    <a:pt x="2202" y="0"/>
                    <a:pt x="2209" y="7"/>
                    <a:pt x="2209" y="16"/>
                  </a:cubicBezTo>
                  <a:cubicBezTo>
                    <a:pt x="2209" y="24"/>
                    <a:pt x="2202" y="31"/>
                    <a:pt x="2194" y="31"/>
                  </a:cubicBezTo>
                  <a:lnTo>
                    <a:pt x="2150" y="31"/>
                  </a:lnTo>
                  <a:cubicBezTo>
                    <a:pt x="2142" y="31"/>
                    <a:pt x="2135" y="24"/>
                    <a:pt x="2135" y="16"/>
                  </a:cubicBezTo>
                  <a:cubicBezTo>
                    <a:pt x="2135" y="7"/>
                    <a:pt x="2142" y="0"/>
                    <a:pt x="2150" y="0"/>
                  </a:cubicBezTo>
                  <a:close/>
                  <a:moveTo>
                    <a:pt x="2194" y="0"/>
                  </a:moveTo>
                  <a:lnTo>
                    <a:pt x="2212" y="0"/>
                  </a:lnTo>
                  <a:cubicBezTo>
                    <a:pt x="2220" y="0"/>
                    <a:pt x="2227" y="7"/>
                    <a:pt x="2227" y="16"/>
                  </a:cubicBezTo>
                  <a:cubicBezTo>
                    <a:pt x="2227" y="24"/>
                    <a:pt x="2220" y="31"/>
                    <a:pt x="2212" y="31"/>
                  </a:cubicBezTo>
                  <a:lnTo>
                    <a:pt x="2194" y="31"/>
                  </a:lnTo>
                  <a:cubicBezTo>
                    <a:pt x="2185" y="31"/>
                    <a:pt x="2179" y="24"/>
                    <a:pt x="2179" y="16"/>
                  </a:cubicBezTo>
                  <a:cubicBezTo>
                    <a:pt x="2179" y="7"/>
                    <a:pt x="2185" y="0"/>
                    <a:pt x="2194" y="0"/>
                  </a:cubicBezTo>
                  <a:close/>
                  <a:moveTo>
                    <a:pt x="2304" y="0"/>
                  </a:moveTo>
                  <a:lnTo>
                    <a:pt x="2365" y="0"/>
                  </a:lnTo>
                  <a:cubicBezTo>
                    <a:pt x="2374" y="0"/>
                    <a:pt x="2381" y="7"/>
                    <a:pt x="2381" y="16"/>
                  </a:cubicBezTo>
                  <a:cubicBezTo>
                    <a:pt x="2381" y="24"/>
                    <a:pt x="2374" y="31"/>
                    <a:pt x="2365" y="31"/>
                  </a:cubicBezTo>
                  <a:lnTo>
                    <a:pt x="2304" y="31"/>
                  </a:lnTo>
                  <a:cubicBezTo>
                    <a:pt x="2295" y="31"/>
                    <a:pt x="2289" y="24"/>
                    <a:pt x="2289" y="16"/>
                  </a:cubicBezTo>
                  <a:cubicBezTo>
                    <a:pt x="2289" y="7"/>
                    <a:pt x="2295" y="0"/>
                    <a:pt x="2304" y="0"/>
                  </a:cubicBezTo>
                  <a:close/>
                  <a:moveTo>
                    <a:pt x="2458" y="0"/>
                  </a:moveTo>
                  <a:lnTo>
                    <a:pt x="2519" y="0"/>
                  </a:lnTo>
                  <a:cubicBezTo>
                    <a:pt x="2527" y="0"/>
                    <a:pt x="2534" y="7"/>
                    <a:pt x="2534" y="16"/>
                  </a:cubicBezTo>
                  <a:cubicBezTo>
                    <a:pt x="2534" y="24"/>
                    <a:pt x="2527" y="31"/>
                    <a:pt x="2519" y="31"/>
                  </a:cubicBezTo>
                  <a:lnTo>
                    <a:pt x="2458" y="31"/>
                  </a:lnTo>
                  <a:cubicBezTo>
                    <a:pt x="2449" y="31"/>
                    <a:pt x="2442" y="24"/>
                    <a:pt x="2442" y="16"/>
                  </a:cubicBezTo>
                  <a:cubicBezTo>
                    <a:pt x="2442" y="7"/>
                    <a:pt x="2449" y="0"/>
                    <a:pt x="2458" y="0"/>
                  </a:cubicBezTo>
                  <a:close/>
                  <a:moveTo>
                    <a:pt x="2611" y="0"/>
                  </a:moveTo>
                  <a:lnTo>
                    <a:pt x="2647" y="0"/>
                  </a:lnTo>
                  <a:lnTo>
                    <a:pt x="2647" y="57"/>
                  </a:lnTo>
                  <a:cubicBezTo>
                    <a:pt x="2647" y="65"/>
                    <a:pt x="2640" y="72"/>
                    <a:pt x="2632" y="72"/>
                  </a:cubicBezTo>
                  <a:cubicBezTo>
                    <a:pt x="2623" y="72"/>
                    <a:pt x="2616" y="65"/>
                    <a:pt x="2616" y="57"/>
                  </a:cubicBezTo>
                  <a:lnTo>
                    <a:pt x="2616" y="16"/>
                  </a:lnTo>
                  <a:lnTo>
                    <a:pt x="2632" y="31"/>
                  </a:lnTo>
                  <a:lnTo>
                    <a:pt x="2611" y="31"/>
                  </a:lnTo>
                  <a:cubicBezTo>
                    <a:pt x="2603" y="31"/>
                    <a:pt x="2596" y="24"/>
                    <a:pt x="2596" y="16"/>
                  </a:cubicBezTo>
                  <a:cubicBezTo>
                    <a:pt x="2596" y="7"/>
                    <a:pt x="2603" y="0"/>
                    <a:pt x="2611" y="0"/>
                  </a:cubicBezTo>
                  <a:close/>
                  <a:moveTo>
                    <a:pt x="2634" y="131"/>
                  </a:moveTo>
                  <a:lnTo>
                    <a:pt x="2696" y="131"/>
                  </a:lnTo>
                  <a:cubicBezTo>
                    <a:pt x="2704" y="131"/>
                    <a:pt x="2711" y="138"/>
                    <a:pt x="2711" y="146"/>
                  </a:cubicBezTo>
                  <a:cubicBezTo>
                    <a:pt x="2711" y="155"/>
                    <a:pt x="2704" y="162"/>
                    <a:pt x="2696" y="162"/>
                  </a:cubicBezTo>
                  <a:lnTo>
                    <a:pt x="2634" y="162"/>
                  </a:lnTo>
                  <a:cubicBezTo>
                    <a:pt x="2626" y="162"/>
                    <a:pt x="2619" y="155"/>
                    <a:pt x="2619" y="146"/>
                  </a:cubicBezTo>
                  <a:cubicBezTo>
                    <a:pt x="2619" y="138"/>
                    <a:pt x="2626" y="131"/>
                    <a:pt x="2634" y="131"/>
                  </a:cubicBezTo>
                  <a:close/>
                  <a:moveTo>
                    <a:pt x="2788" y="131"/>
                  </a:moveTo>
                  <a:lnTo>
                    <a:pt x="2849" y="131"/>
                  </a:lnTo>
                  <a:cubicBezTo>
                    <a:pt x="2858" y="131"/>
                    <a:pt x="2865" y="138"/>
                    <a:pt x="2865" y="146"/>
                  </a:cubicBezTo>
                  <a:cubicBezTo>
                    <a:pt x="2865" y="155"/>
                    <a:pt x="2858" y="162"/>
                    <a:pt x="2849" y="162"/>
                  </a:cubicBezTo>
                  <a:lnTo>
                    <a:pt x="2788" y="162"/>
                  </a:lnTo>
                  <a:cubicBezTo>
                    <a:pt x="2779" y="162"/>
                    <a:pt x="2772" y="155"/>
                    <a:pt x="2772" y="146"/>
                  </a:cubicBezTo>
                  <a:cubicBezTo>
                    <a:pt x="2772" y="138"/>
                    <a:pt x="2779" y="131"/>
                    <a:pt x="2788" y="131"/>
                  </a:cubicBezTo>
                  <a:close/>
                  <a:moveTo>
                    <a:pt x="2941" y="131"/>
                  </a:moveTo>
                  <a:lnTo>
                    <a:pt x="2977" y="131"/>
                  </a:lnTo>
                  <a:lnTo>
                    <a:pt x="2977" y="187"/>
                  </a:lnTo>
                  <a:cubicBezTo>
                    <a:pt x="2977" y="196"/>
                    <a:pt x="2970" y="203"/>
                    <a:pt x="2962" y="203"/>
                  </a:cubicBezTo>
                  <a:cubicBezTo>
                    <a:pt x="2953" y="203"/>
                    <a:pt x="2947" y="196"/>
                    <a:pt x="2947" y="187"/>
                  </a:cubicBezTo>
                  <a:lnTo>
                    <a:pt x="2947" y="146"/>
                  </a:lnTo>
                  <a:lnTo>
                    <a:pt x="2962" y="162"/>
                  </a:lnTo>
                  <a:lnTo>
                    <a:pt x="2941" y="162"/>
                  </a:lnTo>
                  <a:cubicBezTo>
                    <a:pt x="2933" y="162"/>
                    <a:pt x="2926" y="155"/>
                    <a:pt x="2926" y="146"/>
                  </a:cubicBezTo>
                  <a:cubicBezTo>
                    <a:pt x="2926" y="138"/>
                    <a:pt x="2933" y="131"/>
                    <a:pt x="2941" y="131"/>
                  </a:cubicBezTo>
                  <a:close/>
                  <a:moveTo>
                    <a:pt x="2977" y="279"/>
                  </a:moveTo>
                  <a:lnTo>
                    <a:pt x="2977" y="328"/>
                  </a:lnTo>
                  <a:cubicBezTo>
                    <a:pt x="2977" y="337"/>
                    <a:pt x="2970" y="343"/>
                    <a:pt x="2962" y="343"/>
                  </a:cubicBezTo>
                  <a:cubicBezTo>
                    <a:pt x="2953" y="343"/>
                    <a:pt x="2947" y="337"/>
                    <a:pt x="2947" y="328"/>
                  </a:cubicBezTo>
                  <a:lnTo>
                    <a:pt x="2947" y="279"/>
                  </a:lnTo>
                  <a:cubicBezTo>
                    <a:pt x="2947" y="271"/>
                    <a:pt x="2953" y="264"/>
                    <a:pt x="2962" y="264"/>
                  </a:cubicBezTo>
                  <a:cubicBezTo>
                    <a:pt x="2970" y="264"/>
                    <a:pt x="2977" y="271"/>
                    <a:pt x="2977" y="279"/>
                  </a:cubicBezTo>
                  <a:close/>
                  <a:moveTo>
                    <a:pt x="2962" y="313"/>
                  </a:moveTo>
                  <a:lnTo>
                    <a:pt x="2975" y="313"/>
                  </a:lnTo>
                  <a:cubicBezTo>
                    <a:pt x="2983" y="313"/>
                    <a:pt x="2990" y="320"/>
                    <a:pt x="2990" y="328"/>
                  </a:cubicBezTo>
                  <a:cubicBezTo>
                    <a:pt x="2990" y="337"/>
                    <a:pt x="2983" y="343"/>
                    <a:pt x="2975" y="343"/>
                  </a:cubicBezTo>
                  <a:lnTo>
                    <a:pt x="2962" y="343"/>
                  </a:lnTo>
                  <a:cubicBezTo>
                    <a:pt x="2953" y="343"/>
                    <a:pt x="2947" y="337"/>
                    <a:pt x="2947" y="328"/>
                  </a:cubicBezTo>
                  <a:cubicBezTo>
                    <a:pt x="2947" y="320"/>
                    <a:pt x="2953" y="313"/>
                    <a:pt x="2962" y="313"/>
                  </a:cubicBezTo>
                  <a:close/>
                  <a:moveTo>
                    <a:pt x="3067" y="313"/>
                  </a:moveTo>
                  <a:lnTo>
                    <a:pt x="3128" y="313"/>
                  </a:lnTo>
                  <a:cubicBezTo>
                    <a:pt x="3137" y="313"/>
                    <a:pt x="3144" y="320"/>
                    <a:pt x="3144" y="328"/>
                  </a:cubicBezTo>
                  <a:cubicBezTo>
                    <a:pt x="3144" y="337"/>
                    <a:pt x="3137" y="343"/>
                    <a:pt x="3128" y="343"/>
                  </a:cubicBezTo>
                  <a:lnTo>
                    <a:pt x="3067" y="343"/>
                  </a:lnTo>
                  <a:cubicBezTo>
                    <a:pt x="3058" y="343"/>
                    <a:pt x="3051" y="337"/>
                    <a:pt x="3051" y="328"/>
                  </a:cubicBezTo>
                  <a:cubicBezTo>
                    <a:pt x="3051" y="320"/>
                    <a:pt x="3058" y="313"/>
                    <a:pt x="3067" y="313"/>
                  </a:cubicBezTo>
                  <a:close/>
                  <a:moveTo>
                    <a:pt x="3220" y="313"/>
                  </a:moveTo>
                  <a:lnTo>
                    <a:pt x="3282" y="313"/>
                  </a:lnTo>
                  <a:cubicBezTo>
                    <a:pt x="3290" y="313"/>
                    <a:pt x="3297" y="320"/>
                    <a:pt x="3297" y="328"/>
                  </a:cubicBezTo>
                  <a:cubicBezTo>
                    <a:pt x="3297" y="337"/>
                    <a:pt x="3290" y="343"/>
                    <a:pt x="3282" y="343"/>
                  </a:cubicBezTo>
                  <a:lnTo>
                    <a:pt x="3220" y="343"/>
                  </a:lnTo>
                  <a:cubicBezTo>
                    <a:pt x="3212" y="343"/>
                    <a:pt x="3205" y="337"/>
                    <a:pt x="3205" y="328"/>
                  </a:cubicBezTo>
                  <a:cubicBezTo>
                    <a:pt x="3205" y="320"/>
                    <a:pt x="3212" y="313"/>
                    <a:pt x="3220" y="313"/>
                  </a:cubicBezTo>
                  <a:close/>
                  <a:moveTo>
                    <a:pt x="3305" y="413"/>
                  </a:moveTo>
                  <a:lnTo>
                    <a:pt x="3305" y="474"/>
                  </a:lnTo>
                  <a:cubicBezTo>
                    <a:pt x="3305" y="482"/>
                    <a:pt x="3298" y="489"/>
                    <a:pt x="3290" y="489"/>
                  </a:cubicBezTo>
                  <a:cubicBezTo>
                    <a:pt x="3281" y="489"/>
                    <a:pt x="3274" y="482"/>
                    <a:pt x="3274" y="474"/>
                  </a:cubicBezTo>
                  <a:lnTo>
                    <a:pt x="3274" y="413"/>
                  </a:lnTo>
                  <a:cubicBezTo>
                    <a:pt x="3274" y="404"/>
                    <a:pt x="3281" y="397"/>
                    <a:pt x="3290" y="397"/>
                  </a:cubicBezTo>
                  <a:cubicBezTo>
                    <a:pt x="3298" y="397"/>
                    <a:pt x="3305" y="404"/>
                    <a:pt x="3305" y="413"/>
                  </a:cubicBezTo>
                  <a:close/>
                  <a:moveTo>
                    <a:pt x="3305" y="566"/>
                  </a:moveTo>
                  <a:lnTo>
                    <a:pt x="3305" y="579"/>
                  </a:lnTo>
                  <a:cubicBezTo>
                    <a:pt x="3305" y="587"/>
                    <a:pt x="3298" y="594"/>
                    <a:pt x="3290" y="594"/>
                  </a:cubicBezTo>
                  <a:cubicBezTo>
                    <a:pt x="3281" y="594"/>
                    <a:pt x="3274" y="587"/>
                    <a:pt x="3274" y="579"/>
                  </a:cubicBezTo>
                  <a:lnTo>
                    <a:pt x="3274" y="566"/>
                  </a:lnTo>
                  <a:cubicBezTo>
                    <a:pt x="3274" y="558"/>
                    <a:pt x="3281" y="551"/>
                    <a:pt x="3290" y="551"/>
                  </a:cubicBezTo>
                  <a:cubicBezTo>
                    <a:pt x="3298" y="551"/>
                    <a:pt x="3305" y="558"/>
                    <a:pt x="3305" y="566"/>
                  </a:cubicBezTo>
                  <a:close/>
                  <a:moveTo>
                    <a:pt x="3290" y="564"/>
                  </a:moveTo>
                  <a:lnTo>
                    <a:pt x="3338" y="564"/>
                  </a:lnTo>
                  <a:cubicBezTo>
                    <a:pt x="3347" y="564"/>
                    <a:pt x="3354" y="570"/>
                    <a:pt x="3354" y="579"/>
                  </a:cubicBezTo>
                  <a:cubicBezTo>
                    <a:pt x="3354" y="587"/>
                    <a:pt x="3347" y="594"/>
                    <a:pt x="3338" y="594"/>
                  </a:cubicBezTo>
                  <a:lnTo>
                    <a:pt x="3290" y="594"/>
                  </a:lnTo>
                  <a:cubicBezTo>
                    <a:pt x="3281" y="594"/>
                    <a:pt x="3274" y="587"/>
                    <a:pt x="3274" y="579"/>
                  </a:cubicBezTo>
                  <a:cubicBezTo>
                    <a:pt x="3274" y="570"/>
                    <a:pt x="3281" y="564"/>
                    <a:pt x="3290" y="564"/>
                  </a:cubicBezTo>
                  <a:close/>
                  <a:moveTo>
                    <a:pt x="3430" y="564"/>
                  </a:moveTo>
                  <a:lnTo>
                    <a:pt x="3492" y="564"/>
                  </a:lnTo>
                  <a:cubicBezTo>
                    <a:pt x="3500" y="564"/>
                    <a:pt x="3507" y="570"/>
                    <a:pt x="3507" y="579"/>
                  </a:cubicBezTo>
                  <a:cubicBezTo>
                    <a:pt x="3507" y="587"/>
                    <a:pt x="3500" y="594"/>
                    <a:pt x="3492" y="594"/>
                  </a:cubicBezTo>
                  <a:lnTo>
                    <a:pt x="3430" y="594"/>
                  </a:lnTo>
                  <a:cubicBezTo>
                    <a:pt x="3422" y="594"/>
                    <a:pt x="3415" y="587"/>
                    <a:pt x="3415" y="579"/>
                  </a:cubicBezTo>
                  <a:cubicBezTo>
                    <a:pt x="3415" y="570"/>
                    <a:pt x="3422" y="564"/>
                    <a:pt x="3430" y="564"/>
                  </a:cubicBezTo>
                  <a:close/>
                  <a:moveTo>
                    <a:pt x="3584" y="564"/>
                  </a:moveTo>
                  <a:lnTo>
                    <a:pt x="3645" y="564"/>
                  </a:lnTo>
                  <a:cubicBezTo>
                    <a:pt x="3654" y="564"/>
                    <a:pt x="3661" y="570"/>
                    <a:pt x="3661" y="579"/>
                  </a:cubicBezTo>
                  <a:cubicBezTo>
                    <a:pt x="3661" y="587"/>
                    <a:pt x="3654" y="594"/>
                    <a:pt x="3645" y="594"/>
                  </a:cubicBezTo>
                  <a:lnTo>
                    <a:pt x="3584" y="594"/>
                  </a:lnTo>
                  <a:cubicBezTo>
                    <a:pt x="3575" y="594"/>
                    <a:pt x="3569" y="587"/>
                    <a:pt x="3569" y="579"/>
                  </a:cubicBezTo>
                  <a:cubicBezTo>
                    <a:pt x="3569" y="570"/>
                    <a:pt x="3575" y="564"/>
                    <a:pt x="3584" y="564"/>
                  </a:cubicBezTo>
                  <a:close/>
                  <a:moveTo>
                    <a:pt x="3738" y="564"/>
                  </a:moveTo>
                  <a:lnTo>
                    <a:pt x="3799" y="564"/>
                  </a:lnTo>
                  <a:cubicBezTo>
                    <a:pt x="3807" y="564"/>
                    <a:pt x="3814" y="570"/>
                    <a:pt x="3814" y="579"/>
                  </a:cubicBezTo>
                  <a:cubicBezTo>
                    <a:pt x="3814" y="587"/>
                    <a:pt x="3807" y="594"/>
                    <a:pt x="3799" y="594"/>
                  </a:cubicBezTo>
                  <a:lnTo>
                    <a:pt x="3738" y="594"/>
                  </a:lnTo>
                  <a:cubicBezTo>
                    <a:pt x="3729" y="594"/>
                    <a:pt x="3722" y="587"/>
                    <a:pt x="3722" y="579"/>
                  </a:cubicBezTo>
                  <a:cubicBezTo>
                    <a:pt x="3722" y="570"/>
                    <a:pt x="3729" y="564"/>
                    <a:pt x="3738" y="564"/>
                  </a:cubicBezTo>
                  <a:close/>
                  <a:moveTo>
                    <a:pt x="3891" y="564"/>
                  </a:moveTo>
                  <a:lnTo>
                    <a:pt x="3963" y="564"/>
                  </a:lnTo>
                  <a:lnTo>
                    <a:pt x="3963" y="584"/>
                  </a:lnTo>
                  <a:cubicBezTo>
                    <a:pt x="3963" y="593"/>
                    <a:pt x="3956" y="599"/>
                    <a:pt x="3947" y="599"/>
                  </a:cubicBezTo>
                  <a:cubicBezTo>
                    <a:pt x="3939" y="599"/>
                    <a:pt x="3932" y="593"/>
                    <a:pt x="3932" y="584"/>
                  </a:cubicBezTo>
                  <a:lnTo>
                    <a:pt x="3932" y="579"/>
                  </a:lnTo>
                  <a:lnTo>
                    <a:pt x="3947" y="594"/>
                  </a:lnTo>
                  <a:lnTo>
                    <a:pt x="3891" y="594"/>
                  </a:lnTo>
                  <a:cubicBezTo>
                    <a:pt x="3883" y="594"/>
                    <a:pt x="3876" y="587"/>
                    <a:pt x="3876" y="579"/>
                  </a:cubicBezTo>
                  <a:cubicBezTo>
                    <a:pt x="3876" y="570"/>
                    <a:pt x="3883" y="564"/>
                    <a:pt x="3891" y="564"/>
                  </a:cubicBezTo>
                  <a:close/>
                  <a:moveTo>
                    <a:pt x="3963" y="676"/>
                  </a:moveTo>
                  <a:lnTo>
                    <a:pt x="3963" y="738"/>
                  </a:lnTo>
                  <a:cubicBezTo>
                    <a:pt x="3963" y="746"/>
                    <a:pt x="3956" y="753"/>
                    <a:pt x="3947" y="753"/>
                  </a:cubicBezTo>
                  <a:cubicBezTo>
                    <a:pt x="3939" y="753"/>
                    <a:pt x="3932" y="746"/>
                    <a:pt x="3932" y="738"/>
                  </a:cubicBezTo>
                  <a:lnTo>
                    <a:pt x="3932" y="676"/>
                  </a:lnTo>
                  <a:cubicBezTo>
                    <a:pt x="3932" y="668"/>
                    <a:pt x="3939" y="661"/>
                    <a:pt x="3947" y="661"/>
                  </a:cubicBezTo>
                  <a:cubicBezTo>
                    <a:pt x="3956" y="661"/>
                    <a:pt x="3963" y="668"/>
                    <a:pt x="3963" y="676"/>
                  </a:cubicBezTo>
                  <a:close/>
                  <a:moveTo>
                    <a:pt x="3963" y="830"/>
                  </a:moveTo>
                  <a:lnTo>
                    <a:pt x="3963" y="891"/>
                  </a:lnTo>
                  <a:cubicBezTo>
                    <a:pt x="3963" y="900"/>
                    <a:pt x="3956" y="907"/>
                    <a:pt x="3947" y="907"/>
                  </a:cubicBezTo>
                  <a:cubicBezTo>
                    <a:pt x="3939" y="907"/>
                    <a:pt x="3932" y="900"/>
                    <a:pt x="3932" y="891"/>
                  </a:cubicBezTo>
                  <a:lnTo>
                    <a:pt x="3932" y="830"/>
                  </a:lnTo>
                  <a:cubicBezTo>
                    <a:pt x="3932" y="821"/>
                    <a:pt x="3939" y="814"/>
                    <a:pt x="3947" y="814"/>
                  </a:cubicBezTo>
                  <a:cubicBezTo>
                    <a:pt x="3956" y="814"/>
                    <a:pt x="3963" y="821"/>
                    <a:pt x="3963" y="830"/>
                  </a:cubicBezTo>
                  <a:close/>
                  <a:moveTo>
                    <a:pt x="3963" y="983"/>
                  </a:moveTo>
                  <a:lnTo>
                    <a:pt x="3963" y="1019"/>
                  </a:lnTo>
                  <a:cubicBezTo>
                    <a:pt x="3963" y="1028"/>
                    <a:pt x="3956" y="1035"/>
                    <a:pt x="3947" y="1035"/>
                  </a:cubicBezTo>
                  <a:cubicBezTo>
                    <a:pt x="3939" y="1035"/>
                    <a:pt x="3932" y="1028"/>
                    <a:pt x="3932" y="1019"/>
                  </a:cubicBezTo>
                  <a:lnTo>
                    <a:pt x="3932" y="983"/>
                  </a:lnTo>
                  <a:cubicBezTo>
                    <a:pt x="3932" y="975"/>
                    <a:pt x="3939" y="968"/>
                    <a:pt x="3947" y="968"/>
                  </a:cubicBezTo>
                  <a:cubicBezTo>
                    <a:pt x="3956" y="968"/>
                    <a:pt x="3963" y="975"/>
                    <a:pt x="3963" y="983"/>
                  </a:cubicBezTo>
                  <a:close/>
                  <a:moveTo>
                    <a:pt x="3947" y="1004"/>
                  </a:moveTo>
                  <a:lnTo>
                    <a:pt x="3973" y="1004"/>
                  </a:lnTo>
                  <a:cubicBezTo>
                    <a:pt x="3982" y="1004"/>
                    <a:pt x="3988" y="1011"/>
                    <a:pt x="3988" y="1019"/>
                  </a:cubicBezTo>
                  <a:cubicBezTo>
                    <a:pt x="3988" y="1028"/>
                    <a:pt x="3982" y="1035"/>
                    <a:pt x="3973" y="1035"/>
                  </a:cubicBezTo>
                  <a:lnTo>
                    <a:pt x="3947" y="1035"/>
                  </a:lnTo>
                  <a:cubicBezTo>
                    <a:pt x="3939" y="1035"/>
                    <a:pt x="3932" y="1028"/>
                    <a:pt x="3932" y="1019"/>
                  </a:cubicBezTo>
                  <a:cubicBezTo>
                    <a:pt x="3932" y="1011"/>
                    <a:pt x="3939" y="1004"/>
                    <a:pt x="3947" y="1004"/>
                  </a:cubicBezTo>
                  <a:close/>
                  <a:moveTo>
                    <a:pt x="4073" y="1027"/>
                  </a:moveTo>
                  <a:lnTo>
                    <a:pt x="4073" y="1088"/>
                  </a:lnTo>
                  <a:cubicBezTo>
                    <a:pt x="4073" y="1097"/>
                    <a:pt x="4066" y="1104"/>
                    <a:pt x="4058" y="1104"/>
                  </a:cubicBezTo>
                  <a:cubicBezTo>
                    <a:pt x="4049" y="1104"/>
                    <a:pt x="4042" y="1097"/>
                    <a:pt x="4042" y="1088"/>
                  </a:cubicBezTo>
                  <a:lnTo>
                    <a:pt x="4042" y="1027"/>
                  </a:lnTo>
                  <a:cubicBezTo>
                    <a:pt x="4042" y="1018"/>
                    <a:pt x="4049" y="1012"/>
                    <a:pt x="4058" y="1012"/>
                  </a:cubicBezTo>
                  <a:cubicBezTo>
                    <a:pt x="4066" y="1012"/>
                    <a:pt x="4073" y="1018"/>
                    <a:pt x="4073" y="1027"/>
                  </a:cubicBezTo>
                  <a:close/>
                  <a:moveTo>
                    <a:pt x="4073" y="1181"/>
                  </a:moveTo>
                  <a:lnTo>
                    <a:pt x="4073" y="1242"/>
                  </a:lnTo>
                  <a:cubicBezTo>
                    <a:pt x="4073" y="1250"/>
                    <a:pt x="4066" y="1257"/>
                    <a:pt x="4058" y="1257"/>
                  </a:cubicBezTo>
                  <a:cubicBezTo>
                    <a:pt x="4049" y="1257"/>
                    <a:pt x="4042" y="1250"/>
                    <a:pt x="4042" y="1242"/>
                  </a:cubicBezTo>
                  <a:lnTo>
                    <a:pt x="4042" y="1181"/>
                  </a:lnTo>
                  <a:cubicBezTo>
                    <a:pt x="4042" y="1172"/>
                    <a:pt x="4049" y="1165"/>
                    <a:pt x="4058" y="1165"/>
                  </a:cubicBezTo>
                  <a:cubicBezTo>
                    <a:pt x="4066" y="1165"/>
                    <a:pt x="4073" y="1172"/>
                    <a:pt x="4073" y="1181"/>
                  </a:cubicBezTo>
                  <a:close/>
                  <a:moveTo>
                    <a:pt x="4073" y="1334"/>
                  </a:moveTo>
                  <a:lnTo>
                    <a:pt x="4073" y="1396"/>
                  </a:lnTo>
                  <a:cubicBezTo>
                    <a:pt x="4073" y="1404"/>
                    <a:pt x="4066" y="1411"/>
                    <a:pt x="4058" y="1411"/>
                  </a:cubicBezTo>
                  <a:cubicBezTo>
                    <a:pt x="4049" y="1411"/>
                    <a:pt x="4042" y="1404"/>
                    <a:pt x="4042" y="1396"/>
                  </a:cubicBezTo>
                  <a:lnTo>
                    <a:pt x="4042" y="1334"/>
                  </a:lnTo>
                  <a:cubicBezTo>
                    <a:pt x="4042" y="1326"/>
                    <a:pt x="4049" y="1319"/>
                    <a:pt x="4058" y="1319"/>
                  </a:cubicBezTo>
                  <a:cubicBezTo>
                    <a:pt x="4066" y="1319"/>
                    <a:pt x="4073" y="1326"/>
                    <a:pt x="4073" y="1334"/>
                  </a:cubicBezTo>
                  <a:close/>
                  <a:moveTo>
                    <a:pt x="4088" y="1442"/>
                  </a:moveTo>
                  <a:lnTo>
                    <a:pt x="4150" y="1442"/>
                  </a:lnTo>
                  <a:cubicBezTo>
                    <a:pt x="4158" y="1442"/>
                    <a:pt x="4165" y="1449"/>
                    <a:pt x="4165" y="1457"/>
                  </a:cubicBezTo>
                  <a:cubicBezTo>
                    <a:pt x="4165" y="1465"/>
                    <a:pt x="4158" y="1472"/>
                    <a:pt x="4150" y="1472"/>
                  </a:cubicBezTo>
                  <a:lnTo>
                    <a:pt x="4088" y="1472"/>
                  </a:lnTo>
                  <a:cubicBezTo>
                    <a:pt x="4080" y="1472"/>
                    <a:pt x="4073" y="1465"/>
                    <a:pt x="4073" y="1457"/>
                  </a:cubicBezTo>
                  <a:cubicBezTo>
                    <a:pt x="4073" y="1449"/>
                    <a:pt x="4080" y="1442"/>
                    <a:pt x="4088" y="1442"/>
                  </a:cubicBezTo>
                  <a:close/>
                  <a:moveTo>
                    <a:pt x="4242" y="1442"/>
                  </a:moveTo>
                  <a:lnTo>
                    <a:pt x="4293" y="1442"/>
                  </a:lnTo>
                  <a:lnTo>
                    <a:pt x="4293" y="1483"/>
                  </a:lnTo>
                  <a:cubicBezTo>
                    <a:pt x="4293" y="1491"/>
                    <a:pt x="4286" y="1498"/>
                    <a:pt x="4278" y="1498"/>
                  </a:cubicBezTo>
                  <a:cubicBezTo>
                    <a:pt x="4269" y="1498"/>
                    <a:pt x="4262" y="1491"/>
                    <a:pt x="4262" y="1483"/>
                  </a:cubicBezTo>
                  <a:lnTo>
                    <a:pt x="4262" y="1457"/>
                  </a:lnTo>
                  <a:lnTo>
                    <a:pt x="4278" y="1472"/>
                  </a:lnTo>
                  <a:lnTo>
                    <a:pt x="4242" y="1472"/>
                  </a:lnTo>
                  <a:cubicBezTo>
                    <a:pt x="4233" y="1472"/>
                    <a:pt x="4227" y="1465"/>
                    <a:pt x="4227" y="1457"/>
                  </a:cubicBezTo>
                  <a:cubicBezTo>
                    <a:pt x="4227" y="1449"/>
                    <a:pt x="4233" y="1442"/>
                    <a:pt x="4242" y="1442"/>
                  </a:cubicBezTo>
                  <a:close/>
                  <a:moveTo>
                    <a:pt x="4293" y="1575"/>
                  </a:moveTo>
                  <a:lnTo>
                    <a:pt x="4293" y="1636"/>
                  </a:lnTo>
                  <a:cubicBezTo>
                    <a:pt x="4293" y="1645"/>
                    <a:pt x="4286" y="1652"/>
                    <a:pt x="4278" y="1652"/>
                  </a:cubicBezTo>
                  <a:cubicBezTo>
                    <a:pt x="4269" y="1652"/>
                    <a:pt x="4262" y="1645"/>
                    <a:pt x="4262" y="1636"/>
                  </a:cubicBezTo>
                  <a:lnTo>
                    <a:pt x="4262" y="1575"/>
                  </a:lnTo>
                  <a:cubicBezTo>
                    <a:pt x="4262" y="1566"/>
                    <a:pt x="4269" y="1559"/>
                    <a:pt x="4278" y="1559"/>
                  </a:cubicBezTo>
                  <a:cubicBezTo>
                    <a:pt x="4286" y="1559"/>
                    <a:pt x="4293" y="1566"/>
                    <a:pt x="4293" y="1575"/>
                  </a:cubicBezTo>
                  <a:close/>
                  <a:moveTo>
                    <a:pt x="4293" y="1728"/>
                  </a:moveTo>
                  <a:lnTo>
                    <a:pt x="4293" y="1790"/>
                  </a:lnTo>
                  <a:cubicBezTo>
                    <a:pt x="4293" y="1798"/>
                    <a:pt x="4286" y="1805"/>
                    <a:pt x="4278" y="1805"/>
                  </a:cubicBezTo>
                  <a:cubicBezTo>
                    <a:pt x="4269" y="1805"/>
                    <a:pt x="4262" y="1798"/>
                    <a:pt x="4262" y="1790"/>
                  </a:cubicBezTo>
                  <a:lnTo>
                    <a:pt x="4262" y="1728"/>
                  </a:lnTo>
                  <a:cubicBezTo>
                    <a:pt x="4262" y="1720"/>
                    <a:pt x="4269" y="1713"/>
                    <a:pt x="4278" y="1713"/>
                  </a:cubicBezTo>
                  <a:cubicBezTo>
                    <a:pt x="4286" y="1713"/>
                    <a:pt x="4293" y="1720"/>
                    <a:pt x="4293" y="1728"/>
                  </a:cubicBezTo>
                  <a:close/>
                  <a:moveTo>
                    <a:pt x="4293" y="1882"/>
                  </a:moveTo>
                  <a:lnTo>
                    <a:pt x="4293" y="1943"/>
                  </a:lnTo>
                  <a:cubicBezTo>
                    <a:pt x="4293" y="1952"/>
                    <a:pt x="4286" y="1959"/>
                    <a:pt x="4278" y="1959"/>
                  </a:cubicBezTo>
                  <a:cubicBezTo>
                    <a:pt x="4269" y="1959"/>
                    <a:pt x="4262" y="1952"/>
                    <a:pt x="4262" y="1943"/>
                  </a:cubicBezTo>
                  <a:lnTo>
                    <a:pt x="4262" y="1882"/>
                  </a:lnTo>
                  <a:cubicBezTo>
                    <a:pt x="4262" y="1873"/>
                    <a:pt x="4269" y="1867"/>
                    <a:pt x="4278" y="1867"/>
                  </a:cubicBezTo>
                  <a:cubicBezTo>
                    <a:pt x="4286" y="1867"/>
                    <a:pt x="4293" y="1873"/>
                    <a:pt x="4293" y="1882"/>
                  </a:cubicBezTo>
                  <a:close/>
                  <a:moveTo>
                    <a:pt x="4293" y="2036"/>
                  </a:moveTo>
                  <a:lnTo>
                    <a:pt x="4293" y="2097"/>
                  </a:lnTo>
                  <a:cubicBezTo>
                    <a:pt x="4293" y="2105"/>
                    <a:pt x="4286" y="2112"/>
                    <a:pt x="4278" y="2112"/>
                  </a:cubicBezTo>
                  <a:cubicBezTo>
                    <a:pt x="4269" y="2112"/>
                    <a:pt x="4262" y="2105"/>
                    <a:pt x="4262" y="2097"/>
                  </a:cubicBezTo>
                  <a:lnTo>
                    <a:pt x="4262" y="2036"/>
                  </a:lnTo>
                  <a:cubicBezTo>
                    <a:pt x="4262" y="2027"/>
                    <a:pt x="4269" y="2020"/>
                    <a:pt x="4278" y="2020"/>
                  </a:cubicBezTo>
                  <a:cubicBezTo>
                    <a:pt x="4286" y="2020"/>
                    <a:pt x="4293" y="2027"/>
                    <a:pt x="4293" y="2036"/>
                  </a:cubicBezTo>
                  <a:close/>
                  <a:moveTo>
                    <a:pt x="4293" y="2189"/>
                  </a:moveTo>
                  <a:lnTo>
                    <a:pt x="4293" y="2251"/>
                  </a:lnTo>
                  <a:cubicBezTo>
                    <a:pt x="4293" y="2259"/>
                    <a:pt x="4286" y="2266"/>
                    <a:pt x="4278" y="2266"/>
                  </a:cubicBezTo>
                  <a:cubicBezTo>
                    <a:pt x="4269" y="2266"/>
                    <a:pt x="4262" y="2259"/>
                    <a:pt x="4262" y="2251"/>
                  </a:cubicBezTo>
                  <a:lnTo>
                    <a:pt x="4262" y="2189"/>
                  </a:lnTo>
                  <a:cubicBezTo>
                    <a:pt x="4262" y="2181"/>
                    <a:pt x="4269" y="2174"/>
                    <a:pt x="4278" y="2174"/>
                  </a:cubicBezTo>
                  <a:cubicBezTo>
                    <a:pt x="4286" y="2174"/>
                    <a:pt x="4293" y="2181"/>
                    <a:pt x="4293" y="2189"/>
                  </a:cubicBezTo>
                  <a:close/>
                </a:path>
              </a:pathLst>
            </a:custGeom>
            <a:solidFill>
              <a:srgbClr val="FF0000"/>
            </a:solidFill>
            <a:ln w="1588" cap="flat">
              <a:solidFill>
                <a:srgbClr val="FF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6" name="Line 290">
              <a:extLst>
                <a:ext uri="{FF2B5EF4-FFF2-40B4-BE49-F238E27FC236}">
                  <a16:creationId xmlns:a16="http://schemas.microsoft.com/office/drawing/2014/main" id="{19B9ACA4-D314-4822-9A9B-1D30AD6A328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595562" y="4995863"/>
              <a:ext cx="0" cy="36512"/>
            </a:xfrm>
            <a:prstGeom prst="line">
              <a:avLst/>
            </a:pr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7" name="Line 291">
              <a:extLst>
                <a:ext uri="{FF2B5EF4-FFF2-40B4-BE49-F238E27FC236}">
                  <a16:creationId xmlns:a16="http://schemas.microsoft.com/office/drawing/2014/main" id="{2DB7FE6B-9FA6-4FA5-9957-739FB603719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400300" y="4995863"/>
              <a:ext cx="0" cy="36512"/>
            </a:xfrm>
            <a:prstGeom prst="line">
              <a:avLst/>
            </a:pr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8" name="Line 292">
              <a:extLst>
                <a:ext uri="{FF2B5EF4-FFF2-40B4-BE49-F238E27FC236}">
                  <a16:creationId xmlns:a16="http://schemas.microsoft.com/office/drawing/2014/main" id="{7B529602-99AA-40E6-A17A-F74B90895DD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203450" y="4995863"/>
              <a:ext cx="0" cy="36512"/>
            </a:xfrm>
            <a:prstGeom prst="line">
              <a:avLst/>
            </a:pr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9" name="Line 293">
              <a:extLst>
                <a:ext uri="{FF2B5EF4-FFF2-40B4-BE49-F238E27FC236}">
                  <a16:creationId xmlns:a16="http://schemas.microsoft.com/office/drawing/2014/main" id="{809C8C93-D4E2-4A4B-936F-36C89C01C1A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071687" y="4995863"/>
              <a:ext cx="0" cy="36512"/>
            </a:xfrm>
            <a:prstGeom prst="line">
              <a:avLst/>
            </a:pr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0" name="Line 294">
              <a:extLst>
                <a:ext uri="{FF2B5EF4-FFF2-40B4-BE49-F238E27FC236}">
                  <a16:creationId xmlns:a16="http://schemas.microsoft.com/office/drawing/2014/main" id="{7A4B8D8A-8F75-46AB-82FF-0BCC6A4E892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006600" y="4995863"/>
              <a:ext cx="0" cy="36512"/>
            </a:xfrm>
            <a:prstGeom prst="line">
              <a:avLst/>
            </a:pr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1" name="Line 295">
              <a:extLst>
                <a:ext uri="{FF2B5EF4-FFF2-40B4-BE49-F238E27FC236}">
                  <a16:creationId xmlns:a16="http://schemas.microsoft.com/office/drawing/2014/main" id="{AF4E6CEE-A105-4BCC-9686-6DBB6DF9B67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941512" y="4995863"/>
              <a:ext cx="0" cy="36512"/>
            </a:xfrm>
            <a:prstGeom prst="line">
              <a:avLst/>
            </a:pr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2" name="Line 296">
              <a:extLst>
                <a:ext uri="{FF2B5EF4-FFF2-40B4-BE49-F238E27FC236}">
                  <a16:creationId xmlns:a16="http://schemas.microsoft.com/office/drawing/2014/main" id="{7C237A13-DFA4-4DEA-B223-5B38BB90027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876425" y="4995863"/>
              <a:ext cx="0" cy="36512"/>
            </a:xfrm>
            <a:prstGeom prst="line">
              <a:avLst/>
            </a:pr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3" name="Line 297">
              <a:extLst>
                <a:ext uri="{FF2B5EF4-FFF2-40B4-BE49-F238E27FC236}">
                  <a16:creationId xmlns:a16="http://schemas.microsoft.com/office/drawing/2014/main" id="{FCCBC27D-74B0-4E12-B455-B0F44871E7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809750" y="5073650"/>
              <a:ext cx="0" cy="36512"/>
            </a:xfrm>
            <a:prstGeom prst="line">
              <a:avLst/>
            </a:pr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4" name="Line 298">
              <a:extLst>
                <a:ext uri="{FF2B5EF4-FFF2-40B4-BE49-F238E27FC236}">
                  <a16:creationId xmlns:a16="http://schemas.microsoft.com/office/drawing/2014/main" id="{5CB28298-CC28-4303-A70C-DC972EF82FC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744662" y="5073650"/>
              <a:ext cx="0" cy="36512"/>
            </a:xfrm>
            <a:prstGeom prst="line">
              <a:avLst/>
            </a:pr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5" name="Line 299">
              <a:extLst>
                <a:ext uri="{FF2B5EF4-FFF2-40B4-BE49-F238E27FC236}">
                  <a16:creationId xmlns:a16="http://schemas.microsoft.com/office/drawing/2014/main" id="{4933C6DB-89D2-4160-97BC-9F875D488DA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679575" y="5073650"/>
              <a:ext cx="0" cy="36512"/>
            </a:xfrm>
            <a:prstGeom prst="line">
              <a:avLst/>
            </a:pr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6" name="Line 300">
              <a:extLst>
                <a:ext uri="{FF2B5EF4-FFF2-40B4-BE49-F238E27FC236}">
                  <a16:creationId xmlns:a16="http://schemas.microsoft.com/office/drawing/2014/main" id="{0E9E413A-E5DC-4715-A16E-54A81E3AEAF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612900" y="5181600"/>
              <a:ext cx="0" cy="36512"/>
            </a:xfrm>
            <a:prstGeom prst="line">
              <a:avLst/>
            </a:pr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7" name="Line 301">
              <a:extLst>
                <a:ext uri="{FF2B5EF4-FFF2-40B4-BE49-F238E27FC236}">
                  <a16:creationId xmlns:a16="http://schemas.microsoft.com/office/drawing/2014/main" id="{95D67C3D-3398-4FEA-934D-D3AC4061A31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417637" y="5330825"/>
              <a:ext cx="0" cy="38100"/>
            </a:xfrm>
            <a:prstGeom prst="line">
              <a:avLst/>
            </a:pr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9" name="Line 302">
              <a:extLst>
                <a:ext uri="{FF2B5EF4-FFF2-40B4-BE49-F238E27FC236}">
                  <a16:creationId xmlns:a16="http://schemas.microsoft.com/office/drawing/2014/main" id="{940B3439-91F6-4655-938F-39198D23B40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352550" y="5330825"/>
              <a:ext cx="0" cy="38100"/>
            </a:xfrm>
            <a:prstGeom prst="line">
              <a:avLst/>
            </a:pr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0" name="Line 303">
              <a:extLst>
                <a:ext uri="{FF2B5EF4-FFF2-40B4-BE49-F238E27FC236}">
                  <a16:creationId xmlns:a16="http://schemas.microsoft.com/office/drawing/2014/main" id="{B600968F-413E-4D6B-8636-59BD0C2F1BA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958850" y="5856288"/>
              <a:ext cx="0" cy="36512"/>
            </a:xfrm>
            <a:prstGeom prst="line">
              <a:avLst/>
            </a:pr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1" name="Freeform 304">
              <a:extLst>
                <a:ext uri="{FF2B5EF4-FFF2-40B4-BE49-F238E27FC236}">
                  <a16:creationId xmlns:a16="http://schemas.microsoft.com/office/drawing/2014/main" id="{1953238D-64DF-4D98-BEB2-B71FD96B320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-3379787" y="5022850"/>
              <a:ext cx="2036763" cy="1393825"/>
            </a:xfrm>
            <a:custGeom>
              <a:avLst/>
              <a:gdLst>
                <a:gd name="T0" fmla="*/ 0 w 3415"/>
                <a:gd name="T1" fmla="*/ 31 h 2335"/>
                <a:gd name="T2" fmla="*/ 215 w 3415"/>
                <a:gd name="T3" fmla="*/ 31 h 2335"/>
                <a:gd name="T4" fmla="*/ 369 w 3415"/>
                <a:gd name="T5" fmla="*/ 0 h 2335"/>
                <a:gd name="T6" fmla="*/ 307 w 3415"/>
                <a:gd name="T7" fmla="*/ 0 h 2335"/>
                <a:gd name="T8" fmla="*/ 461 w 3415"/>
                <a:gd name="T9" fmla="*/ 31 h 2335"/>
                <a:gd name="T10" fmla="*/ 691 w 3415"/>
                <a:gd name="T11" fmla="*/ 16 h 2335"/>
                <a:gd name="T12" fmla="*/ 768 w 3415"/>
                <a:gd name="T13" fmla="*/ 0 h 2335"/>
                <a:gd name="T14" fmla="*/ 753 w 3415"/>
                <a:gd name="T15" fmla="*/ 16 h 2335"/>
                <a:gd name="T16" fmla="*/ 983 w 3415"/>
                <a:gd name="T17" fmla="*/ 31 h 2335"/>
                <a:gd name="T18" fmla="*/ 1137 w 3415"/>
                <a:gd name="T19" fmla="*/ 0 h 2335"/>
                <a:gd name="T20" fmla="*/ 1075 w 3415"/>
                <a:gd name="T21" fmla="*/ 0 h 2335"/>
                <a:gd name="T22" fmla="*/ 1229 w 3415"/>
                <a:gd name="T23" fmla="*/ 31 h 2335"/>
                <a:gd name="T24" fmla="*/ 1459 w 3415"/>
                <a:gd name="T25" fmla="*/ 16 h 2335"/>
                <a:gd name="T26" fmla="*/ 1536 w 3415"/>
                <a:gd name="T27" fmla="*/ 0 h 2335"/>
                <a:gd name="T28" fmla="*/ 1521 w 3415"/>
                <a:gd name="T29" fmla="*/ 16 h 2335"/>
                <a:gd name="T30" fmla="*/ 1751 w 3415"/>
                <a:gd name="T31" fmla="*/ 31 h 2335"/>
                <a:gd name="T32" fmla="*/ 1905 w 3415"/>
                <a:gd name="T33" fmla="*/ 0 h 2335"/>
                <a:gd name="T34" fmla="*/ 1843 w 3415"/>
                <a:gd name="T35" fmla="*/ 0 h 2335"/>
                <a:gd name="T36" fmla="*/ 1958 w 3415"/>
                <a:gd name="T37" fmla="*/ 39 h 2335"/>
                <a:gd name="T38" fmla="*/ 1974 w 3415"/>
                <a:gd name="T39" fmla="*/ 269 h 2335"/>
                <a:gd name="T40" fmla="*/ 2012 w 3415"/>
                <a:gd name="T41" fmla="*/ 292 h 2335"/>
                <a:gd name="T42" fmla="*/ 1997 w 3415"/>
                <a:gd name="T43" fmla="*/ 308 h 2335"/>
                <a:gd name="T44" fmla="*/ 2194 w 3415"/>
                <a:gd name="T45" fmla="*/ 356 h 2335"/>
                <a:gd name="T46" fmla="*/ 2150 w 3415"/>
                <a:gd name="T47" fmla="*/ 308 h 2335"/>
                <a:gd name="T48" fmla="*/ 2179 w 3415"/>
                <a:gd name="T49" fmla="*/ 494 h 2335"/>
                <a:gd name="T50" fmla="*/ 2304 w 3415"/>
                <a:gd name="T51" fmla="*/ 494 h 2335"/>
                <a:gd name="T52" fmla="*/ 2271 w 3415"/>
                <a:gd name="T53" fmla="*/ 494 h 2335"/>
                <a:gd name="T54" fmla="*/ 2304 w 3415"/>
                <a:gd name="T55" fmla="*/ 525 h 2335"/>
                <a:gd name="T56" fmla="*/ 2501 w 3415"/>
                <a:gd name="T57" fmla="*/ 510 h 2335"/>
                <a:gd name="T58" fmla="*/ 2537 w 3415"/>
                <a:gd name="T59" fmla="*/ 566 h 2335"/>
                <a:gd name="T60" fmla="*/ 2522 w 3415"/>
                <a:gd name="T61" fmla="*/ 551 h 2335"/>
                <a:gd name="T62" fmla="*/ 2506 w 3415"/>
                <a:gd name="T63" fmla="*/ 781 h 2335"/>
                <a:gd name="T64" fmla="*/ 2632 w 3415"/>
                <a:gd name="T65" fmla="*/ 799 h 2335"/>
                <a:gd name="T66" fmla="*/ 2580 w 3415"/>
                <a:gd name="T67" fmla="*/ 799 h 2335"/>
                <a:gd name="T68" fmla="*/ 2632 w 3415"/>
                <a:gd name="T69" fmla="*/ 830 h 2335"/>
                <a:gd name="T70" fmla="*/ 2757 w 3415"/>
                <a:gd name="T71" fmla="*/ 814 h 2335"/>
                <a:gd name="T72" fmla="*/ 2742 w 3415"/>
                <a:gd name="T73" fmla="*/ 799 h 2335"/>
                <a:gd name="T74" fmla="*/ 2726 w 3415"/>
                <a:gd name="T75" fmla="*/ 814 h 2335"/>
                <a:gd name="T76" fmla="*/ 2836 w 3415"/>
                <a:gd name="T77" fmla="*/ 912 h 2335"/>
                <a:gd name="T78" fmla="*/ 2867 w 3415"/>
                <a:gd name="T79" fmla="*/ 1065 h 2335"/>
                <a:gd name="T80" fmla="*/ 2867 w 3415"/>
                <a:gd name="T81" fmla="*/ 1004 h 2335"/>
                <a:gd name="T82" fmla="*/ 2836 w 3415"/>
                <a:gd name="T83" fmla="*/ 1157 h 2335"/>
                <a:gd name="T84" fmla="*/ 2852 w 3415"/>
                <a:gd name="T85" fmla="*/ 1337 h 2335"/>
                <a:gd name="T86" fmla="*/ 2852 w 3415"/>
                <a:gd name="T87" fmla="*/ 1306 h 2335"/>
                <a:gd name="T88" fmla="*/ 2836 w 3415"/>
                <a:gd name="T89" fmla="*/ 1321 h 2335"/>
                <a:gd name="T90" fmla="*/ 3057 w 3415"/>
                <a:gd name="T91" fmla="*/ 1337 h 2335"/>
                <a:gd name="T92" fmla="*/ 3210 w 3415"/>
                <a:gd name="T93" fmla="*/ 1306 h 2335"/>
                <a:gd name="T94" fmla="*/ 3149 w 3415"/>
                <a:gd name="T95" fmla="*/ 1306 h 2335"/>
                <a:gd name="T96" fmla="*/ 3302 w 3415"/>
                <a:gd name="T97" fmla="*/ 1337 h 2335"/>
                <a:gd name="T98" fmla="*/ 3400 w 3415"/>
                <a:gd name="T99" fmla="*/ 1454 h 2335"/>
                <a:gd name="T100" fmla="*/ 3415 w 3415"/>
                <a:gd name="T101" fmla="*/ 1531 h 2335"/>
                <a:gd name="T102" fmla="*/ 3400 w 3415"/>
                <a:gd name="T103" fmla="*/ 1516 h 2335"/>
                <a:gd name="T104" fmla="*/ 3384 w 3415"/>
                <a:gd name="T105" fmla="*/ 1746 h 2335"/>
                <a:gd name="T106" fmla="*/ 3415 w 3415"/>
                <a:gd name="T107" fmla="*/ 1900 h 2335"/>
                <a:gd name="T108" fmla="*/ 3415 w 3415"/>
                <a:gd name="T109" fmla="*/ 1838 h 2335"/>
                <a:gd name="T110" fmla="*/ 3384 w 3415"/>
                <a:gd name="T111" fmla="*/ 1992 h 2335"/>
                <a:gd name="T112" fmla="*/ 3400 w 3415"/>
                <a:gd name="T113" fmla="*/ 2222 h 2335"/>
                <a:gd name="T114" fmla="*/ 3415 w 3415"/>
                <a:gd name="T115" fmla="*/ 2299 h 2335"/>
                <a:gd name="T116" fmla="*/ 3415 w 3415"/>
                <a:gd name="T117" fmla="*/ 2299 h 23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3415" h="2335">
                  <a:moveTo>
                    <a:pt x="0" y="0"/>
                  </a:moveTo>
                  <a:lnTo>
                    <a:pt x="61" y="0"/>
                  </a:lnTo>
                  <a:cubicBezTo>
                    <a:pt x="70" y="0"/>
                    <a:pt x="77" y="7"/>
                    <a:pt x="77" y="16"/>
                  </a:cubicBezTo>
                  <a:cubicBezTo>
                    <a:pt x="77" y="24"/>
                    <a:pt x="70" y="31"/>
                    <a:pt x="61" y="31"/>
                  </a:cubicBezTo>
                  <a:lnTo>
                    <a:pt x="0" y="31"/>
                  </a:lnTo>
                  <a:lnTo>
                    <a:pt x="0" y="0"/>
                  </a:lnTo>
                  <a:close/>
                  <a:moveTo>
                    <a:pt x="154" y="0"/>
                  </a:moveTo>
                  <a:lnTo>
                    <a:pt x="215" y="0"/>
                  </a:lnTo>
                  <a:cubicBezTo>
                    <a:pt x="223" y="0"/>
                    <a:pt x="230" y="7"/>
                    <a:pt x="230" y="16"/>
                  </a:cubicBezTo>
                  <a:cubicBezTo>
                    <a:pt x="230" y="24"/>
                    <a:pt x="223" y="31"/>
                    <a:pt x="215" y="31"/>
                  </a:cubicBezTo>
                  <a:lnTo>
                    <a:pt x="154" y="31"/>
                  </a:lnTo>
                  <a:cubicBezTo>
                    <a:pt x="145" y="31"/>
                    <a:pt x="138" y="24"/>
                    <a:pt x="138" y="16"/>
                  </a:cubicBezTo>
                  <a:cubicBezTo>
                    <a:pt x="138" y="7"/>
                    <a:pt x="145" y="0"/>
                    <a:pt x="154" y="0"/>
                  </a:cubicBezTo>
                  <a:close/>
                  <a:moveTo>
                    <a:pt x="307" y="0"/>
                  </a:moveTo>
                  <a:lnTo>
                    <a:pt x="369" y="0"/>
                  </a:lnTo>
                  <a:cubicBezTo>
                    <a:pt x="377" y="0"/>
                    <a:pt x="384" y="7"/>
                    <a:pt x="384" y="16"/>
                  </a:cubicBezTo>
                  <a:cubicBezTo>
                    <a:pt x="384" y="24"/>
                    <a:pt x="377" y="31"/>
                    <a:pt x="369" y="31"/>
                  </a:cubicBezTo>
                  <a:lnTo>
                    <a:pt x="307" y="31"/>
                  </a:lnTo>
                  <a:cubicBezTo>
                    <a:pt x="299" y="31"/>
                    <a:pt x="292" y="24"/>
                    <a:pt x="292" y="16"/>
                  </a:cubicBezTo>
                  <a:cubicBezTo>
                    <a:pt x="292" y="7"/>
                    <a:pt x="299" y="0"/>
                    <a:pt x="307" y="0"/>
                  </a:cubicBezTo>
                  <a:close/>
                  <a:moveTo>
                    <a:pt x="461" y="0"/>
                  </a:moveTo>
                  <a:lnTo>
                    <a:pt x="522" y="0"/>
                  </a:lnTo>
                  <a:cubicBezTo>
                    <a:pt x="531" y="0"/>
                    <a:pt x="538" y="7"/>
                    <a:pt x="538" y="16"/>
                  </a:cubicBezTo>
                  <a:cubicBezTo>
                    <a:pt x="538" y="24"/>
                    <a:pt x="531" y="31"/>
                    <a:pt x="522" y="31"/>
                  </a:cubicBezTo>
                  <a:lnTo>
                    <a:pt x="461" y="31"/>
                  </a:lnTo>
                  <a:cubicBezTo>
                    <a:pt x="452" y="31"/>
                    <a:pt x="445" y="24"/>
                    <a:pt x="445" y="16"/>
                  </a:cubicBezTo>
                  <a:cubicBezTo>
                    <a:pt x="445" y="7"/>
                    <a:pt x="452" y="0"/>
                    <a:pt x="461" y="0"/>
                  </a:cubicBezTo>
                  <a:close/>
                  <a:moveTo>
                    <a:pt x="614" y="0"/>
                  </a:moveTo>
                  <a:lnTo>
                    <a:pt x="676" y="0"/>
                  </a:lnTo>
                  <a:cubicBezTo>
                    <a:pt x="684" y="0"/>
                    <a:pt x="691" y="7"/>
                    <a:pt x="691" y="16"/>
                  </a:cubicBezTo>
                  <a:cubicBezTo>
                    <a:pt x="691" y="24"/>
                    <a:pt x="684" y="31"/>
                    <a:pt x="676" y="31"/>
                  </a:cubicBezTo>
                  <a:lnTo>
                    <a:pt x="614" y="31"/>
                  </a:lnTo>
                  <a:cubicBezTo>
                    <a:pt x="606" y="31"/>
                    <a:pt x="599" y="24"/>
                    <a:pt x="599" y="16"/>
                  </a:cubicBezTo>
                  <a:cubicBezTo>
                    <a:pt x="599" y="7"/>
                    <a:pt x="606" y="0"/>
                    <a:pt x="614" y="0"/>
                  </a:cubicBezTo>
                  <a:close/>
                  <a:moveTo>
                    <a:pt x="768" y="0"/>
                  </a:moveTo>
                  <a:lnTo>
                    <a:pt x="829" y="0"/>
                  </a:lnTo>
                  <a:cubicBezTo>
                    <a:pt x="838" y="0"/>
                    <a:pt x="845" y="7"/>
                    <a:pt x="845" y="16"/>
                  </a:cubicBezTo>
                  <a:cubicBezTo>
                    <a:pt x="845" y="24"/>
                    <a:pt x="838" y="31"/>
                    <a:pt x="829" y="31"/>
                  </a:cubicBezTo>
                  <a:lnTo>
                    <a:pt x="768" y="31"/>
                  </a:lnTo>
                  <a:cubicBezTo>
                    <a:pt x="759" y="31"/>
                    <a:pt x="753" y="24"/>
                    <a:pt x="753" y="16"/>
                  </a:cubicBezTo>
                  <a:cubicBezTo>
                    <a:pt x="753" y="7"/>
                    <a:pt x="759" y="0"/>
                    <a:pt x="768" y="0"/>
                  </a:cubicBezTo>
                  <a:close/>
                  <a:moveTo>
                    <a:pt x="922" y="0"/>
                  </a:moveTo>
                  <a:lnTo>
                    <a:pt x="983" y="0"/>
                  </a:lnTo>
                  <a:cubicBezTo>
                    <a:pt x="991" y="0"/>
                    <a:pt x="998" y="7"/>
                    <a:pt x="998" y="16"/>
                  </a:cubicBezTo>
                  <a:cubicBezTo>
                    <a:pt x="998" y="24"/>
                    <a:pt x="991" y="31"/>
                    <a:pt x="983" y="31"/>
                  </a:cubicBezTo>
                  <a:lnTo>
                    <a:pt x="922" y="31"/>
                  </a:lnTo>
                  <a:cubicBezTo>
                    <a:pt x="913" y="31"/>
                    <a:pt x="906" y="24"/>
                    <a:pt x="906" y="16"/>
                  </a:cubicBezTo>
                  <a:cubicBezTo>
                    <a:pt x="906" y="7"/>
                    <a:pt x="913" y="0"/>
                    <a:pt x="922" y="0"/>
                  </a:cubicBezTo>
                  <a:close/>
                  <a:moveTo>
                    <a:pt x="1075" y="0"/>
                  </a:moveTo>
                  <a:lnTo>
                    <a:pt x="1137" y="0"/>
                  </a:lnTo>
                  <a:cubicBezTo>
                    <a:pt x="1145" y="0"/>
                    <a:pt x="1152" y="7"/>
                    <a:pt x="1152" y="16"/>
                  </a:cubicBezTo>
                  <a:cubicBezTo>
                    <a:pt x="1152" y="24"/>
                    <a:pt x="1145" y="31"/>
                    <a:pt x="1137" y="31"/>
                  </a:cubicBezTo>
                  <a:lnTo>
                    <a:pt x="1075" y="31"/>
                  </a:lnTo>
                  <a:cubicBezTo>
                    <a:pt x="1067" y="31"/>
                    <a:pt x="1060" y="24"/>
                    <a:pt x="1060" y="16"/>
                  </a:cubicBezTo>
                  <a:cubicBezTo>
                    <a:pt x="1060" y="7"/>
                    <a:pt x="1067" y="0"/>
                    <a:pt x="1075" y="0"/>
                  </a:cubicBezTo>
                  <a:close/>
                  <a:moveTo>
                    <a:pt x="1229" y="0"/>
                  </a:moveTo>
                  <a:lnTo>
                    <a:pt x="1290" y="0"/>
                  </a:lnTo>
                  <a:cubicBezTo>
                    <a:pt x="1299" y="0"/>
                    <a:pt x="1306" y="7"/>
                    <a:pt x="1306" y="16"/>
                  </a:cubicBezTo>
                  <a:cubicBezTo>
                    <a:pt x="1306" y="24"/>
                    <a:pt x="1299" y="31"/>
                    <a:pt x="1290" y="31"/>
                  </a:cubicBezTo>
                  <a:lnTo>
                    <a:pt x="1229" y="31"/>
                  </a:lnTo>
                  <a:cubicBezTo>
                    <a:pt x="1220" y="31"/>
                    <a:pt x="1213" y="24"/>
                    <a:pt x="1213" y="16"/>
                  </a:cubicBezTo>
                  <a:cubicBezTo>
                    <a:pt x="1213" y="7"/>
                    <a:pt x="1220" y="0"/>
                    <a:pt x="1229" y="0"/>
                  </a:cubicBezTo>
                  <a:close/>
                  <a:moveTo>
                    <a:pt x="1382" y="0"/>
                  </a:moveTo>
                  <a:lnTo>
                    <a:pt x="1444" y="0"/>
                  </a:lnTo>
                  <a:cubicBezTo>
                    <a:pt x="1452" y="0"/>
                    <a:pt x="1459" y="7"/>
                    <a:pt x="1459" y="16"/>
                  </a:cubicBezTo>
                  <a:cubicBezTo>
                    <a:pt x="1459" y="24"/>
                    <a:pt x="1452" y="31"/>
                    <a:pt x="1444" y="31"/>
                  </a:cubicBezTo>
                  <a:lnTo>
                    <a:pt x="1382" y="31"/>
                  </a:lnTo>
                  <a:cubicBezTo>
                    <a:pt x="1374" y="31"/>
                    <a:pt x="1367" y="24"/>
                    <a:pt x="1367" y="16"/>
                  </a:cubicBezTo>
                  <a:cubicBezTo>
                    <a:pt x="1367" y="7"/>
                    <a:pt x="1374" y="0"/>
                    <a:pt x="1382" y="0"/>
                  </a:cubicBezTo>
                  <a:close/>
                  <a:moveTo>
                    <a:pt x="1536" y="0"/>
                  </a:moveTo>
                  <a:lnTo>
                    <a:pt x="1597" y="0"/>
                  </a:lnTo>
                  <a:cubicBezTo>
                    <a:pt x="1606" y="0"/>
                    <a:pt x="1613" y="7"/>
                    <a:pt x="1613" y="16"/>
                  </a:cubicBezTo>
                  <a:cubicBezTo>
                    <a:pt x="1613" y="24"/>
                    <a:pt x="1606" y="31"/>
                    <a:pt x="1597" y="31"/>
                  </a:cubicBezTo>
                  <a:lnTo>
                    <a:pt x="1536" y="31"/>
                  </a:lnTo>
                  <a:cubicBezTo>
                    <a:pt x="1527" y="31"/>
                    <a:pt x="1521" y="24"/>
                    <a:pt x="1521" y="16"/>
                  </a:cubicBezTo>
                  <a:cubicBezTo>
                    <a:pt x="1521" y="7"/>
                    <a:pt x="1527" y="0"/>
                    <a:pt x="1536" y="0"/>
                  </a:cubicBezTo>
                  <a:close/>
                  <a:moveTo>
                    <a:pt x="1690" y="0"/>
                  </a:moveTo>
                  <a:lnTo>
                    <a:pt x="1751" y="0"/>
                  </a:lnTo>
                  <a:cubicBezTo>
                    <a:pt x="1759" y="0"/>
                    <a:pt x="1766" y="7"/>
                    <a:pt x="1766" y="16"/>
                  </a:cubicBezTo>
                  <a:cubicBezTo>
                    <a:pt x="1766" y="24"/>
                    <a:pt x="1759" y="31"/>
                    <a:pt x="1751" y="31"/>
                  </a:cubicBezTo>
                  <a:lnTo>
                    <a:pt x="1690" y="31"/>
                  </a:lnTo>
                  <a:cubicBezTo>
                    <a:pt x="1681" y="31"/>
                    <a:pt x="1674" y="24"/>
                    <a:pt x="1674" y="16"/>
                  </a:cubicBezTo>
                  <a:cubicBezTo>
                    <a:pt x="1674" y="7"/>
                    <a:pt x="1681" y="0"/>
                    <a:pt x="1690" y="0"/>
                  </a:cubicBezTo>
                  <a:close/>
                  <a:moveTo>
                    <a:pt x="1843" y="0"/>
                  </a:moveTo>
                  <a:lnTo>
                    <a:pt x="1905" y="0"/>
                  </a:lnTo>
                  <a:cubicBezTo>
                    <a:pt x="1913" y="0"/>
                    <a:pt x="1920" y="7"/>
                    <a:pt x="1920" y="16"/>
                  </a:cubicBezTo>
                  <a:cubicBezTo>
                    <a:pt x="1920" y="24"/>
                    <a:pt x="1913" y="31"/>
                    <a:pt x="1905" y="31"/>
                  </a:cubicBezTo>
                  <a:lnTo>
                    <a:pt x="1843" y="31"/>
                  </a:lnTo>
                  <a:cubicBezTo>
                    <a:pt x="1835" y="31"/>
                    <a:pt x="1828" y="24"/>
                    <a:pt x="1828" y="16"/>
                  </a:cubicBezTo>
                  <a:cubicBezTo>
                    <a:pt x="1828" y="7"/>
                    <a:pt x="1835" y="0"/>
                    <a:pt x="1843" y="0"/>
                  </a:cubicBezTo>
                  <a:close/>
                  <a:moveTo>
                    <a:pt x="1989" y="39"/>
                  </a:moveTo>
                  <a:lnTo>
                    <a:pt x="1989" y="100"/>
                  </a:lnTo>
                  <a:cubicBezTo>
                    <a:pt x="1989" y="109"/>
                    <a:pt x="1982" y="116"/>
                    <a:pt x="1974" y="116"/>
                  </a:cubicBezTo>
                  <a:cubicBezTo>
                    <a:pt x="1965" y="116"/>
                    <a:pt x="1958" y="109"/>
                    <a:pt x="1958" y="100"/>
                  </a:cubicBezTo>
                  <a:lnTo>
                    <a:pt x="1958" y="39"/>
                  </a:lnTo>
                  <a:cubicBezTo>
                    <a:pt x="1958" y="30"/>
                    <a:pt x="1965" y="23"/>
                    <a:pt x="1974" y="23"/>
                  </a:cubicBezTo>
                  <a:cubicBezTo>
                    <a:pt x="1982" y="23"/>
                    <a:pt x="1989" y="30"/>
                    <a:pt x="1989" y="39"/>
                  </a:cubicBezTo>
                  <a:close/>
                  <a:moveTo>
                    <a:pt x="1989" y="192"/>
                  </a:moveTo>
                  <a:lnTo>
                    <a:pt x="1989" y="254"/>
                  </a:lnTo>
                  <a:cubicBezTo>
                    <a:pt x="1989" y="262"/>
                    <a:pt x="1982" y="269"/>
                    <a:pt x="1974" y="269"/>
                  </a:cubicBezTo>
                  <a:cubicBezTo>
                    <a:pt x="1965" y="269"/>
                    <a:pt x="1958" y="262"/>
                    <a:pt x="1958" y="254"/>
                  </a:cubicBezTo>
                  <a:lnTo>
                    <a:pt x="1958" y="192"/>
                  </a:lnTo>
                  <a:cubicBezTo>
                    <a:pt x="1958" y="184"/>
                    <a:pt x="1965" y="177"/>
                    <a:pt x="1974" y="177"/>
                  </a:cubicBezTo>
                  <a:cubicBezTo>
                    <a:pt x="1982" y="177"/>
                    <a:pt x="1989" y="184"/>
                    <a:pt x="1989" y="192"/>
                  </a:cubicBezTo>
                  <a:close/>
                  <a:moveTo>
                    <a:pt x="2012" y="292"/>
                  </a:moveTo>
                  <a:lnTo>
                    <a:pt x="2074" y="292"/>
                  </a:lnTo>
                  <a:cubicBezTo>
                    <a:pt x="2082" y="292"/>
                    <a:pt x="2089" y="299"/>
                    <a:pt x="2089" y="308"/>
                  </a:cubicBezTo>
                  <a:cubicBezTo>
                    <a:pt x="2089" y="316"/>
                    <a:pt x="2082" y="323"/>
                    <a:pt x="2074" y="323"/>
                  </a:cubicBezTo>
                  <a:lnTo>
                    <a:pt x="2012" y="323"/>
                  </a:lnTo>
                  <a:cubicBezTo>
                    <a:pt x="2004" y="323"/>
                    <a:pt x="1997" y="316"/>
                    <a:pt x="1997" y="308"/>
                  </a:cubicBezTo>
                  <a:cubicBezTo>
                    <a:pt x="1997" y="299"/>
                    <a:pt x="2004" y="292"/>
                    <a:pt x="2012" y="292"/>
                  </a:cubicBezTo>
                  <a:close/>
                  <a:moveTo>
                    <a:pt x="2166" y="292"/>
                  </a:moveTo>
                  <a:lnTo>
                    <a:pt x="2209" y="292"/>
                  </a:lnTo>
                  <a:lnTo>
                    <a:pt x="2209" y="341"/>
                  </a:lnTo>
                  <a:cubicBezTo>
                    <a:pt x="2209" y="349"/>
                    <a:pt x="2202" y="356"/>
                    <a:pt x="2194" y="356"/>
                  </a:cubicBezTo>
                  <a:cubicBezTo>
                    <a:pt x="2185" y="356"/>
                    <a:pt x="2179" y="349"/>
                    <a:pt x="2179" y="341"/>
                  </a:cubicBezTo>
                  <a:lnTo>
                    <a:pt x="2179" y="308"/>
                  </a:lnTo>
                  <a:lnTo>
                    <a:pt x="2194" y="323"/>
                  </a:lnTo>
                  <a:lnTo>
                    <a:pt x="2166" y="323"/>
                  </a:lnTo>
                  <a:cubicBezTo>
                    <a:pt x="2157" y="323"/>
                    <a:pt x="2150" y="316"/>
                    <a:pt x="2150" y="308"/>
                  </a:cubicBezTo>
                  <a:cubicBezTo>
                    <a:pt x="2150" y="299"/>
                    <a:pt x="2157" y="292"/>
                    <a:pt x="2166" y="292"/>
                  </a:cubicBezTo>
                  <a:close/>
                  <a:moveTo>
                    <a:pt x="2209" y="433"/>
                  </a:moveTo>
                  <a:lnTo>
                    <a:pt x="2209" y="494"/>
                  </a:lnTo>
                  <a:cubicBezTo>
                    <a:pt x="2209" y="503"/>
                    <a:pt x="2202" y="510"/>
                    <a:pt x="2194" y="510"/>
                  </a:cubicBezTo>
                  <a:cubicBezTo>
                    <a:pt x="2185" y="510"/>
                    <a:pt x="2179" y="503"/>
                    <a:pt x="2179" y="494"/>
                  </a:cubicBezTo>
                  <a:lnTo>
                    <a:pt x="2179" y="433"/>
                  </a:lnTo>
                  <a:cubicBezTo>
                    <a:pt x="2179" y="425"/>
                    <a:pt x="2185" y="418"/>
                    <a:pt x="2194" y="418"/>
                  </a:cubicBezTo>
                  <a:cubicBezTo>
                    <a:pt x="2202" y="418"/>
                    <a:pt x="2209" y="425"/>
                    <a:pt x="2209" y="433"/>
                  </a:cubicBezTo>
                  <a:close/>
                  <a:moveTo>
                    <a:pt x="2271" y="494"/>
                  </a:moveTo>
                  <a:lnTo>
                    <a:pt x="2304" y="494"/>
                  </a:lnTo>
                  <a:cubicBezTo>
                    <a:pt x="2312" y="494"/>
                    <a:pt x="2319" y="501"/>
                    <a:pt x="2319" y="510"/>
                  </a:cubicBezTo>
                  <a:cubicBezTo>
                    <a:pt x="2319" y="518"/>
                    <a:pt x="2312" y="525"/>
                    <a:pt x="2304" y="525"/>
                  </a:cubicBezTo>
                  <a:lnTo>
                    <a:pt x="2271" y="525"/>
                  </a:lnTo>
                  <a:cubicBezTo>
                    <a:pt x="2262" y="525"/>
                    <a:pt x="2255" y="518"/>
                    <a:pt x="2255" y="510"/>
                  </a:cubicBezTo>
                  <a:cubicBezTo>
                    <a:pt x="2255" y="501"/>
                    <a:pt x="2262" y="494"/>
                    <a:pt x="2271" y="494"/>
                  </a:cubicBezTo>
                  <a:close/>
                  <a:moveTo>
                    <a:pt x="2304" y="494"/>
                  </a:moveTo>
                  <a:lnTo>
                    <a:pt x="2332" y="494"/>
                  </a:lnTo>
                  <a:cubicBezTo>
                    <a:pt x="2341" y="494"/>
                    <a:pt x="2347" y="501"/>
                    <a:pt x="2347" y="510"/>
                  </a:cubicBezTo>
                  <a:cubicBezTo>
                    <a:pt x="2347" y="518"/>
                    <a:pt x="2341" y="525"/>
                    <a:pt x="2332" y="525"/>
                  </a:cubicBezTo>
                  <a:lnTo>
                    <a:pt x="2304" y="525"/>
                  </a:lnTo>
                  <a:cubicBezTo>
                    <a:pt x="2295" y="525"/>
                    <a:pt x="2289" y="518"/>
                    <a:pt x="2289" y="510"/>
                  </a:cubicBezTo>
                  <a:cubicBezTo>
                    <a:pt x="2289" y="501"/>
                    <a:pt x="2295" y="494"/>
                    <a:pt x="2304" y="494"/>
                  </a:cubicBezTo>
                  <a:close/>
                  <a:moveTo>
                    <a:pt x="2424" y="494"/>
                  </a:moveTo>
                  <a:lnTo>
                    <a:pt x="2486" y="494"/>
                  </a:lnTo>
                  <a:cubicBezTo>
                    <a:pt x="2494" y="494"/>
                    <a:pt x="2501" y="501"/>
                    <a:pt x="2501" y="510"/>
                  </a:cubicBezTo>
                  <a:cubicBezTo>
                    <a:pt x="2501" y="518"/>
                    <a:pt x="2494" y="525"/>
                    <a:pt x="2486" y="525"/>
                  </a:cubicBezTo>
                  <a:lnTo>
                    <a:pt x="2424" y="525"/>
                  </a:lnTo>
                  <a:cubicBezTo>
                    <a:pt x="2416" y="525"/>
                    <a:pt x="2409" y="518"/>
                    <a:pt x="2409" y="510"/>
                  </a:cubicBezTo>
                  <a:cubicBezTo>
                    <a:pt x="2409" y="501"/>
                    <a:pt x="2416" y="494"/>
                    <a:pt x="2424" y="494"/>
                  </a:cubicBezTo>
                  <a:close/>
                  <a:moveTo>
                    <a:pt x="2537" y="566"/>
                  </a:moveTo>
                  <a:lnTo>
                    <a:pt x="2537" y="628"/>
                  </a:lnTo>
                  <a:cubicBezTo>
                    <a:pt x="2537" y="636"/>
                    <a:pt x="2530" y="643"/>
                    <a:pt x="2522" y="643"/>
                  </a:cubicBezTo>
                  <a:cubicBezTo>
                    <a:pt x="2513" y="643"/>
                    <a:pt x="2506" y="636"/>
                    <a:pt x="2506" y="628"/>
                  </a:cubicBezTo>
                  <a:lnTo>
                    <a:pt x="2506" y="566"/>
                  </a:lnTo>
                  <a:cubicBezTo>
                    <a:pt x="2506" y="558"/>
                    <a:pt x="2513" y="551"/>
                    <a:pt x="2522" y="551"/>
                  </a:cubicBezTo>
                  <a:cubicBezTo>
                    <a:pt x="2530" y="551"/>
                    <a:pt x="2537" y="558"/>
                    <a:pt x="2537" y="566"/>
                  </a:cubicBezTo>
                  <a:close/>
                  <a:moveTo>
                    <a:pt x="2537" y="720"/>
                  </a:moveTo>
                  <a:lnTo>
                    <a:pt x="2537" y="781"/>
                  </a:lnTo>
                  <a:cubicBezTo>
                    <a:pt x="2537" y="790"/>
                    <a:pt x="2530" y="797"/>
                    <a:pt x="2522" y="797"/>
                  </a:cubicBezTo>
                  <a:cubicBezTo>
                    <a:pt x="2513" y="797"/>
                    <a:pt x="2506" y="790"/>
                    <a:pt x="2506" y="781"/>
                  </a:cubicBezTo>
                  <a:lnTo>
                    <a:pt x="2506" y="720"/>
                  </a:lnTo>
                  <a:cubicBezTo>
                    <a:pt x="2506" y="711"/>
                    <a:pt x="2513" y="704"/>
                    <a:pt x="2522" y="704"/>
                  </a:cubicBezTo>
                  <a:cubicBezTo>
                    <a:pt x="2530" y="704"/>
                    <a:pt x="2537" y="711"/>
                    <a:pt x="2537" y="720"/>
                  </a:cubicBezTo>
                  <a:close/>
                  <a:moveTo>
                    <a:pt x="2580" y="799"/>
                  </a:moveTo>
                  <a:lnTo>
                    <a:pt x="2632" y="799"/>
                  </a:lnTo>
                  <a:cubicBezTo>
                    <a:pt x="2640" y="799"/>
                    <a:pt x="2647" y="806"/>
                    <a:pt x="2647" y="814"/>
                  </a:cubicBezTo>
                  <a:cubicBezTo>
                    <a:pt x="2647" y="823"/>
                    <a:pt x="2640" y="830"/>
                    <a:pt x="2632" y="830"/>
                  </a:cubicBezTo>
                  <a:lnTo>
                    <a:pt x="2580" y="830"/>
                  </a:lnTo>
                  <a:cubicBezTo>
                    <a:pt x="2572" y="830"/>
                    <a:pt x="2565" y="823"/>
                    <a:pt x="2565" y="814"/>
                  </a:cubicBezTo>
                  <a:cubicBezTo>
                    <a:pt x="2565" y="806"/>
                    <a:pt x="2572" y="799"/>
                    <a:pt x="2580" y="799"/>
                  </a:cubicBezTo>
                  <a:close/>
                  <a:moveTo>
                    <a:pt x="2632" y="799"/>
                  </a:moveTo>
                  <a:lnTo>
                    <a:pt x="2642" y="799"/>
                  </a:lnTo>
                  <a:cubicBezTo>
                    <a:pt x="2650" y="799"/>
                    <a:pt x="2657" y="806"/>
                    <a:pt x="2657" y="814"/>
                  </a:cubicBezTo>
                  <a:cubicBezTo>
                    <a:pt x="2657" y="823"/>
                    <a:pt x="2650" y="830"/>
                    <a:pt x="2642" y="830"/>
                  </a:cubicBezTo>
                  <a:lnTo>
                    <a:pt x="2632" y="830"/>
                  </a:lnTo>
                  <a:cubicBezTo>
                    <a:pt x="2623" y="830"/>
                    <a:pt x="2616" y="823"/>
                    <a:pt x="2616" y="814"/>
                  </a:cubicBezTo>
                  <a:cubicBezTo>
                    <a:pt x="2616" y="806"/>
                    <a:pt x="2623" y="799"/>
                    <a:pt x="2632" y="799"/>
                  </a:cubicBezTo>
                  <a:close/>
                  <a:moveTo>
                    <a:pt x="2734" y="799"/>
                  </a:moveTo>
                  <a:lnTo>
                    <a:pt x="2742" y="799"/>
                  </a:lnTo>
                  <a:cubicBezTo>
                    <a:pt x="2750" y="799"/>
                    <a:pt x="2757" y="806"/>
                    <a:pt x="2757" y="814"/>
                  </a:cubicBezTo>
                  <a:cubicBezTo>
                    <a:pt x="2757" y="823"/>
                    <a:pt x="2750" y="830"/>
                    <a:pt x="2742" y="830"/>
                  </a:cubicBezTo>
                  <a:lnTo>
                    <a:pt x="2734" y="830"/>
                  </a:lnTo>
                  <a:cubicBezTo>
                    <a:pt x="2726" y="830"/>
                    <a:pt x="2719" y="823"/>
                    <a:pt x="2719" y="814"/>
                  </a:cubicBezTo>
                  <a:cubicBezTo>
                    <a:pt x="2719" y="806"/>
                    <a:pt x="2726" y="799"/>
                    <a:pt x="2734" y="799"/>
                  </a:cubicBezTo>
                  <a:close/>
                  <a:moveTo>
                    <a:pt x="2742" y="799"/>
                  </a:moveTo>
                  <a:lnTo>
                    <a:pt x="2795" y="799"/>
                  </a:lnTo>
                  <a:cubicBezTo>
                    <a:pt x="2804" y="799"/>
                    <a:pt x="2811" y="806"/>
                    <a:pt x="2811" y="814"/>
                  </a:cubicBezTo>
                  <a:cubicBezTo>
                    <a:pt x="2811" y="823"/>
                    <a:pt x="2804" y="830"/>
                    <a:pt x="2795" y="830"/>
                  </a:cubicBezTo>
                  <a:lnTo>
                    <a:pt x="2742" y="830"/>
                  </a:lnTo>
                  <a:cubicBezTo>
                    <a:pt x="2733" y="830"/>
                    <a:pt x="2726" y="823"/>
                    <a:pt x="2726" y="814"/>
                  </a:cubicBezTo>
                  <a:cubicBezTo>
                    <a:pt x="2726" y="806"/>
                    <a:pt x="2733" y="799"/>
                    <a:pt x="2742" y="799"/>
                  </a:cubicBezTo>
                  <a:close/>
                  <a:moveTo>
                    <a:pt x="2867" y="850"/>
                  </a:moveTo>
                  <a:lnTo>
                    <a:pt x="2867" y="912"/>
                  </a:lnTo>
                  <a:cubicBezTo>
                    <a:pt x="2867" y="920"/>
                    <a:pt x="2860" y="927"/>
                    <a:pt x="2852" y="927"/>
                  </a:cubicBezTo>
                  <a:cubicBezTo>
                    <a:pt x="2843" y="927"/>
                    <a:pt x="2836" y="920"/>
                    <a:pt x="2836" y="912"/>
                  </a:cubicBezTo>
                  <a:lnTo>
                    <a:pt x="2836" y="850"/>
                  </a:lnTo>
                  <a:cubicBezTo>
                    <a:pt x="2836" y="842"/>
                    <a:pt x="2843" y="835"/>
                    <a:pt x="2852" y="835"/>
                  </a:cubicBezTo>
                  <a:cubicBezTo>
                    <a:pt x="2860" y="835"/>
                    <a:pt x="2867" y="842"/>
                    <a:pt x="2867" y="850"/>
                  </a:cubicBezTo>
                  <a:close/>
                  <a:moveTo>
                    <a:pt x="2867" y="1004"/>
                  </a:moveTo>
                  <a:lnTo>
                    <a:pt x="2867" y="1065"/>
                  </a:lnTo>
                  <a:cubicBezTo>
                    <a:pt x="2867" y="1074"/>
                    <a:pt x="2860" y="1081"/>
                    <a:pt x="2852" y="1081"/>
                  </a:cubicBezTo>
                  <a:cubicBezTo>
                    <a:pt x="2843" y="1081"/>
                    <a:pt x="2836" y="1074"/>
                    <a:pt x="2836" y="1065"/>
                  </a:cubicBezTo>
                  <a:lnTo>
                    <a:pt x="2836" y="1004"/>
                  </a:lnTo>
                  <a:cubicBezTo>
                    <a:pt x="2836" y="995"/>
                    <a:pt x="2843" y="989"/>
                    <a:pt x="2852" y="989"/>
                  </a:cubicBezTo>
                  <a:cubicBezTo>
                    <a:pt x="2860" y="989"/>
                    <a:pt x="2867" y="995"/>
                    <a:pt x="2867" y="1004"/>
                  </a:cubicBezTo>
                  <a:close/>
                  <a:moveTo>
                    <a:pt x="2867" y="1157"/>
                  </a:moveTo>
                  <a:lnTo>
                    <a:pt x="2867" y="1219"/>
                  </a:lnTo>
                  <a:cubicBezTo>
                    <a:pt x="2867" y="1227"/>
                    <a:pt x="2860" y="1234"/>
                    <a:pt x="2852" y="1234"/>
                  </a:cubicBezTo>
                  <a:cubicBezTo>
                    <a:pt x="2843" y="1234"/>
                    <a:pt x="2836" y="1227"/>
                    <a:pt x="2836" y="1219"/>
                  </a:cubicBezTo>
                  <a:lnTo>
                    <a:pt x="2836" y="1157"/>
                  </a:lnTo>
                  <a:cubicBezTo>
                    <a:pt x="2836" y="1149"/>
                    <a:pt x="2843" y="1142"/>
                    <a:pt x="2852" y="1142"/>
                  </a:cubicBezTo>
                  <a:cubicBezTo>
                    <a:pt x="2860" y="1142"/>
                    <a:pt x="2867" y="1149"/>
                    <a:pt x="2867" y="1157"/>
                  </a:cubicBezTo>
                  <a:close/>
                  <a:moveTo>
                    <a:pt x="2867" y="1311"/>
                  </a:moveTo>
                  <a:lnTo>
                    <a:pt x="2867" y="1321"/>
                  </a:lnTo>
                  <a:cubicBezTo>
                    <a:pt x="2867" y="1330"/>
                    <a:pt x="2860" y="1337"/>
                    <a:pt x="2852" y="1337"/>
                  </a:cubicBezTo>
                  <a:cubicBezTo>
                    <a:pt x="2843" y="1337"/>
                    <a:pt x="2836" y="1330"/>
                    <a:pt x="2836" y="1321"/>
                  </a:cubicBezTo>
                  <a:lnTo>
                    <a:pt x="2836" y="1311"/>
                  </a:lnTo>
                  <a:cubicBezTo>
                    <a:pt x="2836" y="1303"/>
                    <a:pt x="2843" y="1296"/>
                    <a:pt x="2852" y="1296"/>
                  </a:cubicBezTo>
                  <a:cubicBezTo>
                    <a:pt x="2860" y="1296"/>
                    <a:pt x="2867" y="1303"/>
                    <a:pt x="2867" y="1311"/>
                  </a:cubicBezTo>
                  <a:close/>
                  <a:moveTo>
                    <a:pt x="2852" y="1306"/>
                  </a:moveTo>
                  <a:lnTo>
                    <a:pt x="2903" y="1306"/>
                  </a:lnTo>
                  <a:cubicBezTo>
                    <a:pt x="2911" y="1306"/>
                    <a:pt x="2918" y="1313"/>
                    <a:pt x="2918" y="1321"/>
                  </a:cubicBezTo>
                  <a:cubicBezTo>
                    <a:pt x="2918" y="1330"/>
                    <a:pt x="2911" y="1337"/>
                    <a:pt x="2903" y="1337"/>
                  </a:cubicBezTo>
                  <a:lnTo>
                    <a:pt x="2852" y="1337"/>
                  </a:lnTo>
                  <a:cubicBezTo>
                    <a:pt x="2843" y="1337"/>
                    <a:pt x="2836" y="1330"/>
                    <a:pt x="2836" y="1321"/>
                  </a:cubicBezTo>
                  <a:cubicBezTo>
                    <a:pt x="2836" y="1313"/>
                    <a:pt x="2843" y="1306"/>
                    <a:pt x="2852" y="1306"/>
                  </a:cubicBezTo>
                  <a:close/>
                  <a:moveTo>
                    <a:pt x="2995" y="1306"/>
                  </a:moveTo>
                  <a:lnTo>
                    <a:pt x="3057" y="1306"/>
                  </a:lnTo>
                  <a:cubicBezTo>
                    <a:pt x="3065" y="1306"/>
                    <a:pt x="3072" y="1313"/>
                    <a:pt x="3072" y="1321"/>
                  </a:cubicBezTo>
                  <a:cubicBezTo>
                    <a:pt x="3072" y="1330"/>
                    <a:pt x="3065" y="1337"/>
                    <a:pt x="3057" y="1337"/>
                  </a:cubicBezTo>
                  <a:lnTo>
                    <a:pt x="2995" y="1337"/>
                  </a:lnTo>
                  <a:cubicBezTo>
                    <a:pt x="2987" y="1337"/>
                    <a:pt x="2980" y="1330"/>
                    <a:pt x="2980" y="1321"/>
                  </a:cubicBezTo>
                  <a:cubicBezTo>
                    <a:pt x="2980" y="1313"/>
                    <a:pt x="2987" y="1306"/>
                    <a:pt x="2995" y="1306"/>
                  </a:cubicBezTo>
                  <a:close/>
                  <a:moveTo>
                    <a:pt x="3149" y="1306"/>
                  </a:moveTo>
                  <a:lnTo>
                    <a:pt x="3210" y="1306"/>
                  </a:lnTo>
                  <a:cubicBezTo>
                    <a:pt x="3219" y="1306"/>
                    <a:pt x="3226" y="1313"/>
                    <a:pt x="3226" y="1321"/>
                  </a:cubicBezTo>
                  <a:cubicBezTo>
                    <a:pt x="3226" y="1330"/>
                    <a:pt x="3219" y="1337"/>
                    <a:pt x="3210" y="1337"/>
                  </a:cubicBezTo>
                  <a:lnTo>
                    <a:pt x="3149" y="1337"/>
                  </a:lnTo>
                  <a:cubicBezTo>
                    <a:pt x="3140" y="1337"/>
                    <a:pt x="3133" y="1330"/>
                    <a:pt x="3133" y="1321"/>
                  </a:cubicBezTo>
                  <a:cubicBezTo>
                    <a:pt x="3133" y="1313"/>
                    <a:pt x="3140" y="1306"/>
                    <a:pt x="3149" y="1306"/>
                  </a:cubicBezTo>
                  <a:close/>
                  <a:moveTo>
                    <a:pt x="3302" y="1306"/>
                  </a:moveTo>
                  <a:lnTo>
                    <a:pt x="3364" y="1306"/>
                  </a:lnTo>
                  <a:cubicBezTo>
                    <a:pt x="3372" y="1306"/>
                    <a:pt x="3379" y="1313"/>
                    <a:pt x="3379" y="1321"/>
                  </a:cubicBezTo>
                  <a:cubicBezTo>
                    <a:pt x="3379" y="1330"/>
                    <a:pt x="3372" y="1337"/>
                    <a:pt x="3364" y="1337"/>
                  </a:cubicBezTo>
                  <a:lnTo>
                    <a:pt x="3302" y="1337"/>
                  </a:lnTo>
                  <a:cubicBezTo>
                    <a:pt x="3294" y="1337"/>
                    <a:pt x="3287" y="1330"/>
                    <a:pt x="3287" y="1321"/>
                  </a:cubicBezTo>
                  <a:cubicBezTo>
                    <a:pt x="3287" y="1313"/>
                    <a:pt x="3294" y="1306"/>
                    <a:pt x="3302" y="1306"/>
                  </a:cubicBezTo>
                  <a:close/>
                  <a:moveTo>
                    <a:pt x="3415" y="1378"/>
                  </a:moveTo>
                  <a:lnTo>
                    <a:pt x="3415" y="1439"/>
                  </a:lnTo>
                  <a:cubicBezTo>
                    <a:pt x="3415" y="1448"/>
                    <a:pt x="3408" y="1454"/>
                    <a:pt x="3400" y="1454"/>
                  </a:cubicBezTo>
                  <a:cubicBezTo>
                    <a:pt x="3391" y="1454"/>
                    <a:pt x="3384" y="1448"/>
                    <a:pt x="3384" y="1439"/>
                  </a:cubicBezTo>
                  <a:lnTo>
                    <a:pt x="3384" y="1378"/>
                  </a:lnTo>
                  <a:cubicBezTo>
                    <a:pt x="3384" y="1369"/>
                    <a:pt x="3391" y="1362"/>
                    <a:pt x="3400" y="1362"/>
                  </a:cubicBezTo>
                  <a:cubicBezTo>
                    <a:pt x="3408" y="1362"/>
                    <a:pt x="3415" y="1369"/>
                    <a:pt x="3415" y="1378"/>
                  </a:cubicBezTo>
                  <a:close/>
                  <a:moveTo>
                    <a:pt x="3415" y="1531"/>
                  </a:moveTo>
                  <a:lnTo>
                    <a:pt x="3415" y="1593"/>
                  </a:lnTo>
                  <a:cubicBezTo>
                    <a:pt x="3415" y="1601"/>
                    <a:pt x="3408" y="1608"/>
                    <a:pt x="3400" y="1608"/>
                  </a:cubicBezTo>
                  <a:cubicBezTo>
                    <a:pt x="3391" y="1608"/>
                    <a:pt x="3384" y="1601"/>
                    <a:pt x="3384" y="1593"/>
                  </a:cubicBezTo>
                  <a:lnTo>
                    <a:pt x="3384" y="1531"/>
                  </a:lnTo>
                  <a:cubicBezTo>
                    <a:pt x="3384" y="1523"/>
                    <a:pt x="3391" y="1516"/>
                    <a:pt x="3400" y="1516"/>
                  </a:cubicBezTo>
                  <a:cubicBezTo>
                    <a:pt x="3408" y="1516"/>
                    <a:pt x="3415" y="1523"/>
                    <a:pt x="3415" y="1531"/>
                  </a:cubicBezTo>
                  <a:close/>
                  <a:moveTo>
                    <a:pt x="3415" y="1685"/>
                  </a:moveTo>
                  <a:lnTo>
                    <a:pt x="3415" y="1746"/>
                  </a:lnTo>
                  <a:cubicBezTo>
                    <a:pt x="3415" y="1755"/>
                    <a:pt x="3408" y="1762"/>
                    <a:pt x="3400" y="1762"/>
                  </a:cubicBezTo>
                  <a:cubicBezTo>
                    <a:pt x="3391" y="1762"/>
                    <a:pt x="3384" y="1755"/>
                    <a:pt x="3384" y="1746"/>
                  </a:cubicBezTo>
                  <a:lnTo>
                    <a:pt x="3384" y="1685"/>
                  </a:lnTo>
                  <a:cubicBezTo>
                    <a:pt x="3384" y="1676"/>
                    <a:pt x="3391" y="1669"/>
                    <a:pt x="3400" y="1669"/>
                  </a:cubicBezTo>
                  <a:cubicBezTo>
                    <a:pt x="3408" y="1669"/>
                    <a:pt x="3415" y="1676"/>
                    <a:pt x="3415" y="1685"/>
                  </a:cubicBezTo>
                  <a:close/>
                  <a:moveTo>
                    <a:pt x="3415" y="1838"/>
                  </a:moveTo>
                  <a:lnTo>
                    <a:pt x="3415" y="1900"/>
                  </a:lnTo>
                  <a:cubicBezTo>
                    <a:pt x="3415" y="1908"/>
                    <a:pt x="3408" y="1915"/>
                    <a:pt x="3400" y="1915"/>
                  </a:cubicBezTo>
                  <a:cubicBezTo>
                    <a:pt x="3391" y="1915"/>
                    <a:pt x="3384" y="1908"/>
                    <a:pt x="3384" y="1900"/>
                  </a:cubicBezTo>
                  <a:lnTo>
                    <a:pt x="3384" y="1838"/>
                  </a:lnTo>
                  <a:cubicBezTo>
                    <a:pt x="3384" y="1830"/>
                    <a:pt x="3391" y="1823"/>
                    <a:pt x="3400" y="1823"/>
                  </a:cubicBezTo>
                  <a:cubicBezTo>
                    <a:pt x="3408" y="1823"/>
                    <a:pt x="3415" y="1830"/>
                    <a:pt x="3415" y="1838"/>
                  </a:cubicBezTo>
                  <a:close/>
                  <a:moveTo>
                    <a:pt x="3415" y="1992"/>
                  </a:moveTo>
                  <a:lnTo>
                    <a:pt x="3415" y="2053"/>
                  </a:lnTo>
                  <a:cubicBezTo>
                    <a:pt x="3415" y="2062"/>
                    <a:pt x="3408" y="2069"/>
                    <a:pt x="3400" y="2069"/>
                  </a:cubicBezTo>
                  <a:cubicBezTo>
                    <a:pt x="3391" y="2069"/>
                    <a:pt x="3384" y="2062"/>
                    <a:pt x="3384" y="2053"/>
                  </a:cubicBezTo>
                  <a:lnTo>
                    <a:pt x="3384" y="1992"/>
                  </a:lnTo>
                  <a:cubicBezTo>
                    <a:pt x="3384" y="1984"/>
                    <a:pt x="3391" y="1977"/>
                    <a:pt x="3400" y="1977"/>
                  </a:cubicBezTo>
                  <a:cubicBezTo>
                    <a:pt x="3408" y="1977"/>
                    <a:pt x="3415" y="1984"/>
                    <a:pt x="3415" y="1992"/>
                  </a:cubicBezTo>
                  <a:close/>
                  <a:moveTo>
                    <a:pt x="3415" y="2146"/>
                  </a:moveTo>
                  <a:lnTo>
                    <a:pt x="3415" y="2207"/>
                  </a:lnTo>
                  <a:cubicBezTo>
                    <a:pt x="3415" y="2216"/>
                    <a:pt x="3408" y="2222"/>
                    <a:pt x="3400" y="2222"/>
                  </a:cubicBezTo>
                  <a:cubicBezTo>
                    <a:pt x="3391" y="2222"/>
                    <a:pt x="3384" y="2216"/>
                    <a:pt x="3384" y="2207"/>
                  </a:cubicBezTo>
                  <a:lnTo>
                    <a:pt x="3384" y="2146"/>
                  </a:lnTo>
                  <a:cubicBezTo>
                    <a:pt x="3384" y="2137"/>
                    <a:pt x="3391" y="2130"/>
                    <a:pt x="3400" y="2130"/>
                  </a:cubicBezTo>
                  <a:cubicBezTo>
                    <a:pt x="3408" y="2130"/>
                    <a:pt x="3415" y="2137"/>
                    <a:pt x="3415" y="2146"/>
                  </a:cubicBezTo>
                  <a:close/>
                  <a:moveTo>
                    <a:pt x="3415" y="2299"/>
                  </a:moveTo>
                  <a:lnTo>
                    <a:pt x="3415" y="2335"/>
                  </a:lnTo>
                  <a:lnTo>
                    <a:pt x="3384" y="2335"/>
                  </a:lnTo>
                  <a:lnTo>
                    <a:pt x="3384" y="2299"/>
                  </a:lnTo>
                  <a:cubicBezTo>
                    <a:pt x="3384" y="2291"/>
                    <a:pt x="3391" y="2284"/>
                    <a:pt x="3400" y="2284"/>
                  </a:cubicBezTo>
                  <a:cubicBezTo>
                    <a:pt x="3408" y="2284"/>
                    <a:pt x="3415" y="2291"/>
                    <a:pt x="3415" y="2299"/>
                  </a:cubicBezTo>
                  <a:close/>
                </a:path>
              </a:pathLst>
            </a:custGeom>
            <a:solidFill>
              <a:srgbClr val="0000C0"/>
            </a:solidFill>
            <a:ln w="1588" cap="flat">
              <a:solidFill>
                <a:srgbClr val="0000C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2" name="Line 305">
              <a:extLst>
                <a:ext uri="{FF2B5EF4-FFF2-40B4-BE49-F238E27FC236}">
                  <a16:creationId xmlns:a16="http://schemas.microsoft.com/office/drawing/2014/main" id="{A288296D-DA17-4806-AF43-AC9F1C87B43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595562" y="4995863"/>
              <a:ext cx="0" cy="36512"/>
            </a:xfrm>
            <a:prstGeom prst="line">
              <a:avLst/>
            </a:prstGeom>
            <a:noFill/>
            <a:ln w="19050" cap="flat">
              <a:solidFill>
                <a:srgbClr val="0000C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3" name="Line 306">
              <a:extLst>
                <a:ext uri="{FF2B5EF4-FFF2-40B4-BE49-F238E27FC236}">
                  <a16:creationId xmlns:a16="http://schemas.microsoft.com/office/drawing/2014/main" id="{A17258B7-2001-4B9D-B4A3-46127F4C07C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400300" y="4995863"/>
              <a:ext cx="0" cy="36512"/>
            </a:xfrm>
            <a:prstGeom prst="line">
              <a:avLst/>
            </a:prstGeom>
            <a:noFill/>
            <a:ln w="19050" cap="flat">
              <a:solidFill>
                <a:srgbClr val="0000C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4" name="Line 307">
              <a:extLst>
                <a:ext uri="{FF2B5EF4-FFF2-40B4-BE49-F238E27FC236}">
                  <a16:creationId xmlns:a16="http://schemas.microsoft.com/office/drawing/2014/main" id="{F72520EB-80AF-40C8-8115-482885529A1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203450" y="5168900"/>
              <a:ext cx="0" cy="38100"/>
            </a:xfrm>
            <a:prstGeom prst="line">
              <a:avLst/>
            </a:prstGeom>
            <a:noFill/>
            <a:ln w="19050" cap="flat">
              <a:solidFill>
                <a:srgbClr val="0000C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5" name="Line 308">
              <a:extLst>
                <a:ext uri="{FF2B5EF4-FFF2-40B4-BE49-F238E27FC236}">
                  <a16:creationId xmlns:a16="http://schemas.microsoft.com/office/drawing/2014/main" id="{939FC3A6-3D76-4298-AC70-2A56B1FB4D9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006600" y="5289550"/>
              <a:ext cx="0" cy="38100"/>
            </a:xfrm>
            <a:prstGeom prst="line">
              <a:avLst/>
            </a:prstGeom>
            <a:noFill/>
            <a:ln w="19050" cap="flat">
              <a:solidFill>
                <a:srgbClr val="0000C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6" name="Line 309">
              <a:extLst>
                <a:ext uri="{FF2B5EF4-FFF2-40B4-BE49-F238E27FC236}">
                  <a16:creationId xmlns:a16="http://schemas.microsoft.com/office/drawing/2014/main" id="{84D4F5A6-E17C-4205-909B-80054E07641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941512" y="5289550"/>
              <a:ext cx="0" cy="38100"/>
            </a:xfrm>
            <a:prstGeom prst="line">
              <a:avLst/>
            </a:prstGeom>
            <a:noFill/>
            <a:ln w="19050" cap="flat">
              <a:solidFill>
                <a:srgbClr val="0000C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7" name="Line 310">
              <a:extLst>
                <a:ext uri="{FF2B5EF4-FFF2-40B4-BE49-F238E27FC236}">
                  <a16:creationId xmlns:a16="http://schemas.microsoft.com/office/drawing/2014/main" id="{853624B7-0C62-46E9-93C7-B524EE88079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809750" y="5472113"/>
              <a:ext cx="0" cy="36512"/>
            </a:xfrm>
            <a:prstGeom prst="line">
              <a:avLst/>
            </a:prstGeom>
            <a:noFill/>
            <a:ln w="19050" cap="flat">
              <a:solidFill>
                <a:srgbClr val="0000C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8" name="Line 311">
              <a:extLst>
                <a:ext uri="{FF2B5EF4-FFF2-40B4-BE49-F238E27FC236}">
                  <a16:creationId xmlns:a16="http://schemas.microsoft.com/office/drawing/2014/main" id="{6F29DE53-28E0-483A-9C92-B223C947973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744662" y="5472113"/>
              <a:ext cx="0" cy="36512"/>
            </a:xfrm>
            <a:prstGeom prst="line">
              <a:avLst/>
            </a:prstGeom>
            <a:noFill/>
            <a:ln w="19050" cap="flat">
              <a:solidFill>
                <a:srgbClr val="0000C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9" name="Line 312">
              <a:extLst>
                <a:ext uri="{FF2B5EF4-FFF2-40B4-BE49-F238E27FC236}">
                  <a16:creationId xmlns:a16="http://schemas.microsoft.com/office/drawing/2014/main" id="{402271AE-240B-49FE-A991-590E34B712B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612900" y="5773738"/>
              <a:ext cx="0" cy="36512"/>
            </a:xfrm>
            <a:prstGeom prst="line">
              <a:avLst/>
            </a:prstGeom>
            <a:noFill/>
            <a:ln w="19050" cap="flat">
              <a:solidFill>
                <a:srgbClr val="0000C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0" name="Freeform 313">
              <a:extLst>
                <a:ext uri="{FF2B5EF4-FFF2-40B4-BE49-F238E27FC236}">
                  <a16:creationId xmlns:a16="http://schemas.microsoft.com/office/drawing/2014/main" id="{E9A0BF8F-966B-45DC-868A-9035AB987459}"/>
                </a:ext>
              </a:extLst>
            </p:cNvPr>
            <p:cNvSpPr>
              <a:spLocks/>
            </p:cNvSpPr>
            <p:nvPr/>
          </p:nvSpPr>
          <p:spPr bwMode="auto">
            <a:xfrm>
              <a:off x="-3379787" y="5032375"/>
              <a:ext cx="1831975" cy="1384300"/>
            </a:xfrm>
            <a:custGeom>
              <a:avLst/>
              <a:gdLst>
                <a:gd name="T0" fmla="*/ 0 w 1154"/>
                <a:gd name="T1" fmla="*/ 0 h 872"/>
                <a:gd name="T2" fmla="*/ 494 w 1154"/>
                <a:gd name="T3" fmla="*/ 0 h 872"/>
                <a:gd name="T4" fmla="*/ 494 w 1154"/>
                <a:gd name="T5" fmla="*/ 0 h 872"/>
                <a:gd name="T6" fmla="*/ 494 w 1154"/>
                <a:gd name="T7" fmla="*/ 0 h 872"/>
                <a:gd name="T8" fmla="*/ 617 w 1154"/>
                <a:gd name="T9" fmla="*/ 0 h 872"/>
                <a:gd name="T10" fmla="*/ 617 w 1154"/>
                <a:gd name="T11" fmla="*/ 110 h 872"/>
                <a:gd name="T12" fmla="*/ 617 w 1154"/>
                <a:gd name="T13" fmla="*/ 110 h 872"/>
                <a:gd name="T14" fmla="*/ 741 w 1154"/>
                <a:gd name="T15" fmla="*/ 110 h 872"/>
                <a:gd name="T16" fmla="*/ 741 w 1154"/>
                <a:gd name="T17" fmla="*/ 186 h 872"/>
                <a:gd name="T18" fmla="*/ 741 w 1154"/>
                <a:gd name="T19" fmla="*/ 186 h 872"/>
                <a:gd name="T20" fmla="*/ 865 w 1154"/>
                <a:gd name="T21" fmla="*/ 186 h 872"/>
                <a:gd name="T22" fmla="*/ 865 w 1154"/>
                <a:gd name="T23" fmla="*/ 300 h 872"/>
                <a:gd name="T24" fmla="*/ 865 w 1154"/>
                <a:gd name="T25" fmla="*/ 300 h 872"/>
                <a:gd name="T26" fmla="*/ 906 w 1154"/>
                <a:gd name="T27" fmla="*/ 300 h 872"/>
                <a:gd name="T28" fmla="*/ 906 w 1154"/>
                <a:gd name="T29" fmla="*/ 300 h 872"/>
                <a:gd name="T30" fmla="*/ 906 w 1154"/>
                <a:gd name="T31" fmla="*/ 300 h 872"/>
                <a:gd name="T32" fmla="*/ 989 w 1154"/>
                <a:gd name="T33" fmla="*/ 300 h 872"/>
                <a:gd name="T34" fmla="*/ 989 w 1154"/>
                <a:gd name="T35" fmla="*/ 300 h 872"/>
                <a:gd name="T36" fmla="*/ 989 w 1154"/>
                <a:gd name="T37" fmla="*/ 300 h 872"/>
                <a:gd name="T38" fmla="*/ 1030 w 1154"/>
                <a:gd name="T39" fmla="*/ 300 h 872"/>
                <a:gd name="T40" fmla="*/ 1030 w 1154"/>
                <a:gd name="T41" fmla="*/ 586 h 872"/>
                <a:gd name="T42" fmla="*/ 1030 w 1154"/>
                <a:gd name="T43" fmla="*/ 586 h 872"/>
                <a:gd name="T44" fmla="*/ 1154 w 1154"/>
                <a:gd name="T45" fmla="*/ 586 h 872"/>
                <a:gd name="T46" fmla="*/ 1154 w 1154"/>
                <a:gd name="T47" fmla="*/ 872 h 8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</a:cxnLst>
              <a:rect l="0" t="0" r="r" b="b"/>
              <a:pathLst>
                <a:path w="1154" h="872">
                  <a:moveTo>
                    <a:pt x="0" y="0"/>
                  </a:moveTo>
                  <a:lnTo>
                    <a:pt x="494" y="0"/>
                  </a:lnTo>
                  <a:lnTo>
                    <a:pt x="494" y="0"/>
                  </a:lnTo>
                  <a:lnTo>
                    <a:pt x="494" y="0"/>
                  </a:lnTo>
                  <a:lnTo>
                    <a:pt x="617" y="0"/>
                  </a:lnTo>
                  <a:lnTo>
                    <a:pt x="617" y="110"/>
                  </a:lnTo>
                  <a:lnTo>
                    <a:pt x="617" y="110"/>
                  </a:lnTo>
                  <a:lnTo>
                    <a:pt x="741" y="110"/>
                  </a:lnTo>
                  <a:lnTo>
                    <a:pt x="741" y="186"/>
                  </a:lnTo>
                  <a:lnTo>
                    <a:pt x="741" y="186"/>
                  </a:lnTo>
                  <a:lnTo>
                    <a:pt x="865" y="186"/>
                  </a:lnTo>
                  <a:lnTo>
                    <a:pt x="865" y="300"/>
                  </a:lnTo>
                  <a:lnTo>
                    <a:pt x="865" y="300"/>
                  </a:lnTo>
                  <a:lnTo>
                    <a:pt x="906" y="300"/>
                  </a:lnTo>
                  <a:lnTo>
                    <a:pt x="906" y="300"/>
                  </a:lnTo>
                  <a:lnTo>
                    <a:pt x="906" y="300"/>
                  </a:lnTo>
                  <a:lnTo>
                    <a:pt x="989" y="300"/>
                  </a:lnTo>
                  <a:lnTo>
                    <a:pt x="989" y="300"/>
                  </a:lnTo>
                  <a:lnTo>
                    <a:pt x="989" y="300"/>
                  </a:lnTo>
                  <a:lnTo>
                    <a:pt x="1030" y="300"/>
                  </a:lnTo>
                  <a:lnTo>
                    <a:pt x="1030" y="586"/>
                  </a:lnTo>
                  <a:lnTo>
                    <a:pt x="1030" y="586"/>
                  </a:lnTo>
                  <a:lnTo>
                    <a:pt x="1154" y="586"/>
                  </a:lnTo>
                  <a:lnTo>
                    <a:pt x="1154" y="872"/>
                  </a:lnTo>
                </a:path>
              </a:pathLst>
            </a:cu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1" name="Line 314">
              <a:extLst>
                <a:ext uri="{FF2B5EF4-FFF2-40B4-BE49-F238E27FC236}">
                  <a16:creationId xmlns:a16="http://schemas.microsoft.com/office/drawing/2014/main" id="{F6E0FB8C-B478-442F-8666-DDCE5355971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595562" y="4995863"/>
              <a:ext cx="0" cy="36512"/>
            </a:xfrm>
            <a:prstGeom prst="line">
              <a:avLst/>
            </a:prstGeom>
            <a:noFill/>
            <a:ln w="9525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2" name="Line 315">
              <a:extLst>
                <a:ext uri="{FF2B5EF4-FFF2-40B4-BE49-F238E27FC236}">
                  <a16:creationId xmlns:a16="http://schemas.microsoft.com/office/drawing/2014/main" id="{4AF9E91B-0560-49D8-9A2D-A4961420643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400300" y="5168900"/>
              <a:ext cx="0" cy="38100"/>
            </a:xfrm>
            <a:prstGeom prst="line">
              <a:avLst/>
            </a:prstGeom>
            <a:noFill/>
            <a:ln w="9525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3" name="Line 316">
              <a:extLst>
                <a:ext uri="{FF2B5EF4-FFF2-40B4-BE49-F238E27FC236}">
                  <a16:creationId xmlns:a16="http://schemas.microsoft.com/office/drawing/2014/main" id="{6F0F7AAB-39A7-46D0-B653-FED5C0CF7BD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203450" y="5289550"/>
              <a:ext cx="0" cy="38100"/>
            </a:xfrm>
            <a:prstGeom prst="line">
              <a:avLst/>
            </a:prstGeom>
            <a:noFill/>
            <a:ln w="9525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4" name="Line 317">
              <a:extLst>
                <a:ext uri="{FF2B5EF4-FFF2-40B4-BE49-F238E27FC236}">
                  <a16:creationId xmlns:a16="http://schemas.microsoft.com/office/drawing/2014/main" id="{CD1FDAA8-CC43-40A3-9929-05195148760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006600" y="5472113"/>
              <a:ext cx="0" cy="36512"/>
            </a:xfrm>
            <a:prstGeom prst="line">
              <a:avLst/>
            </a:prstGeom>
            <a:noFill/>
            <a:ln w="9525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5" name="Line 318">
              <a:extLst>
                <a:ext uri="{FF2B5EF4-FFF2-40B4-BE49-F238E27FC236}">
                  <a16:creationId xmlns:a16="http://schemas.microsoft.com/office/drawing/2014/main" id="{4E4E1E74-7D9C-4BE4-888A-F6C7E046855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941512" y="5472113"/>
              <a:ext cx="0" cy="36512"/>
            </a:xfrm>
            <a:prstGeom prst="line">
              <a:avLst/>
            </a:prstGeom>
            <a:noFill/>
            <a:ln w="9525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6" name="Line 319">
              <a:extLst>
                <a:ext uri="{FF2B5EF4-FFF2-40B4-BE49-F238E27FC236}">
                  <a16:creationId xmlns:a16="http://schemas.microsoft.com/office/drawing/2014/main" id="{4F4F0F25-2FB3-4353-A157-A1BA27A0FA6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809750" y="5472113"/>
              <a:ext cx="0" cy="36512"/>
            </a:xfrm>
            <a:prstGeom prst="line">
              <a:avLst/>
            </a:prstGeom>
            <a:noFill/>
            <a:ln w="9525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7" name="Freeform 320">
              <a:extLst>
                <a:ext uri="{FF2B5EF4-FFF2-40B4-BE49-F238E27FC236}">
                  <a16:creationId xmlns:a16="http://schemas.microsoft.com/office/drawing/2014/main" id="{57673662-B3B7-45E0-A52F-DA2FEF873413}"/>
                </a:ext>
              </a:extLst>
            </p:cNvPr>
            <p:cNvSpPr>
              <a:spLocks/>
            </p:cNvSpPr>
            <p:nvPr/>
          </p:nvSpPr>
          <p:spPr bwMode="auto">
            <a:xfrm>
              <a:off x="-3379787" y="5032375"/>
              <a:ext cx="1700213" cy="1384300"/>
            </a:xfrm>
            <a:custGeom>
              <a:avLst/>
              <a:gdLst>
                <a:gd name="T0" fmla="*/ 0 w 1071"/>
                <a:gd name="T1" fmla="*/ 0 h 872"/>
                <a:gd name="T2" fmla="*/ 494 w 1071"/>
                <a:gd name="T3" fmla="*/ 0 h 872"/>
                <a:gd name="T4" fmla="*/ 494 w 1071"/>
                <a:gd name="T5" fmla="*/ 49 h 872"/>
                <a:gd name="T6" fmla="*/ 494 w 1071"/>
                <a:gd name="T7" fmla="*/ 49 h 872"/>
                <a:gd name="T8" fmla="*/ 617 w 1071"/>
                <a:gd name="T9" fmla="*/ 49 h 872"/>
                <a:gd name="T10" fmla="*/ 617 w 1071"/>
                <a:gd name="T11" fmla="*/ 117 h 872"/>
                <a:gd name="T12" fmla="*/ 617 w 1071"/>
                <a:gd name="T13" fmla="*/ 117 h 872"/>
                <a:gd name="T14" fmla="*/ 741 w 1071"/>
                <a:gd name="T15" fmla="*/ 117 h 872"/>
                <a:gd name="T16" fmla="*/ 741 w 1071"/>
                <a:gd name="T17" fmla="*/ 225 h 872"/>
                <a:gd name="T18" fmla="*/ 741 w 1071"/>
                <a:gd name="T19" fmla="*/ 225 h 872"/>
                <a:gd name="T20" fmla="*/ 865 w 1071"/>
                <a:gd name="T21" fmla="*/ 225 h 872"/>
                <a:gd name="T22" fmla="*/ 865 w 1071"/>
                <a:gd name="T23" fmla="*/ 225 h 872"/>
                <a:gd name="T24" fmla="*/ 865 w 1071"/>
                <a:gd name="T25" fmla="*/ 225 h 872"/>
                <a:gd name="T26" fmla="*/ 906 w 1071"/>
                <a:gd name="T27" fmla="*/ 225 h 872"/>
                <a:gd name="T28" fmla="*/ 906 w 1071"/>
                <a:gd name="T29" fmla="*/ 440 h 872"/>
                <a:gd name="T30" fmla="*/ 906 w 1071"/>
                <a:gd name="T31" fmla="*/ 440 h 872"/>
                <a:gd name="T32" fmla="*/ 989 w 1071"/>
                <a:gd name="T33" fmla="*/ 440 h 872"/>
                <a:gd name="T34" fmla="*/ 989 w 1071"/>
                <a:gd name="T35" fmla="*/ 656 h 872"/>
                <a:gd name="T36" fmla="*/ 989 w 1071"/>
                <a:gd name="T37" fmla="*/ 656 h 872"/>
                <a:gd name="T38" fmla="*/ 1071 w 1071"/>
                <a:gd name="T39" fmla="*/ 656 h 872"/>
                <a:gd name="T40" fmla="*/ 1071 w 1071"/>
                <a:gd name="T41" fmla="*/ 872 h 8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071" h="872">
                  <a:moveTo>
                    <a:pt x="0" y="0"/>
                  </a:moveTo>
                  <a:lnTo>
                    <a:pt x="494" y="0"/>
                  </a:lnTo>
                  <a:lnTo>
                    <a:pt x="494" y="49"/>
                  </a:lnTo>
                  <a:lnTo>
                    <a:pt x="494" y="49"/>
                  </a:lnTo>
                  <a:lnTo>
                    <a:pt x="617" y="49"/>
                  </a:lnTo>
                  <a:lnTo>
                    <a:pt x="617" y="117"/>
                  </a:lnTo>
                  <a:lnTo>
                    <a:pt x="617" y="117"/>
                  </a:lnTo>
                  <a:lnTo>
                    <a:pt x="741" y="117"/>
                  </a:lnTo>
                  <a:lnTo>
                    <a:pt x="741" y="225"/>
                  </a:lnTo>
                  <a:lnTo>
                    <a:pt x="741" y="225"/>
                  </a:lnTo>
                  <a:lnTo>
                    <a:pt x="865" y="225"/>
                  </a:lnTo>
                  <a:lnTo>
                    <a:pt x="865" y="225"/>
                  </a:lnTo>
                  <a:lnTo>
                    <a:pt x="865" y="225"/>
                  </a:lnTo>
                  <a:lnTo>
                    <a:pt x="906" y="225"/>
                  </a:lnTo>
                  <a:lnTo>
                    <a:pt x="906" y="440"/>
                  </a:lnTo>
                  <a:lnTo>
                    <a:pt x="906" y="440"/>
                  </a:lnTo>
                  <a:lnTo>
                    <a:pt x="989" y="440"/>
                  </a:lnTo>
                  <a:lnTo>
                    <a:pt x="989" y="656"/>
                  </a:lnTo>
                  <a:lnTo>
                    <a:pt x="989" y="656"/>
                  </a:lnTo>
                  <a:lnTo>
                    <a:pt x="1071" y="656"/>
                  </a:lnTo>
                  <a:lnTo>
                    <a:pt x="1071" y="872"/>
                  </a:lnTo>
                </a:path>
              </a:pathLst>
            </a:custGeom>
            <a:noFill/>
            <a:ln w="19050" cap="flat">
              <a:solidFill>
                <a:srgbClr val="0000C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8" name="Line 321">
              <a:extLst>
                <a:ext uri="{FF2B5EF4-FFF2-40B4-BE49-F238E27FC236}">
                  <a16:creationId xmlns:a16="http://schemas.microsoft.com/office/drawing/2014/main" id="{B55319DE-A910-412C-92C8-04BE30A0595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595562" y="5073650"/>
              <a:ext cx="0" cy="36512"/>
            </a:xfrm>
            <a:prstGeom prst="line">
              <a:avLst/>
            </a:prstGeom>
            <a:noFill/>
            <a:ln w="9525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9" name="Line 322">
              <a:extLst>
                <a:ext uri="{FF2B5EF4-FFF2-40B4-BE49-F238E27FC236}">
                  <a16:creationId xmlns:a16="http://schemas.microsoft.com/office/drawing/2014/main" id="{AB8626B8-B8FA-4867-96E5-CC553B1D4E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400300" y="5181600"/>
              <a:ext cx="0" cy="36512"/>
            </a:xfrm>
            <a:prstGeom prst="line">
              <a:avLst/>
            </a:prstGeom>
            <a:noFill/>
            <a:ln w="9525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0" name="Line 323">
              <a:extLst>
                <a:ext uri="{FF2B5EF4-FFF2-40B4-BE49-F238E27FC236}">
                  <a16:creationId xmlns:a16="http://schemas.microsoft.com/office/drawing/2014/main" id="{90CBF324-5BCB-4229-8911-446BCAE24D3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203450" y="5353050"/>
              <a:ext cx="0" cy="36512"/>
            </a:xfrm>
            <a:prstGeom prst="line">
              <a:avLst/>
            </a:prstGeom>
            <a:noFill/>
            <a:ln w="9525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1" name="Line 324">
              <a:extLst>
                <a:ext uri="{FF2B5EF4-FFF2-40B4-BE49-F238E27FC236}">
                  <a16:creationId xmlns:a16="http://schemas.microsoft.com/office/drawing/2014/main" id="{D374577E-13B5-459F-8B1D-FED9D75BF58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006600" y="5353050"/>
              <a:ext cx="0" cy="36512"/>
            </a:xfrm>
            <a:prstGeom prst="line">
              <a:avLst/>
            </a:prstGeom>
            <a:noFill/>
            <a:ln w="9525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41713114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AD88F69A-B4DC-4D98-8A42-52155D72C71F}"/>
              </a:ext>
            </a:extLst>
          </p:cNvPr>
          <p:cNvGraphicFramePr>
            <a:graphicFrameLocks/>
          </p:cNvGraphicFramePr>
          <p:nvPr/>
        </p:nvGraphicFramePr>
        <p:xfrm>
          <a:off x="1524123" y="4116277"/>
          <a:ext cx="2323549" cy="15143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154502E2-9566-43ED-8672-4FD82B97E879}"/>
              </a:ext>
            </a:extLst>
          </p:cNvPr>
          <p:cNvGraphicFramePr>
            <a:graphicFrameLocks/>
          </p:cNvGraphicFramePr>
          <p:nvPr/>
        </p:nvGraphicFramePr>
        <p:xfrm>
          <a:off x="3882789" y="4077806"/>
          <a:ext cx="2456103" cy="14312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97A8BD48-FE3F-45AE-9090-A6E6DC3BAE36}"/>
              </a:ext>
            </a:extLst>
          </p:cNvPr>
          <p:cNvGraphicFramePr>
            <a:graphicFrameLocks/>
          </p:cNvGraphicFramePr>
          <p:nvPr/>
        </p:nvGraphicFramePr>
        <p:xfrm>
          <a:off x="3923872" y="5617469"/>
          <a:ext cx="2415021" cy="13968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5285B91C-D395-4B90-851A-C7B1F8E238EE}"/>
              </a:ext>
            </a:extLst>
          </p:cNvPr>
          <p:cNvGraphicFramePr>
            <a:graphicFrameLocks/>
          </p:cNvGraphicFramePr>
          <p:nvPr/>
        </p:nvGraphicFramePr>
        <p:xfrm>
          <a:off x="1522191" y="5543856"/>
          <a:ext cx="2323549" cy="16228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5ACB4509-E54E-4B30-8392-458BDAADDBBE}"/>
              </a:ext>
            </a:extLst>
          </p:cNvPr>
          <p:cNvSpPr txBox="1"/>
          <p:nvPr/>
        </p:nvSpPr>
        <p:spPr>
          <a:xfrm>
            <a:off x="2813659" y="7084848"/>
            <a:ext cx="19736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ays receiving treatment (Tx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E9D56C5-81FC-4C15-B23D-290C38EEE35E}"/>
              </a:ext>
            </a:extLst>
          </p:cNvPr>
          <p:cNvSpPr txBox="1"/>
          <p:nvPr/>
        </p:nvSpPr>
        <p:spPr>
          <a:xfrm rot="16200000">
            <a:off x="537306" y="5301757"/>
            <a:ext cx="14782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umor Volume (mm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grpSp>
        <p:nvGrpSpPr>
          <p:cNvPr id="114" name="Group 113">
            <a:extLst>
              <a:ext uri="{FF2B5EF4-FFF2-40B4-BE49-F238E27FC236}">
                <a16:creationId xmlns:a16="http://schemas.microsoft.com/office/drawing/2014/main" id="{DB4408BD-14D9-4A0D-854D-95AC72714664}"/>
              </a:ext>
            </a:extLst>
          </p:cNvPr>
          <p:cNvGrpSpPr/>
          <p:nvPr/>
        </p:nvGrpSpPr>
        <p:grpSpPr>
          <a:xfrm>
            <a:off x="1023787" y="2033222"/>
            <a:ext cx="2821627" cy="1596702"/>
            <a:chOff x="1502411" y="5692106"/>
            <a:chExt cx="2821627" cy="1596702"/>
          </a:xfrm>
        </p:grpSpPr>
        <p:sp>
          <p:nvSpPr>
            <p:cNvPr id="28" name="Rectangle 17">
              <a:extLst>
                <a:ext uri="{FF2B5EF4-FFF2-40B4-BE49-F238E27FC236}">
                  <a16:creationId xmlns:a16="http://schemas.microsoft.com/office/drawing/2014/main" id="{9B5E9246-E2A9-4869-95D6-F297D07F2F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1999" y="6836322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9" name="Rectangle 18">
              <a:extLst>
                <a:ext uri="{FF2B5EF4-FFF2-40B4-BE49-F238E27FC236}">
                  <a16:creationId xmlns:a16="http://schemas.microsoft.com/office/drawing/2014/main" id="{26885F77-B940-4018-ABD0-27B1675990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2560" y="628420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0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0" name="Rectangle 19">
              <a:extLst>
                <a:ext uri="{FF2B5EF4-FFF2-40B4-BE49-F238E27FC236}">
                  <a16:creationId xmlns:a16="http://schemas.microsoft.com/office/drawing/2014/main" id="{CAD1E661-39A4-4046-ACA2-E6054F8AC5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1599" y="5732088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grpSp>
          <p:nvGrpSpPr>
            <p:cNvPr id="74" name="Group 73">
              <a:extLst>
                <a:ext uri="{FF2B5EF4-FFF2-40B4-BE49-F238E27FC236}">
                  <a16:creationId xmlns:a16="http://schemas.microsoft.com/office/drawing/2014/main" id="{76A0AE87-03F2-4112-9EA6-F82A0E45E8D1}"/>
                </a:ext>
              </a:extLst>
            </p:cNvPr>
            <p:cNvGrpSpPr/>
            <p:nvPr/>
          </p:nvGrpSpPr>
          <p:grpSpPr>
            <a:xfrm>
              <a:off x="1974425" y="5784788"/>
              <a:ext cx="1861877" cy="1504020"/>
              <a:chOff x="1860550" y="6516688"/>
              <a:chExt cx="2225204" cy="1852205"/>
            </a:xfrm>
          </p:grpSpPr>
          <p:sp>
            <p:nvSpPr>
              <p:cNvPr id="16" name="Rectangle 5">
                <a:extLst>
                  <a:ext uri="{FF2B5EF4-FFF2-40B4-BE49-F238E27FC236}">
                    <a16:creationId xmlns:a16="http://schemas.microsoft.com/office/drawing/2014/main" id="{C8784B3E-6F43-49F6-B645-20B45AAEAE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78013" y="7977188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en-US" altLang="en-US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" name="Rectangle 6">
                <a:extLst>
                  <a:ext uri="{FF2B5EF4-FFF2-40B4-BE49-F238E27FC236}">
                    <a16:creationId xmlns:a16="http://schemas.microsoft.com/office/drawing/2014/main" id="{E3E012AC-9EB9-45B8-8D6A-CD31920B13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89150" y="7977188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</a:t>
                </a:r>
                <a:endParaRPr kumimoji="0" lang="en-US" altLang="en-US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" name="Rectangle 7">
                <a:extLst>
                  <a:ext uri="{FF2B5EF4-FFF2-40B4-BE49-F238E27FC236}">
                    <a16:creationId xmlns:a16="http://schemas.microsoft.com/office/drawing/2014/main" id="{56D921DC-E911-4AE5-8DF7-F1F6DCE6AC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98700" y="7977188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</a:t>
                </a:r>
                <a:endParaRPr kumimoji="0" lang="en-US" altLang="en-US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" name="Rectangle 8">
                <a:extLst>
                  <a:ext uri="{FF2B5EF4-FFF2-40B4-BE49-F238E27FC236}">
                    <a16:creationId xmlns:a16="http://schemas.microsoft.com/office/drawing/2014/main" id="{3932740C-22E8-4C85-B095-C927DA7755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87613" y="7977188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2</a:t>
                </a:r>
                <a:endParaRPr kumimoji="0" lang="en-US" altLang="en-US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" name="Rectangle 9">
                <a:extLst>
                  <a:ext uri="{FF2B5EF4-FFF2-40B4-BE49-F238E27FC236}">
                    <a16:creationId xmlns:a16="http://schemas.microsoft.com/office/drawing/2014/main" id="{7F5D68C0-FFFC-4D1A-AAC8-F96D40E6085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98750" y="7977188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6</a:t>
                </a:r>
                <a:endParaRPr kumimoji="0" lang="en-US" altLang="en-US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" name="Rectangle 10">
                <a:extLst>
                  <a:ext uri="{FF2B5EF4-FFF2-40B4-BE49-F238E27FC236}">
                    <a16:creationId xmlns:a16="http://schemas.microsoft.com/office/drawing/2014/main" id="{6EF90BF6-32BD-4247-8A53-B34C33D84F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09888" y="7977188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</a:t>
                </a:r>
                <a:endParaRPr kumimoji="0" lang="en-US" altLang="en-US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" name="Rectangle 11">
                <a:extLst>
                  <a:ext uri="{FF2B5EF4-FFF2-40B4-BE49-F238E27FC236}">
                    <a16:creationId xmlns:a16="http://schemas.microsoft.com/office/drawing/2014/main" id="{6648470A-9974-411D-828C-579A0E50D0D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19438" y="7977188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4</a:t>
                </a:r>
                <a:endParaRPr kumimoji="0" lang="en-US" altLang="en-US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" name="Rectangle 12">
                <a:extLst>
                  <a:ext uri="{FF2B5EF4-FFF2-40B4-BE49-F238E27FC236}">
                    <a16:creationId xmlns:a16="http://schemas.microsoft.com/office/drawing/2014/main" id="{F39FC35F-77DA-4F9C-A178-668E08B7BA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30575" y="7977188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8</a:t>
                </a:r>
                <a:endParaRPr kumimoji="0" lang="en-US" altLang="en-US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" name="Rectangle 13">
                <a:extLst>
                  <a:ext uri="{FF2B5EF4-FFF2-40B4-BE49-F238E27FC236}">
                    <a16:creationId xmlns:a16="http://schemas.microsoft.com/office/drawing/2014/main" id="{007070A6-617B-451E-9F39-B52C967EE8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48063" y="7977188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2</a:t>
                </a:r>
                <a:endParaRPr kumimoji="0" lang="en-US" altLang="en-US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" name="Rectangle 14">
                <a:extLst>
                  <a:ext uri="{FF2B5EF4-FFF2-40B4-BE49-F238E27FC236}">
                    <a16:creationId xmlns:a16="http://schemas.microsoft.com/office/drawing/2014/main" id="{71438A2D-AE36-49CD-9DE9-E92F4775EE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59200" y="7977188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6</a:t>
                </a:r>
                <a:endParaRPr kumimoji="0" lang="en-US" altLang="en-US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6" name="Rectangle 15">
                <a:extLst>
                  <a:ext uri="{FF2B5EF4-FFF2-40B4-BE49-F238E27FC236}">
                    <a16:creationId xmlns:a16="http://schemas.microsoft.com/office/drawing/2014/main" id="{959F12E7-A991-4570-943F-E9CF69A639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70338" y="7977188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</a:t>
                </a:r>
                <a:endParaRPr kumimoji="0" lang="en-US" altLang="en-US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" name="Freeform 16">
                <a:extLst>
                  <a:ext uri="{FF2B5EF4-FFF2-40B4-BE49-F238E27FC236}">
                    <a16:creationId xmlns:a16="http://schemas.microsoft.com/office/drawing/2014/main" id="{C3937FD5-4D3B-486D-94FC-4186018E1407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1892300" y="7916863"/>
                <a:ext cx="2133600" cy="39688"/>
              </a:xfrm>
              <a:custGeom>
                <a:avLst/>
                <a:gdLst>
                  <a:gd name="T0" fmla="*/ 0 w 1344"/>
                  <a:gd name="T1" fmla="*/ 0 h 25"/>
                  <a:gd name="T2" fmla="*/ 1344 w 1344"/>
                  <a:gd name="T3" fmla="*/ 0 h 25"/>
                  <a:gd name="T4" fmla="*/ 4 w 1344"/>
                  <a:gd name="T5" fmla="*/ 0 h 25"/>
                  <a:gd name="T6" fmla="*/ 4 w 1344"/>
                  <a:gd name="T7" fmla="*/ 25 h 25"/>
                  <a:gd name="T8" fmla="*/ 138 w 1344"/>
                  <a:gd name="T9" fmla="*/ 0 h 25"/>
                  <a:gd name="T10" fmla="*/ 138 w 1344"/>
                  <a:gd name="T11" fmla="*/ 25 h 25"/>
                  <a:gd name="T12" fmla="*/ 271 w 1344"/>
                  <a:gd name="T13" fmla="*/ 0 h 25"/>
                  <a:gd name="T14" fmla="*/ 271 w 1344"/>
                  <a:gd name="T15" fmla="*/ 25 h 25"/>
                  <a:gd name="T16" fmla="*/ 405 w 1344"/>
                  <a:gd name="T17" fmla="*/ 0 h 25"/>
                  <a:gd name="T18" fmla="*/ 405 w 1344"/>
                  <a:gd name="T19" fmla="*/ 25 h 25"/>
                  <a:gd name="T20" fmla="*/ 538 w 1344"/>
                  <a:gd name="T21" fmla="*/ 0 h 25"/>
                  <a:gd name="T22" fmla="*/ 538 w 1344"/>
                  <a:gd name="T23" fmla="*/ 25 h 25"/>
                  <a:gd name="T24" fmla="*/ 671 w 1344"/>
                  <a:gd name="T25" fmla="*/ 0 h 25"/>
                  <a:gd name="T26" fmla="*/ 671 w 1344"/>
                  <a:gd name="T27" fmla="*/ 25 h 25"/>
                  <a:gd name="T28" fmla="*/ 806 w 1344"/>
                  <a:gd name="T29" fmla="*/ 0 h 25"/>
                  <a:gd name="T30" fmla="*/ 806 w 1344"/>
                  <a:gd name="T31" fmla="*/ 25 h 25"/>
                  <a:gd name="T32" fmla="*/ 939 w 1344"/>
                  <a:gd name="T33" fmla="*/ 0 h 25"/>
                  <a:gd name="T34" fmla="*/ 939 w 1344"/>
                  <a:gd name="T35" fmla="*/ 25 h 25"/>
                  <a:gd name="T36" fmla="*/ 1073 w 1344"/>
                  <a:gd name="T37" fmla="*/ 0 h 25"/>
                  <a:gd name="T38" fmla="*/ 1073 w 1344"/>
                  <a:gd name="T39" fmla="*/ 25 h 25"/>
                  <a:gd name="T40" fmla="*/ 1206 w 1344"/>
                  <a:gd name="T41" fmla="*/ 0 h 25"/>
                  <a:gd name="T42" fmla="*/ 1206 w 1344"/>
                  <a:gd name="T43" fmla="*/ 25 h 25"/>
                  <a:gd name="T44" fmla="*/ 1340 w 1344"/>
                  <a:gd name="T45" fmla="*/ 0 h 25"/>
                  <a:gd name="T46" fmla="*/ 1340 w 1344"/>
                  <a:gd name="T47" fmla="*/ 25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</a:cxnLst>
                <a:rect l="0" t="0" r="r" b="b"/>
                <a:pathLst>
                  <a:path w="1344" h="25">
                    <a:moveTo>
                      <a:pt x="0" y="0"/>
                    </a:moveTo>
                    <a:lnTo>
                      <a:pt x="1344" y="0"/>
                    </a:lnTo>
                    <a:moveTo>
                      <a:pt x="4" y="0"/>
                    </a:moveTo>
                    <a:lnTo>
                      <a:pt x="4" y="25"/>
                    </a:lnTo>
                    <a:moveTo>
                      <a:pt x="138" y="0"/>
                    </a:moveTo>
                    <a:lnTo>
                      <a:pt x="138" y="25"/>
                    </a:lnTo>
                    <a:moveTo>
                      <a:pt x="271" y="0"/>
                    </a:moveTo>
                    <a:lnTo>
                      <a:pt x="271" y="25"/>
                    </a:lnTo>
                    <a:moveTo>
                      <a:pt x="405" y="0"/>
                    </a:moveTo>
                    <a:lnTo>
                      <a:pt x="405" y="25"/>
                    </a:lnTo>
                    <a:moveTo>
                      <a:pt x="538" y="0"/>
                    </a:moveTo>
                    <a:lnTo>
                      <a:pt x="538" y="25"/>
                    </a:lnTo>
                    <a:moveTo>
                      <a:pt x="671" y="0"/>
                    </a:moveTo>
                    <a:lnTo>
                      <a:pt x="671" y="25"/>
                    </a:lnTo>
                    <a:moveTo>
                      <a:pt x="806" y="0"/>
                    </a:moveTo>
                    <a:lnTo>
                      <a:pt x="806" y="25"/>
                    </a:lnTo>
                    <a:moveTo>
                      <a:pt x="939" y="0"/>
                    </a:moveTo>
                    <a:lnTo>
                      <a:pt x="939" y="25"/>
                    </a:lnTo>
                    <a:moveTo>
                      <a:pt x="1073" y="0"/>
                    </a:moveTo>
                    <a:lnTo>
                      <a:pt x="1073" y="25"/>
                    </a:lnTo>
                    <a:moveTo>
                      <a:pt x="1206" y="0"/>
                    </a:moveTo>
                    <a:lnTo>
                      <a:pt x="1206" y="25"/>
                    </a:lnTo>
                    <a:moveTo>
                      <a:pt x="1340" y="0"/>
                    </a:moveTo>
                    <a:lnTo>
                      <a:pt x="1340" y="25"/>
                    </a:lnTo>
                  </a:path>
                </a:pathLst>
              </a:custGeom>
              <a:noFill/>
              <a:ln w="142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1" name="Freeform 20">
                <a:extLst>
                  <a:ext uri="{FF2B5EF4-FFF2-40B4-BE49-F238E27FC236}">
                    <a16:creationId xmlns:a16="http://schemas.microsoft.com/office/drawing/2014/main" id="{773F39B7-B7B1-425A-815E-7AC641A17A84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1860550" y="6516688"/>
                <a:ext cx="38100" cy="1408113"/>
              </a:xfrm>
              <a:custGeom>
                <a:avLst/>
                <a:gdLst>
                  <a:gd name="T0" fmla="*/ 24 w 24"/>
                  <a:gd name="T1" fmla="*/ 887 h 887"/>
                  <a:gd name="T2" fmla="*/ 24 w 24"/>
                  <a:gd name="T3" fmla="*/ 0 h 887"/>
                  <a:gd name="T4" fmla="*/ 24 w 24"/>
                  <a:gd name="T5" fmla="*/ 882 h 887"/>
                  <a:gd name="T6" fmla="*/ 0 w 24"/>
                  <a:gd name="T7" fmla="*/ 882 h 887"/>
                  <a:gd name="T8" fmla="*/ 24 w 24"/>
                  <a:gd name="T9" fmla="*/ 443 h 887"/>
                  <a:gd name="T10" fmla="*/ 0 w 24"/>
                  <a:gd name="T11" fmla="*/ 443 h 887"/>
                  <a:gd name="T12" fmla="*/ 24 w 24"/>
                  <a:gd name="T13" fmla="*/ 4 h 887"/>
                  <a:gd name="T14" fmla="*/ 0 w 24"/>
                  <a:gd name="T15" fmla="*/ 4 h 8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4" h="887">
                    <a:moveTo>
                      <a:pt x="24" y="887"/>
                    </a:moveTo>
                    <a:lnTo>
                      <a:pt x="24" y="0"/>
                    </a:lnTo>
                    <a:moveTo>
                      <a:pt x="24" y="882"/>
                    </a:moveTo>
                    <a:lnTo>
                      <a:pt x="0" y="882"/>
                    </a:lnTo>
                    <a:moveTo>
                      <a:pt x="24" y="443"/>
                    </a:moveTo>
                    <a:lnTo>
                      <a:pt x="0" y="443"/>
                    </a:lnTo>
                    <a:moveTo>
                      <a:pt x="24" y="4"/>
                    </a:moveTo>
                    <a:lnTo>
                      <a:pt x="0" y="4"/>
                    </a:lnTo>
                  </a:path>
                </a:pathLst>
              </a:custGeom>
              <a:noFill/>
              <a:ln w="142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Freeform 21">
                <a:extLst>
                  <a:ext uri="{FF2B5EF4-FFF2-40B4-BE49-F238E27FC236}">
                    <a16:creationId xmlns:a16="http://schemas.microsoft.com/office/drawing/2014/main" id="{42136D09-D265-46BE-BA91-3DE44B92A1B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98650" y="6523038"/>
                <a:ext cx="1749425" cy="1393825"/>
              </a:xfrm>
              <a:custGeom>
                <a:avLst/>
                <a:gdLst>
                  <a:gd name="T0" fmla="*/ 0 w 1102"/>
                  <a:gd name="T1" fmla="*/ 0 h 878"/>
                  <a:gd name="T2" fmla="*/ 0 w 1102"/>
                  <a:gd name="T3" fmla="*/ 0 h 878"/>
                  <a:gd name="T4" fmla="*/ 0 w 1102"/>
                  <a:gd name="T5" fmla="*/ 0 h 878"/>
                  <a:gd name="T6" fmla="*/ 0 w 1102"/>
                  <a:gd name="T7" fmla="*/ 0 h 878"/>
                  <a:gd name="T8" fmla="*/ 568 w 1102"/>
                  <a:gd name="T9" fmla="*/ 0 h 878"/>
                  <a:gd name="T10" fmla="*/ 568 w 1102"/>
                  <a:gd name="T11" fmla="*/ 220 h 878"/>
                  <a:gd name="T12" fmla="*/ 568 w 1102"/>
                  <a:gd name="T13" fmla="*/ 220 h 878"/>
                  <a:gd name="T14" fmla="*/ 768 w 1102"/>
                  <a:gd name="T15" fmla="*/ 220 h 878"/>
                  <a:gd name="T16" fmla="*/ 768 w 1102"/>
                  <a:gd name="T17" fmla="*/ 439 h 878"/>
                  <a:gd name="T18" fmla="*/ 768 w 1102"/>
                  <a:gd name="T19" fmla="*/ 439 h 878"/>
                  <a:gd name="T20" fmla="*/ 1002 w 1102"/>
                  <a:gd name="T21" fmla="*/ 439 h 878"/>
                  <a:gd name="T22" fmla="*/ 1002 w 1102"/>
                  <a:gd name="T23" fmla="*/ 659 h 878"/>
                  <a:gd name="T24" fmla="*/ 1002 w 1102"/>
                  <a:gd name="T25" fmla="*/ 659 h 878"/>
                  <a:gd name="T26" fmla="*/ 1102 w 1102"/>
                  <a:gd name="T27" fmla="*/ 659 h 878"/>
                  <a:gd name="T28" fmla="*/ 1102 w 1102"/>
                  <a:gd name="T29" fmla="*/ 878 h 8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</a:cxnLst>
                <a:rect l="0" t="0" r="r" b="b"/>
                <a:pathLst>
                  <a:path w="1102" h="878">
                    <a:moveTo>
                      <a:pt x="0" y="0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568" y="0"/>
                    </a:lnTo>
                    <a:lnTo>
                      <a:pt x="568" y="220"/>
                    </a:lnTo>
                    <a:lnTo>
                      <a:pt x="568" y="220"/>
                    </a:lnTo>
                    <a:lnTo>
                      <a:pt x="768" y="220"/>
                    </a:lnTo>
                    <a:lnTo>
                      <a:pt x="768" y="439"/>
                    </a:lnTo>
                    <a:lnTo>
                      <a:pt x="768" y="439"/>
                    </a:lnTo>
                    <a:lnTo>
                      <a:pt x="1002" y="439"/>
                    </a:lnTo>
                    <a:lnTo>
                      <a:pt x="1002" y="659"/>
                    </a:lnTo>
                    <a:lnTo>
                      <a:pt x="1002" y="659"/>
                    </a:lnTo>
                    <a:lnTo>
                      <a:pt x="1102" y="659"/>
                    </a:lnTo>
                    <a:lnTo>
                      <a:pt x="1102" y="878"/>
                    </a:lnTo>
                  </a:path>
                </a:pathLst>
              </a:custGeom>
              <a:noFill/>
              <a:ln w="14288" cap="flat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" name="Freeform 22">
                <a:extLst>
                  <a:ext uri="{FF2B5EF4-FFF2-40B4-BE49-F238E27FC236}">
                    <a16:creationId xmlns:a16="http://schemas.microsoft.com/office/drawing/2014/main" id="{215DC36D-1BEC-449C-9CEE-52C230CCA32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98650" y="6523038"/>
                <a:ext cx="1962150" cy="1393825"/>
              </a:xfrm>
              <a:custGeom>
                <a:avLst/>
                <a:gdLst>
                  <a:gd name="T0" fmla="*/ 0 w 1236"/>
                  <a:gd name="T1" fmla="*/ 0 h 878"/>
                  <a:gd name="T2" fmla="*/ 0 w 1236"/>
                  <a:gd name="T3" fmla="*/ 0 h 878"/>
                  <a:gd name="T4" fmla="*/ 0 w 1236"/>
                  <a:gd name="T5" fmla="*/ 0 h 878"/>
                  <a:gd name="T6" fmla="*/ 0 w 1236"/>
                  <a:gd name="T7" fmla="*/ 0 h 878"/>
                  <a:gd name="T8" fmla="*/ 668 w 1236"/>
                  <a:gd name="T9" fmla="*/ 0 h 878"/>
                  <a:gd name="T10" fmla="*/ 668 w 1236"/>
                  <a:gd name="T11" fmla="*/ 176 h 878"/>
                  <a:gd name="T12" fmla="*/ 668 w 1236"/>
                  <a:gd name="T13" fmla="*/ 176 h 878"/>
                  <a:gd name="T14" fmla="*/ 902 w 1236"/>
                  <a:gd name="T15" fmla="*/ 176 h 878"/>
                  <a:gd name="T16" fmla="*/ 902 w 1236"/>
                  <a:gd name="T17" fmla="*/ 352 h 878"/>
                  <a:gd name="T18" fmla="*/ 902 w 1236"/>
                  <a:gd name="T19" fmla="*/ 352 h 878"/>
                  <a:gd name="T20" fmla="*/ 1102 w 1236"/>
                  <a:gd name="T21" fmla="*/ 352 h 878"/>
                  <a:gd name="T22" fmla="*/ 1102 w 1236"/>
                  <a:gd name="T23" fmla="*/ 703 h 878"/>
                  <a:gd name="T24" fmla="*/ 1102 w 1236"/>
                  <a:gd name="T25" fmla="*/ 703 h 878"/>
                  <a:gd name="T26" fmla="*/ 1236 w 1236"/>
                  <a:gd name="T27" fmla="*/ 703 h 878"/>
                  <a:gd name="T28" fmla="*/ 1236 w 1236"/>
                  <a:gd name="T29" fmla="*/ 878 h 8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</a:cxnLst>
                <a:rect l="0" t="0" r="r" b="b"/>
                <a:pathLst>
                  <a:path w="1236" h="878">
                    <a:moveTo>
                      <a:pt x="0" y="0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668" y="0"/>
                    </a:lnTo>
                    <a:lnTo>
                      <a:pt x="668" y="176"/>
                    </a:lnTo>
                    <a:lnTo>
                      <a:pt x="668" y="176"/>
                    </a:lnTo>
                    <a:lnTo>
                      <a:pt x="902" y="176"/>
                    </a:lnTo>
                    <a:lnTo>
                      <a:pt x="902" y="352"/>
                    </a:lnTo>
                    <a:lnTo>
                      <a:pt x="902" y="352"/>
                    </a:lnTo>
                    <a:lnTo>
                      <a:pt x="1102" y="352"/>
                    </a:lnTo>
                    <a:lnTo>
                      <a:pt x="1102" y="703"/>
                    </a:lnTo>
                    <a:lnTo>
                      <a:pt x="1102" y="703"/>
                    </a:lnTo>
                    <a:lnTo>
                      <a:pt x="1236" y="703"/>
                    </a:lnTo>
                    <a:lnTo>
                      <a:pt x="1236" y="878"/>
                    </a:lnTo>
                  </a:path>
                </a:pathLst>
              </a:custGeom>
              <a:noFill/>
              <a:ln w="142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" name="Freeform 23">
                <a:extLst>
                  <a:ext uri="{FF2B5EF4-FFF2-40B4-BE49-F238E27FC236}">
                    <a16:creationId xmlns:a16="http://schemas.microsoft.com/office/drawing/2014/main" id="{11170317-2F7C-48E1-B40D-970F2F131D1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98650" y="6523038"/>
                <a:ext cx="1962150" cy="558800"/>
              </a:xfrm>
              <a:custGeom>
                <a:avLst/>
                <a:gdLst>
                  <a:gd name="T0" fmla="*/ 0 w 1236"/>
                  <a:gd name="T1" fmla="*/ 0 h 352"/>
                  <a:gd name="T2" fmla="*/ 0 w 1236"/>
                  <a:gd name="T3" fmla="*/ 0 h 352"/>
                  <a:gd name="T4" fmla="*/ 0 w 1236"/>
                  <a:gd name="T5" fmla="*/ 0 h 352"/>
                  <a:gd name="T6" fmla="*/ 0 w 1236"/>
                  <a:gd name="T7" fmla="*/ 0 h 352"/>
                  <a:gd name="T8" fmla="*/ 1102 w 1236"/>
                  <a:gd name="T9" fmla="*/ 0 h 352"/>
                  <a:gd name="T10" fmla="*/ 1102 w 1236"/>
                  <a:gd name="T11" fmla="*/ 176 h 352"/>
                  <a:gd name="T12" fmla="*/ 1102 w 1236"/>
                  <a:gd name="T13" fmla="*/ 176 h 352"/>
                  <a:gd name="T14" fmla="*/ 1236 w 1236"/>
                  <a:gd name="T15" fmla="*/ 176 h 352"/>
                  <a:gd name="T16" fmla="*/ 1236 w 1236"/>
                  <a:gd name="T17" fmla="*/ 352 h 3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1236" h="352">
                    <a:moveTo>
                      <a:pt x="0" y="0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1102" y="0"/>
                    </a:lnTo>
                    <a:lnTo>
                      <a:pt x="1102" y="176"/>
                    </a:lnTo>
                    <a:lnTo>
                      <a:pt x="1102" y="176"/>
                    </a:lnTo>
                    <a:lnTo>
                      <a:pt x="1236" y="176"/>
                    </a:lnTo>
                    <a:lnTo>
                      <a:pt x="1236" y="352"/>
                    </a:lnTo>
                  </a:path>
                </a:pathLst>
              </a:custGeom>
              <a:noFill/>
              <a:ln w="14288" cap="flat">
                <a:solidFill>
                  <a:srgbClr val="F9404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" name="Line 24">
                <a:extLst>
                  <a:ext uri="{FF2B5EF4-FFF2-40B4-BE49-F238E27FC236}">
                    <a16:creationId xmlns:a16="http://schemas.microsoft.com/office/drawing/2014/main" id="{4D7E816E-BD3F-4DF6-8595-EDCB5E10D6A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60800" y="7053263"/>
                <a:ext cx="0" cy="28575"/>
              </a:xfrm>
              <a:prstGeom prst="line">
                <a:avLst/>
              </a:prstGeom>
              <a:noFill/>
              <a:ln w="142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" name="Freeform 25">
                <a:extLst>
                  <a:ext uri="{FF2B5EF4-FFF2-40B4-BE49-F238E27FC236}">
                    <a16:creationId xmlns:a16="http://schemas.microsoft.com/office/drawing/2014/main" id="{63E66F5C-6638-4B4B-8957-8921F4FF17D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98650" y="6523038"/>
                <a:ext cx="1962150" cy="279400"/>
              </a:xfrm>
              <a:custGeom>
                <a:avLst/>
                <a:gdLst>
                  <a:gd name="T0" fmla="*/ 0 w 1236"/>
                  <a:gd name="T1" fmla="*/ 0 h 176"/>
                  <a:gd name="T2" fmla="*/ 0 w 1236"/>
                  <a:gd name="T3" fmla="*/ 0 h 176"/>
                  <a:gd name="T4" fmla="*/ 0 w 1236"/>
                  <a:gd name="T5" fmla="*/ 0 h 176"/>
                  <a:gd name="T6" fmla="*/ 0 w 1236"/>
                  <a:gd name="T7" fmla="*/ 0 h 176"/>
                  <a:gd name="T8" fmla="*/ 1102 w 1236"/>
                  <a:gd name="T9" fmla="*/ 0 h 176"/>
                  <a:gd name="T10" fmla="*/ 1102 w 1236"/>
                  <a:gd name="T11" fmla="*/ 88 h 176"/>
                  <a:gd name="T12" fmla="*/ 1102 w 1236"/>
                  <a:gd name="T13" fmla="*/ 88 h 176"/>
                  <a:gd name="T14" fmla="*/ 1236 w 1236"/>
                  <a:gd name="T15" fmla="*/ 88 h 176"/>
                  <a:gd name="T16" fmla="*/ 1236 w 1236"/>
                  <a:gd name="T17" fmla="*/ 176 h 1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1236" h="176">
                    <a:moveTo>
                      <a:pt x="0" y="0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1102" y="0"/>
                    </a:lnTo>
                    <a:lnTo>
                      <a:pt x="1102" y="88"/>
                    </a:lnTo>
                    <a:lnTo>
                      <a:pt x="1102" y="88"/>
                    </a:lnTo>
                    <a:lnTo>
                      <a:pt x="1236" y="88"/>
                    </a:lnTo>
                    <a:lnTo>
                      <a:pt x="1236" y="176"/>
                    </a:lnTo>
                  </a:path>
                </a:pathLst>
              </a:custGeom>
              <a:noFill/>
              <a:ln w="14288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" name="Line 26">
                <a:extLst>
                  <a:ext uri="{FF2B5EF4-FFF2-40B4-BE49-F238E27FC236}">
                    <a16:creationId xmlns:a16="http://schemas.microsoft.com/office/drawing/2014/main" id="{9BB93B27-5D0B-4C20-818E-AA9F5DE9EE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60800" y="6773863"/>
                <a:ext cx="0" cy="28575"/>
              </a:xfrm>
              <a:prstGeom prst="line">
                <a:avLst/>
              </a:prstGeom>
              <a:noFill/>
              <a:ln w="142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" name="Rectangle 28">
                <a:extLst>
                  <a:ext uri="{FF2B5EF4-FFF2-40B4-BE49-F238E27FC236}">
                    <a16:creationId xmlns:a16="http://schemas.microsoft.com/office/drawing/2014/main" id="{AA136488-BB1C-4E94-9C67-22C67EA1259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77268" y="8230394"/>
                <a:ext cx="1404231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Days since treatment (Tx)</a:t>
                </a:r>
                <a:endParaRPr kumimoji="0" lang="en-US" altLang="en-US" sz="1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grpSp>
            <p:nvGrpSpPr>
              <p:cNvPr id="72" name="Group 71">
                <a:extLst>
                  <a:ext uri="{FF2B5EF4-FFF2-40B4-BE49-F238E27FC236}">
                    <a16:creationId xmlns:a16="http://schemas.microsoft.com/office/drawing/2014/main" id="{79DDB4B5-99AC-465C-B28F-7D1144371ED1}"/>
                  </a:ext>
                </a:extLst>
              </p:cNvPr>
              <p:cNvGrpSpPr/>
              <p:nvPr/>
            </p:nvGrpSpPr>
            <p:grpSpPr>
              <a:xfrm>
                <a:off x="2089150" y="7207528"/>
                <a:ext cx="806543" cy="631037"/>
                <a:chOff x="4313722" y="6553200"/>
                <a:chExt cx="806543" cy="631037"/>
              </a:xfrm>
            </p:grpSpPr>
            <p:sp>
              <p:nvSpPr>
                <p:cNvPr id="56" name="Rectangle 45">
                  <a:extLst>
                    <a:ext uri="{FF2B5EF4-FFF2-40B4-BE49-F238E27FC236}">
                      <a16:creationId xmlns:a16="http://schemas.microsoft.com/office/drawing/2014/main" id="{426C89F7-E6B6-489F-8784-C9FCF613961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732338" y="6713538"/>
                  <a:ext cx="322204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B10G5</a:t>
                  </a:r>
                  <a:endPara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7" name="Line 46">
                  <a:extLst>
                    <a:ext uri="{FF2B5EF4-FFF2-40B4-BE49-F238E27FC236}">
                      <a16:creationId xmlns:a16="http://schemas.microsoft.com/office/drawing/2014/main" id="{8EAB2362-D42F-4FC6-82C6-0EB4C7403FF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324350" y="6778625"/>
                  <a:ext cx="322263" cy="0"/>
                </a:xfrm>
                <a:prstGeom prst="line">
                  <a:avLst/>
                </a:prstGeom>
                <a:noFill/>
                <a:ln w="14288" cap="flat">
                  <a:solidFill>
                    <a:srgbClr val="F9404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8" name="Line 47">
                  <a:extLst>
                    <a:ext uri="{FF2B5EF4-FFF2-40B4-BE49-F238E27FC236}">
                      <a16:creationId xmlns:a16="http://schemas.microsoft.com/office/drawing/2014/main" id="{94BFE135-D78D-44EA-8B42-83DA3367C0E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486275" y="6750050"/>
                  <a:ext cx="0" cy="28575"/>
                </a:xfrm>
                <a:prstGeom prst="line">
                  <a:avLst/>
                </a:prstGeom>
                <a:noFill/>
                <a:ln w="142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9" name="Rectangle 48">
                  <a:extLst>
                    <a:ext uri="{FF2B5EF4-FFF2-40B4-BE49-F238E27FC236}">
                      <a16:creationId xmlns:a16="http://schemas.microsoft.com/office/drawing/2014/main" id="{AE1F8215-E4B9-45AD-967F-9DE930A05A8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732338" y="6553200"/>
                  <a:ext cx="387927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COMBO</a:t>
                  </a:r>
                  <a:endPara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0" name="Line 49">
                  <a:extLst>
                    <a:ext uri="{FF2B5EF4-FFF2-40B4-BE49-F238E27FC236}">
                      <a16:creationId xmlns:a16="http://schemas.microsoft.com/office/drawing/2014/main" id="{A4618D5D-47D2-4D10-98C0-6DB8F99AD4E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324350" y="6616700"/>
                  <a:ext cx="322263" cy="0"/>
                </a:xfrm>
                <a:prstGeom prst="line">
                  <a:avLst/>
                </a:prstGeom>
                <a:noFill/>
                <a:ln w="14288" cap="flat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1" name="Line 50">
                  <a:extLst>
                    <a:ext uri="{FF2B5EF4-FFF2-40B4-BE49-F238E27FC236}">
                      <a16:creationId xmlns:a16="http://schemas.microsoft.com/office/drawing/2014/main" id="{58D150B9-334C-475A-AD92-B575BA19721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486275" y="6589713"/>
                  <a:ext cx="0" cy="26988"/>
                </a:xfrm>
                <a:prstGeom prst="line">
                  <a:avLst/>
                </a:prstGeom>
                <a:noFill/>
                <a:ln w="142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" name="Rectangle 51">
                  <a:extLst>
                    <a:ext uri="{FF2B5EF4-FFF2-40B4-BE49-F238E27FC236}">
                      <a16:creationId xmlns:a16="http://schemas.microsoft.com/office/drawing/2014/main" id="{CDD3BD90-DC54-4C5B-9300-3B05894049B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732339" y="6872287"/>
                  <a:ext cx="322262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PD1</a:t>
                  </a:r>
                  <a:endParaRPr kumimoji="0" lang="en-US" altLang="en-US" sz="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5" name="Rectangle 54">
                  <a:extLst>
                    <a:ext uri="{FF2B5EF4-FFF2-40B4-BE49-F238E27FC236}">
                      <a16:creationId xmlns:a16="http://schemas.microsoft.com/office/drawing/2014/main" id="{BD8E6024-5D49-487A-9A29-6AEBEF69C86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732338" y="7032625"/>
                  <a:ext cx="348679" cy="15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cIgGsl</a:t>
                  </a:r>
                  <a:endParaRPr kumimoji="0" lang="en-US" altLang="en-US" sz="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68" name="Group 67">
                  <a:extLst>
                    <a:ext uri="{FF2B5EF4-FFF2-40B4-BE49-F238E27FC236}">
                      <a16:creationId xmlns:a16="http://schemas.microsoft.com/office/drawing/2014/main" id="{0E87F97B-494B-4714-A6A0-E03F69336D31}"/>
                    </a:ext>
                  </a:extLst>
                </p:cNvPr>
                <p:cNvGrpSpPr/>
                <p:nvPr/>
              </p:nvGrpSpPr>
              <p:grpSpPr>
                <a:xfrm>
                  <a:off x="4324350" y="7070725"/>
                  <a:ext cx="322263" cy="26988"/>
                  <a:chOff x="4324350" y="7070725"/>
                  <a:chExt cx="322263" cy="26988"/>
                </a:xfrm>
              </p:grpSpPr>
              <p:sp>
                <p:nvSpPr>
                  <p:cNvPr id="66" name="Line 55">
                    <a:extLst>
                      <a:ext uri="{FF2B5EF4-FFF2-40B4-BE49-F238E27FC236}">
                        <a16:creationId xmlns:a16="http://schemas.microsoft.com/office/drawing/2014/main" id="{B11725A9-941E-4803-849A-DF7750D23480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324350" y="7097713"/>
                    <a:ext cx="322263" cy="0"/>
                  </a:xfrm>
                  <a:prstGeom prst="line">
                    <a:avLst/>
                  </a:prstGeom>
                  <a:noFill/>
                  <a:ln w="14288" cap="flat">
                    <a:solidFill>
                      <a:srgbClr val="80808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7" name="Line 56">
                    <a:extLst>
                      <a:ext uri="{FF2B5EF4-FFF2-40B4-BE49-F238E27FC236}">
                        <a16:creationId xmlns:a16="http://schemas.microsoft.com/office/drawing/2014/main" id="{33368578-20DE-4636-B8A7-05033E478D10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486275" y="7070725"/>
                    <a:ext cx="0" cy="26988"/>
                  </a:xfrm>
                  <a:prstGeom prst="line">
                    <a:avLst/>
                  </a:prstGeom>
                  <a:noFill/>
                  <a:ln w="142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69" name="Group 68">
                  <a:extLst>
                    <a:ext uri="{FF2B5EF4-FFF2-40B4-BE49-F238E27FC236}">
                      <a16:creationId xmlns:a16="http://schemas.microsoft.com/office/drawing/2014/main" id="{4BFCC614-53A1-437C-90BF-C7E3DD03439D}"/>
                    </a:ext>
                  </a:extLst>
                </p:cNvPr>
                <p:cNvGrpSpPr/>
                <p:nvPr/>
              </p:nvGrpSpPr>
              <p:grpSpPr>
                <a:xfrm>
                  <a:off x="4313722" y="6903244"/>
                  <a:ext cx="322263" cy="26988"/>
                  <a:chOff x="4324350" y="7070725"/>
                  <a:chExt cx="322263" cy="26988"/>
                </a:xfrm>
              </p:grpSpPr>
              <p:sp>
                <p:nvSpPr>
                  <p:cNvPr id="70" name="Line 55">
                    <a:extLst>
                      <a:ext uri="{FF2B5EF4-FFF2-40B4-BE49-F238E27FC236}">
                        <a16:creationId xmlns:a16="http://schemas.microsoft.com/office/drawing/2014/main" id="{3A06F0FB-DB28-4EDB-AB9D-D1D5B0EFDA47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324350" y="7097713"/>
                    <a:ext cx="322263" cy="0"/>
                  </a:xfrm>
                  <a:prstGeom prst="line">
                    <a:avLst/>
                  </a:prstGeom>
                  <a:ln w="12700"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1" name="Line 56">
                    <a:extLst>
                      <a:ext uri="{FF2B5EF4-FFF2-40B4-BE49-F238E27FC236}">
                        <a16:creationId xmlns:a16="http://schemas.microsoft.com/office/drawing/2014/main" id="{1A84DF14-A1AA-40F4-9E0C-E0BE45F5AB70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486275" y="7070725"/>
                    <a:ext cx="0" cy="26988"/>
                  </a:xfrm>
                  <a:prstGeom prst="line">
                    <a:avLst/>
                  </a:prstGeom>
                  <a:ln w="12700"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FA68E87F-9E59-4FDE-B82C-BD914F37B093}"/>
                </a:ext>
              </a:extLst>
            </p:cNvPr>
            <p:cNvSpPr txBox="1"/>
            <p:nvPr/>
          </p:nvSpPr>
          <p:spPr>
            <a:xfrm rot="16200000">
              <a:off x="931261" y="6263256"/>
              <a:ext cx="13885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ercentage survival</a:t>
              </a:r>
            </a:p>
          </p:txBody>
        </p:sp>
        <p:sp>
          <p:nvSpPr>
            <p:cNvPr id="75" name="Right Bracket 74">
              <a:extLst>
                <a:ext uri="{FF2B5EF4-FFF2-40B4-BE49-F238E27FC236}">
                  <a16:creationId xmlns:a16="http://schemas.microsoft.com/office/drawing/2014/main" id="{B5B61ACD-F58F-4F3A-883B-93623542FD9B}"/>
                </a:ext>
              </a:extLst>
            </p:cNvPr>
            <p:cNvSpPr/>
            <p:nvPr/>
          </p:nvSpPr>
          <p:spPr>
            <a:xfrm>
              <a:off x="3698659" y="6031881"/>
              <a:ext cx="47620" cy="216275"/>
            </a:xfrm>
            <a:prstGeom prst="rightBracket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6EC95B11-DA1E-45D8-9782-1586D910D7F2}"/>
                </a:ext>
              </a:extLst>
            </p:cNvPr>
            <p:cNvSpPr txBox="1"/>
            <p:nvPr/>
          </p:nvSpPr>
          <p:spPr>
            <a:xfrm>
              <a:off x="3751445" y="6012336"/>
              <a:ext cx="57259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 &lt; 0.05</a:t>
              </a:r>
            </a:p>
          </p:txBody>
        </p:sp>
      </p:grpSp>
      <p:sp>
        <p:nvSpPr>
          <p:cNvPr id="77" name="TextBox 76">
            <a:extLst>
              <a:ext uri="{FF2B5EF4-FFF2-40B4-BE49-F238E27FC236}">
                <a16:creationId xmlns:a16="http://schemas.microsoft.com/office/drawing/2014/main" id="{B00E667C-D8E1-4D75-9F39-4DAB5A162802}"/>
              </a:ext>
            </a:extLst>
          </p:cNvPr>
          <p:cNvSpPr txBox="1"/>
          <p:nvPr/>
        </p:nvSpPr>
        <p:spPr>
          <a:xfrm>
            <a:off x="440411" y="1949197"/>
            <a:ext cx="322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D1122640-36A4-4BF1-8303-DDBB29F0027B}"/>
              </a:ext>
            </a:extLst>
          </p:cNvPr>
          <p:cNvSpPr txBox="1"/>
          <p:nvPr/>
        </p:nvSpPr>
        <p:spPr>
          <a:xfrm>
            <a:off x="443929" y="3813722"/>
            <a:ext cx="3268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grpSp>
        <p:nvGrpSpPr>
          <p:cNvPr id="80" name="Group 79">
            <a:extLst>
              <a:ext uri="{FF2B5EF4-FFF2-40B4-BE49-F238E27FC236}">
                <a16:creationId xmlns:a16="http://schemas.microsoft.com/office/drawing/2014/main" id="{1848981E-02F5-4D2A-9FAB-093D4C27EC15}"/>
              </a:ext>
            </a:extLst>
          </p:cNvPr>
          <p:cNvGrpSpPr/>
          <p:nvPr/>
        </p:nvGrpSpPr>
        <p:grpSpPr>
          <a:xfrm>
            <a:off x="701712" y="550214"/>
            <a:ext cx="3680867" cy="1402054"/>
            <a:chOff x="890462" y="500433"/>
            <a:chExt cx="3680867" cy="1402054"/>
          </a:xfrm>
        </p:grpSpPr>
        <p:grpSp>
          <p:nvGrpSpPr>
            <p:cNvPr id="81" name="Group 80">
              <a:extLst>
                <a:ext uri="{FF2B5EF4-FFF2-40B4-BE49-F238E27FC236}">
                  <a16:creationId xmlns:a16="http://schemas.microsoft.com/office/drawing/2014/main" id="{D642E749-C44E-4D5C-9B33-1B9511E2FE51}"/>
                </a:ext>
              </a:extLst>
            </p:cNvPr>
            <p:cNvGrpSpPr/>
            <p:nvPr/>
          </p:nvGrpSpPr>
          <p:grpSpPr>
            <a:xfrm>
              <a:off x="1335648" y="500433"/>
              <a:ext cx="3235681" cy="1076458"/>
              <a:chOff x="538566" y="7080116"/>
              <a:chExt cx="3235681" cy="1076458"/>
            </a:xfrm>
          </p:grpSpPr>
          <p:grpSp>
            <p:nvGrpSpPr>
              <p:cNvPr id="95" name="Group 94">
                <a:extLst>
                  <a:ext uri="{FF2B5EF4-FFF2-40B4-BE49-F238E27FC236}">
                    <a16:creationId xmlns:a16="http://schemas.microsoft.com/office/drawing/2014/main" id="{D8EEC690-1BF1-42DC-A8D5-E7EEFBE67465}"/>
                  </a:ext>
                </a:extLst>
              </p:cNvPr>
              <p:cNvGrpSpPr/>
              <p:nvPr/>
            </p:nvGrpSpPr>
            <p:grpSpPr>
              <a:xfrm>
                <a:off x="577493" y="7383702"/>
                <a:ext cx="3196754" cy="772872"/>
                <a:chOff x="517951" y="762054"/>
                <a:chExt cx="3196754" cy="772872"/>
              </a:xfrm>
            </p:grpSpPr>
            <p:cxnSp>
              <p:nvCxnSpPr>
                <p:cNvPr id="97" name="Straight Arrow Connector 96">
                  <a:extLst>
                    <a:ext uri="{FF2B5EF4-FFF2-40B4-BE49-F238E27FC236}">
                      <a16:creationId xmlns:a16="http://schemas.microsoft.com/office/drawing/2014/main" id="{DAA6EAD5-11CD-4518-93E4-E6BF8F7C9A8C}"/>
                    </a:ext>
                  </a:extLst>
                </p:cNvPr>
                <p:cNvCxnSpPr/>
                <p:nvPr/>
              </p:nvCxnSpPr>
              <p:spPr>
                <a:xfrm flipV="1">
                  <a:off x="818358" y="1462911"/>
                  <a:ext cx="2381220" cy="2647"/>
                </a:xfrm>
                <a:prstGeom prst="straightConnector1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  <a:tailEnd type="triangle"/>
                </a:ln>
                <a:effectLst/>
              </p:spPr>
            </p:cxnSp>
            <p:cxnSp>
              <p:nvCxnSpPr>
                <p:cNvPr id="98" name="Straight Connector 97">
                  <a:extLst>
                    <a:ext uri="{FF2B5EF4-FFF2-40B4-BE49-F238E27FC236}">
                      <a16:creationId xmlns:a16="http://schemas.microsoft.com/office/drawing/2014/main" id="{AEEA17AC-A364-493A-9B92-3D85E8FEC8CD}"/>
                    </a:ext>
                  </a:extLst>
                </p:cNvPr>
                <p:cNvCxnSpPr/>
                <p:nvPr/>
              </p:nvCxnSpPr>
              <p:spPr>
                <a:xfrm>
                  <a:off x="818358" y="1396193"/>
                  <a:ext cx="0" cy="138733"/>
                </a:xfrm>
                <a:prstGeom prst="line">
                  <a:avLst/>
                </a:prstGeom>
                <a:noFill/>
                <a:ln w="317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99" name="Straight Connector 98">
                  <a:extLst>
                    <a:ext uri="{FF2B5EF4-FFF2-40B4-BE49-F238E27FC236}">
                      <a16:creationId xmlns:a16="http://schemas.microsoft.com/office/drawing/2014/main" id="{BEF3E1E2-DA7E-437F-8D5A-8AD24673E486}"/>
                    </a:ext>
                  </a:extLst>
                </p:cNvPr>
                <p:cNvCxnSpPr/>
                <p:nvPr/>
              </p:nvCxnSpPr>
              <p:spPr>
                <a:xfrm>
                  <a:off x="1707546" y="1396193"/>
                  <a:ext cx="0" cy="138733"/>
                </a:xfrm>
                <a:prstGeom prst="line">
                  <a:avLst/>
                </a:prstGeom>
                <a:noFill/>
                <a:ln w="254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100" name="Straight Connector 99">
                  <a:extLst>
                    <a:ext uri="{FF2B5EF4-FFF2-40B4-BE49-F238E27FC236}">
                      <a16:creationId xmlns:a16="http://schemas.microsoft.com/office/drawing/2014/main" id="{564ECAEB-F4CD-4E40-B8B8-AA87D6CC98E8}"/>
                    </a:ext>
                  </a:extLst>
                </p:cNvPr>
                <p:cNvCxnSpPr/>
                <p:nvPr/>
              </p:nvCxnSpPr>
              <p:spPr>
                <a:xfrm>
                  <a:off x="3199578" y="1405762"/>
                  <a:ext cx="0" cy="114300"/>
                </a:xfrm>
                <a:prstGeom prst="line">
                  <a:avLst/>
                </a:prstGeom>
                <a:noFill/>
                <a:ln w="28575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pic>
              <p:nvPicPr>
                <p:cNvPr id="101" name="Picture 3" descr="C:\Users\Shengjun LU\Desktop\F7_large.jpg">
                  <a:extLst>
                    <a:ext uri="{FF2B5EF4-FFF2-40B4-BE49-F238E27FC236}">
                      <a16:creationId xmlns:a16="http://schemas.microsoft.com/office/drawing/2014/main" id="{13195524-C43A-4A0A-9551-55D4F650EE4E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6238" t="5801" r="50000" b="88397"/>
                <a:stretch/>
              </p:blipFill>
              <p:spPr bwMode="auto">
                <a:xfrm>
                  <a:off x="517951" y="1064184"/>
                  <a:ext cx="579342" cy="403605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02" name="Down Arrow 171">
                  <a:extLst>
                    <a:ext uri="{FF2B5EF4-FFF2-40B4-BE49-F238E27FC236}">
                      <a16:creationId xmlns:a16="http://schemas.microsoft.com/office/drawing/2014/main" id="{A4A6D66B-A506-41BB-A927-4BFD9F7EC695}"/>
                    </a:ext>
                  </a:extLst>
                </p:cNvPr>
                <p:cNvSpPr/>
                <p:nvPr/>
              </p:nvSpPr>
              <p:spPr>
                <a:xfrm>
                  <a:off x="1678164" y="1182419"/>
                  <a:ext cx="45719" cy="132970"/>
                </a:xfrm>
                <a:prstGeom prst="downArrow">
                  <a:avLst/>
                </a:prstGeom>
                <a:ln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3" name="TextBox 102">
                  <a:extLst>
                    <a:ext uri="{FF2B5EF4-FFF2-40B4-BE49-F238E27FC236}">
                      <a16:creationId xmlns:a16="http://schemas.microsoft.com/office/drawing/2014/main" id="{EA788FA1-463A-436D-8D35-9792FAAE7AD3}"/>
                    </a:ext>
                  </a:extLst>
                </p:cNvPr>
                <p:cNvSpPr txBox="1"/>
                <p:nvPr/>
              </p:nvSpPr>
              <p:spPr>
                <a:xfrm>
                  <a:off x="2737333" y="762054"/>
                  <a:ext cx="977372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nd point </a:t>
                  </a:r>
                </a:p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1400mm3)</a:t>
                  </a:r>
                </a:p>
              </p:txBody>
            </p:sp>
            <p:sp>
              <p:nvSpPr>
                <p:cNvPr id="104" name="Down Arrow 174">
                  <a:extLst>
                    <a:ext uri="{FF2B5EF4-FFF2-40B4-BE49-F238E27FC236}">
                      <a16:creationId xmlns:a16="http://schemas.microsoft.com/office/drawing/2014/main" id="{ECFC87C7-90A8-4A41-84C7-9B22715E70F8}"/>
                    </a:ext>
                  </a:extLst>
                </p:cNvPr>
                <p:cNvSpPr/>
                <p:nvPr/>
              </p:nvSpPr>
              <p:spPr>
                <a:xfrm>
                  <a:off x="3154681" y="1182419"/>
                  <a:ext cx="45719" cy="132970"/>
                </a:xfrm>
                <a:prstGeom prst="downArrow">
                  <a:avLst/>
                </a:prstGeom>
                <a:ln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64B5760F-79FA-459A-A3AD-EF0106F2133E}"/>
                  </a:ext>
                </a:extLst>
              </p:cNvPr>
              <p:cNvSpPr txBox="1"/>
              <p:nvPr/>
            </p:nvSpPr>
            <p:spPr>
              <a:xfrm>
                <a:off x="538566" y="7080116"/>
                <a:ext cx="243967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RAMP-C2-sMICB (TC2-sMICB) cells</a:t>
                </a:r>
              </a:p>
            </p:txBody>
          </p:sp>
        </p:grpSp>
        <p:sp>
          <p:nvSpPr>
            <p:cNvPr id="82" name="Rectangle 6">
              <a:extLst>
                <a:ext uri="{FF2B5EF4-FFF2-40B4-BE49-F238E27FC236}">
                  <a16:creationId xmlns:a16="http://schemas.microsoft.com/office/drawing/2014/main" id="{D9263BF8-7C33-4F22-A930-1BE939C756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0462" y="1228224"/>
              <a:ext cx="3168650" cy="2958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800"/>
            </a:p>
          </p:txBody>
        </p:sp>
        <p:sp>
          <p:nvSpPr>
            <p:cNvPr id="83" name="Left Brace 82">
              <a:extLst>
                <a:ext uri="{FF2B5EF4-FFF2-40B4-BE49-F238E27FC236}">
                  <a16:creationId xmlns:a16="http://schemas.microsoft.com/office/drawing/2014/main" id="{EF3FCF22-DCCA-4D6B-8C33-D2DCF2F26524}"/>
                </a:ext>
              </a:extLst>
            </p:cNvPr>
            <p:cNvSpPr/>
            <p:nvPr/>
          </p:nvSpPr>
          <p:spPr>
            <a:xfrm rot="5400000" flipH="1">
              <a:off x="3293421" y="886204"/>
              <a:ext cx="53318" cy="1501727"/>
            </a:xfrm>
            <a:prstGeom prst="leftBrace">
              <a:avLst/>
            </a:prstGeom>
            <a:solidFill>
              <a:schemeClr val="tx1"/>
            </a:solidFill>
            <a:ln w="6350" cap="flat" cmpd="sng" algn="ctr">
              <a:solidFill>
                <a:schemeClr val="tx1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800" b="0" i="0" u="none" strike="noStrike" kern="0" cap="none" spc="0" normalizeH="0" baseline="0" noProof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8102619D-9DAC-474F-BE53-658D20A9066E}"/>
                </a:ext>
              </a:extLst>
            </p:cNvPr>
            <p:cNvSpPr txBox="1"/>
            <p:nvPr/>
          </p:nvSpPr>
          <p:spPr>
            <a:xfrm>
              <a:off x="2623894" y="1687043"/>
              <a:ext cx="16527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herapy,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i.p.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, twice weekly 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4D221A35-F0A0-44C7-A3BA-485D4238E590}"/>
                </a:ext>
              </a:extLst>
            </p:cNvPr>
            <p:cNvSpPr txBox="1"/>
            <p:nvPr/>
          </p:nvSpPr>
          <p:spPr>
            <a:xfrm>
              <a:off x="2155724" y="952588"/>
              <a:ext cx="10706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(50-100 mm3) </a:t>
              </a:r>
            </a:p>
          </p:txBody>
        </p:sp>
        <p:grpSp>
          <p:nvGrpSpPr>
            <p:cNvPr id="86" name="Group 85">
              <a:extLst>
                <a:ext uri="{FF2B5EF4-FFF2-40B4-BE49-F238E27FC236}">
                  <a16:creationId xmlns:a16="http://schemas.microsoft.com/office/drawing/2014/main" id="{5179713C-8D22-4BCB-BA83-5788761F5684}"/>
                </a:ext>
              </a:extLst>
            </p:cNvPr>
            <p:cNvGrpSpPr/>
            <p:nvPr/>
          </p:nvGrpSpPr>
          <p:grpSpPr>
            <a:xfrm rot="2739784">
              <a:off x="1787163" y="837011"/>
              <a:ext cx="127898" cy="379314"/>
              <a:chOff x="5010320" y="600992"/>
              <a:chExt cx="387690" cy="830602"/>
            </a:xfrm>
          </p:grpSpPr>
          <p:sp>
            <p:nvSpPr>
              <p:cNvPr id="87" name="Rounded Rectangle 10">
                <a:extLst>
                  <a:ext uri="{FF2B5EF4-FFF2-40B4-BE49-F238E27FC236}">
                    <a16:creationId xmlns:a16="http://schemas.microsoft.com/office/drawing/2014/main" id="{7BB0A7FC-A0DC-42C9-8144-C8B8D06DB730}"/>
                  </a:ext>
                </a:extLst>
              </p:cNvPr>
              <p:cNvSpPr/>
              <p:nvPr/>
            </p:nvSpPr>
            <p:spPr>
              <a:xfrm>
                <a:off x="5152246" y="724102"/>
                <a:ext cx="138964" cy="558670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cxnSp>
            <p:nvCxnSpPr>
              <p:cNvPr id="88" name="Straight Connector 87">
                <a:extLst>
                  <a:ext uri="{FF2B5EF4-FFF2-40B4-BE49-F238E27FC236}">
                    <a16:creationId xmlns:a16="http://schemas.microsoft.com/office/drawing/2014/main" id="{2F3E13A6-3C4B-4860-B8B1-A2D43D0BBCCF}"/>
                  </a:ext>
                </a:extLst>
              </p:cNvPr>
              <p:cNvCxnSpPr/>
              <p:nvPr/>
            </p:nvCxnSpPr>
            <p:spPr>
              <a:xfrm>
                <a:off x="5150731" y="861717"/>
                <a:ext cx="5740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Straight Connector 88">
                <a:extLst>
                  <a:ext uri="{FF2B5EF4-FFF2-40B4-BE49-F238E27FC236}">
                    <a16:creationId xmlns:a16="http://schemas.microsoft.com/office/drawing/2014/main" id="{DC87E773-71D4-420F-B795-5C19E6E521D9}"/>
                  </a:ext>
                </a:extLst>
              </p:cNvPr>
              <p:cNvCxnSpPr/>
              <p:nvPr/>
            </p:nvCxnSpPr>
            <p:spPr>
              <a:xfrm>
                <a:off x="5146375" y="1014117"/>
                <a:ext cx="5740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Straight Connector 89">
                <a:extLst>
                  <a:ext uri="{FF2B5EF4-FFF2-40B4-BE49-F238E27FC236}">
                    <a16:creationId xmlns:a16="http://schemas.microsoft.com/office/drawing/2014/main" id="{35DEE79A-75AA-4825-8EF3-F90197F7F2E7}"/>
                  </a:ext>
                </a:extLst>
              </p:cNvPr>
              <p:cNvCxnSpPr/>
              <p:nvPr/>
            </p:nvCxnSpPr>
            <p:spPr>
              <a:xfrm>
                <a:off x="5159438" y="1118621"/>
                <a:ext cx="5740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Straight Connector 90">
                <a:extLst>
                  <a:ext uri="{FF2B5EF4-FFF2-40B4-BE49-F238E27FC236}">
                    <a16:creationId xmlns:a16="http://schemas.microsoft.com/office/drawing/2014/main" id="{BDBFBB57-6085-40DB-B532-634F3079B6D9}"/>
                  </a:ext>
                </a:extLst>
              </p:cNvPr>
              <p:cNvCxnSpPr/>
              <p:nvPr/>
            </p:nvCxnSpPr>
            <p:spPr>
              <a:xfrm>
                <a:off x="5094848" y="600992"/>
                <a:ext cx="2306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Straight Connector 91">
                <a:extLst>
                  <a:ext uri="{FF2B5EF4-FFF2-40B4-BE49-F238E27FC236}">
                    <a16:creationId xmlns:a16="http://schemas.microsoft.com/office/drawing/2014/main" id="{44F910A1-65AD-4761-B963-97E8013FE0F1}"/>
                  </a:ext>
                </a:extLst>
              </p:cNvPr>
              <p:cNvCxnSpPr>
                <a:endCxn id="87" idx="0"/>
              </p:cNvCxnSpPr>
              <p:nvPr/>
            </p:nvCxnSpPr>
            <p:spPr>
              <a:xfrm flipH="1">
                <a:off x="5221728" y="600992"/>
                <a:ext cx="11077" cy="12311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Straight Connector 92">
                <a:extLst>
                  <a:ext uri="{FF2B5EF4-FFF2-40B4-BE49-F238E27FC236}">
                    <a16:creationId xmlns:a16="http://schemas.microsoft.com/office/drawing/2014/main" id="{11E2E510-0941-41F4-9B9F-8E81BA320384}"/>
                  </a:ext>
                </a:extLst>
              </p:cNvPr>
              <p:cNvCxnSpPr>
                <a:stCxn id="87" idx="2"/>
              </p:cNvCxnSpPr>
              <p:nvPr/>
            </p:nvCxnSpPr>
            <p:spPr>
              <a:xfrm>
                <a:off x="5221728" y="1282772"/>
                <a:ext cx="5538" cy="14882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Straight Connector 93">
                <a:extLst>
                  <a:ext uri="{FF2B5EF4-FFF2-40B4-BE49-F238E27FC236}">
                    <a16:creationId xmlns:a16="http://schemas.microsoft.com/office/drawing/2014/main" id="{49649746-A274-45C5-8EC3-6B9E35FD29EE}"/>
                  </a:ext>
                </a:extLst>
              </p:cNvPr>
              <p:cNvCxnSpPr/>
              <p:nvPr/>
            </p:nvCxnSpPr>
            <p:spPr>
              <a:xfrm>
                <a:off x="5010320" y="724102"/>
                <a:ext cx="38769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05" name="TextBox 104">
            <a:extLst>
              <a:ext uri="{FF2B5EF4-FFF2-40B4-BE49-F238E27FC236}">
                <a16:creationId xmlns:a16="http://schemas.microsoft.com/office/drawing/2014/main" id="{0FCB1A14-254E-4D4B-A425-3FE5260CBAD5}"/>
              </a:ext>
            </a:extLst>
          </p:cNvPr>
          <p:cNvSpPr txBox="1"/>
          <p:nvPr/>
        </p:nvSpPr>
        <p:spPr>
          <a:xfrm>
            <a:off x="427977" y="457200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0359E672-82E1-4775-A0C3-6E8B7FC2395A}"/>
              </a:ext>
            </a:extLst>
          </p:cNvPr>
          <p:cNvSpPr txBox="1"/>
          <p:nvPr/>
        </p:nvSpPr>
        <p:spPr>
          <a:xfrm>
            <a:off x="2623017" y="123264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6CAB2794-7D66-4343-8DFA-753F8EE4C55E}"/>
              </a:ext>
            </a:extLst>
          </p:cNvPr>
          <p:cNvSpPr txBox="1"/>
          <p:nvPr/>
        </p:nvSpPr>
        <p:spPr>
          <a:xfrm>
            <a:off x="427977" y="7411125"/>
            <a:ext cx="6052822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Cooperative therapy effect of anti-PD1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MIC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argeting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10G5.</a:t>
            </a: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rapeutic Schema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MIC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expressing TRAMP-C2-sMICB mouse prostate tumor cell lines were inoculated into syngeneic MICB-transgenic male mice as we have previously described (Basher et al.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cotarge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016). When tumors reached the volume of approximately 100 mm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size, animals were randomized into four therapeutic groups: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ontrol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gG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i) B10G5, iii) anti-PD1 (</a:t>
            </a:r>
            <a:r>
              <a:rPr lang="en-US" sz="1200" dirty="0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clone RMP1-14, </a:t>
            </a:r>
            <a:r>
              <a:rPr lang="en-US" sz="1200" dirty="0" err="1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Bioxcel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; iv) combination of anti-PD1 and B10G5. All reagents were given at the dose of 4.0 mg/Kg via I.P. twice weekly. Tumor volume 1400 mm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designated as survival end point according to Institutional Approved animal use protocol. Tumor growth  were followed to day 40 of treatment.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1B81ADFC-FF2E-4E91-B5B4-F3E0433CAD1D}"/>
              </a:ext>
            </a:extLst>
          </p:cNvPr>
          <p:cNvSpPr txBox="1"/>
          <p:nvPr/>
        </p:nvSpPr>
        <p:spPr>
          <a:xfrm>
            <a:off x="1744707" y="6859582"/>
            <a:ext cx="22202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   1   3    5   9   11  14 16  18 21  23  25  28 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76EF02A7-AF67-4E6A-8F76-6E648C80EB4E}"/>
              </a:ext>
            </a:extLst>
          </p:cNvPr>
          <p:cNvSpPr txBox="1"/>
          <p:nvPr/>
        </p:nvSpPr>
        <p:spPr>
          <a:xfrm>
            <a:off x="4153810" y="6888108"/>
            <a:ext cx="23235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   1    3    5    9   11  14  16  18  21  23  25  28 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D55C66CD-5DF7-413D-8B8D-FCFA7DBC7018}"/>
              </a:ext>
            </a:extLst>
          </p:cNvPr>
          <p:cNvSpPr txBox="1"/>
          <p:nvPr/>
        </p:nvSpPr>
        <p:spPr>
          <a:xfrm>
            <a:off x="4088827" y="5276169"/>
            <a:ext cx="23235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   1    3    5    9   11  14  16  18  21  23  25  28 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313348F0-F836-4141-9601-4ACB85C4C6A9}"/>
              </a:ext>
            </a:extLst>
          </p:cNvPr>
          <p:cNvSpPr txBox="1"/>
          <p:nvPr/>
        </p:nvSpPr>
        <p:spPr>
          <a:xfrm>
            <a:off x="1741768" y="5291468"/>
            <a:ext cx="22202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   1   3    5   9  11  14 16 18 21  23  25  28 </a:t>
            </a:r>
          </a:p>
        </p:txBody>
      </p:sp>
    </p:spTree>
    <p:extLst>
      <p:ext uri="{BB962C8B-B14F-4D97-AF65-F5344CB8AC3E}">
        <p14:creationId xmlns:p14="http://schemas.microsoft.com/office/powerpoint/2010/main" val="17618496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39">
            <a:extLst>
              <a:ext uri="{FF2B5EF4-FFF2-40B4-BE49-F238E27FC236}">
                <a16:creationId xmlns:a16="http://schemas.microsoft.com/office/drawing/2014/main" id="{CEB15F5C-00C5-46CE-8284-C4C3293B488C}"/>
              </a:ext>
            </a:extLst>
          </p:cNvPr>
          <p:cNvSpPr txBox="1"/>
          <p:nvPr/>
        </p:nvSpPr>
        <p:spPr>
          <a:xfrm>
            <a:off x="569091" y="5974921"/>
            <a:ext cx="57198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ure </a:t>
            </a:r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.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kumimoji="0" lang="en-US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learance of </a:t>
            </a:r>
            <a:r>
              <a:rPr kumimoji="0" lang="en-US" sz="12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MIC</a:t>
            </a:r>
            <a:r>
              <a:rPr kumimoji="0" lang="en-US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does not increase co-stimulatory molecules CD28 or NKG2D on CD4 T cells </a:t>
            </a:r>
            <a:r>
              <a:rPr lang="en-US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kumimoji="0" lang="en-US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 tumor draining lymph node (</a:t>
            </a:r>
            <a:r>
              <a:rPr kumimoji="0" lang="en-US" sz="12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LN</a:t>
            </a:r>
            <a:r>
              <a:rPr kumimoji="0" lang="en-US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.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6EC34373-D637-4E27-971B-466F867D9D19}"/>
              </a:ext>
            </a:extLst>
          </p:cNvPr>
          <p:cNvGrpSpPr/>
          <p:nvPr/>
        </p:nvGrpSpPr>
        <p:grpSpPr>
          <a:xfrm>
            <a:off x="1905000" y="1828800"/>
            <a:ext cx="4114800" cy="3858674"/>
            <a:chOff x="1676400" y="1534059"/>
            <a:chExt cx="2993021" cy="2629415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F51F092-A7F3-46E0-8A61-75D06F740D61}"/>
                </a:ext>
              </a:extLst>
            </p:cNvPr>
            <p:cNvSpPr txBox="1"/>
            <p:nvPr/>
          </p:nvSpPr>
          <p:spPr>
            <a:xfrm>
              <a:off x="3442736" y="3508006"/>
              <a:ext cx="12266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nti-PD-L1+B10G5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9EB7CADA-10F5-4883-85E8-32C0B33D0674}"/>
                </a:ext>
              </a:extLst>
            </p:cNvPr>
            <p:cNvSpPr txBox="1"/>
            <p:nvPr/>
          </p:nvSpPr>
          <p:spPr>
            <a:xfrm>
              <a:off x="3400472" y="2292945"/>
              <a:ext cx="9664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nti-PD-L1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2C81DEED-DC62-4448-BAF1-14279062F7B8}"/>
                </a:ext>
              </a:extLst>
            </p:cNvPr>
            <p:cNvSpPr txBox="1"/>
            <p:nvPr/>
          </p:nvSpPr>
          <p:spPr>
            <a:xfrm>
              <a:off x="3400472" y="2941968"/>
              <a:ext cx="85411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10G5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886B0F1-5E51-40EB-BCA9-B47DE3D8F644}"/>
                </a:ext>
              </a:extLst>
            </p:cNvPr>
            <p:cNvSpPr txBox="1"/>
            <p:nvPr/>
          </p:nvSpPr>
          <p:spPr>
            <a:xfrm>
              <a:off x="3379245" y="1704474"/>
              <a:ext cx="4482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IgG</a:t>
              </a:r>
              <a:endPara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D1C5A5A3-9788-4647-9962-98DDEC6D8426}"/>
                </a:ext>
              </a:extLst>
            </p:cNvPr>
            <p:cNvGrpSpPr/>
            <p:nvPr/>
          </p:nvGrpSpPr>
          <p:grpSpPr>
            <a:xfrm>
              <a:off x="1676400" y="1534059"/>
              <a:ext cx="1758777" cy="2629415"/>
              <a:chOff x="1676400" y="1534059"/>
              <a:chExt cx="1758777" cy="2629415"/>
            </a:xfrm>
          </p:grpSpPr>
          <p:grpSp>
            <p:nvGrpSpPr>
              <p:cNvPr id="96" name="Group 95">
                <a:extLst>
                  <a:ext uri="{FF2B5EF4-FFF2-40B4-BE49-F238E27FC236}">
                    <a16:creationId xmlns:a16="http://schemas.microsoft.com/office/drawing/2014/main" id="{F37F2666-54A5-4F59-9F1F-5D6D5C17E1E8}"/>
                  </a:ext>
                </a:extLst>
              </p:cNvPr>
              <p:cNvGrpSpPr/>
              <p:nvPr/>
            </p:nvGrpSpPr>
            <p:grpSpPr>
              <a:xfrm>
                <a:off x="1676400" y="1534059"/>
                <a:ext cx="868569" cy="2372418"/>
                <a:chOff x="722734" y="1926302"/>
                <a:chExt cx="868569" cy="2364379"/>
              </a:xfrm>
            </p:grpSpPr>
            <p:pic>
              <p:nvPicPr>
                <p:cNvPr id="44" name="Picture 43">
                  <a:extLst>
                    <a:ext uri="{FF2B5EF4-FFF2-40B4-BE49-F238E27FC236}">
                      <a16:creationId xmlns:a16="http://schemas.microsoft.com/office/drawing/2014/main" id="{751E2AE9-BB7E-4530-8412-700D729D0D6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722734" y="3744040"/>
                  <a:ext cx="786629" cy="546641"/>
                </a:xfrm>
                <a:prstGeom prst="rect">
                  <a:avLst/>
                </a:prstGeom>
              </p:spPr>
            </p:pic>
            <p:pic>
              <p:nvPicPr>
                <p:cNvPr id="45" name="Picture 44">
                  <a:extLst>
                    <a:ext uri="{FF2B5EF4-FFF2-40B4-BE49-F238E27FC236}">
                      <a16:creationId xmlns:a16="http://schemas.microsoft.com/office/drawing/2014/main" id="{CC48072C-2122-48B2-A2F4-773B33EF278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724765" y="3148833"/>
                  <a:ext cx="789607" cy="546395"/>
                </a:xfrm>
                <a:prstGeom prst="rect">
                  <a:avLst/>
                </a:prstGeom>
              </p:spPr>
            </p:pic>
            <p:pic>
              <p:nvPicPr>
                <p:cNvPr id="25" name="Picture 24">
                  <a:extLst>
                    <a:ext uri="{FF2B5EF4-FFF2-40B4-BE49-F238E27FC236}">
                      <a16:creationId xmlns:a16="http://schemas.microsoft.com/office/drawing/2014/main" id="{CC8B0F5F-4936-4A66-A359-EDB87352A24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733008" y="2536387"/>
                  <a:ext cx="762402" cy="550789"/>
                </a:xfrm>
                <a:prstGeom prst="rect">
                  <a:avLst/>
                </a:prstGeom>
              </p:spPr>
            </p:pic>
            <p:sp>
              <p:nvSpPr>
                <p:cNvPr id="51" name="TextBox 50">
                  <a:extLst>
                    <a:ext uri="{FF2B5EF4-FFF2-40B4-BE49-F238E27FC236}">
                      <a16:creationId xmlns:a16="http://schemas.microsoft.com/office/drawing/2014/main" id="{C72A6066-D801-4255-B16E-36BC73507B53}"/>
                    </a:ext>
                  </a:extLst>
                </p:cNvPr>
                <p:cNvSpPr txBox="1"/>
                <p:nvPr/>
              </p:nvSpPr>
              <p:spPr>
                <a:xfrm>
                  <a:off x="1166526" y="3776916"/>
                  <a:ext cx="359044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MFI </a:t>
                  </a:r>
                </a:p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395</a:t>
                  </a:r>
                </a:p>
              </p:txBody>
            </p:sp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id="{3A22A07D-EEC0-423C-91E2-794606CECE7F}"/>
                    </a:ext>
                  </a:extLst>
                </p:cNvPr>
                <p:cNvSpPr txBox="1"/>
                <p:nvPr/>
              </p:nvSpPr>
              <p:spPr>
                <a:xfrm>
                  <a:off x="1131083" y="3147037"/>
                  <a:ext cx="405636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MFI </a:t>
                  </a:r>
                </a:p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411</a:t>
                  </a:r>
                </a:p>
              </p:txBody>
            </p:sp>
            <p:sp>
              <p:nvSpPr>
                <p:cNvPr id="54" name="TextBox 53">
                  <a:extLst>
                    <a:ext uri="{FF2B5EF4-FFF2-40B4-BE49-F238E27FC236}">
                      <a16:creationId xmlns:a16="http://schemas.microsoft.com/office/drawing/2014/main" id="{1CDBBE44-F003-497F-B7D6-77B71403090D}"/>
                    </a:ext>
                  </a:extLst>
                </p:cNvPr>
                <p:cNvSpPr txBox="1"/>
                <p:nvPr/>
              </p:nvSpPr>
              <p:spPr>
                <a:xfrm>
                  <a:off x="1114209" y="2623410"/>
                  <a:ext cx="477094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MFI </a:t>
                  </a:r>
                </a:p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396</a:t>
                  </a:r>
                </a:p>
              </p:txBody>
            </p:sp>
            <p:pic>
              <p:nvPicPr>
                <p:cNvPr id="10" name="Picture 9">
                  <a:extLst>
                    <a:ext uri="{FF2B5EF4-FFF2-40B4-BE49-F238E27FC236}">
                      <a16:creationId xmlns:a16="http://schemas.microsoft.com/office/drawing/2014/main" id="{C2043116-718B-4391-899D-37175843F3D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764343" y="1926302"/>
                  <a:ext cx="745020" cy="550789"/>
                </a:xfrm>
                <a:prstGeom prst="rect">
                  <a:avLst/>
                </a:prstGeom>
              </p:spPr>
            </p:pic>
            <p:sp>
              <p:nvSpPr>
                <p:cNvPr id="86" name="TextBox 85">
                  <a:extLst>
                    <a:ext uri="{FF2B5EF4-FFF2-40B4-BE49-F238E27FC236}">
                      <a16:creationId xmlns:a16="http://schemas.microsoft.com/office/drawing/2014/main" id="{9FDE6A57-9E14-4E19-BBB1-9021CABD1D6B}"/>
                    </a:ext>
                  </a:extLst>
                </p:cNvPr>
                <p:cNvSpPr txBox="1"/>
                <p:nvPr/>
              </p:nvSpPr>
              <p:spPr>
                <a:xfrm>
                  <a:off x="1144637" y="1992220"/>
                  <a:ext cx="364726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MFI </a:t>
                  </a:r>
                </a:p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337</a:t>
                  </a:r>
                </a:p>
              </p:txBody>
            </p:sp>
          </p:grpSp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6A0D4E80-63D2-4548-92C4-69650A2117E7}"/>
                  </a:ext>
                </a:extLst>
              </p:cNvPr>
              <p:cNvSpPr txBox="1"/>
              <p:nvPr/>
            </p:nvSpPr>
            <p:spPr>
              <a:xfrm>
                <a:off x="1874523" y="3941400"/>
                <a:ext cx="4475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D28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DDBE33E4-0FF1-4057-8090-41D8D9E36CA3}"/>
                  </a:ext>
                </a:extLst>
              </p:cNvPr>
              <p:cNvSpPr txBox="1"/>
              <p:nvPr/>
            </p:nvSpPr>
            <p:spPr>
              <a:xfrm>
                <a:off x="2840315" y="3948030"/>
                <a:ext cx="53893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KG2D</a:t>
                </a:r>
              </a:p>
            </p:txBody>
          </p:sp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268FB5EE-273A-4B45-B57D-823BBACCBA9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2742199" y="2170055"/>
                <a:ext cx="657491" cy="533512"/>
              </a:xfrm>
              <a:prstGeom prst="rect">
                <a:avLst/>
              </a:prstGeom>
            </p:spPr>
          </p:pic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7E3953BF-17D8-4539-BA47-F7F72BCC22F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2754737" y="1548654"/>
                <a:ext cx="669446" cy="527085"/>
              </a:xfrm>
              <a:prstGeom prst="rect">
                <a:avLst/>
              </a:prstGeom>
            </p:spPr>
          </p:pic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85FC1830-19D0-4979-BA8A-4C789845548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2750752" y="2770769"/>
                <a:ext cx="673431" cy="536727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AF985785-CC8A-4CA4-A2E6-6237641605E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2742614" y="3369749"/>
                <a:ext cx="692563" cy="536727"/>
              </a:xfrm>
              <a:prstGeom prst="rect">
                <a:avLst/>
              </a:prstGeom>
            </p:spPr>
          </p:pic>
        </p:grpSp>
      </p:grpSp>
      <p:sp>
        <p:nvSpPr>
          <p:cNvPr id="8" name="Rectangle 7">
            <a:extLst>
              <a:ext uri="{FF2B5EF4-FFF2-40B4-BE49-F238E27FC236}">
                <a16:creationId xmlns:a16="http://schemas.microsoft.com/office/drawing/2014/main" id="{22E7479F-A5C2-4561-8755-5316169A1AD4}"/>
              </a:ext>
            </a:extLst>
          </p:cNvPr>
          <p:cNvSpPr/>
          <p:nvPr/>
        </p:nvSpPr>
        <p:spPr>
          <a:xfrm>
            <a:off x="2745231" y="719094"/>
            <a:ext cx="12362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516389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4E58303E-92E1-462D-B4CE-4EBE5C49B649}"/>
              </a:ext>
            </a:extLst>
          </p:cNvPr>
          <p:cNvSpPr txBox="1"/>
          <p:nvPr/>
        </p:nvSpPr>
        <p:spPr>
          <a:xfrm rot="16200000">
            <a:off x="1533419" y="1585338"/>
            <a:ext cx="5212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D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450</a:t>
            </a:r>
          </a:p>
        </p:txBody>
      </p:sp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DE4C83C2-AAF0-46E3-A994-4FB28757440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28968832"/>
              </p:ext>
            </p:extLst>
          </p:nvPr>
        </p:nvGraphicFramePr>
        <p:xfrm>
          <a:off x="2047401" y="914400"/>
          <a:ext cx="2448399" cy="1752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22D53073-D2CC-4FF2-AE10-7C7FBE7A99C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546406"/>
              </p:ext>
            </p:extLst>
          </p:nvPr>
        </p:nvGraphicFramePr>
        <p:xfrm>
          <a:off x="2047401" y="3505200"/>
          <a:ext cx="2781363" cy="1752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558165DF-E7CD-4107-9E61-3FB8201D9D64}"/>
              </a:ext>
            </a:extLst>
          </p:cNvPr>
          <p:cNvSpPr txBox="1"/>
          <p:nvPr/>
        </p:nvSpPr>
        <p:spPr>
          <a:xfrm rot="16200000">
            <a:off x="1533419" y="4188241"/>
            <a:ext cx="5212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D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45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745FAF8-CF41-4127-9C98-FB40D17F262F}"/>
              </a:ext>
            </a:extLst>
          </p:cNvPr>
          <p:cNvSpPr txBox="1"/>
          <p:nvPr/>
        </p:nvSpPr>
        <p:spPr>
          <a:xfrm>
            <a:off x="2930571" y="5410200"/>
            <a:ext cx="10150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10G5 (ng/ml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202C0BE-ED5C-4E0D-9ABF-256A8411FE3E}"/>
              </a:ext>
            </a:extLst>
          </p:cNvPr>
          <p:cNvSpPr txBox="1"/>
          <p:nvPr/>
        </p:nvSpPr>
        <p:spPr>
          <a:xfrm>
            <a:off x="2921489" y="2667000"/>
            <a:ext cx="10150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10G5 (ng/ml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FB9311B-3F8C-4E20-BF8C-0D0BC7D46C7F}"/>
              </a:ext>
            </a:extLst>
          </p:cNvPr>
          <p:cNvSpPr txBox="1"/>
          <p:nvPr/>
        </p:nvSpPr>
        <p:spPr>
          <a:xfrm>
            <a:off x="1143000" y="6096000"/>
            <a:ext cx="4859461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igure S5. Detection of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MI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A and B) binds to NKG2D and B10G5 simultaneously. Recombinant soluble NKG2D-His tagged (2 ug/ml) was immobilized to the 96-well plate overnight at 4C. 50 ul of recombinant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MICB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His tagged, Sino Biologicals, 2 ug/ml) or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MIC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R&amp;D) 2ug/ml) was mixed with various amount of B10G5 as indicated on the X-axis for 30 min at RT and them added to the plate that has been washed three times. After 1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incubation followed by four washes, binding to NKG2D of the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mi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/B10G5 complex was detected by HRP-conjugated goat anti-mouse IgG. 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BA266E33-3ED8-4533-8CCA-9059432D22A4}"/>
              </a:ext>
            </a:extLst>
          </p:cNvPr>
          <p:cNvSpPr/>
          <p:nvPr/>
        </p:nvSpPr>
        <p:spPr>
          <a:xfrm>
            <a:off x="2772409" y="249079"/>
            <a:ext cx="13003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5 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7020336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1" name="Group 70">
            <a:extLst>
              <a:ext uri="{FF2B5EF4-FFF2-40B4-BE49-F238E27FC236}">
                <a16:creationId xmlns:a16="http://schemas.microsoft.com/office/drawing/2014/main" id="{225B94CE-12B5-4D45-865B-6280EF3C14B8}"/>
              </a:ext>
            </a:extLst>
          </p:cNvPr>
          <p:cNvGrpSpPr/>
          <p:nvPr/>
        </p:nvGrpSpPr>
        <p:grpSpPr>
          <a:xfrm>
            <a:off x="3810000" y="1143000"/>
            <a:ext cx="724820" cy="4014082"/>
            <a:chOff x="3892191" y="557918"/>
            <a:chExt cx="724820" cy="4014082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F7D07DF-7BC3-4992-A613-922B7EEFEBEF}"/>
                </a:ext>
              </a:extLst>
            </p:cNvPr>
            <p:cNvSpPr txBox="1"/>
            <p:nvPr/>
          </p:nvSpPr>
          <p:spPr>
            <a:xfrm>
              <a:off x="3903683" y="4374745"/>
              <a:ext cx="713328" cy="1972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D107a</a:t>
              </a:r>
            </a:p>
          </p:txBody>
        </p:sp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56E5ED36-CDDB-4F8A-9492-29CD95E68DF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7" t="67165" r="3222" b="17113"/>
            <a:stretch/>
          </p:blipFill>
          <p:spPr>
            <a:xfrm>
              <a:off x="3892191" y="1090278"/>
              <a:ext cx="599637" cy="557838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83758095-E7BA-4F20-8FE0-1F91B3F0097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7" t="83755" r="3222" b="721"/>
            <a:stretch/>
          </p:blipFill>
          <p:spPr>
            <a:xfrm>
              <a:off x="3937706" y="2747995"/>
              <a:ext cx="592713" cy="544487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6B9A82A7-D493-4CB9-8115-03BBF59A2C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7" t="541" r="3222" b="85017"/>
            <a:stretch/>
          </p:blipFill>
          <p:spPr>
            <a:xfrm>
              <a:off x="3946716" y="2243354"/>
              <a:ext cx="583082" cy="498282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7F86E49A-35BE-4CF9-9B5D-F21DEFE1669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7" t="50419" r="2334" b="33294"/>
            <a:stretch/>
          </p:blipFill>
          <p:spPr>
            <a:xfrm>
              <a:off x="3926169" y="1637043"/>
              <a:ext cx="605350" cy="577891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068C4797-29F2-4FF3-9811-3BF172E9E3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7" t="541" r="3222" b="85010"/>
            <a:stretch/>
          </p:blipFill>
          <p:spPr>
            <a:xfrm>
              <a:off x="3902370" y="557918"/>
              <a:ext cx="599637" cy="512697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3DE13212-0523-424F-B26D-7E1C0C37676B}"/>
                </a:ext>
              </a:extLst>
            </p:cNvPr>
            <p:cNvSpPr txBox="1"/>
            <p:nvPr/>
          </p:nvSpPr>
          <p:spPr>
            <a:xfrm>
              <a:off x="4080173" y="1255206"/>
              <a:ext cx="440979" cy="1972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4.42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FF6265F0-C674-4FD7-9B2D-5851D69263B2}"/>
                </a:ext>
              </a:extLst>
            </p:cNvPr>
            <p:cNvSpPr txBox="1"/>
            <p:nvPr/>
          </p:nvSpPr>
          <p:spPr>
            <a:xfrm>
              <a:off x="4135814" y="1751350"/>
              <a:ext cx="359765" cy="197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.39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DFCACE6A-6CC7-4584-BE1B-F9D8C988721C}"/>
                </a:ext>
              </a:extLst>
            </p:cNvPr>
            <p:cNvSpPr txBox="1"/>
            <p:nvPr/>
          </p:nvSpPr>
          <p:spPr>
            <a:xfrm>
              <a:off x="4147761" y="2353788"/>
              <a:ext cx="359765" cy="197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32</a:t>
              </a:r>
            </a:p>
          </p:txBody>
        </p:sp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1C037F04-45EA-4F25-A7FC-59845B89BCC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6" t="83688" r="1611" b="720"/>
            <a:stretch/>
          </p:blipFill>
          <p:spPr>
            <a:xfrm>
              <a:off x="3946490" y="3815671"/>
              <a:ext cx="610004" cy="553199"/>
            </a:xfrm>
            <a:prstGeom prst="rect">
              <a:avLst/>
            </a:prstGeom>
          </p:spPr>
        </p:pic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910E4D78-97A7-4563-8A80-B22CC592AC80}"/>
                </a:ext>
              </a:extLst>
            </p:cNvPr>
            <p:cNvSpPr txBox="1"/>
            <p:nvPr/>
          </p:nvSpPr>
          <p:spPr>
            <a:xfrm>
              <a:off x="4151652" y="4007656"/>
              <a:ext cx="375195" cy="1972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4.7</a:t>
              </a:r>
            </a:p>
          </p:txBody>
        </p:sp>
        <p:pic>
          <p:nvPicPr>
            <p:cNvPr id="56" name="Picture 55">
              <a:extLst>
                <a:ext uri="{FF2B5EF4-FFF2-40B4-BE49-F238E27FC236}">
                  <a16:creationId xmlns:a16="http://schemas.microsoft.com/office/drawing/2014/main" id="{2911412F-1F94-4BD5-861C-20B982B231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7" t="16754" r="935" b="66678"/>
            <a:stretch/>
          </p:blipFill>
          <p:spPr>
            <a:xfrm>
              <a:off x="3939297" y="3282975"/>
              <a:ext cx="614353" cy="587859"/>
            </a:xfrm>
            <a:prstGeom prst="rect">
              <a:avLst/>
            </a:prstGeom>
          </p:spPr>
        </p:pic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E9628242-6C1A-41D1-85E3-0C9F1365685A}"/>
                </a:ext>
              </a:extLst>
            </p:cNvPr>
            <p:cNvSpPr txBox="1"/>
            <p:nvPr/>
          </p:nvSpPr>
          <p:spPr>
            <a:xfrm>
              <a:off x="4157945" y="3448438"/>
              <a:ext cx="359765" cy="197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2.73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CD8FFC3B-F9D3-4964-8350-48170EA92E87}"/>
                </a:ext>
              </a:extLst>
            </p:cNvPr>
            <p:cNvSpPr txBox="1"/>
            <p:nvPr/>
          </p:nvSpPr>
          <p:spPr>
            <a:xfrm>
              <a:off x="4156340" y="2907521"/>
              <a:ext cx="375195" cy="1972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4.9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46607CB8-F70E-46C5-9593-DF2F7627BCB0}"/>
                </a:ext>
              </a:extLst>
            </p:cNvPr>
            <p:cNvSpPr txBox="1"/>
            <p:nvPr/>
          </p:nvSpPr>
          <p:spPr>
            <a:xfrm>
              <a:off x="4096208" y="725005"/>
              <a:ext cx="440979" cy="1972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29</a:t>
              </a:r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569BF9FD-FB51-4BDB-869B-57794433CBF4}"/>
              </a:ext>
            </a:extLst>
          </p:cNvPr>
          <p:cNvSpPr txBox="1"/>
          <p:nvPr/>
        </p:nvSpPr>
        <p:spPr>
          <a:xfrm>
            <a:off x="2517353" y="4916920"/>
            <a:ext cx="585536" cy="1972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IFN</a:t>
            </a:r>
            <a:r>
              <a:rPr kumimoji="0" lang="en-US" sz="800" b="1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ymbol" panose="05050102010706020507" pitchFamily="18" charset="2"/>
                <a:cs typeface="Arial" panose="020B0604020202020204" pitchFamily="34" charset="0"/>
              </a:rPr>
              <a:t>g</a:t>
            </a:r>
            <a:endParaRPr kumimoji="0" lang="en-US" sz="8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4848569A-FD76-4557-B558-9C4A7A4B3790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120" t="84390" r="-603"/>
          <a:stretch/>
        </p:blipFill>
        <p:spPr>
          <a:xfrm>
            <a:off x="2402393" y="3315674"/>
            <a:ext cx="674857" cy="550847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1C0E7917-8475-4537-8D3C-0D8D7E509BC1}"/>
              </a:ext>
            </a:extLst>
          </p:cNvPr>
          <p:cNvPicPr>
            <a:picLocks noChangeAspect="1"/>
          </p:cNvPicPr>
          <p:nvPr/>
        </p:nvPicPr>
        <p:blipFill rotWithShape="1"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119" t="721" r="2203" b="84758"/>
          <a:stretch/>
        </p:blipFill>
        <p:spPr>
          <a:xfrm>
            <a:off x="2421142" y="2796886"/>
            <a:ext cx="637358" cy="512429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1286B972-A33D-4355-A4EC-43AC58E20CA2}"/>
              </a:ext>
            </a:extLst>
          </p:cNvPr>
          <p:cNvPicPr>
            <a:picLocks noChangeAspect="1"/>
          </p:cNvPicPr>
          <p:nvPr/>
        </p:nvPicPr>
        <p:blipFill rotWithShape="1"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119" t="721" r="2203" b="84758"/>
          <a:stretch/>
        </p:blipFill>
        <p:spPr>
          <a:xfrm>
            <a:off x="2421952" y="1120891"/>
            <a:ext cx="637358" cy="512429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ED273DF9-AC96-416A-A83A-3C6916C2502D}"/>
              </a:ext>
            </a:extLst>
          </p:cNvPr>
          <p:cNvPicPr>
            <a:picLocks noChangeAspect="1"/>
          </p:cNvPicPr>
          <p:nvPr/>
        </p:nvPicPr>
        <p:blipFill rotWithShape="1"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119" t="67329" r="-471" b="16335"/>
          <a:stretch/>
        </p:blipFill>
        <p:spPr>
          <a:xfrm>
            <a:off x="2399798" y="1654889"/>
            <a:ext cx="673099" cy="576458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94923377-108F-44A3-8DDB-BA5ADF3FEF7F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119" t="50361" r="-185" b="34077"/>
          <a:stretch/>
        </p:blipFill>
        <p:spPr>
          <a:xfrm>
            <a:off x="2396619" y="2225027"/>
            <a:ext cx="669280" cy="549165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A928A65C-3781-42FB-AB1F-661710E9E769}"/>
              </a:ext>
            </a:extLst>
          </p:cNvPr>
          <p:cNvSpPr txBox="1"/>
          <p:nvPr/>
        </p:nvSpPr>
        <p:spPr>
          <a:xfrm>
            <a:off x="2637824" y="1416730"/>
            <a:ext cx="359765" cy="197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9.7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DC7A391-1F83-4440-8B3A-66A81878B535}"/>
              </a:ext>
            </a:extLst>
          </p:cNvPr>
          <p:cNvSpPr txBox="1"/>
          <p:nvPr/>
        </p:nvSpPr>
        <p:spPr>
          <a:xfrm>
            <a:off x="2645222" y="1924431"/>
            <a:ext cx="359765" cy="197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22.9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4287B42-C4A7-4C00-8FBC-3DDA9F6AB995}"/>
              </a:ext>
            </a:extLst>
          </p:cNvPr>
          <p:cNvSpPr txBox="1"/>
          <p:nvPr/>
        </p:nvSpPr>
        <p:spPr>
          <a:xfrm>
            <a:off x="2626276" y="3045614"/>
            <a:ext cx="359765" cy="197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11.2</a:t>
            </a: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E22A4B24-03FB-4BE5-B6AC-90AAADC44CA5}"/>
              </a:ext>
            </a:extLst>
          </p:cNvPr>
          <p:cNvPicPr>
            <a:picLocks noChangeAspect="1"/>
          </p:cNvPicPr>
          <p:nvPr/>
        </p:nvPicPr>
        <p:blipFill rotWithShape="1"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119" t="67059" r="2203" b="16910"/>
          <a:stretch/>
        </p:blipFill>
        <p:spPr>
          <a:xfrm>
            <a:off x="2412938" y="4390632"/>
            <a:ext cx="637358" cy="565724"/>
          </a:xfrm>
          <a:prstGeom prst="rect">
            <a:avLst/>
          </a:prstGeom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id="{22FDB70A-F9A2-4F2E-83E5-5A2EAE2BC568}"/>
              </a:ext>
            </a:extLst>
          </p:cNvPr>
          <p:cNvSpPr txBox="1"/>
          <p:nvPr/>
        </p:nvSpPr>
        <p:spPr>
          <a:xfrm>
            <a:off x="2670197" y="4669002"/>
            <a:ext cx="359765" cy="197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23.9</a:t>
            </a:r>
          </a:p>
        </p:txBody>
      </p:sp>
      <p:grpSp>
        <p:nvGrpSpPr>
          <p:cNvPr id="73" name="Group 72">
            <a:extLst>
              <a:ext uri="{FF2B5EF4-FFF2-40B4-BE49-F238E27FC236}">
                <a16:creationId xmlns:a16="http://schemas.microsoft.com/office/drawing/2014/main" id="{8D8A9DD8-2B43-4F93-AD25-95B17C3BE814}"/>
              </a:ext>
            </a:extLst>
          </p:cNvPr>
          <p:cNvGrpSpPr/>
          <p:nvPr/>
        </p:nvGrpSpPr>
        <p:grpSpPr>
          <a:xfrm>
            <a:off x="1024153" y="1197652"/>
            <a:ext cx="1210425" cy="3605497"/>
            <a:chOff x="928578" y="741215"/>
            <a:chExt cx="1210425" cy="3605497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2AF40438-BE7C-45B2-822C-D382F7ACD581}"/>
                </a:ext>
              </a:extLst>
            </p:cNvPr>
            <p:cNvSpPr txBox="1"/>
            <p:nvPr/>
          </p:nvSpPr>
          <p:spPr>
            <a:xfrm>
              <a:off x="928578" y="741215"/>
              <a:ext cx="121042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OVA peptide (control) +sMIC+B10G5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D5D7243-8B93-4D5A-9251-CF36C784C6AB}"/>
                </a:ext>
              </a:extLst>
            </p:cNvPr>
            <p:cNvSpPr txBox="1"/>
            <p:nvPr/>
          </p:nvSpPr>
          <p:spPr>
            <a:xfrm>
              <a:off x="1158406" y="2444391"/>
              <a:ext cx="9765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800" b="1" kern="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0" lang="en-US" sz="800" b="1" i="0" u="none" strike="noStrike" kern="0" cap="none" spc="0" normalizeH="0" baseline="0" noProof="0" dirty="0" err="1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MICA</a:t>
              </a: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+ B10G5 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41A70BB9-7B6B-40D7-8959-4EA0C14F91E5}"/>
                </a:ext>
              </a:extLst>
            </p:cNvPr>
            <p:cNvSpPr txBox="1"/>
            <p:nvPr/>
          </p:nvSpPr>
          <p:spPr>
            <a:xfrm>
              <a:off x="1122703" y="2864868"/>
              <a:ext cx="101261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YR peptide </a:t>
              </a:r>
            </a:p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+ sMICA+B10G5 </a:t>
              </a:r>
            </a:p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NKG2D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CC8E507F-4CC8-4B34-B746-D0E1F7A79F91}"/>
                </a:ext>
              </a:extLst>
            </p:cNvPr>
            <p:cNvSpPr txBox="1"/>
            <p:nvPr/>
          </p:nvSpPr>
          <p:spPr>
            <a:xfrm>
              <a:off x="1232341" y="1375435"/>
              <a:ext cx="8715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TYR peptide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E9EF1BD0-0047-4C6C-83B8-1DC54102FC51}"/>
                </a:ext>
              </a:extLst>
            </p:cNvPr>
            <p:cNvSpPr txBox="1"/>
            <p:nvPr/>
          </p:nvSpPr>
          <p:spPr>
            <a:xfrm>
              <a:off x="1030661" y="1931099"/>
              <a:ext cx="108476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RY peptide </a:t>
              </a:r>
            </a:p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kumimoji="0" lang="en-US" sz="800" b="1" i="0" u="none" strike="noStrike" kern="0" cap="none" spc="0" normalizeH="0" baseline="0" noProof="0" dirty="0" err="1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MICA</a:t>
              </a: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+ B10G5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CF8E6C9F-C021-4594-9ACE-F0778CE768D3}"/>
                </a:ext>
              </a:extLst>
            </p:cNvPr>
            <p:cNvSpPr txBox="1"/>
            <p:nvPr/>
          </p:nvSpPr>
          <p:spPr>
            <a:xfrm>
              <a:off x="1025448" y="4008158"/>
              <a:ext cx="108476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YR peptide </a:t>
              </a:r>
            </a:p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+ B10G5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0700556F-C64A-4B5B-93A1-A5EB6228E22E}"/>
                </a:ext>
              </a:extLst>
            </p:cNvPr>
            <p:cNvSpPr txBox="1"/>
            <p:nvPr/>
          </p:nvSpPr>
          <p:spPr>
            <a:xfrm>
              <a:off x="1328548" y="3531280"/>
              <a:ext cx="8071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TYR peptide </a:t>
              </a:r>
            </a:p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kumimoji="0" lang="en-US" sz="8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MICA</a:t>
              </a:r>
              <a:endPara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58" name="Picture 57">
            <a:extLst>
              <a:ext uri="{FF2B5EF4-FFF2-40B4-BE49-F238E27FC236}">
                <a16:creationId xmlns:a16="http://schemas.microsoft.com/office/drawing/2014/main" id="{E6072666-A598-49B9-AE75-4C6F671D0043}"/>
              </a:ext>
            </a:extLst>
          </p:cNvPr>
          <p:cNvPicPr>
            <a:picLocks noChangeAspect="1"/>
          </p:cNvPicPr>
          <p:nvPr/>
        </p:nvPicPr>
        <p:blipFill rotWithShape="1"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119" t="17014" r="2203" b="67493"/>
          <a:stretch/>
        </p:blipFill>
        <p:spPr>
          <a:xfrm>
            <a:off x="2426212" y="3875931"/>
            <a:ext cx="637358" cy="546748"/>
          </a:xfrm>
          <a:prstGeom prst="rect">
            <a:avLst/>
          </a:prstGeom>
        </p:spPr>
      </p:pic>
      <p:sp>
        <p:nvSpPr>
          <p:cNvPr id="59" name="TextBox 58">
            <a:extLst>
              <a:ext uri="{FF2B5EF4-FFF2-40B4-BE49-F238E27FC236}">
                <a16:creationId xmlns:a16="http://schemas.microsoft.com/office/drawing/2014/main" id="{86B7BE56-DF6F-4834-A5FA-98E81E71490B}"/>
              </a:ext>
            </a:extLst>
          </p:cNvPr>
          <p:cNvSpPr txBox="1"/>
          <p:nvPr/>
        </p:nvSpPr>
        <p:spPr>
          <a:xfrm>
            <a:off x="2683471" y="4144503"/>
            <a:ext cx="359765" cy="197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14.9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5BD89023-F9F4-4410-AB4E-BFC51FEEED7C}"/>
              </a:ext>
            </a:extLst>
          </p:cNvPr>
          <p:cNvSpPr txBox="1"/>
          <p:nvPr/>
        </p:nvSpPr>
        <p:spPr>
          <a:xfrm>
            <a:off x="2643895" y="3585212"/>
            <a:ext cx="359765" cy="197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24.4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414A4715-D925-435E-93E4-AA1F20FDB8ED}"/>
              </a:ext>
            </a:extLst>
          </p:cNvPr>
          <p:cNvSpPr txBox="1"/>
          <p:nvPr/>
        </p:nvSpPr>
        <p:spPr>
          <a:xfrm>
            <a:off x="2637740" y="2486999"/>
            <a:ext cx="359765" cy="197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35.1</a:t>
            </a:r>
          </a:p>
        </p:txBody>
      </p:sp>
      <p:grpSp>
        <p:nvGrpSpPr>
          <p:cNvPr id="72" name="Group 71">
            <a:extLst>
              <a:ext uri="{FF2B5EF4-FFF2-40B4-BE49-F238E27FC236}">
                <a16:creationId xmlns:a16="http://schemas.microsoft.com/office/drawing/2014/main" id="{5F40DF42-828F-4423-9F2A-5C47EEC13181}"/>
              </a:ext>
            </a:extLst>
          </p:cNvPr>
          <p:cNvGrpSpPr/>
          <p:nvPr/>
        </p:nvGrpSpPr>
        <p:grpSpPr>
          <a:xfrm>
            <a:off x="3170314" y="1143000"/>
            <a:ext cx="636275" cy="4002481"/>
            <a:chOff x="3273450" y="565854"/>
            <a:chExt cx="636275" cy="4002481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DCED41D-1D5E-48EF-83F5-96E628C1C435}"/>
                </a:ext>
              </a:extLst>
            </p:cNvPr>
            <p:cNvSpPr txBox="1"/>
            <p:nvPr/>
          </p:nvSpPr>
          <p:spPr>
            <a:xfrm>
              <a:off x="3319820" y="4371080"/>
              <a:ext cx="589905" cy="1972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NF</a:t>
              </a:r>
              <a:r>
                <a:rPr kumimoji="0" lang="en-US" sz="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endPara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ED6D7309-8763-4D9B-A779-07E5B6E14C7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 cstate="print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482" t="50875" r="1762" b="33728"/>
            <a:stretch/>
          </p:blipFill>
          <p:spPr>
            <a:xfrm>
              <a:off x="3274130" y="1666729"/>
              <a:ext cx="565851" cy="547332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A59EB82C-2B0E-41FF-8EC6-D54B4AD3B6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 cstate="print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482" t="721" r="1762" b="84863"/>
            <a:stretch/>
          </p:blipFill>
          <p:spPr>
            <a:xfrm>
              <a:off x="3294429" y="2241368"/>
              <a:ext cx="565851" cy="512430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DB95C499-EAF1-4235-A58E-EAE77E0046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 cstate="print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482" t="721" r="1762" b="84863"/>
            <a:stretch/>
          </p:blipFill>
          <p:spPr>
            <a:xfrm>
              <a:off x="3273450" y="565854"/>
              <a:ext cx="565851" cy="512430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F7455082-673D-424E-A732-6089FAA485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3" cstate="print"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sharpenSoften amount="50000"/>
                      </a14:imgEffect>
                      <a14:imgEffect>
                        <a14:brightnessContrast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482" t="67690" r="1762" b="16516"/>
            <a:stretch/>
          </p:blipFill>
          <p:spPr>
            <a:xfrm>
              <a:off x="3307698" y="2766834"/>
              <a:ext cx="565851" cy="561452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6615F12D-DB49-448F-A273-C6CA5B8641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5" cstate="print"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482" t="67690" r="1762" b="16516"/>
            <a:stretch/>
          </p:blipFill>
          <p:spPr>
            <a:xfrm>
              <a:off x="3285201" y="1129631"/>
              <a:ext cx="565851" cy="561452"/>
            </a:xfrm>
            <a:prstGeom prst="rect">
              <a:avLst/>
            </a:prstGeom>
          </p:spPr>
        </p:pic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7041EEC9-0025-4F96-9AA6-0F180AC7BDEE}"/>
                </a:ext>
              </a:extLst>
            </p:cNvPr>
            <p:cNvSpPr txBox="1"/>
            <p:nvPr/>
          </p:nvSpPr>
          <p:spPr>
            <a:xfrm>
              <a:off x="3400574" y="838611"/>
              <a:ext cx="359765" cy="197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2.42</a:t>
              </a:r>
            </a:p>
          </p:txBody>
        </p:sp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9534DC6B-4372-40AC-B9DC-3671C92D8B8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 cstate="print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482" t="83484" r="1762" b="721"/>
            <a:stretch/>
          </p:blipFill>
          <p:spPr>
            <a:xfrm>
              <a:off x="3317574" y="3820969"/>
              <a:ext cx="565851" cy="561452"/>
            </a:xfrm>
            <a:prstGeom prst="rect">
              <a:avLst/>
            </a:prstGeom>
          </p:spPr>
        </p:pic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27ADA644-6F94-46FC-BF48-430709AE0DE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5" cstate="print"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482" t="16736" r="1762" b="67249"/>
            <a:stretch/>
          </p:blipFill>
          <p:spPr>
            <a:xfrm>
              <a:off x="3303659" y="3296356"/>
              <a:ext cx="565851" cy="569287"/>
            </a:xfrm>
            <a:prstGeom prst="rect">
              <a:avLst/>
            </a:prstGeom>
          </p:spPr>
        </p:pic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BE9B663F-48ED-4067-942D-5B6B4E9AD0C4}"/>
                </a:ext>
              </a:extLst>
            </p:cNvPr>
            <p:cNvSpPr txBox="1"/>
            <p:nvPr/>
          </p:nvSpPr>
          <p:spPr>
            <a:xfrm>
              <a:off x="3424340" y="3598356"/>
              <a:ext cx="359765" cy="197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5.76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6FFBE7AC-279C-462A-9A43-7B0EF73C0B4E}"/>
                </a:ext>
              </a:extLst>
            </p:cNvPr>
            <p:cNvSpPr txBox="1"/>
            <p:nvPr/>
          </p:nvSpPr>
          <p:spPr>
            <a:xfrm>
              <a:off x="3434583" y="4152280"/>
              <a:ext cx="359765" cy="197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1.9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9ECDB54F-D169-4D5E-BD83-022A4BA230F8}"/>
                </a:ext>
              </a:extLst>
            </p:cNvPr>
            <p:cNvSpPr txBox="1"/>
            <p:nvPr/>
          </p:nvSpPr>
          <p:spPr>
            <a:xfrm>
              <a:off x="3400574" y="1410357"/>
              <a:ext cx="359765" cy="197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0.7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C359DB3F-B7FC-460B-A98E-A7659764875C}"/>
                </a:ext>
              </a:extLst>
            </p:cNvPr>
            <p:cNvSpPr txBox="1"/>
            <p:nvPr/>
          </p:nvSpPr>
          <p:spPr>
            <a:xfrm>
              <a:off x="3402210" y="2501337"/>
              <a:ext cx="359765" cy="197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.17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789C3EE5-2BB6-465C-879B-0939ABA646EC}"/>
                </a:ext>
              </a:extLst>
            </p:cNvPr>
            <p:cNvSpPr txBox="1"/>
            <p:nvPr/>
          </p:nvSpPr>
          <p:spPr>
            <a:xfrm>
              <a:off x="3423638" y="3053630"/>
              <a:ext cx="359765" cy="197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2.6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87ABBA6C-4CF9-4217-9D98-344EBE432C7B}"/>
                </a:ext>
              </a:extLst>
            </p:cNvPr>
            <p:cNvSpPr txBox="1"/>
            <p:nvPr/>
          </p:nvSpPr>
          <p:spPr>
            <a:xfrm>
              <a:off x="3326885" y="1933248"/>
              <a:ext cx="359765" cy="197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7.6</a:t>
              </a:r>
            </a:p>
          </p:txBody>
        </p:sp>
      </p:grpSp>
      <p:sp>
        <p:nvSpPr>
          <p:cNvPr id="74" name="TextBox 73">
            <a:extLst>
              <a:ext uri="{FF2B5EF4-FFF2-40B4-BE49-F238E27FC236}">
                <a16:creationId xmlns:a16="http://schemas.microsoft.com/office/drawing/2014/main" id="{B9163141-D7CC-4EF3-A383-94968A154F94}"/>
              </a:ext>
            </a:extLst>
          </p:cNvPr>
          <p:cNvSpPr txBox="1"/>
          <p:nvPr/>
        </p:nvSpPr>
        <p:spPr>
          <a:xfrm>
            <a:off x="436108" y="995995"/>
            <a:ext cx="391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CF3AAE51-5605-49E0-8257-F758A2FB80AF}"/>
              </a:ext>
            </a:extLst>
          </p:cNvPr>
          <p:cNvSpPr txBox="1"/>
          <p:nvPr/>
        </p:nvSpPr>
        <p:spPr>
          <a:xfrm>
            <a:off x="481959" y="5176458"/>
            <a:ext cx="391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6853C342-36D8-4929-9CF2-200CF2C8BAF2}"/>
              </a:ext>
            </a:extLst>
          </p:cNvPr>
          <p:cNvSpPr txBox="1"/>
          <p:nvPr/>
        </p:nvSpPr>
        <p:spPr>
          <a:xfrm flipH="1">
            <a:off x="2606070" y="232537"/>
            <a:ext cx="20599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</a:p>
        </p:txBody>
      </p:sp>
      <p:grpSp>
        <p:nvGrpSpPr>
          <p:cNvPr id="107" name="Group 106">
            <a:extLst>
              <a:ext uri="{FF2B5EF4-FFF2-40B4-BE49-F238E27FC236}">
                <a16:creationId xmlns:a16="http://schemas.microsoft.com/office/drawing/2014/main" id="{F7DF0095-8E9F-4459-80D6-E344F40445EE}"/>
              </a:ext>
            </a:extLst>
          </p:cNvPr>
          <p:cNvGrpSpPr/>
          <p:nvPr/>
        </p:nvGrpSpPr>
        <p:grpSpPr>
          <a:xfrm>
            <a:off x="288805" y="5416850"/>
            <a:ext cx="6080586" cy="2945962"/>
            <a:chOff x="288805" y="5416850"/>
            <a:chExt cx="6080586" cy="2945962"/>
          </a:xfrm>
        </p:grpSpPr>
        <p:grpSp>
          <p:nvGrpSpPr>
            <p:cNvPr id="79" name="Group 78">
              <a:extLst>
                <a:ext uri="{FF2B5EF4-FFF2-40B4-BE49-F238E27FC236}">
                  <a16:creationId xmlns:a16="http://schemas.microsoft.com/office/drawing/2014/main" id="{C78F0AB8-10FF-4D07-9A02-B8FC6E2D0F3D}"/>
                </a:ext>
              </a:extLst>
            </p:cNvPr>
            <p:cNvGrpSpPr/>
            <p:nvPr/>
          </p:nvGrpSpPr>
          <p:grpSpPr>
            <a:xfrm>
              <a:off x="288805" y="5890772"/>
              <a:ext cx="1840172" cy="2332059"/>
              <a:chOff x="244014" y="5242277"/>
              <a:chExt cx="1840172" cy="2332059"/>
            </a:xfrm>
          </p:grpSpPr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431C39EE-5FEF-4A12-A654-3D0405A324FF}"/>
                  </a:ext>
                </a:extLst>
              </p:cNvPr>
              <p:cNvSpPr txBox="1"/>
              <p:nvPr/>
            </p:nvSpPr>
            <p:spPr>
              <a:xfrm>
                <a:off x="1174376" y="5620156"/>
                <a:ext cx="87154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TYR peptide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F51360F4-8D57-45E3-9C99-081E61281F9C}"/>
                  </a:ext>
                </a:extLst>
              </p:cNvPr>
              <p:cNvSpPr txBox="1"/>
              <p:nvPr/>
            </p:nvSpPr>
            <p:spPr>
              <a:xfrm>
                <a:off x="950498" y="5891444"/>
                <a:ext cx="108476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1" i="0" u="none" strike="noStrike" kern="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TRY peptide </a:t>
                </a:r>
              </a:p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1" i="0" u="none" strike="noStrike" kern="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+ </a:t>
                </a:r>
                <a:r>
                  <a:rPr kumimoji="0" lang="en-US" sz="800" b="1" i="0" u="none" strike="noStrike" kern="0" cap="none" spc="0" normalizeH="0" baseline="0" noProof="0" dirty="0" err="1">
                    <a:ln>
                      <a:noFill/>
                    </a:ln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sMICA</a:t>
                </a:r>
                <a:r>
                  <a:rPr kumimoji="0" lang="en-US" sz="800" b="1" i="0" u="none" strike="noStrike" kern="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+ B10G5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486D5A56-1E56-4F11-98DB-4023CB669997}"/>
                  </a:ext>
                </a:extLst>
              </p:cNvPr>
              <p:cNvSpPr txBox="1"/>
              <p:nvPr/>
            </p:nvSpPr>
            <p:spPr>
              <a:xfrm>
                <a:off x="1107636" y="6282301"/>
                <a:ext cx="9765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800" b="1" kern="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0" lang="en-US" sz="800" b="1" i="0" u="none" strike="noStrike" kern="0" cap="none" spc="0" normalizeH="0" baseline="0" noProof="0" dirty="0" err="1">
                    <a:ln>
                      <a:noFill/>
                    </a:ln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sMICA</a:t>
                </a:r>
                <a:r>
                  <a:rPr kumimoji="0" lang="en-US" sz="800" b="1" i="0" u="none" strike="noStrike" kern="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+ B10G5 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EE3A98DA-DD3F-43CC-B49D-7844793C5E41}"/>
                  </a:ext>
                </a:extLst>
              </p:cNvPr>
              <p:cNvSpPr txBox="1"/>
              <p:nvPr/>
            </p:nvSpPr>
            <p:spPr>
              <a:xfrm>
                <a:off x="557988" y="6566164"/>
                <a:ext cx="14862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TYR peptide </a:t>
                </a:r>
              </a:p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+ sMICA+B10G5 + </a:t>
                </a:r>
                <a:r>
                  <a:rPr lang="en-US" sz="800" kern="0" dirty="0">
                    <a:solidFill>
                      <a:prstClr val="black"/>
                    </a:solidFill>
                    <a:latin typeface="Symbol" panose="05050102010706020507" pitchFamily="18" charset="2"/>
                    <a:cs typeface="Arial" panose="020B0604020202020204" pitchFamily="34" charset="0"/>
                  </a:rPr>
                  <a:t>a</a:t>
                </a:r>
                <a:r>
                  <a:rPr kumimoji="0" lang="en-US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NKG2D</a:t>
                </a: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FDF6EC19-D60D-4CE0-B7D1-97E367279065}"/>
                  </a:ext>
                </a:extLst>
              </p:cNvPr>
              <p:cNvSpPr txBox="1"/>
              <p:nvPr/>
            </p:nvSpPr>
            <p:spPr>
              <a:xfrm>
                <a:off x="244014" y="5242277"/>
                <a:ext cx="180022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OVA peptide (control) +sMIC+B10G5</a:t>
                </a: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FD1FB4C8-3C1A-4A25-A16E-48A497B2EAC8}"/>
                  </a:ext>
                </a:extLst>
              </p:cNvPr>
              <p:cNvSpPr txBox="1"/>
              <p:nvPr/>
            </p:nvSpPr>
            <p:spPr>
              <a:xfrm>
                <a:off x="1192359" y="6875422"/>
                <a:ext cx="80710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 TYR peptide </a:t>
                </a:r>
              </a:p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+ </a:t>
                </a:r>
                <a:r>
                  <a:rPr kumimoji="0" lang="en-US" sz="8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sMICA</a:t>
                </a:r>
                <a:endPara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083477CA-A344-4D4D-BE7D-BCAA6F186876}"/>
                  </a:ext>
                </a:extLst>
              </p:cNvPr>
              <p:cNvSpPr txBox="1"/>
              <p:nvPr/>
            </p:nvSpPr>
            <p:spPr>
              <a:xfrm>
                <a:off x="939910" y="7235782"/>
                <a:ext cx="108476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TYR peptide </a:t>
                </a:r>
              </a:p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+ B10G5</a:t>
                </a:r>
              </a:p>
            </p:txBody>
          </p:sp>
        </p:grp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CC08885C-9ED8-4917-9E20-4079AFCD5C3F}"/>
                </a:ext>
              </a:extLst>
            </p:cNvPr>
            <p:cNvSpPr txBox="1"/>
            <p:nvPr/>
          </p:nvSpPr>
          <p:spPr>
            <a:xfrm>
              <a:off x="2165468" y="5418547"/>
              <a:ext cx="6373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FN</a:t>
              </a:r>
              <a:r>
                <a:rPr kumimoji="0" lang="en-US" sz="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anose="05050102010706020507" pitchFamily="18" charset="2"/>
                  <a:cs typeface="Arial" panose="020B0604020202020204" pitchFamily="34" charset="0"/>
                </a:rPr>
                <a:t>g</a:t>
              </a:r>
              <a:r>
                <a:rPr kumimoji="0" lang="en-US" sz="8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anose="05050102010706020507" pitchFamily="18" charset="2"/>
                  <a:cs typeface="Arial" panose="020B0604020202020204" pitchFamily="34" charset="0"/>
                </a:rPr>
                <a:t>+</a:t>
              </a: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anose="05050102010706020507" pitchFamily="18" charset="2"/>
                  <a:cs typeface="Arial" panose="020B0604020202020204" pitchFamily="34" charset="0"/>
                </a:rPr>
                <a:t> % 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9E29C1C6-3555-442B-B815-4BC2889AC385}"/>
                </a:ext>
              </a:extLst>
            </p:cNvPr>
            <p:cNvSpPr txBox="1"/>
            <p:nvPr/>
          </p:nvSpPr>
          <p:spPr>
            <a:xfrm>
              <a:off x="3705840" y="5416850"/>
              <a:ext cx="1023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NF</a:t>
              </a:r>
              <a:r>
                <a:rPr kumimoji="0" lang="en-US" sz="8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kumimoji="0" lang="en-US" sz="8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anose="05050102010706020507" pitchFamily="18" charset="2"/>
                  <a:cs typeface="Arial" panose="020B0604020202020204" pitchFamily="34" charset="0"/>
                </a:rPr>
                <a:t>+</a:t>
              </a: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anose="05050102010706020507" pitchFamily="18" charset="2"/>
                  <a:cs typeface="Arial" panose="020B0604020202020204" pitchFamily="34" charset="0"/>
                </a:rPr>
                <a:t> %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E5CFDBAC-6868-4DBE-B67F-8FF0F4A7A5F7}"/>
                </a:ext>
              </a:extLst>
            </p:cNvPr>
            <p:cNvSpPr txBox="1"/>
            <p:nvPr/>
          </p:nvSpPr>
          <p:spPr>
            <a:xfrm>
              <a:off x="5222419" y="5448484"/>
              <a:ext cx="11469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D107a</a:t>
              </a:r>
              <a:r>
                <a:rPr kumimoji="0" lang="en-US" sz="800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kumimoji="0" lang="en-US" sz="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% </a:t>
              </a:r>
            </a:p>
          </p:txBody>
        </p:sp>
        <p:cxnSp>
          <p:nvCxnSpPr>
            <p:cNvPr id="81" name="Straight Connector 80">
              <a:extLst>
                <a:ext uri="{FF2B5EF4-FFF2-40B4-BE49-F238E27FC236}">
                  <a16:creationId xmlns:a16="http://schemas.microsoft.com/office/drawing/2014/main" id="{4D743A51-2943-48E2-AF57-B2247824AFD2}"/>
                </a:ext>
              </a:extLst>
            </p:cNvPr>
            <p:cNvCxnSpPr/>
            <p:nvPr/>
          </p:nvCxnSpPr>
          <p:spPr>
            <a:xfrm>
              <a:off x="3005714" y="6360984"/>
              <a:ext cx="0" cy="284914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523A05A5-1A70-46B6-9C46-2F8E8113AED2}"/>
                </a:ext>
              </a:extLst>
            </p:cNvPr>
            <p:cNvSpPr txBox="1"/>
            <p:nvPr/>
          </p:nvSpPr>
          <p:spPr>
            <a:xfrm>
              <a:off x="3024250" y="6360984"/>
              <a:ext cx="457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83" name="Straight Connector 82">
              <a:extLst>
                <a:ext uri="{FF2B5EF4-FFF2-40B4-BE49-F238E27FC236}">
                  <a16:creationId xmlns:a16="http://schemas.microsoft.com/office/drawing/2014/main" id="{CA15B823-BD42-4445-9A98-436F1796FFC6}"/>
                </a:ext>
              </a:extLst>
            </p:cNvPr>
            <p:cNvCxnSpPr>
              <a:cxnSpLocks/>
            </p:cNvCxnSpPr>
            <p:nvPr/>
          </p:nvCxnSpPr>
          <p:spPr>
            <a:xfrm>
              <a:off x="3014021" y="6716855"/>
              <a:ext cx="169" cy="724634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D16C9CC8-227B-4213-9471-F40D72B16CF1}"/>
                </a:ext>
              </a:extLst>
            </p:cNvPr>
            <p:cNvSpPr txBox="1"/>
            <p:nvPr/>
          </p:nvSpPr>
          <p:spPr>
            <a:xfrm>
              <a:off x="3062926" y="6921750"/>
              <a:ext cx="457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graphicFrame>
          <p:nvGraphicFramePr>
            <p:cNvPr id="94" name="Chart 93">
              <a:extLst>
                <a:ext uri="{FF2B5EF4-FFF2-40B4-BE49-F238E27FC236}">
                  <a16:creationId xmlns:a16="http://schemas.microsoft.com/office/drawing/2014/main" id="{A1DDD77A-40B7-4BB1-8442-412E6CD9DEA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50819463"/>
                </p:ext>
              </p:extLst>
            </p:nvPr>
          </p:nvGraphicFramePr>
          <p:xfrm>
            <a:off x="1964369" y="5619612"/>
            <a:ext cx="131611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6"/>
            </a:graphicData>
          </a:graphic>
        </p:graphicFrame>
        <p:graphicFrame>
          <p:nvGraphicFramePr>
            <p:cNvPr id="97" name="Chart 96">
              <a:extLst>
                <a:ext uri="{FF2B5EF4-FFF2-40B4-BE49-F238E27FC236}">
                  <a16:creationId xmlns:a16="http://schemas.microsoft.com/office/drawing/2014/main" id="{AD571608-32D7-4D69-99E7-48B94BB5780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96557996"/>
                </p:ext>
              </p:extLst>
            </p:nvPr>
          </p:nvGraphicFramePr>
          <p:xfrm>
            <a:off x="3387602" y="5593741"/>
            <a:ext cx="1427272" cy="276907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7"/>
            </a:graphicData>
          </a:graphic>
        </p:graphicFrame>
        <p:graphicFrame>
          <p:nvGraphicFramePr>
            <p:cNvPr id="98" name="Chart 97">
              <a:extLst>
                <a:ext uri="{FF2B5EF4-FFF2-40B4-BE49-F238E27FC236}">
                  <a16:creationId xmlns:a16="http://schemas.microsoft.com/office/drawing/2014/main" id="{2E0CA16F-2C37-4CEC-871A-DD8792B44DD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84473524"/>
                </p:ext>
              </p:extLst>
            </p:nvPr>
          </p:nvGraphicFramePr>
          <p:xfrm>
            <a:off x="4919210" y="5606676"/>
            <a:ext cx="1441188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8"/>
            </a:graphicData>
          </a:graphic>
        </p:graphicFrame>
        <p:cxnSp>
          <p:nvCxnSpPr>
            <p:cNvPr id="99" name="Straight Connector 98">
              <a:extLst>
                <a:ext uri="{FF2B5EF4-FFF2-40B4-BE49-F238E27FC236}">
                  <a16:creationId xmlns:a16="http://schemas.microsoft.com/office/drawing/2014/main" id="{5FA2971C-A993-41BA-A34C-69915CCF360D}"/>
                </a:ext>
              </a:extLst>
            </p:cNvPr>
            <p:cNvCxnSpPr/>
            <p:nvPr/>
          </p:nvCxnSpPr>
          <p:spPr>
            <a:xfrm>
              <a:off x="4321809" y="6349393"/>
              <a:ext cx="0" cy="284914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2654BDA7-3F6E-4274-8EFB-4EBA4159CC88}"/>
                </a:ext>
              </a:extLst>
            </p:cNvPr>
            <p:cNvSpPr txBox="1"/>
            <p:nvPr/>
          </p:nvSpPr>
          <p:spPr>
            <a:xfrm>
              <a:off x="4340345" y="6349393"/>
              <a:ext cx="457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id="{5A1843C5-C6D8-4C25-BDF0-269876BB51EA}"/>
                </a:ext>
              </a:extLst>
            </p:cNvPr>
            <p:cNvCxnSpPr>
              <a:cxnSpLocks/>
            </p:cNvCxnSpPr>
            <p:nvPr/>
          </p:nvCxnSpPr>
          <p:spPr>
            <a:xfrm>
              <a:off x="4330116" y="6705264"/>
              <a:ext cx="169" cy="724634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DB8515B0-EFFB-43F3-A7BE-B1B21291E659}"/>
                </a:ext>
              </a:extLst>
            </p:cNvPr>
            <p:cNvSpPr txBox="1"/>
            <p:nvPr/>
          </p:nvSpPr>
          <p:spPr>
            <a:xfrm>
              <a:off x="4379021" y="6910159"/>
              <a:ext cx="457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103" name="Straight Connector 102">
              <a:extLst>
                <a:ext uri="{FF2B5EF4-FFF2-40B4-BE49-F238E27FC236}">
                  <a16:creationId xmlns:a16="http://schemas.microsoft.com/office/drawing/2014/main" id="{6D278BF0-0FBE-4FB2-915A-4D222919098C}"/>
                </a:ext>
              </a:extLst>
            </p:cNvPr>
            <p:cNvCxnSpPr/>
            <p:nvPr/>
          </p:nvCxnSpPr>
          <p:spPr>
            <a:xfrm>
              <a:off x="5962588" y="6370030"/>
              <a:ext cx="0" cy="284914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59188B7E-9D79-4EDC-BDB9-B2FF92F43AE7}"/>
                </a:ext>
              </a:extLst>
            </p:cNvPr>
            <p:cNvSpPr txBox="1"/>
            <p:nvPr/>
          </p:nvSpPr>
          <p:spPr>
            <a:xfrm>
              <a:off x="5981124" y="6370030"/>
              <a:ext cx="457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id="{C4040CEF-8255-44BE-9528-26BFE0E43E8E}"/>
                </a:ext>
              </a:extLst>
            </p:cNvPr>
            <p:cNvCxnSpPr>
              <a:cxnSpLocks/>
            </p:cNvCxnSpPr>
            <p:nvPr/>
          </p:nvCxnSpPr>
          <p:spPr>
            <a:xfrm>
              <a:off x="5970895" y="6725901"/>
              <a:ext cx="169" cy="724634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47661465-B4BF-4432-89A1-6E2585B78EE9}"/>
                </a:ext>
              </a:extLst>
            </p:cNvPr>
            <p:cNvSpPr txBox="1"/>
            <p:nvPr/>
          </p:nvSpPr>
          <p:spPr>
            <a:xfrm>
              <a:off x="6019800" y="6930796"/>
              <a:ext cx="457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4746108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9">
            <a:extLst>
              <a:ext uri="{FF2B5EF4-FFF2-40B4-BE49-F238E27FC236}">
                <a16:creationId xmlns:a16="http://schemas.microsoft.com/office/drawing/2014/main" id="{599A4659-B397-4AE2-BADD-9AECC2D5D7D3}"/>
              </a:ext>
            </a:extLst>
          </p:cNvPr>
          <p:cNvSpPr txBox="1"/>
          <p:nvPr/>
        </p:nvSpPr>
        <p:spPr>
          <a:xfrm>
            <a:off x="609600" y="3352800"/>
            <a:ext cx="5434279" cy="1981200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lvl="0" algn="just">
              <a:lnSpc>
                <a:spcPct val="107000"/>
              </a:lnSpc>
              <a:spcAft>
                <a:spcPts val="800"/>
              </a:spcAft>
            </a:pPr>
            <a:r>
              <a:rPr kumimoji="0" lang="en-US" sz="11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 S6. </a:t>
            </a:r>
            <a:r>
              <a:rPr kumimoji="0" lang="en-US" sz="1100" b="1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MI</a:t>
            </a:r>
            <a:r>
              <a:rPr kumimoji="0" lang="en-US" sz="1100" b="1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/B10G5 co-stimulation amplifies antigen-specific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CR-signaling through NKG2D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man tyrosinase-specific </a:t>
            </a:r>
            <a:r>
              <a: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LA-A</a:t>
            </a:r>
            <a:r>
              <a:rPr kumimoji="0" lang="en-US" sz="1100" b="0" i="0" u="none" strike="noStrike" kern="0" cap="none" spc="0" normalizeH="0" baseline="-2500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highlight>
                  <a:srgbClr val="FFFF00"/>
                </a:highlight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stricted </a:t>
            </a:r>
            <a:r>
              <a: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IL13831</a:t>
            </a:r>
            <a:r>
              <a: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was co-cultured o/n with antigen presenting cells (APC) T2-A2 cells under indicated condition before functional assay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ith HLA-A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surrogate T2-A2 APC, in the presence or absence of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MI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A)+B10G5 or tyrosinase peptide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369-377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After o/n culture, we assessed the TIL13831 activation by intracellular staining for </a:t>
            </a:r>
            <a:r>
              <a:rPr lang="en-US" sz="1100" dirty="0" err="1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IFN</a:t>
            </a:r>
            <a:r>
              <a:rPr lang="en-US" sz="1100" dirty="0" err="1">
                <a:highlight>
                  <a:srgbClr val="FFFF00"/>
                </a:highlight>
                <a:latin typeface="Symbol" panose="05050102010706020507" pitchFamily="18" charset="2"/>
                <a:cs typeface="Arial" panose="020B0604020202020204" pitchFamily="34" charset="0"/>
              </a:rPr>
              <a:t>g</a:t>
            </a:r>
            <a:r>
              <a:rPr lang="en-US" sz="1100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dirty="0" err="1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  <a:r>
              <a:rPr lang="en-US" sz="1100" dirty="0" err="1">
                <a:highlight>
                  <a:srgbClr val="FFFF00"/>
                </a:highlight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1100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, and CD107a (degranulation). (</a:t>
            </a:r>
            <a:r>
              <a:rPr lang="en-US" sz="1100" b="1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100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) Representative plots from flow cytometry assay with indicated stimulation. (</a:t>
            </a:r>
            <a:r>
              <a:rPr lang="en-US" sz="1100" b="1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100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) Representative summary data from three independent experiments. *, p&lt;0.05.</a:t>
            </a:r>
            <a:endParaRPr kumimoji="0" lang="en-US" sz="1100" b="0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highlight>
                <a:srgbClr val="FFFF00"/>
              </a:highlight>
              <a:uLnTx/>
              <a:uFillTx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898119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4022D5F1-231B-4C23-ADF1-8335B575038B}"/>
              </a:ext>
            </a:extLst>
          </p:cNvPr>
          <p:cNvSpPr txBox="1"/>
          <p:nvPr/>
        </p:nvSpPr>
        <p:spPr>
          <a:xfrm>
            <a:off x="3200705" y="3085143"/>
            <a:ext cx="654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284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KG2D</a:t>
            </a:r>
          </a:p>
        </p:txBody>
      </p:sp>
      <p:grpSp>
        <p:nvGrpSpPr>
          <p:cNvPr id="86" name="Group 85">
            <a:extLst>
              <a:ext uri="{FF2B5EF4-FFF2-40B4-BE49-F238E27FC236}">
                <a16:creationId xmlns:a16="http://schemas.microsoft.com/office/drawing/2014/main" id="{F94B3695-98E7-4EFC-8A75-6238DBC157D5}"/>
              </a:ext>
            </a:extLst>
          </p:cNvPr>
          <p:cNvGrpSpPr/>
          <p:nvPr/>
        </p:nvGrpSpPr>
        <p:grpSpPr>
          <a:xfrm>
            <a:off x="1430440" y="1174947"/>
            <a:ext cx="3709645" cy="1779034"/>
            <a:chOff x="1430440" y="1174947"/>
            <a:chExt cx="3709645" cy="1779034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34228005-9568-4E90-BF60-7C5E27D5D128}"/>
                </a:ext>
              </a:extLst>
            </p:cNvPr>
            <p:cNvSpPr txBox="1"/>
            <p:nvPr/>
          </p:nvSpPr>
          <p:spPr>
            <a:xfrm>
              <a:off x="1430440" y="1546323"/>
              <a:ext cx="6266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pleen</a:t>
              </a:r>
            </a:p>
          </p:txBody>
        </p:sp>
        <p:pic>
          <p:nvPicPr>
            <p:cNvPr id="45" name="Picture 44">
              <a:extLst>
                <a:ext uri="{FF2B5EF4-FFF2-40B4-BE49-F238E27FC236}">
                  <a16:creationId xmlns:a16="http://schemas.microsoft.com/office/drawing/2014/main" id="{D9A9E455-903B-4657-AECE-D9223ED2ED2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02" t="3345" r="6902" b="52744"/>
            <a:stretch/>
          </p:blipFill>
          <p:spPr>
            <a:xfrm>
              <a:off x="3607873" y="1465103"/>
              <a:ext cx="696911" cy="600824"/>
            </a:xfrm>
            <a:prstGeom prst="rect">
              <a:avLst/>
            </a:prstGeom>
          </p:spPr>
        </p:pic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C8C4DE60-367A-4915-883A-564C7F350A9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71" t="6902" r="53903" b="6902"/>
            <a:stretch/>
          </p:blipFill>
          <p:spPr>
            <a:xfrm>
              <a:off x="2829419" y="1463582"/>
              <a:ext cx="735628" cy="626400"/>
            </a:xfrm>
            <a:prstGeom prst="rect">
              <a:avLst/>
            </a:prstGeom>
          </p:spPr>
        </p:pic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9F834B9E-0A97-452C-AB55-9D16C1D22ADE}"/>
                </a:ext>
              </a:extLst>
            </p:cNvPr>
            <p:cNvSpPr txBox="1"/>
            <p:nvPr/>
          </p:nvSpPr>
          <p:spPr>
            <a:xfrm>
              <a:off x="2938187" y="1191768"/>
              <a:ext cx="4585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8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IC</a:t>
              </a:r>
            </a:p>
          </p:txBody>
        </p:sp>
        <p:pic>
          <p:nvPicPr>
            <p:cNvPr id="48" name="Picture 47">
              <a:extLst>
                <a:ext uri="{FF2B5EF4-FFF2-40B4-BE49-F238E27FC236}">
                  <a16:creationId xmlns:a16="http://schemas.microsoft.com/office/drawing/2014/main" id="{F906736E-46C2-468A-83BF-2A9462F7E19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00" t="54448" r="58889" b="2555"/>
            <a:stretch/>
          </p:blipFill>
          <p:spPr>
            <a:xfrm>
              <a:off x="4375397" y="1465102"/>
              <a:ext cx="757454" cy="619615"/>
            </a:xfrm>
            <a:prstGeom prst="rect">
              <a:avLst/>
            </a:prstGeom>
          </p:spPr>
        </p:pic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4F9C5D88-75AA-472C-901E-4A37BCBC2D19}"/>
                </a:ext>
              </a:extLst>
            </p:cNvPr>
            <p:cNvSpPr txBox="1"/>
            <p:nvPr/>
          </p:nvSpPr>
          <p:spPr>
            <a:xfrm>
              <a:off x="2063211" y="1174947"/>
              <a:ext cx="69671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cIgG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0" name="Picture 49">
              <a:extLst>
                <a:ext uri="{FF2B5EF4-FFF2-40B4-BE49-F238E27FC236}">
                  <a16:creationId xmlns:a16="http://schemas.microsoft.com/office/drawing/2014/main" id="{8DE2CB3D-5987-460B-A842-9997CD20EBB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71" t="6902" r="53903" b="6902"/>
            <a:stretch/>
          </p:blipFill>
          <p:spPr>
            <a:xfrm>
              <a:off x="2027130" y="1450470"/>
              <a:ext cx="730322" cy="626400"/>
            </a:xfrm>
            <a:prstGeom prst="rect">
              <a:avLst/>
            </a:prstGeom>
          </p:spPr>
        </p:pic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F1F234EF-B312-4E8A-9C22-71369B82FF1A}"/>
                </a:ext>
              </a:extLst>
            </p:cNvPr>
            <p:cNvSpPr txBox="1"/>
            <p:nvPr/>
          </p:nvSpPr>
          <p:spPr>
            <a:xfrm>
              <a:off x="4298188" y="1182892"/>
              <a:ext cx="84189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8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D-L1+</a:t>
              </a:r>
              <a:r>
                <a:rPr lang="el-GR" sz="8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IC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5491FF6D-27C7-427B-B596-F81D651A375E}"/>
                </a:ext>
              </a:extLst>
            </p:cNvPr>
            <p:cNvSpPr txBox="1"/>
            <p:nvPr/>
          </p:nvSpPr>
          <p:spPr>
            <a:xfrm>
              <a:off x="3627175" y="1199074"/>
              <a:ext cx="5357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8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D-L1</a:t>
              </a:r>
            </a:p>
          </p:txBody>
        </p:sp>
        <p:pic>
          <p:nvPicPr>
            <p:cNvPr id="61" name="Picture 60">
              <a:extLst>
                <a:ext uri="{FF2B5EF4-FFF2-40B4-BE49-F238E27FC236}">
                  <a16:creationId xmlns:a16="http://schemas.microsoft.com/office/drawing/2014/main" id="{00371BEB-DA8E-49FC-B0DB-598BF2CEE4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15" t="28191" r="53554" b="50027"/>
            <a:stretch/>
          </p:blipFill>
          <p:spPr>
            <a:xfrm>
              <a:off x="2785736" y="2180292"/>
              <a:ext cx="749618" cy="706742"/>
            </a:xfrm>
            <a:prstGeom prst="rect">
              <a:avLst/>
            </a:prstGeom>
          </p:spPr>
        </p:pic>
        <p:pic>
          <p:nvPicPr>
            <p:cNvPr id="65" name="Picture 64">
              <a:extLst>
                <a:ext uri="{FF2B5EF4-FFF2-40B4-BE49-F238E27FC236}">
                  <a16:creationId xmlns:a16="http://schemas.microsoft.com/office/drawing/2014/main" id="{F516E674-D014-4A36-B6E0-15A4E1077D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t="68428" r="56021" b="3439"/>
            <a:stretch/>
          </p:blipFill>
          <p:spPr>
            <a:xfrm>
              <a:off x="2045058" y="2180292"/>
              <a:ext cx="702809" cy="660050"/>
            </a:xfrm>
            <a:prstGeom prst="rect">
              <a:avLst/>
            </a:prstGeom>
          </p:spPr>
        </p:pic>
        <p:pic>
          <p:nvPicPr>
            <p:cNvPr id="67" name="Picture 66">
              <a:extLst>
                <a:ext uri="{FF2B5EF4-FFF2-40B4-BE49-F238E27FC236}">
                  <a16:creationId xmlns:a16="http://schemas.microsoft.com/office/drawing/2014/main" id="{CD798FB4-B8A1-4EB7-A409-4740A3CD3E5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t="3386" r="56711" b="55038"/>
            <a:stretch/>
          </p:blipFill>
          <p:spPr>
            <a:xfrm>
              <a:off x="3593772" y="2193142"/>
              <a:ext cx="701428" cy="672068"/>
            </a:xfrm>
            <a:prstGeom prst="rect">
              <a:avLst/>
            </a:prstGeom>
          </p:spPr>
        </p:pic>
        <p:pic>
          <p:nvPicPr>
            <p:cNvPr id="68" name="Picture 67">
              <a:extLst>
                <a:ext uri="{FF2B5EF4-FFF2-40B4-BE49-F238E27FC236}">
                  <a16:creationId xmlns:a16="http://schemas.microsoft.com/office/drawing/2014/main" id="{7DFA13E4-D298-4FFF-A91E-3D2ACD9D312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t="76704" r="56059" b="2477"/>
            <a:stretch/>
          </p:blipFill>
          <p:spPr>
            <a:xfrm>
              <a:off x="4375397" y="2204549"/>
              <a:ext cx="757454" cy="659121"/>
            </a:xfrm>
            <a:prstGeom prst="rect">
              <a:avLst/>
            </a:prstGeom>
          </p:spPr>
        </p:pic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DF47D10E-8696-4E83-9B11-594F75918BC5}"/>
                </a:ext>
              </a:extLst>
            </p:cNvPr>
            <p:cNvSpPr txBox="1"/>
            <p:nvPr/>
          </p:nvSpPr>
          <p:spPr>
            <a:xfrm>
              <a:off x="1507143" y="2386898"/>
              <a:ext cx="4280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IL</a:t>
              </a:r>
            </a:p>
          </p:txBody>
        </p:sp>
        <p:cxnSp>
          <p:nvCxnSpPr>
            <p:cNvPr id="74" name="Straight Arrow Connector 73">
              <a:extLst>
                <a:ext uri="{FF2B5EF4-FFF2-40B4-BE49-F238E27FC236}">
                  <a16:creationId xmlns:a16="http://schemas.microsoft.com/office/drawing/2014/main" id="{0D7DAB98-B083-4E00-9AC4-1D52287B2A62}"/>
                </a:ext>
              </a:extLst>
            </p:cNvPr>
            <p:cNvCxnSpPr/>
            <p:nvPr/>
          </p:nvCxnSpPr>
          <p:spPr>
            <a:xfrm>
              <a:off x="2086557" y="2953981"/>
              <a:ext cx="2950382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7" name="Group 86">
            <a:extLst>
              <a:ext uri="{FF2B5EF4-FFF2-40B4-BE49-F238E27FC236}">
                <a16:creationId xmlns:a16="http://schemas.microsoft.com/office/drawing/2014/main" id="{DDC67A30-E84F-4E15-B74C-634A7858B876}"/>
              </a:ext>
            </a:extLst>
          </p:cNvPr>
          <p:cNvGrpSpPr/>
          <p:nvPr/>
        </p:nvGrpSpPr>
        <p:grpSpPr>
          <a:xfrm>
            <a:off x="2048909" y="3625790"/>
            <a:ext cx="3385238" cy="2959264"/>
            <a:chOff x="2048909" y="3625790"/>
            <a:chExt cx="3385238" cy="2959264"/>
          </a:xfrm>
        </p:grpSpPr>
        <p:sp>
          <p:nvSpPr>
            <p:cNvPr id="8" name="TextBox 48">
              <a:extLst>
                <a:ext uri="{FF2B5EF4-FFF2-40B4-BE49-F238E27FC236}">
                  <a16:creationId xmlns:a16="http://schemas.microsoft.com/office/drawing/2014/main" id="{94A2B889-BA4D-4592-981E-9E63A2B7A0FF}"/>
                </a:ext>
              </a:extLst>
            </p:cNvPr>
            <p:cNvSpPr txBox="1"/>
            <p:nvPr/>
          </p:nvSpPr>
          <p:spPr>
            <a:xfrm rot="16200000">
              <a:off x="1216136" y="4765883"/>
              <a:ext cx="191176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MFI of NKG2D in NK cells</a:t>
              </a:r>
              <a:endParaRPr lang="en-US" sz="10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grpSp>
          <p:nvGrpSpPr>
            <p:cNvPr id="75" name="Group 74">
              <a:extLst>
                <a:ext uri="{FF2B5EF4-FFF2-40B4-BE49-F238E27FC236}">
                  <a16:creationId xmlns:a16="http://schemas.microsoft.com/office/drawing/2014/main" id="{A5E18B20-BB04-4DDA-B3CD-6128B6F778AE}"/>
                </a:ext>
              </a:extLst>
            </p:cNvPr>
            <p:cNvGrpSpPr/>
            <p:nvPr/>
          </p:nvGrpSpPr>
          <p:grpSpPr>
            <a:xfrm>
              <a:off x="2286000" y="3810000"/>
              <a:ext cx="3148147" cy="1072304"/>
              <a:chOff x="2109653" y="3708058"/>
              <a:chExt cx="2075825" cy="1072304"/>
            </a:xfrm>
          </p:grpSpPr>
          <p:graphicFrame>
            <p:nvGraphicFramePr>
              <p:cNvPr id="16" name="Chart 15">
                <a:extLst>
                  <a:ext uri="{FF2B5EF4-FFF2-40B4-BE49-F238E27FC236}">
                    <a16:creationId xmlns:a16="http://schemas.microsoft.com/office/drawing/2014/main" id="{70E167AC-A7B5-4EDA-A449-1756913E6549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60935697"/>
                  </p:ext>
                </p:extLst>
              </p:nvPr>
            </p:nvGraphicFramePr>
            <p:xfrm>
              <a:off x="2109653" y="3729208"/>
              <a:ext cx="1839829" cy="105115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0"/>
              </a:graphicData>
            </a:graphic>
          </p:graphicFrame>
          <p:cxnSp>
            <p:nvCxnSpPr>
              <p:cNvPr id="17" name="Straight Connector 16">
                <a:extLst>
                  <a:ext uri="{FF2B5EF4-FFF2-40B4-BE49-F238E27FC236}">
                    <a16:creationId xmlns:a16="http://schemas.microsoft.com/office/drawing/2014/main" id="{EFE5F087-A025-4AAA-B9AD-FEEB2335E985}"/>
                  </a:ext>
                </a:extLst>
              </p:cNvPr>
              <p:cNvCxnSpPr/>
              <p:nvPr/>
            </p:nvCxnSpPr>
            <p:spPr>
              <a:xfrm>
                <a:off x="2958214" y="3912038"/>
                <a:ext cx="74433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id="{4A6F7DDD-F568-499A-B855-80E608510E2D}"/>
                  </a:ext>
                </a:extLst>
              </p:cNvPr>
              <p:cNvCxnSpPr/>
              <p:nvPr/>
            </p:nvCxnSpPr>
            <p:spPr>
              <a:xfrm>
                <a:off x="3225697" y="4092901"/>
                <a:ext cx="48168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918E9D62-4881-4A1D-B436-D3D4CC020B7D}"/>
                  </a:ext>
                </a:extLst>
              </p:cNvPr>
              <p:cNvSpPr txBox="1"/>
              <p:nvPr/>
            </p:nvSpPr>
            <p:spPr>
              <a:xfrm>
                <a:off x="3075820" y="3708058"/>
                <a:ext cx="103301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&lt;0.05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57384A3E-CACF-4AB2-B3E9-A6F3E8EFA761}"/>
                  </a:ext>
                </a:extLst>
              </p:cNvPr>
              <p:cNvSpPr txBox="1"/>
              <p:nvPr/>
            </p:nvSpPr>
            <p:spPr>
              <a:xfrm>
                <a:off x="3133451" y="3897875"/>
                <a:ext cx="105202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&lt;0.01</a:t>
                </a:r>
              </a:p>
            </p:txBody>
          </p:sp>
        </p:grpSp>
        <p:grpSp>
          <p:nvGrpSpPr>
            <p:cNvPr id="76" name="Group 75">
              <a:extLst>
                <a:ext uri="{FF2B5EF4-FFF2-40B4-BE49-F238E27FC236}">
                  <a16:creationId xmlns:a16="http://schemas.microsoft.com/office/drawing/2014/main" id="{74E18344-B0EA-4D76-A680-659C460DC374}"/>
                </a:ext>
              </a:extLst>
            </p:cNvPr>
            <p:cNvGrpSpPr/>
            <p:nvPr/>
          </p:nvGrpSpPr>
          <p:grpSpPr>
            <a:xfrm>
              <a:off x="2356840" y="5137595"/>
              <a:ext cx="2880449" cy="1447459"/>
              <a:chOff x="2169269" y="5035654"/>
              <a:chExt cx="2274833" cy="1447459"/>
            </a:xfrm>
          </p:grpSpPr>
          <p:graphicFrame>
            <p:nvGraphicFramePr>
              <p:cNvPr id="29" name="Chart 28">
                <a:extLst>
                  <a:ext uri="{FF2B5EF4-FFF2-40B4-BE49-F238E27FC236}">
                    <a16:creationId xmlns:a16="http://schemas.microsoft.com/office/drawing/2014/main" id="{67181A41-6901-4F8E-8A2E-49239CBEEC1C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543917320"/>
                  </p:ext>
                </p:extLst>
              </p:nvPr>
            </p:nvGraphicFramePr>
            <p:xfrm>
              <a:off x="2169269" y="5078141"/>
              <a:ext cx="2169217" cy="115693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1"/>
              </a:graphicData>
            </a:graphic>
          </p:graphicFrame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id="{6226D5BF-C02D-4B8D-9CF9-776FE87F0A2B}"/>
                  </a:ext>
                </a:extLst>
              </p:cNvPr>
              <p:cNvCxnSpPr/>
              <p:nvPr/>
            </p:nvCxnSpPr>
            <p:spPr>
              <a:xfrm>
                <a:off x="3189555" y="5243808"/>
                <a:ext cx="758038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>
                <a:extLst>
                  <a:ext uri="{FF2B5EF4-FFF2-40B4-BE49-F238E27FC236}">
                    <a16:creationId xmlns:a16="http://schemas.microsoft.com/office/drawing/2014/main" id="{C730ABF5-BA93-47D2-8DE7-E3407CFC035B}"/>
                  </a:ext>
                </a:extLst>
              </p:cNvPr>
              <p:cNvCxnSpPr/>
              <p:nvPr/>
            </p:nvCxnSpPr>
            <p:spPr>
              <a:xfrm>
                <a:off x="3457038" y="5424671"/>
                <a:ext cx="49055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02699564-837E-47F1-B7AD-27CEFDECBF2B}"/>
                  </a:ext>
                </a:extLst>
              </p:cNvPr>
              <p:cNvSpPr txBox="1"/>
              <p:nvPr/>
            </p:nvSpPr>
            <p:spPr>
              <a:xfrm>
                <a:off x="2999883" y="6134299"/>
                <a:ext cx="4585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IC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945FC9BB-30C7-40E9-9E09-B2C8AE9775EE}"/>
                  </a:ext>
                </a:extLst>
              </p:cNvPr>
              <p:cNvSpPr txBox="1"/>
              <p:nvPr/>
            </p:nvSpPr>
            <p:spPr>
              <a:xfrm>
                <a:off x="2597801" y="6112219"/>
                <a:ext cx="45504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IgG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7DEC0F5A-1974-41E9-9612-DFE9DB6B40D4}"/>
                  </a:ext>
                </a:extLst>
              </p:cNvPr>
              <p:cNvSpPr txBox="1"/>
              <p:nvPr/>
            </p:nvSpPr>
            <p:spPr>
              <a:xfrm>
                <a:off x="3763423" y="6144559"/>
                <a:ext cx="44967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PD-L1</a:t>
                </a:r>
              </a:p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l-G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IC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0A4EDE8E-0AFB-4EA2-B5CF-6487A4798198}"/>
                  </a:ext>
                </a:extLst>
              </p:cNvPr>
              <p:cNvSpPr txBox="1"/>
              <p:nvPr/>
            </p:nvSpPr>
            <p:spPr>
              <a:xfrm>
                <a:off x="3305473" y="5035654"/>
                <a:ext cx="103301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&lt;0.05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581ED25B-3FD4-4D88-AF71-C36808F4E3BD}"/>
                  </a:ext>
                </a:extLst>
              </p:cNvPr>
              <p:cNvSpPr txBox="1"/>
              <p:nvPr/>
            </p:nvSpPr>
            <p:spPr>
              <a:xfrm>
                <a:off x="3411089" y="5260250"/>
                <a:ext cx="103301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&lt;0.05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8371E967-E7E9-4208-84F3-5B782E1F3DCD}"/>
                  </a:ext>
                </a:extLst>
              </p:cNvPr>
              <p:cNvSpPr txBox="1"/>
              <p:nvPr/>
            </p:nvSpPr>
            <p:spPr>
              <a:xfrm>
                <a:off x="3315941" y="6124149"/>
                <a:ext cx="5357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D-L1</a:t>
                </a:r>
              </a:p>
            </p:txBody>
          </p:sp>
        </p:grp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A2C7175E-6C7F-4A4D-861C-7991A8DBA98F}"/>
                </a:ext>
              </a:extLst>
            </p:cNvPr>
            <p:cNvSpPr txBox="1"/>
            <p:nvPr/>
          </p:nvSpPr>
          <p:spPr>
            <a:xfrm>
              <a:off x="2827777" y="3625790"/>
              <a:ext cx="6266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pleen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109353A7-164F-408E-944D-A23B375C3370}"/>
                </a:ext>
              </a:extLst>
            </p:cNvPr>
            <p:cNvSpPr txBox="1"/>
            <p:nvPr/>
          </p:nvSpPr>
          <p:spPr>
            <a:xfrm>
              <a:off x="2867774" y="5014485"/>
              <a:ext cx="4280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IL</a:t>
              </a:r>
            </a:p>
          </p:txBody>
        </p:sp>
        <p:cxnSp>
          <p:nvCxnSpPr>
            <p:cNvPr id="83" name="Straight Connector 82">
              <a:extLst>
                <a:ext uri="{FF2B5EF4-FFF2-40B4-BE49-F238E27FC236}">
                  <a16:creationId xmlns:a16="http://schemas.microsoft.com/office/drawing/2014/main" id="{25D340F2-49A0-432E-A717-9DCC1683DED0}"/>
                </a:ext>
              </a:extLst>
            </p:cNvPr>
            <p:cNvCxnSpPr/>
            <p:nvPr/>
          </p:nvCxnSpPr>
          <p:spPr>
            <a:xfrm>
              <a:off x="2368899" y="3933110"/>
              <a:ext cx="0" cy="231339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84" name="TextBox 83">
            <a:extLst>
              <a:ext uri="{FF2B5EF4-FFF2-40B4-BE49-F238E27FC236}">
                <a16:creationId xmlns:a16="http://schemas.microsoft.com/office/drawing/2014/main" id="{AC61BD81-DDB5-4618-B776-CB330B728E85}"/>
              </a:ext>
            </a:extLst>
          </p:cNvPr>
          <p:cNvSpPr txBox="1"/>
          <p:nvPr/>
        </p:nvSpPr>
        <p:spPr>
          <a:xfrm>
            <a:off x="985235" y="913337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BE4F2ED5-4A44-4D1D-9580-F3F5AF4F0AC2}"/>
              </a:ext>
            </a:extLst>
          </p:cNvPr>
          <p:cNvSpPr txBox="1"/>
          <p:nvPr/>
        </p:nvSpPr>
        <p:spPr>
          <a:xfrm>
            <a:off x="1107801" y="3554151"/>
            <a:ext cx="322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35031CB4-6CA9-44C9-811D-58DA96D031AC}"/>
              </a:ext>
            </a:extLst>
          </p:cNvPr>
          <p:cNvSpPr txBox="1"/>
          <p:nvPr/>
        </p:nvSpPr>
        <p:spPr>
          <a:xfrm>
            <a:off x="2666317" y="232126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Figure S7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BFE6574A-965C-4420-BCDD-5026EFB18F2B}"/>
              </a:ext>
            </a:extLst>
          </p:cNvPr>
          <p:cNvSpPr txBox="1"/>
          <p:nvPr/>
        </p:nvSpPr>
        <p:spPr>
          <a:xfrm>
            <a:off x="472201" y="6830622"/>
            <a:ext cx="5820824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7. Therapy results in increase in NKG2D expression on NK cells.</a:t>
            </a:r>
          </a:p>
          <a:p>
            <a:pPr marL="228600" indent="-228600">
              <a:buAutoNum type="alphaLcPeriod"/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epresentative histogram of NKG2D expression on NK cells in each cohort of animals.</a:t>
            </a:r>
          </a:p>
          <a:p>
            <a:pPr marL="228600" indent="-228600">
              <a:buAutoNum type="alphaLcPeriod"/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ooled summary data of NKG2D expression in all animals (n=6-10) from each cohort.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IL, tumor infiltrates. The </a:t>
            </a:r>
            <a:r>
              <a:rPr lang="en-US" sz="1100" dirty="0" err="1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I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tibody is B10G5.</a:t>
            </a:r>
          </a:p>
        </p:txBody>
      </p:sp>
    </p:spTree>
    <p:extLst>
      <p:ext uri="{BB962C8B-B14F-4D97-AF65-F5344CB8AC3E}">
        <p14:creationId xmlns:p14="http://schemas.microsoft.com/office/powerpoint/2010/main" val="8772749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0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9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46602</TotalTime>
  <Words>1141</Words>
  <Application>Microsoft Office PowerPoint</Application>
  <PresentationFormat>On-screen Show (4:3)</PresentationFormat>
  <Paragraphs>212</Paragraphs>
  <Slides>8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nglan Wu</dc:creator>
  <cp:lastModifiedBy>Jennifer Donglan Wu</cp:lastModifiedBy>
  <cp:revision>2059</cp:revision>
  <cp:lastPrinted>2017-03-06T18:14:30Z</cp:lastPrinted>
  <dcterms:created xsi:type="dcterms:W3CDTF">2016-02-24T21:48:23Z</dcterms:created>
  <dcterms:modified xsi:type="dcterms:W3CDTF">2019-06-22T06:40:19Z</dcterms:modified>
</cp:coreProperties>
</file>